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F5609-EEDA-4D9F-9637-C3D492D05C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84A4C-23D1-4D53-A7E2-725B047068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C80D4-9CC2-4EBF-8AA3-6A90F634C4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3414C-CDFA-45D0-8CA1-0155F1FF36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E62E8-FF29-4B4F-AFF1-CEA4EA46F6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97252-8222-4562-BFA2-020814E3DB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A6623-4462-4DD8-8B96-4125E1E56F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F305B-D8EE-4DAD-B63B-FE9BEA08C6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22A14-0CE8-4A3F-B325-B455AAB34C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220D6-28C4-4A49-BC99-35FECE0555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F6380-B8F3-462E-8E37-2064328661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F81A9-C318-469B-940B-8F69C824C6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D892BA-1461-4EAF-9143-943EDCF267C8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3"/>
          <p:cNvSpPr/>
          <p:nvPr/>
        </p:nvSpPr>
        <p:spPr>
          <a:xfrm>
            <a:off x="3059280" y="1630440"/>
            <a:ext cx="502920" cy="217440"/>
          </a:xfrm>
          <a:prstGeom prst="rightArrow">
            <a:avLst>
              <a:gd name="adj1" fmla="val 50000"/>
              <a:gd name="adj2" fmla="val 57823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4"/>
          <p:cNvSpPr/>
          <p:nvPr/>
        </p:nvSpPr>
        <p:spPr>
          <a:xfrm>
            <a:off x="2902320" y="1270080"/>
            <a:ext cx="81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BP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6"/>
          <p:cNvSpPr/>
          <p:nvPr/>
        </p:nvSpPr>
        <p:spPr>
          <a:xfrm>
            <a:off x="6228000" y="2158920"/>
            <a:ext cx="81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LR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19"/>
          <p:cNvSpPr/>
          <p:nvPr/>
        </p:nvSpPr>
        <p:spPr>
          <a:xfrm>
            <a:off x="6329520" y="2590920"/>
            <a:ext cx="502920" cy="217440"/>
          </a:xfrm>
          <a:prstGeom prst="rightArrow">
            <a:avLst>
              <a:gd name="adj1" fmla="val 50000"/>
              <a:gd name="adj2" fmla="val 57823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21"/>
          <p:cNvSpPr/>
          <p:nvPr/>
        </p:nvSpPr>
        <p:spPr>
          <a:xfrm>
            <a:off x="2855880" y="982800"/>
            <a:ext cx="73080" cy="2158920"/>
          </a:xfrm>
          <a:custGeom>
            <a:avLst/>
            <a:gdLst>
              <a:gd name="textAreaLeft" fmla="*/ 0 w 73080"/>
              <a:gd name="textAreaRight" fmla="*/ 51480 w 73080"/>
              <a:gd name="textAreaTop" fmla="*/ 89640 h 2158920"/>
              <a:gd name="textAreaBottom" fmla="*/ 2069280 h 2158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22"/>
          <p:cNvSpPr/>
          <p:nvPr/>
        </p:nvSpPr>
        <p:spPr>
          <a:xfrm>
            <a:off x="6084720" y="1582560"/>
            <a:ext cx="144720" cy="2376720"/>
          </a:xfrm>
          <a:custGeom>
            <a:avLst/>
            <a:gdLst>
              <a:gd name="textAreaLeft" fmla="*/ 0 w 144720"/>
              <a:gd name="textAreaRight" fmla="*/ 101520 w 144720"/>
              <a:gd name="textAreaTop" fmla="*/ 99000 h 2376720"/>
              <a:gd name="textAreaBottom" fmla="*/ 2277720 h 2376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224 Grupo"/>
          <p:cNvGrpSpPr/>
          <p:nvPr/>
        </p:nvGrpSpPr>
        <p:grpSpPr>
          <a:xfrm>
            <a:off x="181440" y="1628640"/>
            <a:ext cx="2414520" cy="1839960"/>
            <a:chOff x="181440" y="1628640"/>
            <a:chExt cx="2414520" cy="1839960"/>
          </a:xfrm>
        </p:grpSpPr>
        <p:sp>
          <p:nvSpPr>
            <p:cNvPr id="48" name="AutoShape 76"/>
            <p:cNvSpPr/>
            <p:nvPr/>
          </p:nvSpPr>
          <p:spPr>
            <a:xfrm>
              <a:off x="323640" y="1628640"/>
              <a:ext cx="2244960" cy="183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78"/>
            <p:cNvSpPr/>
            <p:nvPr/>
          </p:nvSpPr>
          <p:spPr>
            <a:xfrm>
              <a:off x="804600" y="1676160"/>
              <a:ext cx="1592280" cy="1594080"/>
            </a:xfrm>
            <a:custGeom>
              <a:avLst/>
              <a:gdLst>
                <a:gd name="textAreaLeft" fmla="*/ 0 w 1592280"/>
                <a:gd name="textAreaRight" fmla="*/ 1592640 w 1592280"/>
                <a:gd name="textAreaTop" fmla="*/ 0 h 1594080"/>
                <a:gd name="textAreaBottom" fmla="*/ 1594440 h 1594080"/>
              </a:gdLst>
              <a:ahLst/>
              <a:rect l="textAreaLeft" t="textAreaTop" r="textAreaRight" b="textAreaBottom"/>
              <a:pathLst>
                <a:path w="1003" h="1004">
                  <a:moveTo>
                    <a:pt x="506" y="0"/>
                  </a:moveTo>
                  <a:lnTo>
                    <a:pt x="461" y="2"/>
                  </a:lnTo>
                  <a:lnTo>
                    <a:pt x="416" y="7"/>
                  </a:lnTo>
                  <a:lnTo>
                    <a:pt x="373" y="17"/>
                  </a:lnTo>
                  <a:lnTo>
                    <a:pt x="330" y="31"/>
                  </a:lnTo>
                  <a:lnTo>
                    <a:pt x="289" y="48"/>
                  </a:lnTo>
                  <a:lnTo>
                    <a:pt x="249" y="69"/>
                  </a:lnTo>
                  <a:lnTo>
                    <a:pt x="211" y="93"/>
                  </a:lnTo>
                  <a:lnTo>
                    <a:pt x="176" y="121"/>
                  </a:lnTo>
                  <a:lnTo>
                    <a:pt x="143" y="151"/>
                  </a:lnTo>
                  <a:lnTo>
                    <a:pt x="113" y="184"/>
                  </a:lnTo>
                  <a:lnTo>
                    <a:pt x="87" y="220"/>
                  </a:lnTo>
                  <a:lnTo>
                    <a:pt x="64" y="259"/>
                  </a:lnTo>
                  <a:lnTo>
                    <a:pt x="44" y="300"/>
                  </a:lnTo>
                  <a:lnTo>
                    <a:pt x="26" y="341"/>
                  </a:lnTo>
                  <a:lnTo>
                    <a:pt x="14" y="384"/>
                  </a:lnTo>
                  <a:lnTo>
                    <a:pt x="5" y="429"/>
                  </a:lnTo>
                  <a:lnTo>
                    <a:pt x="2" y="473"/>
                  </a:lnTo>
                  <a:lnTo>
                    <a:pt x="0" y="518"/>
                  </a:lnTo>
                  <a:lnTo>
                    <a:pt x="4" y="563"/>
                  </a:lnTo>
                  <a:lnTo>
                    <a:pt x="11" y="607"/>
                  </a:lnTo>
                  <a:lnTo>
                    <a:pt x="23" y="651"/>
                  </a:lnTo>
                  <a:lnTo>
                    <a:pt x="37" y="693"/>
                  </a:lnTo>
                  <a:lnTo>
                    <a:pt x="57" y="734"/>
                  </a:lnTo>
                  <a:lnTo>
                    <a:pt x="80" y="772"/>
                  </a:lnTo>
                  <a:lnTo>
                    <a:pt x="106" y="809"/>
                  </a:lnTo>
                  <a:lnTo>
                    <a:pt x="134" y="843"/>
                  </a:lnTo>
                  <a:lnTo>
                    <a:pt x="166" y="875"/>
                  </a:lnTo>
                  <a:lnTo>
                    <a:pt x="201" y="903"/>
                  </a:lnTo>
                  <a:lnTo>
                    <a:pt x="237" y="928"/>
                  </a:lnTo>
                  <a:lnTo>
                    <a:pt x="276" y="951"/>
                  </a:lnTo>
                  <a:lnTo>
                    <a:pt x="317" y="969"/>
                  </a:lnTo>
                  <a:lnTo>
                    <a:pt x="359" y="983"/>
                  </a:lnTo>
                  <a:lnTo>
                    <a:pt x="403" y="994"/>
                  </a:lnTo>
                  <a:lnTo>
                    <a:pt x="447" y="1001"/>
                  </a:lnTo>
                  <a:lnTo>
                    <a:pt x="492" y="1004"/>
                  </a:lnTo>
                  <a:lnTo>
                    <a:pt x="538" y="1003"/>
                  </a:lnTo>
                  <a:lnTo>
                    <a:pt x="582" y="998"/>
                  </a:lnTo>
                  <a:lnTo>
                    <a:pt x="626" y="988"/>
                  </a:lnTo>
                  <a:lnTo>
                    <a:pt x="669" y="975"/>
                  </a:lnTo>
                  <a:lnTo>
                    <a:pt x="710" y="958"/>
                  </a:lnTo>
                  <a:lnTo>
                    <a:pt x="749" y="938"/>
                  </a:lnTo>
                  <a:lnTo>
                    <a:pt x="788" y="915"/>
                  </a:lnTo>
                  <a:lnTo>
                    <a:pt x="824" y="887"/>
                  </a:lnTo>
                  <a:lnTo>
                    <a:pt x="856" y="856"/>
                  </a:lnTo>
                  <a:lnTo>
                    <a:pt x="887" y="823"/>
                  </a:lnTo>
                  <a:lnTo>
                    <a:pt x="914" y="788"/>
                  </a:lnTo>
                  <a:lnTo>
                    <a:pt x="938" y="750"/>
                  </a:lnTo>
                  <a:lnTo>
                    <a:pt x="957" y="710"/>
                  </a:lnTo>
                  <a:lnTo>
                    <a:pt x="975" y="668"/>
                  </a:lnTo>
                  <a:lnTo>
                    <a:pt x="987" y="624"/>
                  </a:lnTo>
                  <a:lnTo>
                    <a:pt x="997" y="581"/>
                  </a:lnTo>
                  <a:lnTo>
                    <a:pt x="1002" y="536"/>
                  </a:lnTo>
                  <a:lnTo>
                    <a:pt x="1003" y="492"/>
                  </a:lnTo>
                  <a:lnTo>
                    <a:pt x="1000" y="447"/>
                  </a:lnTo>
                  <a:lnTo>
                    <a:pt x="993" y="403"/>
                  </a:lnTo>
                  <a:lnTo>
                    <a:pt x="982" y="359"/>
                  </a:lnTo>
                  <a:lnTo>
                    <a:pt x="967" y="317"/>
                  </a:lnTo>
                  <a:lnTo>
                    <a:pt x="949" y="276"/>
                  </a:lnTo>
                  <a:lnTo>
                    <a:pt x="928" y="237"/>
                  </a:lnTo>
                  <a:lnTo>
                    <a:pt x="902" y="199"/>
                  </a:lnTo>
                  <a:lnTo>
                    <a:pt x="873" y="165"/>
                  </a:lnTo>
                  <a:lnTo>
                    <a:pt x="841" y="134"/>
                  </a:lnTo>
                  <a:lnTo>
                    <a:pt x="808" y="104"/>
                  </a:lnTo>
                  <a:lnTo>
                    <a:pt x="771" y="78"/>
                  </a:lnTo>
                  <a:lnTo>
                    <a:pt x="732" y="56"/>
                  </a:lnTo>
                  <a:lnTo>
                    <a:pt x="691" y="37"/>
                  </a:lnTo>
                  <a:lnTo>
                    <a:pt x="649" y="22"/>
                  </a:lnTo>
                  <a:lnTo>
                    <a:pt x="606" y="11"/>
                  </a:lnTo>
                  <a:lnTo>
                    <a:pt x="561" y="3"/>
                  </a:lnTo>
                  <a:lnTo>
                    <a:pt x="517" y="0"/>
                  </a:lnTo>
                  <a:lnTo>
                    <a:pt x="507" y="0"/>
                  </a:lnTo>
                  <a:lnTo>
                    <a:pt x="507" y="11"/>
                  </a:lnTo>
                  <a:lnTo>
                    <a:pt x="550" y="13"/>
                  </a:lnTo>
                  <a:lnTo>
                    <a:pt x="593" y="20"/>
                  </a:lnTo>
                  <a:lnTo>
                    <a:pt x="637" y="29"/>
                  </a:lnTo>
                  <a:lnTo>
                    <a:pt x="678" y="43"/>
                  </a:lnTo>
                  <a:lnTo>
                    <a:pt x="718" y="60"/>
                  </a:lnTo>
                  <a:lnTo>
                    <a:pt x="757" y="82"/>
                  </a:lnTo>
                  <a:lnTo>
                    <a:pt x="793" y="106"/>
                  </a:lnTo>
                  <a:lnTo>
                    <a:pt x="827" y="135"/>
                  </a:lnTo>
                  <a:lnTo>
                    <a:pt x="858" y="165"/>
                  </a:lnTo>
                  <a:lnTo>
                    <a:pt x="887" y="198"/>
                  </a:lnTo>
                  <a:lnTo>
                    <a:pt x="913" y="234"/>
                  </a:lnTo>
                  <a:lnTo>
                    <a:pt x="935" y="271"/>
                  </a:lnTo>
                  <a:lnTo>
                    <a:pt x="954" y="311"/>
                  </a:lnTo>
                  <a:lnTo>
                    <a:pt x="969" y="353"/>
                  </a:lnTo>
                  <a:lnTo>
                    <a:pt x="981" y="395"/>
                  </a:lnTo>
                  <a:lnTo>
                    <a:pt x="988" y="439"/>
                  </a:lnTo>
                  <a:lnTo>
                    <a:pt x="992" y="482"/>
                  </a:lnTo>
                  <a:lnTo>
                    <a:pt x="992" y="525"/>
                  </a:lnTo>
                  <a:lnTo>
                    <a:pt x="987" y="570"/>
                  </a:lnTo>
                  <a:lnTo>
                    <a:pt x="980" y="613"/>
                  </a:lnTo>
                  <a:lnTo>
                    <a:pt x="967" y="655"/>
                  </a:lnTo>
                  <a:lnTo>
                    <a:pt x="953" y="696"/>
                  </a:lnTo>
                  <a:lnTo>
                    <a:pt x="933" y="736"/>
                  </a:lnTo>
                  <a:lnTo>
                    <a:pt x="910" y="773"/>
                  </a:lnTo>
                  <a:lnTo>
                    <a:pt x="884" y="809"/>
                  </a:lnTo>
                  <a:lnTo>
                    <a:pt x="856" y="841"/>
                  </a:lnTo>
                  <a:lnTo>
                    <a:pt x="824" y="872"/>
                  </a:lnTo>
                  <a:lnTo>
                    <a:pt x="790" y="900"/>
                  </a:lnTo>
                  <a:lnTo>
                    <a:pt x="753" y="923"/>
                  </a:lnTo>
                  <a:lnTo>
                    <a:pt x="715" y="944"/>
                  </a:lnTo>
                  <a:lnTo>
                    <a:pt x="674" y="962"/>
                  </a:lnTo>
                  <a:lnTo>
                    <a:pt x="633" y="975"/>
                  </a:lnTo>
                  <a:lnTo>
                    <a:pt x="590" y="985"/>
                  </a:lnTo>
                  <a:lnTo>
                    <a:pt x="546" y="991"/>
                  </a:lnTo>
                  <a:lnTo>
                    <a:pt x="503" y="993"/>
                  </a:lnTo>
                  <a:lnTo>
                    <a:pt x="458" y="991"/>
                  </a:lnTo>
                  <a:lnTo>
                    <a:pt x="415" y="985"/>
                  </a:lnTo>
                  <a:lnTo>
                    <a:pt x="372" y="975"/>
                  </a:lnTo>
                  <a:lnTo>
                    <a:pt x="331" y="963"/>
                  </a:lnTo>
                  <a:lnTo>
                    <a:pt x="290" y="946"/>
                  </a:lnTo>
                  <a:lnTo>
                    <a:pt x="252" y="924"/>
                  </a:lnTo>
                  <a:lnTo>
                    <a:pt x="215" y="901"/>
                  </a:lnTo>
                  <a:lnTo>
                    <a:pt x="180" y="874"/>
                  </a:lnTo>
                  <a:lnTo>
                    <a:pt x="149" y="843"/>
                  </a:lnTo>
                  <a:lnTo>
                    <a:pt x="119" y="810"/>
                  </a:lnTo>
                  <a:lnTo>
                    <a:pt x="93" y="774"/>
                  </a:lnTo>
                  <a:lnTo>
                    <a:pt x="71" y="737"/>
                  </a:lnTo>
                  <a:lnTo>
                    <a:pt x="51" y="698"/>
                  </a:lnTo>
                  <a:lnTo>
                    <a:pt x="36" y="657"/>
                  </a:lnTo>
                  <a:lnTo>
                    <a:pt x="24" y="615"/>
                  </a:lnTo>
                  <a:lnTo>
                    <a:pt x="16" y="571"/>
                  </a:lnTo>
                  <a:lnTo>
                    <a:pt x="11" y="528"/>
                  </a:lnTo>
                  <a:lnTo>
                    <a:pt x="11" y="483"/>
                  </a:lnTo>
                  <a:lnTo>
                    <a:pt x="15" y="440"/>
                  </a:lnTo>
                  <a:lnTo>
                    <a:pt x="23" y="396"/>
                  </a:lnTo>
                  <a:lnTo>
                    <a:pt x="34" y="354"/>
                  </a:lnTo>
                  <a:lnTo>
                    <a:pt x="49" y="312"/>
                  </a:lnTo>
                  <a:lnTo>
                    <a:pt x="67" y="272"/>
                  </a:lnTo>
                  <a:lnTo>
                    <a:pt x="90" y="235"/>
                  </a:lnTo>
                  <a:lnTo>
                    <a:pt x="116" y="199"/>
                  </a:lnTo>
                  <a:lnTo>
                    <a:pt x="144" y="166"/>
                  </a:lnTo>
                  <a:lnTo>
                    <a:pt x="175" y="135"/>
                  </a:lnTo>
                  <a:lnTo>
                    <a:pt x="210" y="108"/>
                  </a:lnTo>
                  <a:lnTo>
                    <a:pt x="246" y="83"/>
                  </a:lnTo>
                  <a:lnTo>
                    <a:pt x="284" y="62"/>
                  </a:lnTo>
                  <a:lnTo>
                    <a:pt x="324" y="44"/>
                  </a:lnTo>
                  <a:lnTo>
                    <a:pt x="366" y="29"/>
                  </a:lnTo>
                  <a:lnTo>
                    <a:pt x="408" y="20"/>
                  </a:lnTo>
                  <a:lnTo>
                    <a:pt x="452" y="13"/>
                  </a:lnTo>
                  <a:lnTo>
                    <a:pt x="496" y="11"/>
                  </a:lnTo>
                  <a:lnTo>
                    <a:pt x="506" y="11"/>
                  </a:lnTo>
                  <a:lnTo>
                    <a:pt x="506" y="0"/>
                  </a:lnTo>
                  <a:close/>
                </a:path>
              </a:pathLst>
            </a:cu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Oval 79"/>
            <p:cNvSpPr/>
            <p:nvPr/>
          </p:nvSpPr>
          <p:spPr>
            <a:xfrm>
              <a:off x="804600" y="1676160"/>
              <a:ext cx="1592280" cy="159408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Oval 80"/>
            <p:cNvSpPr/>
            <p:nvPr/>
          </p:nvSpPr>
          <p:spPr>
            <a:xfrm>
              <a:off x="822240" y="1693440"/>
              <a:ext cx="1557360" cy="155916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81"/>
            <p:cNvSpPr/>
            <p:nvPr/>
          </p:nvSpPr>
          <p:spPr>
            <a:xfrm flipV="1">
              <a:off x="1608120" y="1676160"/>
              <a:ext cx="1440" cy="17280"/>
            </a:xfrm>
            <a:prstGeom prst="line">
              <a:avLst/>
            </a:prstGeom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82"/>
            <p:cNvSpPr/>
            <p:nvPr/>
          </p:nvSpPr>
          <p:spPr>
            <a:xfrm>
              <a:off x="1343160" y="2349360"/>
              <a:ext cx="57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DONR/Ze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83"/>
            <p:cNvSpPr/>
            <p:nvPr/>
          </p:nvSpPr>
          <p:spPr>
            <a:xfrm>
              <a:off x="1493280" y="250488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4291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84"/>
            <p:cNvSpPr/>
            <p:nvPr/>
          </p:nvSpPr>
          <p:spPr>
            <a:xfrm>
              <a:off x="2208240" y="2620800"/>
              <a:ext cx="210960" cy="338040"/>
            </a:xfrm>
            <a:custGeom>
              <a:avLst/>
              <a:gdLst>
                <a:gd name="textAreaLeft" fmla="*/ 0 w 210960"/>
                <a:gd name="textAreaRight" fmla="*/ 211320 w 210960"/>
                <a:gd name="textAreaTop" fmla="*/ 0 h 338040"/>
                <a:gd name="textAreaBottom" fmla="*/ 338400 h 338040"/>
              </a:gdLst>
              <a:ahLst/>
              <a:rect l="textAreaLeft" t="textAreaTop" r="textAreaRight" b="textAreaBottom"/>
              <a:pathLst>
                <a:path w="133" h="213">
                  <a:moveTo>
                    <a:pt x="34" y="213"/>
                  </a:moveTo>
                  <a:lnTo>
                    <a:pt x="59" y="176"/>
                  </a:lnTo>
                  <a:lnTo>
                    <a:pt x="81" y="135"/>
                  </a:lnTo>
                  <a:lnTo>
                    <a:pt x="99" y="93"/>
                  </a:lnTo>
                  <a:lnTo>
                    <a:pt x="114" y="48"/>
                  </a:lnTo>
                  <a:lnTo>
                    <a:pt x="117" y="37"/>
                  </a:lnTo>
                  <a:lnTo>
                    <a:pt x="133" y="41"/>
                  </a:lnTo>
                  <a:lnTo>
                    <a:pt x="104" y="0"/>
                  </a:lnTo>
                  <a:lnTo>
                    <a:pt x="62" y="22"/>
                  </a:lnTo>
                  <a:lnTo>
                    <a:pt x="78" y="26"/>
                  </a:lnTo>
                  <a:lnTo>
                    <a:pt x="66" y="67"/>
                  </a:lnTo>
                  <a:lnTo>
                    <a:pt x="50" y="106"/>
                  </a:lnTo>
                  <a:lnTo>
                    <a:pt x="30" y="145"/>
                  </a:lnTo>
                  <a:lnTo>
                    <a:pt x="7" y="181"/>
                  </a:lnTo>
                  <a:lnTo>
                    <a:pt x="0" y="189"/>
                  </a:lnTo>
                  <a:lnTo>
                    <a:pt x="34" y="213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Arc 85"/>
            <p:cNvSpPr/>
            <p:nvPr/>
          </p:nvSpPr>
          <p:spPr>
            <a:xfrm>
              <a:off x="1601640" y="2473200"/>
              <a:ext cx="793800" cy="485640"/>
            </a:xfrm>
            <a:custGeom>
              <a:avLst/>
              <a:gdLst>
                <a:gd name="textAreaLeft" fmla="*/ 0 w 793800"/>
                <a:gd name="textAreaRight" fmla="*/ 794160 w 793800"/>
                <a:gd name="textAreaTop" fmla="*/ 0 h 485640"/>
                <a:gd name="textAreaBottom" fmla="*/ 486000 h 485640"/>
              </a:gdLst>
              <a:ahLst/>
              <a:rect l="textAreaLeft" t="textAreaTop" r="textAreaRight" b="textAreaBottom"/>
              <a:pathLst>
                <a:path fill="none" w="20904" h="12791">
                  <a:moveTo>
                    <a:pt x="20903" y="5440"/>
                  </a:moveTo>
                  <a:cubicBezTo>
                    <a:pt x="20213" y="8090"/>
                    <a:pt x="19026" y="10584"/>
                    <a:pt x="17405" y="12790"/>
                  </a:cubicBezTo>
                </a:path>
                <a:path stroke="0" w="20904" h="12791">
                  <a:moveTo>
                    <a:pt x="20903" y="5440"/>
                  </a:moveTo>
                  <a:cubicBezTo>
                    <a:pt x="20213" y="8090"/>
                    <a:pt x="19026" y="10584"/>
                    <a:pt x="17405" y="12790"/>
                  </a:cubicBezTo>
                  <a:lnTo>
                    <a:pt x="0" y="0"/>
                  </a:lnTo>
                  <a:lnTo>
                    <a:pt x="20903" y="5440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Arc 86"/>
            <p:cNvSpPr/>
            <p:nvPr/>
          </p:nvSpPr>
          <p:spPr>
            <a:xfrm>
              <a:off x="1601640" y="2473200"/>
              <a:ext cx="730080" cy="449280"/>
            </a:xfrm>
            <a:custGeom>
              <a:avLst/>
              <a:gdLst>
                <a:gd name="textAreaLeft" fmla="*/ 0 w 730080"/>
                <a:gd name="textAreaRight" fmla="*/ 730080 w 730080"/>
                <a:gd name="textAreaTop" fmla="*/ 0 h 449280"/>
                <a:gd name="textAreaBottom" fmla="*/ 449640 h 449280"/>
              </a:gdLst>
              <a:ahLst/>
              <a:rect l="textAreaLeft" t="textAreaTop" r="textAreaRight" b="textAreaBottom"/>
              <a:pathLst>
                <a:path fill="none" w="20913" h="12820">
                  <a:moveTo>
                    <a:pt x="20913" y="5404"/>
                  </a:moveTo>
                  <a:cubicBezTo>
                    <a:pt x="20221" y="8078"/>
                    <a:pt x="19023" y="10596"/>
                    <a:pt x="17384" y="12820"/>
                  </a:cubicBezTo>
                </a:path>
                <a:path stroke="0" w="20913" h="12820">
                  <a:moveTo>
                    <a:pt x="20913" y="5404"/>
                  </a:moveTo>
                  <a:cubicBezTo>
                    <a:pt x="20221" y="8078"/>
                    <a:pt x="19023" y="10596"/>
                    <a:pt x="17384" y="12820"/>
                  </a:cubicBezTo>
                  <a:lnTo>
                    <a:pt x="0" y="0"/>
                  </a:lnTo>
                  <a:lnTo>
                    <a:pt x="20913" y="5404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87"/>
            <p:cNvSpPr/>
            <p:nvPr/>
          </p:nvSpPr>
          <p:spPr>
            <a:xfrm>
              <a:off x="2208240" y="2921040"/>
              <a:ext cx="53640" cy="3780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88"/>
            <p:cNvSpPr/>
            <p:nvPr/>
          </p:nvSpPr>
          <p:spPr>
            <a:xfrm>
              <a:off x="2306520" y="2620800"/>
              <a:ext cx="112680" cy="64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57" h="33">
                  <a:moveTo>
                    <a:pt x="13" y="21"/>
                  </a:moveTo>
                  <a:lnTo>
                    <a:pt x="0" y="18"/>
                  </a:lnTo>
                  <a:lnTo>
                    <a:pt x="34" y="0"/>
                  </a:lnTo>
                  <a:lnTo>
                    <a:pt x="57" y="33"/>
                  </a:lnTo>
                  <a:lnTo>
                    <a:pt x="44" y="30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89"/>
            <p:cNvSpPr/>
            <p:nvPr/>
          </p:nvSpPr>
          <p:spPr>
            <a:xfrm flipH="1" flipV="1">
              <a:off x="2352600" y="2801880"/>
              <a:ext cx="2376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90"/>
            <p:cNvSpPr/>
            <p:nvPr/>
          </p:nvSpPr>
          <p:spPr>
            <a:xfrm>
              <a:off x="2380320" y="283356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ccd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91"/>
            <p:cNvSpPr/>
            <p:nvPr/>
          </p:nvSpPr>
          <p:spPr>
            <a:xfrm>
              <a:off x="1184040" y="3124080"/>
              <a:ext cx="747720" cy="169560"/>
            </a:xfrm>
            <a:custGeom>
              <a:avLst/>
              <a:gdLst>
                <a:gd name="textAreaLeft" fmla="*/ 0 w 747720"/>
                <a:gd name="textAreaRight" fmla="*/ 748080 w 747720"/>
                <a:gd name="textAreaTop" fmla="*/ 0 h 169560"/>
                <a:gd name="textAreaBottom" fmla="*/ 169560 h 169560"/>
              </a:gdLst>
              <a:ahLst/>
              <a:rect l="textAreaLeft" t="textAreaTop" r="textAreaRight" b="textAreaBottom"/>
              <a:pathLst>
                <a:path w="471" h="107">
                  <a:moveTo>
                    <a:pt x="0" y="35"/>
                  </a:moveTo>
                  <a:lnTo>
                    <a:pt x="41" y="57"/>
                  </a:lnTo>
                  <a:lnTo>
                    <a:pt x="85" y="74"/>
                  </a:lnTo>
                  <a:lnTo>
                    <a:pt x="128" y="89"/>
                  </a:lnTo>
                  <a:lnTo>
                    <a:pt x="174" y="99"/>
                  </a:lnTo>
                  <a:lnTo>
                    <a:pt x="219" y="105"/>
                  </a:lnTo>
                  <a:lnTo>
                    <a:pt x="265" y="107"/>
                  </a:lnTo>
                  <a:lnTo>
                    <a:pt x="311" y="104"/>
                  </a:lnTo>
                  <a:lnTo>
                    <a:pt x="357" y="98"/>
                  </a:lnTo>
                  <a:lnTo>
                    <a:pt x="401" y="88"/>
                  </a:lnTo>
                  <a:lnTo>
                    <a:pt x="446" y="73"/>
                  </a:lnTo>
                  <a:lnTo>
                    <a:pt x="447" y="72"/>
                  </a:lnTo>
                  <a:lnTo>
                    <a:pt x="453" y="88"/>
                  </a:lnTo>
                  <a:lnTo>
                    <a:pt x="471" y="41"/>
                  </a:lnTo>
                  <a:lnTo>
                    <a:pt x="427" y="19"/>
                  </a:lnTo>
                  <a:lnTo>
                    <a:pt x="434" y="34"/>
                  </a:lnTo>
                  <a:lnTo>
                    <a:pt x="393" y="48"/>
                  </a:lnTo>
                  <a:lnTo>
                    <a:pt x="352" y="57"/>
                  </a:lnTo>
                  <a:lnTo>
                    <a:pt x="310" y="63"/>
                  </a:lnTo>
                  <a:lnTo>
                    <a:pt x="267" y="66"/>
                  </a:lnTo>
                  <a:lnTo>
                    <a:pt x="224" y="65"/>
                  </a:lnTo>
                  <a:lnTo>
                    <a:pt x="182" y="60"/>
                  </a:lnTo>
                  <a:lnTo>
                    <a:pt x="141" y="50"/>
                  </a:lnTo>
                  <a:lnTo>
                    <a:pt x="101" y="37"/>
                  </a:lnTo>
                  <a:lnTo>
                    <a:pt x="61" y="21"/>
                  </a:lnTo>
                  <a:lnTo>
                    <a:pt x="24" y="1"/>
                  </a:lnTo>
                  <a:lnTo>
                    <a:pt x="21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rc 92"/>
            <p:cNvSpPr/>
            <p:nvPr/>
          </p:nvSpPr>
          <p:spPr>
            <a:xfrm>
              <a:off x="1184040" y="2473200"/>
              <a:ext cx="709560" cy="820800"/>
            </a:xfrm>
            <a:custGeom>
              <a:avLst/>
              <a:gdLst>
                <a:gd name="textAreaLeft" fmla="*/ 0 w 709560"/>
                <a:gd name="textAreaRight" fmla="*/ 709920 w 709560"/>
                <a:gd name="textAreaTop" fmla="*/ 0 h 820800"/>
                <a:gd name="textAreaBottom" fmla="*/ 821160 h 820800"/>
              </a:gdLst>
              <a:ahLst/>
              <a:rect l="textAreaLeft" t="textAreaTop" r="textAreaRight" b="textAreaBottom"/>
              <a:pathLst>
                <a:path fill="none" w="18708" h="21600">
                  <a:moveTo>
                    <a:pt x="18708" y="20177"/>
                  </a:moveTo>
                  <a:cubicBezTo>
                    <a:pt x="16246" y="21117"/>
                    <a:pt x="13633" y="21599"/>
                    <a:pt x="10998" y="21600"/>
                  </a:cubicBezTo>
                  <a:cubicBezTo>
                    <a:pt x="7128" y="21600"/>
                    <a:pt x="3330" y="20560"/>
                    <a:pt x="0" y="18590"/>
                  </a:cubicBezTo>
                </a:path>
                <a:path stroke="0" w="18708" h="21600">
                  <a:moveTo>
                    <a:pt x="18708" y="20177"/>
                  </a:moveTo>
                  <a:cubicBezTo>
                    <a:pt x="16246" y="21117"/>
                    <a:pt x="13633" y="21599"/>
                    <a:pt x="10998" y="21600"/>
                  </a:cubicBezTo>
                  <a:cubicBezTo>
                    <a:pt x="7128" y="21600"/>
                    <a:pt x="3330" y="20560"/>
                    <a:pt x="0" y="18590"/>
                  </a:cubicBezTo>
                  <a:lnTo>
                    <a:pt x="10998" y="0"/>
                  </a:lnTo>
                  <a:lnTo>
                    <a:pt x="18708" y="20177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rc 93"/>
            <p:cNvSpPr/>
            <p:nvPr/>
          </p:nvSpPr>
          <p:spPr>
            <a:xfrm>
              <a:off x="1217520" y="2473200"/>
              <a:ext cx="655560" cy="755640"/>
            </a:xfrm>
            <a:custGeom>
              <a:avLst/>
              <a:gdLst>
                <a:gd name="textAreaLeft" fmla="*/ 0 w 655560"/>
                <a:gd name="textAreaRight" fmla="*/ 655920 w 655560"/>
                <a:gd name="textAreaTop" fmla="*/ 0 h 755640"/>
                <a:gd name="textAreaBottom" fmla="*/ 756000 h 755640"/>
              </a:gdLst>
              <a:ahLst/>
              <a:rect l="textAreaLeft" t="textAreaTop" r="textAreaRight" b="textAreaBottom"/>
              <a:pathLst>
                <a:path fill="none" w="18758" h="21600">
                  <a:moveTo>
                    <a:pt x="18758" y="20154"/>
                  </a:moveTo>
                  <a:cubicBezTo>
                    <a:pt x="16278" y="21109"/>
                    <a:pt x="13644" y="21599"/>
                    <a:pt x="10988" y="21600"/>
                  </a:cubicBezTo>
                  <a:cubicBezTo>
                    <a:pt x="7122" y="21600"/>
                    <a:pt x="3327" y="20562"/>
                    <a:pt x="-1" y="18596"/>
                  </a:cubicBezTo>
                </a:path>
                <a:path stroke="0" w="18758" h="21600">
                  <a:moveTo>
                    <a:pt x="18758" y="20154"/>
                  </a:moveTo>
                  <a:cubicBezTo>
                    <a:pt x="16278" y="21109"/>
                    <a:pt x="13644" y="21599"/>
                    <a:pt x="10988" y="21600"/>
                  </a:cubicBezTo>
                  <a:cubicBezTo>
                    <a:pt x="7122" y="21600"/>
                    <a:pt x="3327" y="20562"/>
                    <a:pt x="-1" y="18596"/>
                  </a:cubicBezTo>
                  <a:lnTo>
                    <a:pt x="10988" y="0"/>
                  </a:lnTo>
                  <a:lnTo>
                    <a:pt x="18758" y="20154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94"/>
            <p:cNvSpPr/>
            <p:nvPr/>
          </p:nvSpPr>
          <p:spPr>
            <a:xfrm flipH="1">
              <a:off x="1184040" y="3124080"/>
              <a:ext cx="33120" cy="5544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95"/>
            <p:cNvSpPr/>
            <p:nvPr/>
          </p:nvSpPr>
          <p:spPr>
            <a:xfrm>
              <a:off x="1861920" y="3154320"/>
              <a:ext cx="69840" cy="1094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35" h="56">
                  <a:moveTo>
                    <a:pt x="5" y="12"/>
                  </a:moveTo>
                  <a:lnTo>
                    <a:pt x="0" y="0"/>
                  </a:lnTo>
                  <a:lnTo>
                    <a:pt x="35" y="18"/>
                  </a:lnTo>
                  <a:lnTo>
                    <a:pt x="21" y="56"/>
                  </a:lnTo>
                  <a:lnTo>
                    <a:pt x="16" y="43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96"/>
            <p:cNvSpPr/>
            <p:nvPr/>
          </p:nvSpPr>
          <p:spPr>
            <a:xfrm flipH="1" flipV="1">
              <a:off x="1560240" y="3290760"/>
              <a:ext cx="28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97"/>
            <p:cNvSpPr/>
            <p:nvPr/>
          </p:nvSpPr>
          <p:spPr>
            <a:xfrm>
              <a:off x="1385640" y="3359160"/>
              <a:ext cx="26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Cm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98"/>
            <p:cNvSpPr/>
            <p:nvPr/>
          </p:nvSpPr>
          <p:spPr>
            <a:xfrm>
              <a:off x="760320" y="2160360"/>
              <a:ext cx="142560" cy="434880"/>
            </a:xfrm>
            <a:custGeom>
              <a:avLst/>
              <a:gdLst>
                <a:gd name="textAreaLeft" fmla="*/ 0 w 142560"/>
                <a:gd name="textAreaRight" fmla="*/ 142920 w 142560"/>
                <a:gd name="textAreaTop" fmla="*/ 0 h 434880"/>
                <a:gd name="textAreaBottom" fmla="*/ 435240 h 434880"/>
              </a:gdLst>
              <a:ahLst/>
              <a:rect l="textAreaLeft" t="textAreaTop" r="textAreaRight" b="textAreaBottom"/>
              <a:pathLst>
                <a:path w="90" h="274">
                  <a:moveTo>
                    <a:pt x="53" y="0"/>
                  </a:moveTo>
                  <a:lnTo>
                    <a:pt x="37" y="43"/>
                  </a:lnTo>
                  <a:lnTo>
                    <a:pt x="25" y="88"/>
                  </a:lnTo>
                  <a:lnTo>
                    <a:pt x="17" y="132"/>
                  </a:lnTo>
                  <a:lnTo>
                    <a:pt x="13" y="179"/>
                  </a:lnTo>
                  <a:lnTo>
                    <a:pt x="13" y="225"/>
                  </a:lnTo>
                  <a:lnTo>
                    <a:pt x="16" y="244"/>
                  </a:lnTo>
                  <a:lnTo>
                    <a:pt x="0" y="245"/>
                  </a:lnTo>
                  <a:lnTo>
                    <a:pt x="39" y="274"/>
                  </a:lnTo>
                  <a:lnTo>
                    <a:pt x="73" y="238"/>
                  </a:lnTo>
                  <a:lnTo>
                    <a:pt x="57" y="240"/>
                  </a:lnTo>
                  <a:lnTo>
                    <a:pt x="54" y="197"/>
                  </a:lnTo>
                  <a:lnTo>
                    <a:pt x="56" y="155"/>
                  </a:lnTo>
                  <a:lnTo>
                    <a:pt x="62" y="112"/>
                  </a:lnTo>
                  <a:lnTo>
                    <a:pt x="72" y="70"/>
                  </a:lnTo>
                  <a:lnTo>
                    <a:pt x="84" y="31"/>
                  </a:lnTo>
                  <a:lnTo>
                    <a:pt x="90" y="15"/>
                  </a:lnTo>
                  <a:lnTo>
                    <a:pt x="53" y="0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Arc 99"/>
            <p:cNvSpPr/>
            <p:nvPr/>
          </p:nvSpPr>
          <p:spPr>
            <a:xfrm>
              <a:off x="780840" y="2160360"/>
              <a:ext cx="820800" cy="387360"/>
            </a:xfrm>
            <a:custGeom>
              <a:avLst/>
              <a:gdLst>
                <a:gd name="textAreaLeft" fmla="*/ 0 w 820800"/>
                <a:gd name="textAreaRight" fmla="*/ 821160 w 82080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fill="none" w="21600" h="10203">
                  <a:moveTo>
                    <a:pt x="89" y="10203"/>
                  </a:moveTo>
                  <a:cubicBezTo>
                    <a:pt x="29" y="9549"/>
                    <a:pt x="0" y="8894"/>
                    <a:pt x="0" y="8238"/>
                  </a:cubicBezTo>
                  <a:cubicBezTo>
                    <a:pt x="-1" y="5411"/>
                    <a:pt x="554" y="2612"/>
                    <a:pt x="1632" y="-1"/>
                  </a:cubicBezTo>
                </a:path>
                <a:path stroke="0" w="21600" h="10203">
                  <a:moveTo>
                    <a:pt x="89" y="10203"/>
                  </a:moveTo>
                  <a:cubicBezTo>
                    <a:pt x="29" y="9549"/>
                    <a:pt x="0" y="8894"/>
                    <a:pt x="0" y="8238"/>
                  </a:cubicBezTo>
                  <a:cubicBezTo>
                    <a:pt x="-1" y="5411"/>
                    <a:pt x="554" y="2612"/>
                    <a:pt x="1632" y="-1"/>
                  </a:cubicBezTo>
                  <a:lnTo>
                    <a:pt x="21600" y="8238"/>
                  </a:lnTo>
                  <a:lnTo>
                    <a:pt x="89" y="10203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Arc 100"/>
            <p:cNvSpPr/>
            <p:nvPr/>
          </p:nvSpPr>
          <p:spPr>
            <a:xfrm>
              <a:off x="846000" y="2184120"/>
              <a:ext cx="755640" cy="357120"/>
            </a:xfrm>
            <a:custGeom>
              <a:avLst/>
              <a:gdLst>
                <a:gd name="textAreaLeft" fmla="*/ 0 w 755640"/>
                <a:gd name="textAreaRight" fmla="*/ 756000 w 755640"/>
                <a:gd name="textAreaTop" fmla="*/ 0 h 357120"/>
                <a:gd name="textAreaBottom" fmla="*/ 357480 h 357120"/>
              </a:gdLst>
              <a:ahLst/>
              <a:rect l="textAreaLeft" t="textAreaTop" r="textAreaRight" b="textAreaBottom"/>
              <a:pathLst>
                <a:path fill="none" w="21600" h="10203">
                  <a:moveTo>
                    <a:pt x="88" y="10203"/>
                  </a:moveTo>
                  <a:cubicBezTo>
                    <a:pt x="29" y="9553"/>
                    <a:pt x="0" y="8901"/>
                    <a:pt x="0" y="8249"/>
                  </a:cubicBezTo>
                  <a:cubicBezTo>
                    <a:pt x="-1" y="5418"/>
                    <a:pt x="556" y="2615"/>
                    <a:pt x="1637" y="0"/>
                  </a:cubicBezTo>
                </a:path>
                <a:path stroke="0" w="21600" h="10203">
                  <a:moveTo>
                    <a:pt x="88" y="10203"/>
                  </a:moveTo>
                  <a:cubicBezTo>
                    <a:pt x="29" y="9553"/>
                    <a:pt x="0" y="8901"/>
                    <a:pt x="0" y="8249"/>
                  </a:cubicBezTo>
                  <a:cubicBezTo>
                    <a:pt x="-1" y="5418"/>
                    <a:pt x="556" y="2615"/>
                    <a:pt x="1637" y="0"/>
                  </a:cubicBezTo>
                  <a:lnTo>
                    <a:pt x="21600" y="8249"/>
                  </a:lnTo>
                  <a:lnTo>
                    <a:pt x="88" y="10203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01"/>
            <p:cNvSpPr/>
            <p:nvPr/>
          </p:nvSpPr>
          <p:spPr>
            <a:xfrm flipH="1" flipV="1">
              <a:off x="843840" y="2160360"/>
              <a:ext cx="58680" cy="2376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02"/>
            <p:cNvSpPr/>
            <p:nvPr/>
          </p:nvSpPr>
          <p:spPr>
            <a:xfrm>
              <a:off x="760320" y="2538360"/>
              <a:ext cx="115560" cy="56880"/>
            </a:xfrm>
            <a:custGeom>
              <a:avLst/>
              <a:gdLst>
                <a:gd name="textAreaLeft" fmla="*/ 0 w 115560"/>
                <a:gd name="textAreaRight" fmla="*/ 115920 w 11556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59" h="29">
                  <a:moveTo>
                    <a:pt x="46" y="2"/>
                  </a:moveTo>
                  <a:lnTo>
                    <a:pt x="59" y="0"/>
                  </a:lnTo>
                  <a:lnTo>
                    <a:pt x="32" y="29"/>
                  </a:lnTo>
                  <a:lnTo>
                    <a:pt x="0" y="6"/>
                  </a:lnTo>
                  <a:lnTo>
                    <a:pt x="13" y="5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03"/>
            <p:cNvSpPr/>
            <p:nvPr/>
          </p:nvSpPr>
          <p:spPr>
            <a:xfrm>
              <a:off x="738000" y="2350800"/>
              <a:ext cx="48960" cy="25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04"/>
            <p:cNvSpPr/>
            <p:nvPr/>
          </p:nvSpPr>
          <p:spPr>
            <a:xfrm>
              <a:off x="420840" y="2260440"/>
              <a:ext cx="277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Zeo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105"/>
            <p:cNvSpPr/>
            <p:nvPr/>
          </p:nvSpPr>
          <p:spPr>
            <a:xfrm>
              <a:off x="836280" y="2085840"/>
              <a:ext cx="106200" cy="8568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67" h="54">
                  <a:moveTo>
                    <a:pt x="26" y="0"/>
                  </a:moveTo>
                  <a:lnTo>
                    <a:pt x="15" y="23"/>
                  </a:lnTo>
                  <a:lnTo>
                    <a:pt x="0" y="16"/>
                  </a:lnTo>
                  <a:lnTo>
                    <a:pt x="24" y="54"/>
                  </a:lnTo>
                  <a:lnTo>
                    <a:pt x="67" y="47"/>
                  </a:lnTo>
                  <a:lnTo>
                    <a:pt x="52" y="40"/>
                  </a:lnTo>
                  <a:lnTo>
                    <a:pt x="63" y="19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Arc 106"/>
            <p:cNvSpPr/>
            <p:nvPr/>
          </p:nvSpPr>
          <p:spPr>
            <a:xfrm>
              <a:off x="860400" y="2085840"/>
              <a:ext cx="741240" cy="387360"/>
            </a:xfrm>
            <a:custGeom>
              <a:avLst/>
              <a:gdLst>
                <a:gd name="textAreaLeft" fmla="*/ 0 w 741240"/>
                <a:gd name="textAreaRight" fmla="*/ 741600 w 74124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fill="none" w="19528" h="10183">
                  <a:moveTo>
                    <a:pt x="0" y="951"/>
                  </a:moveTo>
                  <a:cubicBezTo>
                    <a:pt x="151" y="630"/>
                    <a:pt x="311" y="313"/>
                    <a:pt x="478" y="-1"/>
                  </a:cubicBezTo>
                </a:path>
                <a:path stroke="0" w="19528" h="10183">
                  <a:moveTo>
                    <a:pt x="0" y="951"/>
                  </a:moveTo>
                  <a:cubicBezTo>
                    <a:pt x="151" y="630"/>
                    <a:pt x="311" y="313"/>
                    <a:pt x="478" y="-1"/>
                  </a:cubicBezTo>
                  <a:lnTo>
                    <a:pt x="19528" y="10183"/>
                  </a:lnTo>
                  <a:lnTo>
                    <a:pt x="0" y="95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Arc 107"/>
            <p:cNvSpPr/>
            <p:nvPr/>
          </p:nvSpPr>
          <p:spPr>
            <a:xfrm>
              <a:off x="919080" y="2116080"/>
              <a:ext cx="682560" cy="357120"/>
            </a:xfrm>
            <a:custGeom>
              <a:avLst/>
              <a:gdLst>
                <a:gd name="textAreaLeft" fmla="*/ 0 w 682560"/>
                <a:gd name="textAreaRight" fmla="*/ 682920 w 682560"/>
                <a:gd name="textAreaTop" fmla="*/ 0 h 357120"/>
                <a:gd name="textAreaBottom" fmla="*/ 357480 h 357120"/>
              </a:gdLst>
              <a:ahLst/>
              <a:rect l="textAreaLeft" t="textAreaTop" r="textAreaRight" b="textAreaBottom"/>
              <a:pathLst>
                <a:path fill="none" w="19519" h="10211">
                  <a:moveTo>
                    <a:pt x="-1" y="960"/>
                  </a:moveTo>
                  <a:cubicBezTo>
                    <a:pt x="153" y="636"/>
                    <a:pt x="315" y="316"/>
                    <a:pt x="484" y="-1"/>
                  </a:cubicBezTo>
                </a:path>
                <a:path stroke="0" w="19519" h="10211">
                  <a:moveTo>
                    <a:pt x="-1" y="960"/>
                  </a:moveTo>
                  <a:cubicBezTo>
                    <a:pt x="153" y="636"/>
                    <a:pt x="315" y="316"/>
                    <a:pt x="484" y="-1"/>
                  </a:cubicBezTo>
                  <a:lnTo>
                    <a:pt x="19519" y="10211"/>
                  </a:lnTo>
                  <a:lnTo>
                    <a:pt x="-1" y="96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08"/>
            <p:cNvSpPr/>
            <p:nvPr/>
          </p:nvSpPr>
          <p:spPr>
            <a:xfrm flipH="1" flipV="1">
              <a:off x="877320" y="2085480"/>
              <a:ext cx="5868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109"/>
            <p:cNvSpPr/>
            <p:nvPr/>
          </p:nvSpPr>
          <p:spPr>
            <a:xfrm>
              <a:off x="836280" y="2111040"/>
              <a:ext cx="106200" cy="6012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54" h="31">
                  <a:moveTo>
                    <a:pt x="42" y="20"/>
                  </a:moveTo>
                  <a:lnTo>
                    <a:pt x="54" y="25"/>
                  </a:lnTo>
                  <a:lnTo>
                    <a:pt x="19" y="31"/>
                  </a:lnTo>
                  <a:lnTo>
                    <a:pt x="0" y="0"/>
                  </a:lnTo>
                  <a:lnTo>
                    <a:pt x="12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10"/>
            <p:cNvSpPr/>
            <p:nvPr/>
          </p:nvSpPr>
          <p:spPr>
            <a:xfrm>
              <a:off x="799920" y="2085840"/>
              <a:ext cx="6012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11"/>
            <p:cNvSpPr/>
            <p:nvPr/>
          </p:nvSpPr>
          <p:spPr>
            <a:xfrm>
              <a:off x="181440" y="1963440"/>
              <a:ext cx="59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EM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112"/>
            <p:cNvSpPr/>
            <p:nvPr/>
          </p:nvSpPr>
          <p:spPr>
            <a:xfrm>
              <a:off x="2163600" y="1925280"/>
              <a:ext cx="196560" cy="247680"/>
            </a:xfrm>
            <a:custGeom>
              <a:avLst/>
              <a:gdLst>
                <a:gd name="textAreaLeft" fmla="*/ 0 w 196560"/>
                <a:gd name="textAreaRight" fmla="*/ 196920 w 19656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w="124" h="156">
                  <a:moveTo>
                    <a:pt x="58" y="143"/>
                  </a:moveTo>
                  <a:lnTo>
                    <a:pt x="104" y="156"/>
                  </a:lnTo>
                  <a:lnTo>
                    <a:pt x="124" y="110"/>
                  </a:lnTo>
                  <a:lnTo>
                    <a:pt x="109" y="118"/>
                  </a:lnTo>
                  <a:lnTo>
                    <a:pt x="88" y="77"/>
                  </a:lnTo>
                  <a:lnTo>
                    <a:pt x="62" y="39"/>
                  </a:lnTo>
                  <a:lnTo>
                    <a:pt x="32" y="3"/>
                  </a:lnTo>
                  <a:lnTo>
                    <a:pt x="31" y="0"/>
                  </a:lnTo>
                  <a:lnTo>
                    <a:pt x="0" y="27"/>
                  </a:lnTo>
                  <a:lnTo>
                    <a:pt x="27" y="61"/>
                  </a:lnTo>
                  <a:lnTo>
                    <a:pt x="51" y="96"/>
                  </a:lnTo>
                  <a:lnTo>
                    <a:pt x="72" y="133"/>
                  </a:lnTo>
                  <a:lnTo>
                    <a:pt x="73" y="135"/>
                  </a:lnTo>
                  <a:lnTo>
                    <a:pt x="58" y="143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Arc 113"/>
            <p:cNvSpPr/>
            <p:nvPr/>
          </p:nvSpPr>
          <p:spPr>
            <a:xfrm>
              <a:off x="1601640" y="1925280"/>
              <a:ext cx="736560" cy="547560"/>
            </a:xfrm>
            <a:custGeom>
              <a:avLst/>
              <a:gdLst>
                <a:gd name="textAreaLeft" fmla="*/ 0 w 736560"/>
                <a:gd name="textAreaRight" fmla="*/ 736920 w 736560"/>
                <a:gd name="textAreaTop" fmla="*/ 0 h 547560"/>
                <a:gd name="textAreaBottom" fmla="*/ 547920 h 547560"/>
              </a:gdLst>
              <a:ahLst/>
              <a:rect l="textAreaLeft" t="textAreaTop" r="textAreaRight" b="textAreaBottom"/>
              <a:pathLst>
                <a:path fill="none" w="19398" h="14407">
                  <a:moveTo>
                    <a:pt x="16093" y="-1"/>
                  </a:moveTo>
                  <a:cubicBezTo>
                    <a:pt x="17414" y="1475"/>
                    <a:pt x="18526" y="3126"/>
                    <a:pt x="19398" y="4905"/>
                  </a:cubicBezTo>
                </a:path>
                <a:path stroke="0" w="19398" h="14407">
                  <a:moveTo>
                    <a:pt x="16093" y="-1"/>
                  </a:moveTo>
                  <a:cubicBezTo>
                    <a:pt x="17414" y="1475"/>
                    <a:pt x="18526" y="3126"/>
                    <a:pt x="19398" y="4905"/>
                  </a:cubicBezTo>
                  <a:lnTo>
                    <a:pt x="0" y="14407"/>
                  </a:lnTo>
                  <a:lnTo>
                    <a:pt x="16093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Arc 114"/>
            <p:cNvSpPr/>
            <p:nvPr/>
          </p:nvSpPr>
          <p:spPr>
            <a:xfrm>
              <a:off x="1601640" y="1968120"/>
              <a:ext cx="677880" cy="504720"/>
            </a:xfrm>
            <a:custGeom>
              <a:avLst/>
              <a:gdLst>
                <a:gd name="textAreaLeft" fmla="*/ 0 w 677880"/>
                <a:gd name="textAreaRight" fmla="*/ 678240 w 677880"/>
                <a:gd name="textAreaTop" fmla="*/ 0 h 504720"/>
                <a:gd name="textAreaBottom" fmla="*/ 505080 h 504720"/>
              </a:gdLst>
              <a:ahLst/>
              <a:rect l="textAreaLeft" t="textAreaTop" r="textAreaRight" b="textAreaBottom"/>
              <a:pathLst>
                <a:path fill="none" w="19387" h="14426">
                  <a:moveTo>
                    <a:pt x="16076" y="-1"/>
                  </a:moveTo>
                  <a:cubicBezTo>
                    <a:pt x="17399" y="1474"/>
                    <a:pt x="18513" y="3123"/>
                    <a:pt x="19386" y="4902"/>
                  </a:cubicBezTo>
                </a:path>
                <a:path stroke="0" w="19387" h="14426">
                  <a:moveTo>
                    <a:pt x="16076" y="-1"/>
                  </a:moveTo>
                  <a:cubicBezTo>
                    <a:pt x="17399" y="1474"/>
                    <a:pt x="18513" y="3123"/>
                    <a:pt x="19386" y="4902"/>
                  </a:cubicBezTo>
                  <a:lnTo>
                    <a:pt x="0" y="14426"/>
                  </a:lnTo>
                  <a:lnTo>
                    <a:pt x="16076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115"/>
            <p:cNvSpPr/>
            <p:nvPr/>
          </p:nvSpPr>
          <p:spPr>
            <a:xfrm flipV="1">
              <a:off x="2163600" y="1924920"/>
              <a:ext cx="48960" cy="4284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116"/>
            <p:cNvSpPr/>
            <p:nvPr/>
          </p:nvSpPr>
          <p:spPr>
            <a:xfrm>
              <a:off x="2255760" y="2099880"/>
              <a:ext cx="104760" cy="7272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72720"/>
                <a:gd name="textAreaBottom" fmla="*/ 73080 h 72720"/>
              </a:gdLst>
              <a:ahLst/>
              <a:rect l="textAreaLeft" t="textAreaTop" r="textAreaRight" b="textAreaBottom"/>
              <a:pathLst>
                <a:path w="53" h="37">
                  <a:moveTo>
                    <a:pt x="12" y="20"/>
                  </a:moveTo>
                  <a:lnTo>
                    <a:pt x="0" y="26"/>
                  </a:lnTo>
                  <a:lnTo>
                    <a:pt x="37" y="37"/>
                  </a:lnTo>
                  <a:lnTo>
                    <a:pt x="53" y="0"/>
                  </a:lnTo>
                  <a:lnTo>
                    <a:pt x="41" y="6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117"/>
            <p:cNvSpPr/>
            <p:nvPr/>
          </p:nvSpPr>
          <p:spPr>
            <a:xfrm flipH="1">
              <a:off x="2295360" y="2025360"/>
              <a:ext cx="5076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18"/>
            <p:cNvSpPr/>
            <p:nvPr/>
          </p:nvSpPr>
          <p:spPr>
            <a:xfrm>
              <a:off x="2351880" y="193500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P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119"/>
            <p:cNvSpPr/>
            <p:nvPr/>
          </p:nvSpPr>
          <p:spPr>
            <a:xfrm>
              <a:off x="828360" y="2724120"/>
              <a:ext cx="174600" cy="242640"/>
            </a:xfrm>
            <a:custGeom>
              <a:avLst/>
              <a:gdLst>
                <a:gd name="textAreaLeft" fmla="*/ 0 w 174600"/>
                <a:gd name="textAreaRight" fmla="*/ 174960 w 174600"/>
                <a:gd name="textAreaTop" fmla="*/ 0 h 242640"/>
                <a:gd name="textAreaBottom" fmla="*/ 243000 h 242640"/>
              </a:gdLst>
              <a:ahLst/>
              <a:rect l="textAreaLeft" t="textAreaTop" r="textAreaRight" b="textAreaBottom"/>
              <a:pathLst>
                <a:path w="110" h="153">
                  <a:moveTo>
                    <a:pt x="0" y="14"/>
                  </a:moveTo>
                  <a:lnTo>
                    <a:pt x="16" y="56"/>
                  </a:lnTo>
                  <a:lnTo>
                    <a:pt x="37" y="97"/>
                  </a:lnTo>
                  <a:lnTo>
                    <a:pt x="62" y="137"/>
                  </a:lnTo>
                  <a:lnTo>
                    <a:pt x="65" y="139"/>
                  </a:lnTo>
                  <a:lnTo>
                    <a:pt x="51" y="148"/>
                  </a:lnTo>
                  <a:lnTo>
                    <a:pt x="101" y="153"/>
                  </a:lnTo>
                  <a:lnTo>
                    <a:pt x="110" y="106"/>
                  </a:lnTo>
                  <a:lnTo>
                    <a:pt x="98" y="116"/>
                  </a:lnTo>
                  <a:lnTo>
                    <a:pt x="75" y="80"/>
                  </a:lnTo>
                  <a:lnTo>
                    <a:pt x="55" y="41"/>
                  </a:lnTo>
                  <a:lnTo>
                    <a:pt x="39" y="2"/>
                  </a:lnTo>
                  <a:lnTo>
                    <a:pt x="39" y="0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Arc 120"/>
            <p:cNvSpPr/>
            <p:nvPr/>
          </p:nvSpPr>
          <p:spPr>
            <a:xfrm>
              <a:off x="828360" y="2473200"/>
              <a:ext cx="772920" cy="471240"/>
            </a:xfrm>
            <a:custGeom>
              <a:avLst/>
              <a:gdLst>
                <a:gd name="textAreaLeft" fmla="*/ 0 w 772920"/>
                <a:gd name="textAreaRight" fmla="*/ 773280 w 772920"/>
                <a:gd name="textAreaTop" fmla="*/ 0 h 471240"/>
                <a:gd name="textAreaBottom" fmla="*/ 471600 h 471240"/>
              </a:gdLst>
              <a:ahLst/>
              <a:rect l="textAreaLeft" t="textAreaTop" r="textAreaRight" b="textAreaBottom"/>
              <a:pathLst>
                <a:path fill="none" w="20369" h="12424">
                  <a:moveTo>
                    <a:pt x="2699" y="12423"/>
                  </a:moveTo>
                  <a:cubicBezTo>
                    <a:pt x="1564" y="10809"/>
                    <a:pt x="656" y="9047"/>
                    <a:pt x="-1" y="7187"/>
                  </a:cubicBezTo>
                </a:path>
                <a:path stroke="0" w="20369" h="12424">
                  <a:moveTo>
                    <a:pt x="2699" y="12423"/>
                  </a:moveTo>
                  <a:cubicBezTo>
                    <a:pt x="1564" y="10809"/>
                    <a:pt x="656" y="9047"/>
                    <a:pt x="-1" y="7187"/>
                  </a:cubicBezTo>
                  <a:lnTo>
                    <a:pt x="20369" y="0"/>
                  </a:lnTo>
                  <a:lnTo>
                    <a:pt x="2699" y="12423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Arc 121"/>
            <p:cNvSpPr/>
            <p:nvPr/>
          </p:nvSpPr>
          <p:spPr>
            <a:xfrm>
              <a:off x="890280" y="2473200"/>
              <a:ext cx="711000" cy="434880"/>
            </a:xfrm>
            <a:custGeom>
              <a:avLst/>
              <a:gdLst>
                <a:gd name="textAreaLeft" fmla="*/ 0 w 711000"/>
                <a:gd name="textAreaRight" fmla="*/ 711360 w 711000"/>
                <a:gd name="textAreaTop" fmla="*/ 0 h 434880"/>
                <a:gd name="textAreaBottom" fmla="*/ 435240 h 434880"/>
              </a:gdLst>
              <a:ahLst/>
              <a:rect l="textAreaLeft" t="textAreaTop" r="textAreaRight" b="textAreaBottom"/>
              <a:pathLst>
                <a:path fill="none" w="20373" h="12430">
                  <a:moveTo>
                    <a:pt x="2707" y="12430"/>
                  </a:moveTo>
                  <a:cubicBezTo>
                    <a:pt x="1568" y="10811"/>
                    <a:pt x="657" y="9043"/>
                    <a:pt x="0" y="7176"/>
                  </a:cubicBezTo>
                </a:path>
                <a:path stroke="0" w="20373" h="12430">
                  <a:moveTo>
                    <a:pt x="2707" y="12430"/>
                  </a:moveTo>
                  <a:cubicBezTo>
                    <a:pt x="1568" y="10811"/>
                    <a:pt x="657" y="9043"/>
                    <a:pt x="0" y="7176"/>
                  </a:cubicBezTo>
                  <a:lnTo>
                    <a:pt x="20373" y="0"/>
                  </a:lnTo>
                  <a:lnTo>
                    <a:pt x="2707" y="1243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22"/>
            <p:cNvSpPr/>
            <p:nvPr/>
          </p:nvSpPr>
          <p:spPr>
            <a:xfrm flipH="1">
              <a:off x="828360" y="2724120"/>
              <a:ext cx="61920" cy="2196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123"/>
            <p:cNvSpPr/>
            <p:nvPr/>
          </p:nvSpPr>
          <p:spPr>
            <a:xfrm>
              <a:off x="909360" y="2892240"/>
              <a:ext cx="93600" cy="74520"/>
            </a:xfrm>
            <a:custGeom>
              <a:avLst/>
              <a:gdLst>
                <a:gd name="textAreaLeft" fmla="*/ 0 w 93600"/>
                <a:gd name="textAreaRight" fmla="*/ 93960 w 9360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48" h="38">
                  <a:moveTo>
                    <a:pt x="38" y="8"/>
                  </a:moveTo>
                  <a:lnTo>
                    <a:pt x="48" y="0"/>
                  </a:lnTo>
                  <a:lnTo>
                    <a:pt x="40" y="38"/>
                  </a:lnTo>
                  <a:lnTo>
                    <a:pt x="0" y="34"/>
                  </a:lnTo>
                  <a:lnTo>
                    <a:pt x="11" y="27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24"/>
            <p:cNvSpPr/>
            <p:nvPr/>
          </p:nvSpPr>
          <p:spPr>
            <a:xfrm>
              <a:off x="860400" y="2870280"/>
              <a:ext cx="25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25"/>
            <p:cNvSpPr/>
            <p:nvPr/>
          </p:nvSpPr>
          <p:spPr>
            <a:xfrm>
              <a:off x="616320" y="283212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P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7" name="AutoShape 362"/>
          <p:cNvSpPr/>
          <p:nvPr/>
        </p:nvSpPr>
        <p:spPr>
          <a:xfrm>
            <a:off x="6804000" y="1727280"/>
            <a:ext cx="1920960" cy="1977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Group 319"/>
          <p:cNvGrpSpPr/>
          <p:nvPr/>
        </p:nvGrpSpPr>
        <p:grpSpPr>
          <a:xfrm>
            <a:off x="3489480" y="3213000"/>
            <a:ext cx="2389680" cy="1766880"/>
            <a:chOff x="3489480" y="3213000"/>
            <a:chExt cx="2389680" cy="1766880"/>
          </a:xfrm>
        </p:grpSpPr>
        <p:sp>
          <p:nvSpPr>
            <p:cNvPr id="99" name="AutoShape 318"/>
            <p:cNvSpPr/>
            <p:nvPr/>
          </p:nvSpPr>
          <p:spPr>
            <a:xfrm>
              <a:off x="3492360" y="3213000"/>
              <a:ext cx="2303640" cy="1766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320"/>
            <p:cNvSpPr/>
            <p:nvPr/>
          </p:nvSpPr>
          <p:spPr>
            <a:xfrm>
              <a:off x="3892320" y="3362040"/>
              <a:ext cx="1576440" cy="1573200"/>
            </a:xfrm>
            <a:custGeom>
              <a:avLst/>
              <a:gdLst>
                <a:gd name="textAreaLeft" fmla="*/ 0 w 1576440"/>
                <a:gd name="textAreaRight" fmla="*/ 1576800 w 1576440"/>
                <a:gd name="textAreaTop" fmla="*/ 0 h 1573200"/>
                <a:gd name="textAreaBottom" fmla="*/ 1573560 h 1573200"/>
              </a:gdLst>
              <a:ahLst/>
              <a:rect l="textAreaLeft" t="textAreaTop" r="textAreaRight" b="textAreaBottom"/>
              <a:pathLst>
                <a:path w="993" h="991">
                  <a:moveTo>
                    <a:pt x="501" y="0"/>
                  </a:moveTo>
                  <a:lnTo>
                    <a:pt x="456" y="1"/>
                  </a:lnTo>
                  <a:lnTo>
                    <a:pt x="411" y="6"/>
                  </a:lnTo>
                  <a:lnTo>
                    <a:pt x="369" y="16"/>
                  </a:lnTo>
                  <a:lnTo>
                    <a:pt x="326" y="29"/>
                  </a:lnTo>
                  <a:lnTo>
                    <a:pt x="285" y="46"/>
                  </a:lnTo>
                  <a:lnTo>
                    <a:pt x="246" y="67"/>
                  </a:lnTo>
                  <a:lnTo>
                    <a:pt x="209" y="91"/>
                  </a:lnTo>
                  <a:lnTo>
                    <a:pt x="174" y="118"/>
                  </a:lnTo>
                  <a:lnTo>
                    <a:pt x="141" y="148"/>
                  </a:lnTo>
                  <a:lnTo>
                    <a:pt x="112" y="181"/>
                  </a:lnTo>
                  <a:lnTo>
                    <a:pt x="85" y="217"/>
                  </a:lnTo>
                  <a:lnTo>
                    <a:pt x="62" y="255"/>
                  </a:lnTo>
                  <a:lnTo>
                    <a:pt x="42" y="294"/>
                  </a:lnTo>
                  <a:lnTo>
                    <a:pt x="26" y="336"/>
                  </a:lnTo>
                  <a:lnTo>
                    <a:pt x="14" y="378"/>
                  </a:lnTo>
                  <a:lnTo>
                    <a:pt x="5" y="423"/>
                  </a:lnTo>
                  <a:lnTo>
                    <a:pt x="1" y="466"/>
                  </a:lnTo>
                  <a:lnTo>
                    <a:pt x="0" y="511"/>
                  </a:lnTo>
                  <a:lnTo>
                    <a:pt x="3" y="554"/>
                  </a:lnTo>
                  <a:lnTo>
                    <a:pt x="11" y="599"/>
                  </a:lnTo>
                  <a:lnTo>
                    <a:pt x="21" y="641"/>
                  </a:lnTo>
                  <a:lnTo>
                    <a:pt x="37" y="684"/>
                  </a:lnTo>
                  <a:lnTo>
                    <a:pt x="55" y="724"/>
                  </a:lnTo>
                  <a:lnTo>
                    <a:pt x="77" y="762"/>
                  </a:lnTo>
                  <a:lnTo>
                    <a:pt x="103" y="798"/>
                  </a:lnTo>
                  <a:lnTo>
                    <a:pt x="131" y="831"/>
                  </a:lnTo>
                  <a:lnTo>
                    <a:pt x="163" y="863"/>
                  </a:lnTo>
                  <a:lnTo>
                    <a:pt x="197" y="891"/>
                  </a:lnTo>
                  <a:lnTo>
                    <a:pt x="234" y="916"/>
                  </a:lnTo>
                  <a:lnTo>
                    <a:pt x="273" y="938"/>
                  </a:lnTo>
                  <a:lnTo>
                    <a:pt x="313" y="956"/>
                  </a:lnTo>
                  <a:lnTo>
                    <a:pt x="355" y="971"/>
                  </a:lnTo>
                  <a:lnTo>
                    <a:pt x="398" y="981"/>
                  </a:lnTo>
                  <a:lnTo>
                    <a:pt x="442" y="988"/>
                  </a:lnTo>
                  <a:lnTo>
                    <a:pt x="486" y="991"/>
                  </a:lnTo>
                  <a:lnTo>
                    <a:pt x="531" y="990"/>
                  </a:lnTo>
                  <a:lnTo>
                    <a:pt x="575" y="985"/>
                  </a:lnTo>
                  <a:lnTo>
                    <a:pt x="618" y="976"/>
                  </a:lnTo>
                  <a:lnTo>
                    <a:pt x="661" y="963"/>
                  </a:lnTo>
                  <a:lnTo>
                    <a:pt x="702" y="947"/>
                  </a:lnTo>
                  <a:lnTo>
                    <a:pt x="741" y="926"/>
                  </a:lnTo>
                  <a:lnTo>
                    <a:pt x="779" y="902"/>
                  </a:lnTo>
                  <a:lnTo>
                    <a:pt x="814" y="876"/>
                  </a:lnTo>
                  <a:lnTo>
                    <a:pt x="847" y="846"/>
                  </a:lnTo>
                  <a:lnTo>
                    <a:pt x="878" y="813"/>
                  </a:lnTo>
                  <a:lnTo>
                    <a:pt x="905" y="778"/>
                  </a:lnTo>
                  <a:lnTo>
                    <a:pt x="928" y="740"/>
                  </a:lnTo>
                  <a:lnTo>
                    <a:pt x="948" y="701"/>
                  </a:lnTo>
                  <a:lnTo>
                    <a:pt x="965" y="660"/>
                  </a:lnTo>
                  <a:lnTo>
                    <a:pt x="978" y="617"/>
                  </a:lnTo>
                  <a:lnTo>
                    <a:pt x="986" y="574"/>
                  </a:lnTo>
                  <a:lnTo>
                    <a:pt x="992" y="530"/>
                  </a:lnTo>
                  <a:lnTo>
                    <a:pt x="993" y="486"/>
                  </a:lnTo>
                  <a:lnTo>
                    <a:pt x="990" y="441"/>
                  </a:lnTo>
                  <a:lnTo>
                    <a:pt x="983" y="398"/>
                  </a:lnTo>
                  <a:lnTo>
                    <a:pt x="972" y="354"/>
                  </a:lnTo>
                  <a:lnTo>
                    <a:pt x="958" y="313"/>
                  </a:lnTo>
                  <a:lnTo>
                    <a:pt x="940" y="272"/>
                  </a:lnTo>
                  <a:lnTo>
                    <a:pt x="918" y="233"/>
                  </a:lnTo>
                  <a:lnTo>
                    <a:pt x="893" y="196"/>
                  </a:lnTo>
                  <a:lnTo>
                    <a:pt x="864" y="163"/>
                  </a:lnTo>
                  <a:lnTo>
                    <a:pt x="833" y="131"/>
                  </a:lnTo>
                  <a:lnTo>
                    <a:pt x="799" y="103"/>
                  </a:lnTo>
                  <a:lnTo>
                    <a:pt x="763" y="77"/>
                  </a:lnTo>
                  <a:lnTo>
                    <a:pt x="725" y="55"/>
                  </a:lnTo>
                  <a:lnTo>
                    <a:pt x="685" y="36"/>
                  </a:lnTo>
                  <a:lnTo>
                    <a:pt x="642" y="21"/>
                  </a:lnTo>
                  <a:lnTo>
                    <a:pt x="600" y="10"/>
                  </a:lnTo>
                  <a:lnTo>
                    <a:pt x="555" y="3"/>
                  </a:lnTo>
                  <a:lnTo>
                    <a:pt x="512" y="0"/>
                  </a:lnTo>
                  <a:lnTo>
                    <a:pt x="502" y="0"/>
                  </a:lnTo>
                  <a:lnTo>
                    <a:pt x="501" y="10"/>
                  </a:lnTo>
                  <a:lnTo>
                    <a:pt x="544" y="13"/>
                  </a:lnTo>
                  <a:lnTo>
                    <a:pt x="588" y="18"/>
                  </a:lnTo>
                  <a:lnTo>
                    <a:pt x="630" y="29"/>
                  </a:lnTo>
                  <a:lnTo>
                    <a:pt x="671" y="42"/>
                  </a:lnTo>
                  <a:lnTo>
                    <a:pt x="711" y="59"/>
                  </a:lnTo>
                  <a:lnTo>
                    <a:pt x="749" y="81"/>
                  </a:lnTo>
                  <a:lnTo>
                    <a:pt x="785" y="105"/>
                  </a:lnTo>
                  <a:lnTo>
                    <a:pt x="819" y="132"/>
                  </a:lnTo>
                  <a:lnTo>
                    <a:pt x="850" y="163"/>
                  </a:lnTo>
                  <a:lnTo>
                    <a:pt x="879" y="195"/>
                  </a:lnTo>
                  <a:lnTo>
                    <a:pt x="904" y="231"/>
                  </a:lnTo>
                  <a:lnTo>
                    <a:pt x="925" y="268"/>
                  </a:lnTo>
                  <a:lnTo>
                    <a:pt x="944" y="307"/>
                  </a:lnTo>
                  <a:lnTo>
                    <a:pt x="959" y="348"/>
                  </a:lnTo>
                  <a:lnTo>
                    <a:pt x="971" y="390"/>
                  </a:lnTo>
                  <a:lnTo>
                    <a:pt x="978" y="432"/>
                  </a:lnTo>
                  <a:lnTo>
                    <a:pt x="982" y="476"/>
                  </a:lnTo>
                  <a:lnTo>
                    <a:pt x="982" y="519"/>
                  </a:lnTo>
                  <a:lnTo>
                    <a:pt x="978" y="563"/>
                  </a:lnTo>
                  <a:lnTo>
                    <a:pt x="970" y="605"/>
                  </a:lnTo>
                  <a:lnTo>
                    <a:pt x="958" y="647"/>
                  </a:lnTo>
                  <a:lnTo>
                    <a:pt x="943" y="688"/>
                  </a:lnTo>
                  <a:lnTo>
                    <a:pt x="923" y="727"/>
                  </a:lnTo>
                  <a:lnTo>
                    <a:pt x="901" y="764"/>
                  </a:lnTo>
                  <a:lnTo>
                    <a:pt x="875" y="799"/>
                  </a:lnTo>
                  <a:lnTo>
                    <a:pt x="847" y="831"/>
                  </a:lnTo>
                  <a:lnTo>
                    <a:pt x="815" y="862"/>
                  </a:lnTo>
                  <a:lnTo>
                    <a:pt x="782" y="888"/>
                  </a:lnTo>
                  <a:lnTo>
                    <a:pt x="745" y="912"/>
                  </a:lnTo>
                  <a:lnTo>
                    <a:pt x="707" y="933"/>
                  </a:lnTo>
                  <a:lnTo>
                    <a:pt x="666" y="950"/>
                  </a:lnTo>
                  <a:lnTo>
                    <a:pt x="625" y="963"/>
                  </a:lnTo>
                  <a:lnTo>
                    <a:pt x="583" y="973"/>
                  </a:lnTo>
                  <a:lnTo>
                    <a:pt x="540" y="978"/>
                  </a:lnTo>
                  <a:lnTo>
                    <a:pt x="496" y="980"/>
                  </a:lnTo>
                  <a:lnTo>
                    <a:pt x="453" y="978"/>
                  </a:lnTo>
                  <a:lnTo>
                    <a:pt x="410" y="973"/>
                  </a:lnTo>
                  <a:lnTo>
                    <a:pt x="368" y="963"/>
                  </a:lnTo>
                  <a:lnTo>
                    <a:pt x="326" y="950"/>
                  </a:lnTo>
                  <a:lnTo>
                    <a:pt x="286" y="933"/>
                  </a:lnTo>
                  <a:lnTo>
                    <a:pt x="248" y="913"/>
                  </a:lnTo>
                  <a:lnTo>
                    <a:pt x="211" y="889"/>
                  </a:lnTo>
                  <a:lnTo>
                    <a:pt x="177" y="862"/>
                  </a:lnTo>
                  <a:lnTo>
                    <a:pt x="146" y="831"/>
                  </a:lnTo>
                  <a:lnTo>
                    <a:pt x="117" y="799"/>
                  </a:lnTo>
                  <a:lnTo>
                    <a:pt x="91" y="764"/>
                  </a:lnTo>
                  <a:lnTo>
                    <a:pt x="69" y="727"/>
                  </a:lnTo>
                  <a:lnTo>
                    <a:pt x="50" y="688"/>
                  </a:lnTo>
                  <a:lnTo>
                    <a:pt x="34" y="648"/>
                  </a:lnTo>
                  <a:lnTo>
                    <a:pt x="22" y="605"/>
                  </a:lnTo>
                  <a:lnTo>
                    <a:pt x="15" y="563"/>
                  </a:lnTo>
                  <a:lnTo>
                    <a:pt x="11" y="520"/>
                  </a:lnTo>
                  <a:lnTo>
                    <a:pt x="11" y="477"/>
                  </a:lnTo>
                  <a:lnTo>
                    <a:pt x="14" y="433"/>
                  </a:lnTo>
                  <a:lnTo>
                    <a:pt x="21" y="391"/>
                  </a:lnTo>
                  <a:lnTo>
                    <a:pt x="32" y="349"/>
                  </a:lnTo>
                  <a:lnTo>
                    <a:pt x="48" y="308"/>
                  </a:lnTo>
                  <a:lnTo>
                    <a:pt x="66" y="268"/>
                  </a:lnTo>
                  <a:lnTo>
                    <a:pt x="88" y="231"/>
                  </a:lnTo>
                  <a:lnTo>
                    <a:pt x="113" y="196"/>
                  </a:lnTo>
                  <a:lnTo>
                    <a:pt x="141" y="163"/>
                  </a:lnTo>
                  <a:lnTo>
                    <a:pt x="173" y="132"/>
                  </a:lnTo>
                  <a:lnTo>
                    <a:pt x="207" y="105"/>
                  </a:lnTo>
                  <a:lnTo>
                    <a:pt x="243" y="81"/>
                  </a:lnTo>
                  <a:lnTo>
                    <a:pt x="281" y="60"/>
                  </a:lnTo>
                  <a:lnTo>
                    <a:pt x="321" y="43"/>
                  </a:lnTo>
                  <a:lnTo>
                    <a:pt x="361" y="29"/>
                  </a:lnTo>
                  <a:lnTo>
                    <a:pt x="404" y="19"/>
                  </a:lnTo>
                  <a:lnTo>
                    <a:pt x="447" y="13"/>
                  </a:lnTo>
                  <a:lnTo>
                    <a:pt x="491" y="9"/>
                  </a:lnTo>
                  <a:lnTo>
                    <a:pt x="501" y="10"/>
                  </a:lnTo>
                  <a:lnTo>
                    <a:pt x="501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Oval 321"/>
            <p:cNvSpPr/>
            <p:nvPr/>
          </p:nvSpPr>
          <p:spPr>
            <a:xfrm>
              <a:off x="3892320" y="3362040"/>
              <a:ext cx="1570320" cy="156708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Oval 322"/>
            <p:cNvSpPr/>
            <p:nvPr/>
          </p:nvSpPr>
          <p:spPr>
            <a:xfrm>
              <a:off x="3909960" y="3377880"/>
              <a:ext cx="1535040" cy="153360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323"/>
            <p:cNvSpPr/>
            <p:nvPr/>
          </p:nvSpPr>
          <p:spPr>
            <a:xfrm flipV="1">
              <a:off x="4687920" y="336204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324"/>
            <p:cNvSpPr/>
            <p:nvPr/>
          </p:nvSpPr>
          <p:spPr>
            <a:xfrm>
              <a:off x="4480560" y="4022640"/>
              <a:ext cx="50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K2GW7,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325"/>
            <p:cNvSpPr/>
            <p:nvPr/>
          </p:nvSpPr>
          <p:spPr>
            <a:xfrm>
              <a:off x="4505400" y="415584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1135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326"/>
            <p:cNvSpPr/>
            <p:nvPr/>
          </p:nvSpPr>
          <p:spPr>
            <a:xfrm>
              <a:off x="5151240" y="3517560"/>
              <a:ext cx="338400" cy="579600"/>
            </a:xfrm>
            <a:custGeom>
              <a:avLst/>
              <a:gdLst>
                <a:gd name="textAreaLeft" fmla="*/ 0 w 338400"/>
                <a:gd name="textAreaRight" fmla="*/ 338400 w 338400"/>
                <a:gd name="textAreaTop" fmla="*/ 0 h 579600"/>
                <a:gd name="textAreaBottom" fmla="*/ 579960 h 579600"/>
              </a:gdLst>
              <a:ahLst/>
              <a:rect l="textAreaLeft" t="textAreaTop" r="textAreaRight" b="textAreaBottom"/>
              <a:pathLst>
                <a:path w="213" h="365">
                  <a:moveTo>
                    <a:pt x="213" y="362"/>
                  </a:moveTo>
                  <a:lnTo>
                    <a:pt x="209" y="317"/>
                  </a:lnTo>
                  <a:lnTo>
                    <a:pt x="199" y="272"/>
                  </a:lnTo>
                  <a:lnTo>
                    <a:pt x="186" y="228"/>
                  </a:lnTo>
                  <a:lnTo>
                    <a:pt x="168" y="185"/>
                  </a:lnTo>
                  <a:lnTo>
                    <a:pt x="148" y="145"/>
                  </a:lnTo>
                  <a:lnTo>
                    <a:pt x="124" y="106"/>
                  </a:lnTo>
                  <a:lnTo>
                    <a:pt x="97" y="70"/>
                  </a:lnTo>
                  <a:lnTo>
                    <a:pt x="65" y="36"/>
                  </a:lnTo>
                  <a:lnTo>
                    <a:pt x="31" y="6"/>
                  </a:lnTo>
                  <a:lnTo>
                    <a:pt x="26" y="0"/>
                  </a:lnTo>
                  <a:lnTo>
                    <a:pt x="0" y="32"/>
                  </a:lnTo>
                  <a:lnTo>
                    <a:pt x="31" y="60"/>
                  </a:lnTo>
                  <a:lnTo>
                    <a:pt x="61" y="91"/>
                  </a:lnTo>
                  <a:lnTo>
                    <a:pt x="87" y="123"/>
                  </a:lnTo>
                  <a:lnTo>
                    <a:pt x="110" y="159"/>
                  </a:lnTo>
                  <a:lnTo>
                    <a:pt x="129" y="196"/>
                  </a:lnTo>
                  <a:lnTo>
                    <a:pt x="146" y="235"/>
                  </a:lnTo>
                  <a:lnTo>
                    <a:pt x="159" y="276"/>
                  </a:lnTo>
                  <a:lnTo>
                    <a:pt x="167" y="316"/>
                  </a:lnTo>
                  <a:lnTo>
                    <a:pt x="173" y="358"/>
                  </a:lnTo>
                  <a:lnTo>
                    <a:pt x="173" y="365"/>
                  </a:lnTo>
                  <a:lnTo>
                    <a:pt x="213" y="362"/>
                  </a:lnTo>
                  <a:close/>
                </a:path>
              </a:pathLst>
            </a:custGeom>
            <a:solidFill>
              <a:srgbClr val="ff33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Arc 327"/>
            <p:cNvSpPr/>
            <p:nvPr/>
          </p:nvSpPr>
          <p:spPr>
            <a:xfrm>
              <a:off x="4676760" y="3520800"/>
              <a:ext cx="806400" cy="623880"/>
            </a:xfrm>
            <a:custGeom>
              <a:avLst/>
              <a:gdLst>
                <a:gd name="textAreaLeft" fmla="*/ 0 w 806400"/>
                <a:gd name="textAreaRight" fmla="*/ 806760 w 806400"/>
                <a:gd name="textAreaTop" fmla="*/ 0 h 623880"/>
                <a:gd name="textAreaBottom" fmla="*/ 624240 h 623880"/>
              </a:gdLst>
              <a:ahLst/>
              <a:rect l="textAreaLeft" t="textAreaTop" r="textAreaRight" b="textAreaBottom"/>
              <a:pathLst>
                <a:path fill="none" w="21555" h="16693">
                  <a:moveTo>
                    <a:pt x="13707" y="0"/>
                  </a:moveTo>
                  <a:cubicBezTo>
                    <a:pt x="18328" y="3794"/>
                    <a:pt x="21169" y="9334"/>
                    <a:pt x="21555" y="15300"/>
                  </a:cubicBezTo>
                </a:path>
                <a:path stroke="0" w="21555" h="16693">
                  <a:moveTo>
                    <a:pt x="13707" y="0"/>
                  </a:moveTo>
                  <a:cubicBezTo>
                    <a:pt x="18328" y="3794"/>
                    <a:pt x="21169" y="9334"/>
                    <a:pt x="21555" y="15300"/>
                  </a:cubicBezTo>
                  <a:lnTo>
                    <a:pt x="0" y="16693"/>
                  </a:lnTo>
                  <a:lnTo>
                    <a:pt x="1370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Arc 328"/>
            <p:cNvSpPr/>
            <p:nvPr/>
          </p:nvSpPr>
          <p:spPr>
            <a:xfrm>
              <a:off x="4676760" y="3571560"/>
              <a:ext cx="743040" cy="573120"/>
            </a:xfrm>
            <a:custGeom>
              <a:avLst/>
              <a:gdLst>
                <a:gd name="textAreaLeft" fmla="*/ 0 w 743040"/>
                <a:gd name="textAreaRight" fmla="*/ 743400 w 743040"/>
                <a:gd name="textAreaTop" fmla="*/ 0 h 573120"/>
                <a:gd name="textAreaBottom" fmla="*/ 573480 h 573120"/>
              </a:gdLst>
              <a:ahLst/>
              <a:rect l="textAreaLeft" t="textAreaTop" r="textAreaRight" b="textAreaBottom"/>
              <a:pathLst>
                <a:path fill="none" w="21556" h="16680">
                  <a:moveTo>
                    <a:pt x="13723" y="0"/>
                  </a:moveTo>
                  <a:cubicBezTo>
                    <a:pt x="18340" y="3798"/>
                    <a:pt x="21176" y="9341"/>
                    <a:pt x="21556" y="15307"/>
                  </a:cubicBezTo>
                </a:path>
                <a:path stroke="0" w="21556" h="16680">
                  <a:moveTo>
                    <a:pt x="13723" y="0"/>
                  </a:moveTo>
                  <a:cubicBezTo>
                    <a:pt x="18340" y="3798"/>
                    <a:pt x="21176" y="9341"/>
                    <a:pt x="21556" y="15307"/>
                  </a:cubicBezTo>
                  <a:lnTo>
                    <a:pt x="0" y="16680"/>
                  </a:lnTo>
                  <a:lnTo>
                    <a:pt x="1372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329"/>
            <p:cNvSpPr/>
            <p:nvPr/>
          </p:nvSpPr>
          <p:spPr>
            <a:xfrm flipV="1">
              <a:off x="5425920" y="4092120"/>
              <a:ext cx="6372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330"/>
            <p:cNvSpPr/>
            <p:nvPr/>
          </p:nvSpPr>
          <p:spPr>
            <a:xfrm flipV="1">
              <a:off x="5151240" y="3517200"/>
              <a:ext cx="4140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331"/>
            <p:cNvSpPr/>
            <p:nvPr/>
          </p:nvSpPr>
          <p:spPr>
            <a:xfrm flipH="1">
              <a:off x="5402160" y="3714480"/>
              <a:ext cx="55440" cy="586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332"/>
            <p:cNvSpPr/>
            <p:nvPr/>
          </p:nvSpPr>
          <p:spPr>
            <a:xfrm>
              <a:off x="5427360" y="3625560"/>
              <a:ext cx="451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CmR-ccd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333"/>
            <p:cNvSpPr/>
            <p:nvPr/>
          </p:nvSpPr>
          <p:spPr>
            <a:xfrm>
              <a:off x="4120920" y="3336840"/>
              <a:ext cx="554040" cy="272880"/>
            </a:xfrm>
            <a:custGeom>
              <a:avLst/>
              <a:gdLst>
                <a:gd name="textAreaLeft" fmla="*/ 0 w 554040"/>
                <a:gd name="textAreaRight" fmla="*/ 554400 w 554040"/>
                <a:gd name="textAreaTop" fmla="*/ 0 h 272880"/>
                <a:gd name="textAreaBottom" fmla="*/ 273240 h 272880"/>
              </a:gdLst>
              <a:ahLst/>
              <a:rect l="textAreaLeft" t="textAreaTop" r="textAreaRight" b="textAreaBottom"/>
              <a:pathLst>
                <a:path w="349" h="172">
                  <a:moveTo>
                    <a:pt x="348" y="0"/>
                  </a:moveTo>
                  <a:lnTo>
                    <a:pt x="302" y="2"/>
                  </a:lnTo>
                  <a:lnTo>
                    <a:pt x="258" y="9"/>
                  </a:lnTo>
                  <a:lnTo>
                    <a:pt x="213" y="20"/>
                  </a:lnTo>
                  <a:lnTo>
                    <a:pt x="169" y="34"/>
                  </a:lnTo>
                  <a:lnTo>
                    <a:pt x="128" y="52"/>
                  </a:lnTo>
                  <a:lnTo>
                    <a:pt x="88" y="74"/>
                  </a:lnTo>
                  <a:lnTo>
                    <a:pt x="49" y="99"/>
                  </a:lnTo>
                  <a:lnTo>
                    <a:pt x="14" y="129"/>
                  </a:lnTo>
                  <a:lnTo>
                    <a:pt x="11" y="131"/>
                  </a:lnTo>
                  <a:lnTo>
                    <a:pt x="0" y="118"/>
                  </a:lnTo>
                  <a:lnTo>
                    <a:pt x="2" y="168"/>
                  </a:lnTo>
                  <a:lnTo>
                    <a:pt x="49" y="172"/>
                  </a:lnTo>
                  <a:lnTo>
                    <a:pt x="39" y="160"/>
                  </a:lnTo>
                  <a:lnTo>
                    <a:pt x="71" y="134"/>
                  </a:lnTo>
                  <a:lnTo>
                    <a:pt x="106" y="110"/>
                  </a:lnTo>
                  <a:lnTo>
                    <a:pt x="143" y="89"/>
                  </a:lnTo>
                  <a:lnTo>
                    <a:pt x="181" y="73"/>
                  </a:lnTo>
                  <a:lnTo>
                    <a:pt x="222" y="59"/>
                  </a:lnTo>
                  <a:lnTo>
                    <a:pt x="262" y="49"/>
                  </a:lnTo>
                  <a:lnTo>
                    <a:pt x="304" y="43"/>
                  </a:lnTo>
                  <a:lnTo>
                    <a:pt x="346" y="41"/>
                  </a:lnTo>
                  <a:lnTo>
                    <a:pt x="349" y="41"/>
                  </a:lnTo>
                  <a:lnTo>
                    <a:pt x="348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Arc 334"/>
            <p:cNvSpPr/>
            <p:nvPr/>
          </p:nvSpPr>
          <p:spPr>
            <a:xfrm>
              <a:off x="4136760" y="3336840"/>
              <a:ext cx="540000" cy="807840"/>
            </a:xfrm>
            <a:custGeom>
              <a:avLst/>
              <a:gdLst>
                <a:gd name="textAreaLeft" fmla="*/ 0 w 540000"/>
                <a:gd name="textAreaRight" fmla="*/ 540360 w 540000"/>
                <a:gd name="textAreaTop" fmla="*/ 0 h 807840"/>
                <a:gd name="textAreaBottom" fmla="*/ 808200 h 807840"/>
              </a:gdLst>
              <a:ahLst/>
              <a:rect l="textAreaLeft" t="textAreaTop" r="textAreaRight" b="textAreaBottom"/>
              <a:pathLst>
                <a:path fill="none" w="14406" h="21600">
                  <a:moveTo>
                    <a:pt x="0" y="5505"/>
                  </a:moveTo>
                  <a:cubicBezTo>
                    <a:pt x="3939" y="1979"/>
                    <a:pt x="9034" y="20"/>
                    <a:pt x="14321" y="0"/>
                  </a:cubicBezTo>
                </a:path>
                <a:path stroke="0" w="14406" h="21600">
                  <a:moveTo>
                    <a:pt x="0" y="5505"/>
                  </a:moveTo>
                  <a:cubicBezTo>
                    <a:pt x="3939" y="1979"/>
                    <a:pt x="9034" y="20"/>
                    <a:pt x="14321" y="0"/>
                  </a:cubicBezTo>
                  <a:lnTo>
                    <a:pt x="14406" y="21600"/>
                  </a:lnTo>
                  <a:lnTo>
                    <a:pt x="0" y="550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Arc 335"/>
            <p:cNvSpPr/>
            <p:nvPr/>
          </p:nvSpPr>
          <p:spPr>
            <a:xfrm>
              <a:off x="4181400" y="3401640"/>
              <a:ext cx="495360" cy="743040"/>
            </a:xfrm>
            <a:custGeom>
              <a:avLst/>
              <a:gdLst>
                <a:gd name="textAreaLeft" fmla="*/ 0 w 495360"/>
                <a:gd name="textAreaRight" fmla="*/ 495720 w 49536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14362" h="21600">
                  <a:moveTo>
                    <a:pt x="0" y="5466"/>
                  </a:moveTo>
                  <a:cubicBezTo>
                    <a:pt x="3943" y="1955"/>
                    <a:pt x="9036" y="11"/>
                    <a:pt x="14316" y="0"/>
                  </a:cubicBezTo>
                </a:path>
                <a:path stroke="0" w="14362" h="21600">
                  <a:moveTo>
                    <a:pt x="0" y="5466"/>
                  </a:moveTo>
                  <a:cubicBezTo>
                    <a:pt x="3943" y="1955"/>
                    <a:pt x="9036" y="11"/>
                    <a:pt x="14316" y="0"/>
                  </a:cubicBezTo>
                  <a:lnTo>
                    <a:pt x="14362" y="21600"/>
                  </a:lnTo>
                  <a:lnTo>
                    <a:pt x="0" y="546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336"/>
            <p:cNvSpPr/>
            <p:nvPr/>
          </p:nvSpPr>
          <p:spPr>
            <a:xfrm flipH="1" flipV="1">
              <a:off x="4673520" y="333684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337"/>
            <p:cNvSpPr/>
            <p:nvPr/>
          </p:nvSpPr>
          <p:spPr>
            <a:xfrm>
              <a:off x="4120920" y="3524040"/>
              <a:ext cx="77760" cy="8568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85680"/>
                <a:gd name="textAreaBottom" fmla="*/ 86040 h 85680"/>
              </a:gdLst>
              <a:ahLst/>
              <a:rect l="textAreaLeft" t="textAreaTop" r="textAreaRight" b="textAreaBottom"/>
              <a:pathLst>
                <a:path w="45" h="50">
                  <a:moveTo>
                    <a:pt x="35" y="39"/>
                  </a:moveTo>
                  <a:lnTo>
                    <a:pt x="45" y="50"/>
                  </a:lnTo>
                  <a:lnTo>
                    <a:pt x="1" y="46"/>
                  </a:lnTo>
                  <a:lnTo>
                    <a:pt x="0" y="0"/>
                  </a:lnTo>
                  <a:lnTo>
                    <a:pt x="10" y="1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38"/>
            <p:cNvSpPr/>
            <p:nvPr/>
          </p:nvSpPr>
          <p:spPr>
            <a:xfrm>
              <a:off x="4302000" y="3331800"/>
              <a:ext cx="61920" cy="716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339"/>
            <p:cNvSpPr/>
            <p:nvPr/>
          </p:nvSpPr>
          <p:spPr>
            <a:xfrm>
              <a:off x="4178160" y="324288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K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340"/>
            <p:cNvSpPr/>
            <p:nvPr/>
          </p:nvSpPr>
          <p:spPr>
            <a:xfrm>
              <a:off x="4694040" y="3336840"/>
              <a:ext cx="424080" cy="190440"/>
            </a:xfrm>
            <a:custGeom>
              <a:avLst/>
              <a:gdLst>
                <a:gd name="textAreaLeft" fmla="*/ 0 w 424080"/>
                <a:gd name="textAreaRight" fmla="*/ 424440 w 42408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267" h="120">
                  <a:moveTo>
                    <a:pt x="221" y="120"/>
                  </a:moveTo>
                  <a:lnTo>
                    <a:pt x="267" y="106"/>
                  </a:lnTo>
                  <a:lnTo>
                    <a:pt x="258" y="57"/>
                  </a:lnTo>
                  <a:lnTo>
                    <a:pt x="249" y="71"/>
                  </a:lnTo>
                  <a:lnTo>
                    <a:pt x="209" y="49"/>
                  </a:lnTo>
                  <a:lnTo>
                    <a:pt x="168" y="32"/>
                  </a:lnTo>
                  <a:lnTo>
                    <a:pt x="124" y="18"/>
                  </a:lnTo>
                  <a:lnTo>
                    <a:pt x="80" y="8"/>
                  </a:lnTo>
                  <a:lnTo>
                    <a:pt x="34" y="2"/>
                  </a:lnTo>
                  <a:lnTo>
                    <a:pt x="0" y="0"/>
                  </a:lnTo>
                  <a:lnTo>
                    <a:pt x="0" y="41"/>
                  </a:lnTo>
                  <a:lnTo>
                    <a:pt x="41" y="44"/>
                  </a:lnTo>
                  <a:lnTo>
                    <a:pt x="83" y="50"/>
                  </a:lnTo>
                  <a:lnTo>
                    <a:pt x="124" y="60"/>
                  </a:lnTo>
                  <a:lnTo>
                    <a:pt x="164" y="73"/>
                  </a:lnTo>
                  <a:lnTo>
                    <a:pt x="203" y="91"/>
                  </a:lnTo>
                  <a:lnTo>
                    <a:pt x="230" y="106"/>
                  </a:lnTo>
                  <a:lnTo>
                    <a:pt x="221" y="120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Arc 341"/>
            <p:cNvSpPr/>
            <p:nvPr/>
          </p:nvSpPr>
          <p:spPr>
            <a:xfrm>
              <a:off x="4676760" y="3338280"/>
              <a:ext cx="412560" cy="806400"/>
            </a:xfrm>
            <a:custGeom>
              <a:avLst/>
              <a:gdLst>
                <a:gd name="textAreaLeft" fmla="*/ 0 w 412560"/>
                <a:gd name="textAreaRight" fmla="*/ 412920 w 412560"/>
                <a:gd name="textAreaTop" fmla="*/ 0 h 806400"/>
                <a:gd name="textAreaBottom" fmla="*/ 806760 h 806400"/>
              </a:gdLst>
              <a:ahLst/>
              <a:rect l="textAreaLeft" t="textAreaTop" r="textAreaRight" b="textAreaBottom"/>
              <a:pathLst>
                <a:path fill="none" w="11010" h="21595">
                  <a:moveTo>
                    <a:pt x="465" y="0"/>
                  </a:moveTo>
                  <a:cubicBezTo>
                    <a:pt x="4181" y="80"/>
                    <a:pt x="7812" y="1117"/>
                    <a:pt x="11009" y="3011"/>
                  </a:cubicBezTo>
                </a:path>
                <a:path stroke="0" w="11010" h="21595">
                  <a:moveTo>
                    <a:pt x="465" y="0"/>
                  </a:moveTo>
                  <a:cubicBezTo>
                    <a:pt x="4181" y="80"/>
                    <a:pt x="7812" y="1117"/>
                    <a:pt x="11009" y="3011"/>
                  </a:cubicBezTo>
                  <a:lnTo>
                    <a:pt x="0" y="21595"/>
                  </a:lnTo>
                  <a:lnTo>
                    <a:pt x="46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Arc 342"/>
            <p:cNvSpPr/>
            <p:nvPr/>
          </p:nvSpPr>
          <p:spPr>
            <a:xfrm>
              <a:off x="4676760" y="3401640"/>
              <a:ext cx="380880" cy="743040"/>
            </a:xfrm>
            <a:custGeom>
              <a:avLst/>
              <a:gdLst>
                <a:gd name="textAreaLeft" fmla="*/ 0 w 380880"/>
                <a:gd name="textAreaRight" fmla="*/ 381240 w 38088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11077" h="21594">
                  <a:moveTo>
                    <a:pt x="507" y="-1"/>
                  </a:moveTo>
                  <a:cubicBezTo>
                    <a:pt x="4234" y="87"/>
                    <a:pt x="7876" y="1138"/>
                    <a:pt x="11077" y="3050"/>
                  </a:cubicBezTo>
                </a:path>
                <a:path stroke="0" w="11077" h="21594">
                  <a:moveTo>
                    <a:pt x="507" y="-1"/>
                  </a:moveTo>
                  <a:cubicBezTo>
                    <a:pt x="4234" y="87"/>
                    <a:pt x="7876" y="1138"/>
                    <a:pt x="11077" y="3050"/>
                  </a:cubicBezTo>
                  <a:lnTo>
                    <a:pt x="0" y="21594"/>
                  </a:lnTo>
                  <a:lnTo>
                    <a:pt x="507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43"/>
            <p:cNvSpPr/>
            <p:nvPr/>
          </p:nvSpPr>
          <p:spPr>
            <a:xfrm flipV="1">
              <a:off x="4694040" y="3336840"/>
              <a:ext cx="180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344"/>
            <p:cNvSpPr/>
            <p:nvPr/>
          </p:nvSpPr>
          <p:spPr>
            <a:xfrm>
              <a:off x="5045040" y="3427200"/>
              <a:ext cx="73080" cy="100080"/>
            </a:xfrm>
            <a:custGeom>
              <a:avLst/>
              <a:gdLst>
                <a:gd name="textAreaLeft" fmla="*/ 0 w 73080"/>
                <a:gd name="textAreaRight" fmla="*/ 73080 w 73080"/>
                <a:gd name="textAreaTop" fmla="*/ 0 h 100080"/>
                <a:gd name="textAreaBottom" fmla="*/ 100440 h 100080"/>
              </a:gdLst>
              <a:ahLst/>
              <a:rect l="textAreaLeft" t="textAreaTop" r="textAreaRight" b="textAreaBottom"/>
              <a:pathLst>
                <a:path w="42" h="58">
                  <a:moveTo>
                    <a:pt x="8" y="45"/>
                  </a:moveTo>
                  <a:lnTo>
                    <a:pt x="0" y="58"/>
                  </a:lnTo>
                  <a:lnTo>
                    <a:pt x="42" y="45"/>
                  </a:lnTo>
                  <a:lnTo>
                    <a:pt x="34" y="0"/>
                  </a:lnTo>
                  <a:lnTo>
                    <a:pt x="26" y="1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345"/>
            <p:cNvSpPr/>
            <p:nvPr/>
          </p:nvSpPr>
          <p:spPr>
            <a:xfrm flipH="1">
              <a:off x="4925880" y="3315960"/>
              <a:ext cx="38160" cy="586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346"/>
            <p:cNvSpPr/>
            <p:nvPr/>
          </p:nvSpPr>
          <p:spPr>
            <a:xfrm>
              <a:off x="4960440" y="32270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347"/>
            <p:cNvSpPr/>
            <p:nvPr/>
          </p:nvSpPr>
          <p:spPr>
            <a:xfrm>
              <a:off x="5419800" y="4154400"/>
              <a:ext cx="71280" cy="10152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5" h="64">
                  <a:moveTo>
                    <a:pt x="41" y="64"/>
                  </a:moveTo>
                  <a:lnTo>
                    <a:pt x="45" y="19"/>
                  </a:lnTo>
                  <a:lnTo>
                    <a:pt x="45" y="0"/>
                  </a:lnTo>
                  <a:lnTo>
                    <a:pt x="5" y="0"/>
                  </a:lnTo>
                  <a:lnTo>
                    <a:pt x="3" y="41"/>
                  </a:lnTo>
                  <a:lnTo>
                    <a:pt x="0" y="59"/>
                  </a:lnTo>
                  <a:lnTo>
                    <a:pt x="41" y="64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Arc 348"/>
            <p:cNvSpPr/>
            <p:nvPr/>
          </p:nvSpPr>
          <p:spPr>
            <a:xfrm>
              <a:off x="4676760" y="4144680"/>
              <a:ext cx="807840" cy="109440"/>
            </a:xfrm>
            <a:custGeom>
              <a:avLst/>
              <a:gdLst>
                <a:gd name="textAreaLeft" fmla="*/ 0 w 807840"/>
                <a:gd name="textAreaRight" fmla="*/ 808200 w 8078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fill="none" w="21599" h="2949">
                  <a:moveTo>
                    <a:pt x="21598" y="252"/>
                  </a:moveTo>
                  <a:cubicBezTo>
                    <a:pt x="21587" y="1154"/>
                    <a:pt x="21520" y="2055"/>
                    <a:pt x="21397" y="2948"/>
                  </a:cubicBezTo>
                </a:path>
                <a:path stroke="0" w="21599" h="2949">
                  <a:moveTo>
                    <a:pt x="21598" y="252"/>
                  </a:moveTo>
                  <a:cubicBezTo>
                    <a:pt x="21587" y="1154"/>
                    <a:pt x="21520" y="2055"/>
                    <a:pt x="21397" y="2948"/>
                  </a:cubicBezTo>
                  <a:lnTo>
                    <a:pt x="0" y="0"/>
                  </a:lnTo>
                  <a:lnTo>
                    <a:pt x="21598" y="252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Arc 349"/>
            <p:cNvSpPr/>
            <p:nvPr/>
          </p:nvSpPr>
          <p:spPr>
            <a:xfrm>
              <a:off x="4676760" y="4144680"/>
              <a:ext cx="743040" cy="101520"/>
            </a:xfrm>
            <a:custGeom>
              <a:avLst/>
              <a:gdLst>
                <a:gd name="textAreaLeft" fmla="*/ 0 w 743040"/>
                <a:gd name="textAreaRight" fmla="*/ 743400 w 7430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fill="none" w="21598" h="2975">
                  <a:moveTo>
                    <a:pt x="21598" y="274"/>
                  </a:moveTo>
                  <a:cubicBezTo>
                    <a:pt x="21586" y="1177"/>
                    <a:pt x="21518" y="2079"/>
                    <a:pt x="21394" y="2975"/>
                  </a:cubicBezTo>
                </a:path>
                <a:path stroke="0" w="21598" h="2975">
                  <a:moveTo>
                    <a:pt x="21598" y="274"/>
                  </a:moveTo>
                  <a:cubicBezTo>
                    <a:pt x="21586" y="1177"/>
                    <a:pt x="21518" y="2079"/>
                    <a:pt x="21394" y="2975"/>
                  </a:cubicBezTo>
                  <a:lnTo>
                    <a:pt x="0" y="0"/>
                  </a:lnTo>
                  <a:lnTo>
                    <a:pt x="21598" y="274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350"/>
            <p:cNvSpPr/>
            <p:nvPr/>
          </p:nvSpPr>
          <p:spPr>
            <a:xfrm>
              <a:off x="5419800" y="4248000"/>
              <a:ext cx="64800" cy="7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351"/>
            <p:cNvSpPr/>
            <p:nvPr/>
          </p:nvSpPr>
          <p:spPr>
            <a:xfrm>
              <a:off x="5427720" y="4154400"/>
              <a:ext cx="63360" cy="144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352"/>
            <p:cNvSpPr/>
            <p:nvPr/>
          </p:nvSpPr>
          <p:spPr>
            <a:xfrm flipH="1" flipV="1">
              <a:off x="5489280" y="4204800"/>
              <a:ext cx="123480" cy="349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353"/>
            <p:cNvSpPr/>
            <p:nvPr/>
          </p:nvSpPr>
          <p:spPr>
            <a:xfrm>
              <a:off x="5611320" y="42368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354"/>
            <p:cNvSpPr/>
            <p:nvPr/>
          </p:nvSpPr>
          <p:spPr>
            <a:xfrm>
              <a:off x="5108400" y="3484440"/>
              <a:ext cx="84240" cy="83880"/>
            </a:xfrm>
            <a:custGeom>
              <a:avLst/>
              <a:gdLst>
                <a:gd name="textAreaLeft" fmla="*/ 0 w 84240"/>
                <a:gd name="textAreaRight" fmla="*/ 84240 w 842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53" h="53">
                  <a:moveTo>
                    <a:pt x="53" y="21"/>
                  </a:moveTo>
                  <a:lnTo>
                    <a:pt x="23" y="0"/>
                  </a:lnTo>
                  <a:lnTo>
                    <a:pt x="0" y="33"/>
                  </a:lnTo>
                  <a:lnTo>
                    <a:pt x="27" y="53"/>
                  </a:lnTo>
                  <a:lnTo>
                    <a:pt x="53" y="21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rc 355"/>
            <p:cNvSpPr/>
            <p:nvPr/>
          </p:nvSpPr>
          <p:spPr>
            <a:xfrm>
              <a:off x="4676760" y="3485880"/>
              <a:ext cx="512640" cy="658800"/>
            </a:xfrm>
            <a:custGeom>
              <a:avLst/>
              <a:gdLst>
                <a:gd name="textAreaLeft" fmla="*/ 0 w 512640"/>
                <a:gd name="textAreaRight" fmla="*/ 513000 w 512640"/>
                <a:gd name="textAreaTop" fmla="*/ 0 h 658800"/>
                <a:gd name="textAreaBottom" fmla="*/ 659160 h 658800"/>
              </a:gdLst>
              <a:ahLst/>
              <a:rect l="textAreaLeft" t="textAreaTop" r="textAreaRight" b="textAreaBottom"/>
              <a:pathLst>
                <a:path fill="none" w="13708" h="17631">
                  <a:moveTo>
                    <a:pt x="12478" y="-1"/>
                  </a:moveTo>
                  <a:cubicBezTo>
                    <a:pt x="12899" y="297"/>
                    <a:pt x="13309" y="610"/>
                    <a:pt x="13707" y="938"/>
                  </a:cubicBezTo>
                </a:path>
                <a:path stroke="0" w="13708" h="17631">
                  <a:moveTo>
                    <a:pt x="12478" y="-1"/>
                  </a:moveTo>
                  <a:cubicBezTo>
                    <a:pt x="12899" y="297"/>
                    <a:pt x="13309" y="610"/>
                    <a:pt x="13707" y="938"/>
                  </a:cubicBezTo>
                  <a:lnTo>
                    <a:pt x="0" y="17631"/>
                  </a:lnTo>
                  <a:lnTo>
                    <a:pt x="12478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rc 356"/>
            <p:cNvSpPr/>
            <p:nvPr/>
          </p:nvSpPr>
          <p:spPr>
            <a:xfrm>
              <a:off x="4676760" y="3538440"/>
              <a:ext cx="473040" cy="606240"/>
            </a:xfrm>
            <a:custGeom>
              <a:avLst/>
              <a:gdLst>
                <a:gd name="textAreaLeft" fmla="*/ 0 w 473040"/>
                <a:gd name="textAreaRight" fmla="*/ 473400 w 473040"/>
                <a:gd name="textAreaTop" fmla="*/ 0 h 606240"/>
                <a:gd name="textAreaBottom" fmla="*/ 606600 h 606240"/>
              </a:gdLst>
              <a:ahLst/>
              <a:rect l="textAreaLeft" t="textAreaTop" r="textAreaRight" b="textAreaBottom"/>
              <a:pathLst>
                <a:path fill="none" w="13724" h="17617">
                  <a:moveTo>
                    <a:pt x="12498" y="-1"/>
                  </a:moveTo>
                  <a:cubicBezTo>
                    <a:pt x="12917" y="297"/>
                    <a:pt x="13326" y="610"/>
                    <a:pt x="13723" y="937"/>
                  </a:cubicBezTo>
                </a:path>
                <a:path stroke="0" w="13724" h="17617">
                  <a:moveTo>
                    <a:pt x="12498" y="-1"/>
                  </a:moveTo>
                  <a:cubicBezTo>
                    <a:pt x="12917" y="297"/>
                    <a:pt x="13326" y="610"/>
                    <a:pt x="13723" y="937"/>
                  </a:cubicBezTo>
                  <a:lnTo>
                    <a:pt x="0" y="17617"/>
                  </a:lnTo>
                  <a:lnTo>
                    <a:pt x="12498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357"/>
            <p:cNvSpPr/>
            <p:nvPr/>
          </p:nvSpPr>
          <p:spPr>
            <a:xfrm flipV="1">
              <a:off x="5151240" y="3517200"/>
              <a:ext cx="4140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358"/>
            <p:cNvSpPr/>
            <p:nvPr/>
          </p:nvSpPr>
          <p:spPr>
            <a:xfrm flipV="1">
              <a:off x="5108400" y="3484080"/>
              <a:ext cx="3672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359"/>
            <p:cNvSpPr/>
            <p:nvPr/>
          </p:nvSpPr>
          <p:spPr>
            <a:xfrm flipH="1">
              <a:off x="5169960" y="3454200"/>
              <a:ext cx="41400" cy="475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360"/>
            <p:cNvSpPr/>
            <p:nvPr/>
          </p:nvSpPr>
          <p:spPr>
            <a:xfrm>
              <a:off x="5205600" y="33652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361"/>
            <p:cNvSpPr/>
            <p:nvPr/>
          </p:nvSpPr>
          <p:spPr>
            <a:xfrm>
              <a:off x="5425920" y="4092480"/>
              <a:ext cx="65160" cy="55440"/>
            </a:xfrm>
            <a:custGeom>
              <a:avLst/>
              <a:gdLst>
                <a:gd name="textAreaLeft" fmla="*/ 0 w 65160"/>
                <a:gd name="textAreaRight" fmla="*/ 65520 w 6516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41" h="35">
                  <a:moveTo>
                    <a:pt x="41" y="35"/>
                  </a:moveTo>
                  <a:lnTo>
                    <a:pt x="40" y="0"/>
                  </a:lnTo>
                  <a:lnTo>
                    <a:pt x="0" y="3"/>
                  </a:lnTo>
                  <a:lnTo>
                    <a:pt x="1" y="35"/>
                  </a:lnTo>
                  <a:lnTo>
                    <a:pt x="41" y="35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Arc 362"/>
            <p:cNvSpPr/>
            <p:nvPr/>
          </p:nvSpPr>
          <p:spPr>
            <a:xfrm>
              <a:off x="4676760" y="4092480"/>
              <a:ext cx="809640" cy="55440"/>
            </a:xfrm>
            <a:custGeom>
              <a:avLst/>
              <a:gdLst>
                <a:gd name="textAreaLeft" fmla="*/ 0 w 809640"/>
                <a:gd name="textAreaRight" fmla="*/ 810000 w 8096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fill="none" w="21600" h="1476">
                  <a:moveTo>
                    <a:pt x="21555" y="-1"/>
                  </a:moveTo>
                  <a:cubicBezTo>
                    <a:pt x="21585" y="463"/>
                    <a:pt x="21600" y="927"/>
                    <a:pt x="21600" y="1392"/>
                  </a:cubicBezTo>
                  <a:cubicBezTo>
                    <a:pt x="21600" y="1419"/>
                    <a:pt x="21599" y="1447"/>
                    <a:pt x="21599" y="1475"/>
                  </a:cubicBezTo>
                </a:path>
                <a:path stroke="0" w="21600" h="1476">
                  <a:moveTo>
                    <a:pt x="21555" y="-1"/>
                  </a:moveTo>
                  <a:cubicBezTo>
                    <a:pt x="21585" y="463"/>
                    <a:pt x="21600" y="927"/>
                    <a:pt x="21600" y="1392"/>
                  </a:cubicBezTo>
                  <a:cubicBezTo>
                    <a:pt x="21600" y="1419"/>
                    <a:pt x="21599" y="1447"/>
                    <a:pt x="21599" y="1475"/>
                  </a:cubicBezTo>
                  <a:lnTo>
                    <a:pt x="0" y="1392"/>
                  </a:lnTo>
                  <a:lnTo>
                    <a:pt x="21555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Arc 363"/>
            <p:cNvSpPr/>
            <p:nvPr/>
          </p:nvSpPr>
          <p:spPr>
            <a:xfrm>
              <a:off x="4676760" y="4097160"/>
              <a:ext cx="744480" cy="50760"/>
            </a:xfrm>
            <a:custGeom>
              <a:avLst/>
              <a:gdLst>
                <a:gd name="textAreaLeft" fmla="*/ 0 w 744480"/>
                <a:gd name="textAreaRight" fmla="*/ 744840 w 744480"/>
                <a:gd name="textAreaTop" fmla="*/ 0 h 50760"/>
                <a:gd name="textAreaBottom" fmla="*/ 51120 h 50760"/>
              </a:gdLst>
              <a:ahLst/>
              <a:rect l="textAreaLeft" t="textAreaTop" r="textAreaRight" b="textAreaBottom"/>
              <a:pathLst>
                <a:path fill="none" w="21600" h="1463">
                  <a:moveTo>
                    <a:pt x="21556" y="-1"/>
                  </a:moveTo>
                  <a:cubicBezTo>
                    <a:pt x="21585" y="456"/>
                    <a:pt x="21600" y="914"/>
                    <a:pt x="21600" y="1372"/>
                  </a:cubicBezTo>
                  <a:cubicBezTo>
                    <a:pt x="21600" y="1402"/>
                    <a:pt x="21599" y="1432"/>
                    <a:pt x="21599" y="1462"/>
                  </a:cubicBezTo>
                </a:path>
                <a:path stroke="0" w="21600" h="1463">
                  <a:moveTo>
                    <a:pt x="21556" y="-1"/>
                  </a:moveTo>
                  <a:cubicBezTo>
                    <a:pt x="21585" y="456"/>
                    <a:pt x="21600" y="914"/>
                    <a:pt x="21600" y="1372"/>
                  </a:cubicBezTo>
                  <a:cubicBezTo>
                    <a:pt x="21600" y="1402"/>
                    <a:pt x="21599" y="1432"/>
                    <a:pt x="21599" y="1462"/>
                  </a:cubicBezTo>
                  <a:lnTo>
                    <a:pt x="0" y="1372"/>
                  </a:lnTo>
                  <a:lnTo>
                    <a:pt x="21556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364"/>
            <p:cNvSpPr/>
            <p:nvPr/>
          </p:nvSpPr>
          <p:spPr>
            <a:xfrm>
              <a:off x="5427720" y="4147920"/>
              <a:ext cx="63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365"/>
            <p:cNvSpPr/>
            <p:nvPr/>
          </p:nvSpPr>
          <p:spPr>
            <a:xfrm flipV="1">
              <a:off x="5425920" y="4092120"/>
              <a:ext cx="6372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366"/>
            <p:cNvSpPr/>
            <p:nvPr/>
          </p:nvSpPr>
          <p:spPr>
            <a:xfrm flipH="1">
              <a:off x="5490720" y="4105080"/>
              <a:ext cx="122040" cy="158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367"/>
            <p:cNvSpPr/>
            <p:nvPr/>
          </p:nvSpPr>
          <p:spPr>
            <a:xfrm>
              <a:off x="5608800" y="41032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368"/>
            <p:cNvSpPr/>
            <p:nvPr/>
          </p:nvSpPr>
          <p:spPr>
            <a:xfrm>
              <a:off x="5403600" y="4257360"/>
              <a:ext cx="79560" cy="9864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98640"/>
                <a:gd name="textAreaBottom" fmla="*/ 99000 h 98640"/>
              </a:gdLst>
              <a:ahLst/>
              <a:rect l="textAreaLeft" t="textAreaTop" r="textAreaRight" b="textAreaBottom"/>
              <a:pathLst>
                <a:path w="50" h="62">
                  <a:moveTo>
                    <a:pt x="39" y="62"/>
                  </a:moveTo>
                  <a:lnTo>
                    <a:pt x="49" y="17"/>
                  </a:lnTo>
                  <a:lnTo>
                    <a:pt x="50" y="5"/>
                  </a:lnTo>
                  <a:lnTo>
                    <a:pt x="10" y="0"/>
                  </a:lnTo>
                  <a:lnTo>
                    <a:pt x="2" y="41"/>
                  </a:lnTo>
                  <a:lnTo>
                    <a:pt x="0" y="52"/>
                  </a:lnTo>
                  <a:lnTo>
                    <a:pt x="39" y="6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Arc 369"/>
            <p:cNvSpPr/>
            <p:nvPr/>
          </p:nvSpPr>
          <p:spPr>
            <a:xfrm>
              <a:off x="4676760" y="4144680"/>
              <a:ext cx="799920" cy="209520"/>
            </a:xfrm>
            <a:custGeom>
              <a:avLst/>
              <a:gdLst>
                <a:gd name="textAreaLeft" fmla="*/ 0 w 799920"/>
                <a:gd name="textAreaRight" fmla="*/ 800280 w 799920"/>
                <a:gd name="textAreaTop" fmla="*/ 0 h 209520"/>
                <a:gd name="textAreaBottom" fmla="*/ 209880 h 209520"/>
              </a:gdLst>
              <a:ahLst/>
              <a:rect l="textAreaLeft" t="textAreaTop" r="textAreaRight" b="textAreaBottom"/>
              <a:pathLst>
                <a:path fill="none" w="21361" h="5594">
                  <a:moveTo>
                    <a:pt x="21361" y="3202"/>
                  </a:moveTo>
                  <a:cubicBezTo>
                    <a:pt x="21240" y="4008"/>
                    <a:pt x="21074" y="4806"/>
                    <a:pt x="20863" y="5594"/>
                  </a:cubicBezTo>
                </a:path>
                <a:path stroke="0" w="21361" h="5594">
                  <a:moveTo>
                    <a:pt x="21361" y="3202"/>
                  </a:moveTo>
                  <a:cubicBezTo>
                    <a:pt x="21240" y="4008"/>
                    <a:pt x="21074" y="4806"/>
                    <a:pt x="20863" y="5594"/>
                  </a:cubicBezTo>
                  <a:lnTo>
                    <a:pt x="0" y="0"/>
                  </a:lnTo>
                  <a:lnTo>
                    <a:pt x="21361" y="320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Arc 370"/>
            <p:cNvSpPr/>
            <p:nvPr/>
          </p:nvSpPr>
          <p:spPr>
            <a:xfrm>
              <a:off x="4676760" y="4144680"/>
              <a:ext cx="734760" cy="193680"/>
            </a:xfrm>
            <a:custGeom>
              <a:avLst/>
              <a:gdLst>
                <a:gd name="textAreaLeft" fmla="*/ 0 w 734760"/>
                <a:gd name="textAreaRight" fmla="*/ 734760 w 73476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fill="none" w="21355" h="5608">
                  <a:moveTo>
                    <a:pt x="21355" y="3243"/>
                  </a:moveTo>
                  <a:cubicBezTo>
                    <a:pt x="21234" y="4040"/>
                    <a:pt x="21068" y="4829"/>
                    <a:pt x="20859" y="5608"/>
                  </a:cubicBezTo>
                </a:path>
                <a:path stroke="0" w="21355" h="5608">
                  <a:moveTo>
                    <a:pt x="21355" y="3243"/>
                  </a:moveTo>
                  <a:cubicBezTo>
                    <a:pt x="21234" y="4040"/>
                    <a:pt x="21068" y="4829"/>
                    <a:pt x="20859" y="5608"/>
                  </a:cubicBezTo>
                  <a:lnTo>
                    <a:pt x="0" y="0"/>
                  </a:lnTo>
                  <a:lnTo>
                    <a:pt x="21355" y="324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371"/>
            <p:cNvSpPr/>
            <p:nvPr/>
          </p:nvSpPr>
          <p:spPr>
            <a:xfrm>
              <a:off x="5403600" y="4340160"/>
              <a:ext cx="6192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372"/>
            <p:cNvSpPr/>
            <p:nvPr/>
          </p:nvSpPr>
          <p:spPr>
            <a:xfrm>
              <a:off x="5419800" y="4257360"/>
              <a:ext cx="6336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373"/>
            <p:cNvSpPr/>
            <p:nvPr/>
          </p:nvSpPr>
          <p:spPr>
            <a:xfrm flipH="1" flipV="1">
              <a:off x="5474880" y="4313160"/>
              <a:ext cx="128520" cy="633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374"/>
            <p:cNvSpPr/>
            <p:nvPr/>
          </p:nvSpPr>
          <p:spPr>
            <a:xfrm>
              <a:off x="5608440" y="437328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375"/>
            <p:cNvSpPr/>
            <p:nvPr/>
          </p:nvSpPr>
          <p:spPr>
            <a:xfrm>
              <a:off x="4003560" y="3581280"/>
              <a:ext cx="142920" cy="152280"/>
            </a:xfrm>
            <a:custGeom>
              <a:avLst/>
              <a:gdLst>
                <a:gd name="textAreaLeft" fmla="*/ 0 w 142920"/>
                <a:gd name="textAreaRight" fmla="*/ 143280 w 1429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90" h="96">
                  <a:moveTo>
                    <a:pt x="60" y="0"/>
                  </a:moveTo>
                  <a:lnTo>
                    <a:pt x="30" y="34"/>
                  </a:lnTo>
                  <a:lnTo>
                    <a:pt x="3" y="70"/>
                  </a:lnTo>
                  <a:lnTo>
                    <a:pt x="0" y="75"/>
                  </a:lnTo>
                  <a:lnTo>
                    <a:pt x="34" y="96"/>
                  </a:lnTo>
                  <a:lnTo>
                    <a:pt x="58" y="63"/>
                  </a:lnTo>
                  <a:lnTo>
                    <a:pt x="86" y="31"/>
                  </a:lnTo>
                  <a:lnTo>
                    <a:pt x="90" y="28"/>
                  </a:lnTo>
                  <a:lnTo>
                    <a:pt x="60" y="0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Arc 376"/>
            <p:cNvSpPr/>
            <p:nvPr/>
          </p:nvSpPr>
          <p:spPr>
            <a:xfrm>
              <a:off x="4002120" y="3581280"/>
              <a:ext cx="674640" cy="563400"/>
            </a:xfrm>
            <a:custGeom>
              <a:avLst/>
              <a:gdLst>
                <a:gd name="textAreaLeft" fmla="*/ 0 w 674640"/>
                <a:gd name="textAreaRight" fmla="*/ 675000 w 674640"/>
                <a:gd name="textAreaTop" fmla="*/ 0 h 563400"/>
                <a:gd name="textAreaBottom" fmla="*/ 563760 h 563400"/>
              </a:gdLst>
              <a:ahLst/>
              <a:rect l="textAreaLeft" t="textAreaTop" r="textAreaRight" b="textAreaBottom"/>
              <a:pathLst>
                <a:path fill="none" w="18014" h="15096">
                  <a:moveTo>
                    <a:pt x="0" y="3177"/>
                  </a:moveTo>
                  <a:cubicBezTo>
                    <a:pt x="752" y="2039"/>
                    <a:pt x="1611" y="975"/>
                    <a:pt x="2565" y="0"/>
                  </a:cubicBezTo>
                </a:path>
                <a:path stroke="0" w="18014" h="15096">
                  <a:moveTo>
                    <a:pt x="0" y="3177"/>
                  </a:moveTo>
                  <a:cubicBezTo>
                    <a:pt x="752" y="2039"/>
                    <a:pt x="1611" y="975"/>
                    <a:pt x="2565" y="0"/>
                  </a:cubicBezTo>
                  <a:lnTo>
                    <a:pt x="18014" y="15096"/>
                  </a:lnTo>
                  <a:lnTo>
                    <a:pt x="0" y="317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Arc 377"/>
            <p:cNvSpPr/>
            <p:nvPr/>
          </p:nvSpPr>
          <p:spPr>
            <a:xfrm>
              <a:off x="4057560" y="3624120"/>
              <a:ext cx="619200" cy="520560"/>
            </a:xfrm>
            <a:custGeom>
              <a:avLst/>
              <a:gdLst>
                <a:gd name="textAreaLeft" fmla="*/ 0 w 619200"/>
                <a:gd name="textAreaRight" fmla="*/ 619560 w 619200"/>
                <a:gd name="textAreaTop" fmla="*/ 0 h 520560"/>
                <a:gd name="textAreaBottom" fmla="*/ 520920 h 520560"/>
              </a:gdLst>
              <a:ahLst/>
              <a:rect l="textAreaLeft" t="textAreaTop" r="textAreaRight" b="textAreaBottom"/>
              <a:pathLst>
                <a:path fill="none" w="17988" h="15119">
                  <a:moveTo>
                    <a:pt x="0" y="3161"/>
                  </a:moveTo>
                  <a:cubicBezTo>
                    <a:pt x="752" y="2029"/>
                    <a:pt x="1610" y="970"/>
                    <a:pt x="2561" y="-1"/>
                  </a:cubicBezTo>
                </a:path>
                <a:path stroke="0" w="17988" h="15119">
                  <a:moveTo>
                    <a:pt x="0" y="3161"/>
                  </a:moveTo>
                  <a:cubicBezTo>
                    <a:pt x="752" y="2029"/>
                    <a:pt x="1610" y="970"/>
                    <a:pt x="2561" y="-1"/>
                  </a:cubicBezTo>
                  <a:lnTo>
                    <a:pt x="17988" y="15119"/>
                  </a:lnTo>
                  <a:lnTo>
                    <a:pt x="0" y="316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378"/>
            <p:cNvSpPr/>
            <p:nvPr/>
          </p:nvSpPr>
          <p:spPr>
            <a:xfrm flipH="1" flipV="1">
              <a:off x="4098960" y="3580920"/>
              <a:ext cx="4752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379"/>
            <p:cNvSpPr/>
            <p:nvPr/>
          </p:nvSpPr>
          <p:spPr>
            <a:xfrm flipH="1" flipV="1">
              <a:off x="4003560" y="3699720"/>
              <a:ext cx="54000" cy="33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380"/>
            <p:cNvSpPr/>
            <p:nvPr/>
          </p:nvSpPr>
          <p:spPr>
            <a:xfrm>
              <a:off x="4017960" y="3590640"/>
              <a:ext cx="31680" cy="475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381"/>
            <p:cNvSpPr/>
            <p:nvPr/>
          </p:nvSpPr>
          <p:spPr>
            <a:xfrm>
              <a:off x="3934080" y="350172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382"/>
            <p:cNvSpPr/>
            <p:nvPr/>
          </p:nvSpPr>
          <p:spPr>
            <a:xfrm>
              <a:off x="3843360" y="3701880"/>
              <a:ext cx="212760" cy="539640"/>
            </a:xfrm>
            <a:custGeom>
              <a:avLst/>
              <a:gdLst>
                <a:gd name="textAreaLeft" fmla="*/ 0 w 212760"/>
                <a:gd name="textAreaRight" fmla="*/ 213120 w 212760"/>
                <a:gd name="textAreaTop" fmla="*/ 0 h 539640"/>
                <a:gd name="textAreaBottom" fmla="*/ 540000 h 539640"/>
              </a:gdLst>
              <a:ahLst/>
              <a:rect l="textAreaLeft" t="textAreaTop" r="textAreaRight" b="textAreaBottom"/>
              <a:pathLst>
                <a:path w="134" h="340">
                  <a:moveTo>
                    <a:pt x="100" y="0"/>
                  </a:moveTo>
                  <a:lnTo>
                    <a:pt x="76" y="39"/>
                  </a:lnTo>
                  <a:lnTo>
                    <a:pt x="57" y="80"/>
                  </a:lnTo>
                  <a:lnTo>
                    <a:pt x="40" y="123"/>
                  </a:lnTo>
                  <a:lnTo>
                    <a:pt x="28" y="166"/>
                  </a:lnTo>
                  <a:lnTo>
                    <a:pt x="20" y="212"/>
                  </a:lnTo>
                  <a:lnTo>
                    <a:pt x="16" y="256"/>
                  </a:lnTo>
                  <a:lnTo>
                    <a:pt x="15" y="302"/>
                  </a:lnTo>
                  <a:lnTo>
                    <a:pt x="16" y="309"/>
                  </a:lnTo>
                  <a:lnTo>
                    <a:pt x="0" y="310"/>
                  </a:lnTo>
                  <a:lnTo>
                    <a:pt x="39" y="340"/>
                  </a:lnTo>
                  <a:lnTo>
                    <a:pt x="73" y="305"/>
                  </a:lnTo>
                  <a:lnTo>
                    <a:pt x="57" y="306"/>
                  </a:lnTo>
                  <a:lnTo>
                    <a:pt x="56" y="265"/>
                  </a:lnTo>
                  <a:lnTo>
                    <a:pt x="60" y="223"/>
                  </a:lnTo>
                  <a:lnTo>
                    <a:pt x="67" y="181"/>
                  </a:lnTo>
                  <a:lnTo>
                    <a:pt x="77" y="140"/>
                  </a:lnTo>
                  <a:lnTo>
                    <a:pt x="92" y="101"/>
                  </a:lnTo>
                  <a:lnTo>
                    <a:pt x="110" y="63"/>
                  </a:lnTo>
                  <a:lnTo>
                    <a:pt x="131" y="27"/>
                  </a:lnTo>
                  <a:lnTo>
                    <a:pt x="134" y="21"/>
                  </a:lnTo>
                  <a:lnTo>
                    <a:pt x="100" y="0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Arc 383"/>
            <p:cNvSpPr/>
            <p:nvPr/>
          </p:nvSpPr>
          <p:spPr>
            <a:xfrm>
              <a:off x="3867120" y="3701880"/>
              <a:ext cx="809640" cy="490320"/>
            </a:xfrm>
            <a:custGeom>
              <a:avLst/>
              <a:gdLst>
                <a:gd name="textAreaLeft" fmla="*/ 0 w 809640"/>
                <a:gd name="textAreaRight" fmla="*/ 810000 w 809640"/>
                <a:gd name="textAreaTop" fmla="*/ 0 h 490320"/>
                <a:gd name="textAreaBottom" fmla="*/ 490680 h 490320"/>
              </a:gdLst>
              <a:ahLst/>
              <a:rect l="textAreaLeft" t="textAreaTop" r="textAreaRight" b="textAreaBottom"/>
              <a:pathLst>
                <a:path fill="none" w="21600" h="13143">
                  <a:moveTo>
                    <a:pt x="37" y="13143"/>
                  </a:moveTo>
                  <a:cubicBezTo>
                    <a:pt x="12" y="12719"/>
                    <a:pt x="0" y="12294"/>
                    <a:pt x="0" y="11870"/>
                  </a:cubicBezTo>
                  <a:cubicBezTo>
                    <a:pt x="-1" y="7651"/>
                    <a:pt x="1235" y="3524"/>
                    <a:pt x="3553" y="-1"/>
                  </a:cubicBezTo>
                </a:path>
                <a:path stroke="0" w="21600" h="13143">
                  <a:moveTo>
                    <a:pt x="37" y="13143"/>
                  </a:moveTo>
                  <a:cubicBezTo>
                    <a:pt x="12" y="12719"/>
                    <a:pt x="0" y="12294"/>
                    <a:pt x="0" y="11870"/>
                  </a:cubicBezTo>
                  <a:cubicBezTo>
                    <a:pt x="-1" y="7651"/>
                    <a:pt x="1235" y="3524"/>
                    <a:pt x="3553" y="-1"/>
                  </a:cubicBezTo>
                  <a:lnTo>
                    <a:pt x="21600" y="11870"/>
                  </a:lnTo>
                  <a:lnTo>
                    <a:pt x="37" y="1314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Arc 384"/>
            <p:cNvSpPr/>
            <p:nvPr/>
          </p:nvSpPr>
          <p:spPr>
            <a:xfrm>
              <a:off x="3932280" y="3735000"/>
              <a:ext cx="744480" cy="452520"/>
            </a:xfrm>
            <a:custGeom>
              <a:avLst/>
              <a:gdLst>
                <a:gd name="textAreaLeft" fmla="*/ 0 w 744480"/>
                <a:gd name="textAreaRight" fmla="*/ 744840 w 744480"/>
                <a:gd name="textAreaTop" fmla="*/ 0 h 452520"/>
                <a:gd name="textAreaBottom" fmla="*/ 452880 h 452520"/>
              </a:gdLst>
              <a:ahLst/>
              <a:rect l="textAreaLeft" t="textAreaTop" r="textAreaRight" b="textAreaBottom"/>
              <a:pathLst>
                <a:path fill="none" w="21600" h="13150">
                  <a:moveTo>
                    <a:pt x="35" y="13150"/>
                  </a:moveTo>
                  <a:cubicBezTo>
                    <a:pt x="11" y="12735"/>
                    <a:pt x="0" y="12320"/>
                    <a:pt x="0" y="11905"/>
                  </a:cubicBezTo>
                  <a:cubicBezTo>
                    <a:pt x="-1" y="7671"/>
                    <a:pt x="1243" y="3532"/>
                    <a:pt x="3576" y="-1"/>
                  </a:cubicBezTo>
                </a:path>
                <a:path stroke="0" w="21600" h="13150">
                  <a:moveTo>
                    <a:pt x="35" y="13150"/>
                  </a:moveTo>
                  <a:cubicBezTo>
                    <a:pt x="11" y="12735"/>
                    <a:pt x="0" y="12320"/>
                    <a:pt x="0" y="11905"/>
                  </a:cubicBezTo>
                  <a:cubicBezTo>
                    <a:pt x="-1" y="7671"/>
                    <a:pt x="1243" y="3532"/>
                    <a:pt x="3576" y="-1"/>
                  </a:cubicBezTo>
                  <a:lnTo>
                    <a:pt x="21600" y="11905"/>
                  </a:lnTo>
                  <a:lnTo>
                    <a:pt x="35" y="1315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385"/>
            <p:cNvSpPr/>
            <p:nvPr/>
          </p:nvSpPr>
          <p:spPr>
            <a:xfrm flipH="1" flipV="1">
              <a:off x="4002120" y="3701880"/>
              <a:ext cx="5400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386"/>
            <p:cNvSpPr/>
            <p:nvPr/>
          </p:nvSpPr>
          <p:spPr>
            <a:xfrm>
              <a:off x="3843360" y="4186080"/>
              <a:ext cx="115920" cy="5544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67" h="32">
                  <a:moveTo>
                    <a:pt x="52" y="1"/>
                  </a:moveTo>
                  <a:lnTo>
                    <a:pt x="67" y="0"/>
                  </a:lnTo>
                  <a:lnTo>
                    <a:pt x="36" y="32"/>
                  </a:lnTo>
                  <a:lnTo>
                    <a:pt x="0" y="4"/>
                  </a:lnTo>
                  <a:lnTo>
                    <a:pt x="15" y="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387"/>
            <p:cNvSpPr/>
            <p:nvPr/>
          </p:nvSpPr>
          <p:spPr>
            <a:xfrm>
              <a:off x="3762360" y="3920760"/>
              <a:ext cx="128520" cy="414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388"/>
            <p:cNvSpPr/>
            <p:nvPr/>
          </p:nvSpPr>
          <p:spPr>
            <a:xfrm>
              <a:off x="3489480" y="383184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9" name="Rectangle 59"/>
          <p:cNvSpPr/>
          <p:nvPr/>
        </p:nvSpPr>
        <p:spPr>
          <a:xfrm>
            <a:off x="468360" y="1052640"/>
            <a:ext cx="1798560" cy="19080"/>
          </a:xfrm>
          <a:prstGeom prst="rect">
            <a:avLst/>
          </a:prstGeom>
          <a:solidFill>
            <a:srgbClr val="ffffcc"/>
          </a:solidFill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63"/>
          <p:cNvSpPr/>
          <p:nvPr/>
        </p:nvSpPr>
        <p:spPr>
          <a:xfrm>
            <a:off x="558720" y="993600"/>
            <a:ext cx="1663920" cy="138240"/>
          </a:xfrm>
          <a:custGeom>
            <a:avLst/>
            <a:gdLst>
              <a:gd name="textAreaLeft" fmla="*/ 0 w 1663920"/>
              <a:gd name="textAreaRight" fmla="*/ 1664280 w 166392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1536" h="87">
                <a:moveTo>
                  <a:pt x="1496" y="87"/>
                </a:moveTo>
                <a:lnTo>
                  <a:pt x="1536" y="43"/>
                </a:lnTo>
                <a:lnTo>
                  <a:pt x="1496" y="0"/>
                </a:lnTo>
                <a:lnTo>
                  <a:pt x="1496" y="19"/>
                </a:lnTo>
                <a:lnTo>
                  <a:pt x="0" y="19"/>
                </a:lnTo>
                <a:lnTo>
                  <a:pt x="0" y="68"/>
                </a:lnTo>
                <a:lnTo>
                  <a:pt x="1496" y="68"/>
                </a:lnTo>
                <a:lnTo>
                  <a:pt x="1496" y="87"/>
                </a:lnTo>
                <a:close/>
              </a:path>
            </a:pathLst>
          </a:custGeom>
          <a:solidFill>
            <a:srgbClr val="33ffcc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64"/>
          <p:cNvSpPr/>
          <p:nvPr/>
        </p:nvSpPr>
        <p:spPr>
          <a:xfrm flipH="1">
            <a:off x="1456920" y="912960"/>
            <a:ext cx="3240" cy="110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65"/>
          <p:cNvSpPr/>
          <p:nvPr/>
        </p:nvSpPr>
        <p:spPr>
          <a:xfrm>
            <a:off x="1378080" y="836640"/>
            <a:ext cx="174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600" spc="-1" strike="noStrike">
                <a:solidFill>
                  <a:srgbClr val="000000"/>
                </a:solidFill>
                <a:latin typeface="Arial"/>
              </a:rPr>
              <a:t>PGI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66"/>
          <p:cNvSpPr/>
          <p:nvPr/>
        </p:nvSpPr>
        <p:spPr>
          <a:xfrm>
            <a:off x="471600" y="993600"/>
            <a:ext cx="81000" cy="138240"/>
          </a:xfrm>
          <a:custGeom>
            <a:avLst/>
            <a:gdLst>
              <a:gd name="textAreaLeft" fmla="*/ 0 w 81000"/>
              <a:gd name="textAreaRight" fmla="*/ 81360 w 8100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56" h="87">
                <a:moveTo>
                  <a:pt x="16" y="87"/>
                </a:moveTo>
                <a:lnTo>
                  <a:pt x="56" y="43"/>
                </a:lnTo>
                <a:lnTo>
                  <a:pt x="16" y="0"/>
                </a:lnTo>
                <a:lnTo>
                  <a:pt x="16" y="19"/>
                </a:lnTo>
                <a:lnTo>
                  <a:pt x="0" y="19"/>
                </a:lnTo>
                <a:lnTo>
                  <a:pt x="0" y="68"/>
                </a:lnTo>
                <a:lnTo>
                  <a:pt x="16" y="68"/>
                </a:lnTo>
                <a:lnTo>
                  <a:pt x="16" y="87"/>
                </a:lnTo>
                <a:close/>
              </a:path>
            </a:pathLst>
          </a:cu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67"/>
          <p:cNvSpPr/>
          <p:nvPr/>
        </p:nvSpPr>
        <p:spPr>
          <a:xfrm>
            <a:off x="511200" y="946080"/>
            <a:ext cx="1440" cy="77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68"/>
          <p:cNvSpPr/>
          <p:nvPr/>
        </p:nvSpPr>
        <p:spPr>
          <a:xfrm>
            <a:off x="378360" y="86832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Arial"/>
              </a:rPr>
              <a:t>attB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69"/>
          <p:cNvSpPr/>
          <p:nvPr/>
        </p:nvSpPr>
        <p:spPr>
          <a:xfrm>
            <a:off x="2233440" y="993600"/>
            <a:ext cx="81000" cy="138240"/>
          </a:xfrm>
          <a:custGeom>
            <a:avLst/>
            <a:gdLst>
              <a:gd name="textAreaLeft" fmla="*/ 0 w 81000"/>
              <a:gd name="textAreaRight" fmla="*/ 81360 w 8100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56" h="87">
                <a:moveTo>
                  <a:pt x="56" y="19"/>
                </a:moveTo>
                <a:lnTo>
                  <a:pt x="39" y="19"/>
                </a:lnTo>
                <a:lnTo>
                  <a:pt x="39" y="0"/>
                </a:lnTo>
                <a:lnTo>
                  <a:pt x="0" y="43"/>
                </a:lnTo>
                <a:lnTo>
                  <a:pt x="39" y="87"/>
                </a:lnTo>
                <a:lnTo>
                  <a:pt x="39" y="68"/>
                </a:lnTo>
                <a:lnTo>
                  <a:pt x="56" y="68"/>
                </a:lnTo>
                <a:lnTo>
                  <a:pt x="56" y="19"/>
                </a:lnTo>
                <a:close/>
              </a:path>
            </a:pathLst>
          </a:cu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70"/>
          <p:cNvSpPr/>
          <p:nvPr/>
        </p:nvSpPr>
        <p:spPr>
          <a:xfrm>
            <a:off x="468360" y="1023840"/>
            <a:ext cx="3240" cy="77760"/>
          </a:xfrm>
          <a:prstGeom prst="rect">
            <a:avLst/>
          </a:pr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71"/>
          <p:cNvSpPr/>
          <p:nvPr/>
        </p:nvSpPr>
        <p:spPr>
          <a:xfrm flipH="1">
            <a:off x="2276280" y="949320"/>
            <a:ext cx="21960" cy="74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72"/>
          <p:cNvSpPr/>
          <p:nvPr/>
        </p:nvSpPr>
        <p:spPr>
          <a:xfrm>
            <a:off x="2302200" y="87300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Arial"/>
              </a:rPr>
              <a:t>attB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75"/>
          <p:cNvSpPr/>
          <p:nvPr/>
        </p:nvSpPr>
        <p:spPr>
          <a:xfrm>
            <a:off x="971640" y="1123920"/>
            <a:ext cx="12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(PCR produ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256"/>
          <p:cNvGrpSpPr/>
          <p:nvPr/>
        </p:nvGrpSpPr>
        <p:grpSpPr>
          <a:xfrm>
            <a:off x="7007400" y="1844640"/>
            <a:ext cx="1885680" cy="1944720"/>
            <a:chOff x="7007400" y="1844640"/>
            <a:chExt cx="1885680" cy="1944720"/>
          </a:xfrm>
        </p:grpSpPr>
        <p:sp>
          <p:nvSpPr>
            <p:cNvPr id="182" name="AutoShape 255"/>
            <p:cNvSpPr/>
            <p:nvPr/>
          </p:nvSpPr>
          <p:spPr>
            <a:xfrm>
              <a:off x="7007400" y="1916280"/>
              <a:ext cx="1885680" cy="187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257"/>
            <p:cNvSpPr/>
            <p:nvPr/>
          </p:nvSpPr>
          <p:spPr>
            <a:xfrm>
              <a:off x="7297560" y="2146320"/>
              <a:ext cx="1554480" cy="1554120"/>
            </a:xfrm>
            <a:custGeom>
              <a:avLst/>
              <a:gdLst>
                <a:gd name="textAreaLeft" fmla="*/ 0 w 1554480"/>
                <a:gd name="textAreaRight" fmla="*/ 1554840 w 1554480"/>
                <a:gd name="textAreaTop" fmla="*/ 0 h 1554120"/>
                <a:gd name="textAreaBottom" fmla="*/ 1554480 h 1554120"/>
              </a:gdLst>
              <a:ahLst/>
              <a:rect l="textAreaLeft" t="textAreaTop" r="textAreaRight" b="textAreaBottom"/>
              <a:pathLst>
                <a:path w="979" h="979">
                  <a:moveTo>
                    <a:pt x="494" y="0"/>
                  </a:moveTo>
                  <a:lnTo>
                    <a:pt x="450" y="2"/>
                  </a:lnTo>
                  <a:lnTo>
                    <a:pt x="406" y="7"/>
                  </a:lnTo>
                  <a:lnTo>
                    <a:pt x="364" y="17"/>
                  </a:lnTo>
                  <a:lnTo>
                    <a:pt x="322" y="30"/>
                  </a:lnTo>
                  <a:lnTo>
                    <a:pt x="281" y="46"/>
                  </a:lnTo>
                  <a:lnTo>
                    <a:pt x="242" y="67"/>
                  </a:lnTo>
                  <a:lnTo>
                    <a:pt x="206" y="90"/>
                  </a:lnTo>
                  <a:lnTo>
                    <a:pt x="172" y="118"/>
                  </a:lnTo>
                  <a:lnTo>
                    <a:pt x="139" y="147"/>
                  </a:lnTo>
                  <a:lnTo>
                    <a:pt x="110" y="180"/>
                  </a:lnTo>
                  <a:lnTo>
                    <a:pt x="83" y="216"/>
                  </a:lnTo>
                  <a:lnTo>
                    <a:pt x="61" y="252"/>
                  </a:lnTo>
                  <a:lnTo>
                    <a:pt x="42" y="292"/>
                  </a:lnTo>
                  <a:lnTo>
                    <a:pt x="25" y="333"/>
                  </a:lnTo>
                  <a:lnTo>
                    <a:pt x="14" y="375"/>
                  </a:lnTo>
                  <a:lnTo>
                    <a:pt x="5" y="418"/>
                  </a:lnTo>
                  <a:lnTo>
                    <a:pt x="1" y="461"/>
                  </a:lnTo>
                  <a:lnTo>
                    <a:pt x="0" y="505"/>
                  </a:lnTo>
                  <a:lnTo>
                    <a:pt x="3" y="549"/>
                  </a:lnTo>
                  <a:lnTo>
                    <a:pt x="10" y="592"/>
                  </a:lnTo>
                  <a:lnTo>
                    <a:pt x="21" y="635"/>
                  </a:lnTo>
                  <a:lnTo>
                    <a:pt x="36" y="675"/>
                  </a:lnTo>
                  <a:lnTo>
                    <a:pt x="54" y="715"/>
                  </a:lnTo>
                  <a:lnTo>
                    <a:pt x="76" y="753"/>
                  </a:lnTo>
                  <a:lnTo>
                    <a:pt x="102" y="789"/>
                  </a:lnTo>
                  <a:lnTo>
                    <a:pt x="130" y="823"/>
                  </a:lnTo>
                  <a:lnTo>
                    <a:pt x="161" y="853"/>
                  </a:lnTo>
                  <a:lnTo>
                    <a:pt x="194" y="881"/>
                  </a:lnTo>
                  <a:lnTo>
                    <a:pt x="231" y="906"/>
                  </a:lnTo>
                  <a:lnTo>
                    <a:pt x="269" y="927"/>
                  </a:lnTo>
                  <a:lnTo>
                    <a:pt x="309" y="945"/>
                  </a:lnTo>
                  <a:lnTo>
                    <a:pt x="350" y="959"/>
                  </a:lnTo>
                  <a:lnTo>
                    <a:pt x="393" y="970"/>
                  </a:lnTo>
                  <a:lnTo>
                    <a:pt x="436" y="977"/>
                  </a:lnTo>
                  <a:lnTo>
                    <a:pt x="480" y="979"/>
                  </a:lnTo>
                  <a:lnTo>
                    <a:pt x="524" y="978"/>
                  </a:lnTo>
                  <a:lnTo>
                    <a:pt x="567" y="973"/>
                  </a:lnTo>
                  <a:lnTo>
                    <a:pt x="610" y="964"/>
                  </a:lnTo>
                  <a:lnTo>
                    <a:pt x="652" y="951"/>
                  </a:lnTo>
                  <a:lnTo>
                    <a:pt x="693" y="935"/>
                  </a:lnTo>
                  <a:lnTo>
                    <a:pt x="731" y="916"/>
                  </a:lnTo>
                  <a:lnTo>
                    <a:pt x="769" y="892"/>
                  </a:lnTo>
                  <a:lnTo>
                    <a:pt x="803" y="865"/>
                  </a:lnTo>
                  <a:lnTo>
                    <a:pt x="835" y="836"/>
                  </a:lnTo>
                  <a:lnTo>
                    <a:pt x="866" y="804"/>
                  </a:lnTo>
                  <a:lnTo>
                    <a:pt x="892" y="769"/>
                  </a:lnTo>
                  <a:lnTo>
                    <a:pt x="915" y="732"/>
                  </a:lnTo>
                  <a:lnTo>
                    <a:pt x="935" y="693"/>
                  </a:lnTo>
                  <a:lnTo>
                    <a:pt x="952" y="652"/>
                  </a:lnTo>
                  <a:lnTo>
                    <a:pt x="964" y="610"/>
                  </a:lnTo>
                  <a:lnTo>
                    <a:pt x="973" y="568"/>
                  </a:lnTo>
                  <a:lnTo>
                    <a:pt x="978" y="524"/>
                  </a:lnTo>
                  <a:lnTo>
                    <a:pt x="979" y="480"/>
                  </a:lnTo>
                  <a:lnTo>
                    <a:pt x="976" y="437"/>
                  </a:lnTo>
                  <a:lnTo>
                    <a:pt x="970" y="393"/>
                  </a:lnTo>
                  <a:lnTo>
                    <a:pt x="959" y="351"/>
                  </a:lnTo>
                  <a:lnTo>
                    <a:pt x="945" y="309"/>
                  </a:lnTo>
                  <a:lnTo>
                    <a:pt x="927" y="270"/>
                  </a:lnTo>
                  <a:lnTo>
                    <a:pt x="905" y="231"/>
                  </a:lnTo>
                  <a:lnTo>
                    <a:pt x="881" y="195"/>
                  </a:lnTo>
                  <a:lnTo>
                    <a:pt x="853" y="161"/>
                  </a:lnTo>
                  <a:lnTo>
                    <a:pt x="822" y="130"/>
                  </a:lnTo>
                  <a:lnTo>
                    <a:pt x="788" y="102"/>
                  </a:lnTo>
                  <a:lnTo>
                    <a:pt x="753" y="77"/>
                  </a:lnTo>
                  <a:lnTo>
                    <a:pt x="715" y="55"/>
                  </a:lnTo>
                  <a:lnTo>
                    <a:pt x="675" y="36"/>
                  </a:lnTo>
                  <a:lnTo>
                    <a:pt x="634" y="21"/>
                  </a:lnTo>
                  <a:lnTo>
                    <a:pt x="592" y="11"/>
                  </a:lnTo>
                  <a:lnTo>
                    <a:pt x="548" y="3"/>
                  </a:lnTo>
                  <a:lnTo>
                    <a:pt x="505" y="0"/>
                  </a:lnTo>
                  <a:lnTo>
                    <a:pt x="495" y="0"/>
                  </a:lnTo>
                  <a:lnTo>
                    <a:pt x="494" y="11"/>
                  </a:lnTo>
                  <a:lnTo>
                    <a:pt x="537" y="13"/>
                  </a:lnTo>
                  <a:lnTo>
                    <a:pt x="580" y="19"/>
                  </a:lnTo>
                  <a:lnTo>
                    <a:pt x="622" y="29"/>
                  </a:lnTo>
                  <a:lnTo>
                    <a:pt x="661" y="43"/>
                  </a:lnTo>
                  <a:lnTo>
                    <a:pt x="701" y="60"/>
                  </a:lnTo>
                  <a:lnTo>
                    <a:pt x="739" y="81"/>
                  </a:lnTo>
                  <a:lnTo>
                    <a:pt x="774" y="104"/>
                  </a:lnTo>
                  <a:lnTo>
                    <a:pt x="808" y="131"/>
                  </a:lnTo>
                  <a:lnTo>
                    <a:pt x="839" y="161"/>
                  </a:lnTo>
                  <a:lnTo>
                    <a:pt x="867" y="193"/>
                  </a:lnTo>
                  <a:lnTo>
                    <a:pt x="891" y="229"/>
                  </a:lnTo>
                  <a:lnTo>
                    <a:pt x="913" y="265"/>
                  </a:lnTo>
                  <a:lnTo>
                    <a:pt x="931" y="304"/>
                  </a:lnTo>
                  <a:lnTo>
                    <a:pt x="946" y="345"/>
                  </a:lnTo>
                  <a:lnTo>
                    <a:pt x="958" y="385"/>
                  </a:lnTo>
                  <a:lnTo>
                    <a:pt x="964" y="428"/>
                  </a:lnTo>
                  <a:lnTo>
                    <a:pt x="969" y="470"/>
                  </a:lnTo>
                  <a:lnTo>
                    <a:pt x="969" y="513"/>
                  </a:lnTo>
                  <a:lnTo>
                    <a:pt x="964" y="556"/>
                  </a:lnTo>
                  <a:lnTo>
                    <a:pt x="957" y="598"/>
                  </a:lnTo>
                  <a:lnTo>
                    <a:pt x="945" y="640"/>
                  </a:lnTo>
                  <a:lnTo>
                    <a:pt x="930" y="680"/>
                  </a:lnTo>
                  <a:lnTo>
                    <a:pt x="911" y="718"/>
                  </a:lnTo>
                  <a:lnTo>
                    <a:pt x="889" y="755"/>
                  </a:lnTo>
                  <a:lnTo>
                    <a:pt x="863" y="789"/>
                  </a:lnTo>
                  <a:lnTo>
                    <a:pt x="835" y="821"/>
                  </a:lnTo>
                  <a:lnTo>
                    <a:pt x="804" y="852"/>
                  </a:lnTo>
                  <a:lnTo>
                    <a:pt x="771" y="878"/>
                  </a:lnTo>
                  <a:lnTo>
                    <a:pt x="734" y="902"/>
                  </a:lnTo>
                  <a:lnTo>
                    <a:pt x="697" y="922"/>
                  </a:lnTo>
                  <a:lnTo>
                    <a:pt x="657" y="939"/>
                  </a:lnTo>
                  <a:lnTo>
                    <a:pt x="616" y="952"/>
                  </a:lnTo>
                  <a:lnTo>
                    <a:pt x="575" y="961"/>
                  </a:lnTo>
                  <a:lnTo>
                    <a:pt x="533" y="968"/>
                  </a:lnTo>
                  <a:lnTo>
                    <a:pt x="490" y="970"/>
                  </a:lnTo>
                  <a:lnTo>
                    <a:pt x="447" y="968"/>
                  </a:lnTo>
                  <a:lnTo>
                    <a:pt x="405" y="962"/>
                  </a:lnTo>
                  <a:lnTo>
                    <a:pt x="363" y="952"/>
                  </a:lnTo>
                  <a:lnTo>
                    <a:pt x="322" y="939"/>
                  </a:lnTo>
                  <a:lnTo>
                    <a:pt x="282" y="922"/>
                  </a:lnTo>
                  <a:lnTo>
                    <a:pt x="245" y="902"/>
                  </a:lnTo>
                  <a:lnTo>
                    <a:pt x="208" y="878"/>
                  </a:lnTo>
                  <a:lnTo>
                    <a:pt x="175" y="852"/>
                  </a:lnTo>
                  <a:lnTo>
                    <a:pt x="144" y="823"/>
                  </a:lnTo>
                  <a:lnTo>
                    <a:pt x="116" y="790"/>
                  </a:lnTo>
                  <a:lnTo>
                    <a:pt x="90" y="756"/>
                  </a:lnTo>
                  <a:lnTo>
                    <a:pt x="68" y="719"/>
                  </a:lnTo>
                  <a:lnTo>
                    <a:pt x="49" y="681"/>
                  </a:lnTo>
                  <a:lnTo>
                    <a:pt x="34" y="640"/>
                  </a:lnTo>
                  <a:lnTo>
                    <a:pt x="22" y="599"/>
                  </a:lnTo>
                  <a:lnTo>
                    <a:pt x="15" y="557"/>
                  </a:lnTo>
                  <a:lnTo>
                    <a:pt x="10" y="514"/>
                  </a:lnTo>
                  <a:lnTo>
                    <a:pt x="10" y="471"/>
                  </a:lnTo>
                  <a:lnTo>
                    <a:pt x="14" y="428"/>
                  </a:lnTo>
                  <a:lnTo>
                    <a:pt x="21" y="387"/>
                  </a:lnTo>
                  <a:lnTo>
                    <a:pt x="32" y="345"/>
                  </a:lnTo>
                  <a:lnTo>
                    <a:pt x="47" y="305"/>
                  </a:lnTo>
                  <a:lnTo>
                    <a:pt x="65" y="266"/>
                  </a:lnTo>
                  <a:lnTo>
                    <a:pt x="87" y="229"/>
                  </a:lnTo>
                  <a:lnTo>
                    <a:pt x="111" y="194"/>
                  </a:lnTo>
                  <a:lnTo>
                    <a:pt x="139" y="162"/>
                  </a:lnTo>
                  <a:lnTo>
                    <a:pt x="170" y="132"/>
                  </a:lnTo>
                  <a:lnTo>
                    <a:pt x="204" y="105"/>
                  </a:lnTo>
                  <a:lnTo>
                    <a:pt x="239" y="81"/>
                  </a:lnTo>
                  <a:lnTo>
                    <a:pt x="277" y="60"/>
                  </a:lnTo>
                  <a:lnTo>
                    <a:pt x="317" y="43"/>
                  </a:lnTo>
                  <a:lnTo>
                    <a:pt x="356" y="29"/>
                  </a:lnTo>
                  <a:lnTo>
                    <a:pt x="398" y="19"/>
                  </a:lnTo>
                  <a:lnTo>
                    <a:pt x="441" y="13"/>
                  </a:lnTo>
                  <a:lnTo>
                    <a:pt x="484" y="11"/>
                  </a:lnTo>
                  <a:lnTo>
                    <a:pt x="494" y="11"/>
                  </a:lnTo>
                  <a:lnTo>
                    <a:pt x="494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Oval 258"/>
            <p:cNvSpPr/>
            <p:nvPr/>
          </p:nvSpPr>
          <p:spPr>
            <a:xfrm>
              <a:off x="7297560" y="2146320"/>
              <a:ext cx="1548000" cy="154764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Oval 259"/>
            <p:cNvSpPr/>
            <p:nvPr/>
          </p:nvSpPr>
          <p:spPr>
            <a:xfrm>
              <a:off x="7313760" y="2163600"/>
              <a:ext cx="1514160" cy="151308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260"/>
            <p:cNvSpPr/>
            <p:nvPr/>
          </p:nvSpPr>
          <p:spPr>
            <a:xfrm flipV="1">
              <a:off x="8082000" y="21463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261"/>
            <p:cNvSpPr/>
            <p:nvPr/>
          </p:nvSpPr>
          <p:spPr>
            <a:xfrm>
              <a:off x="7671240" y="2798640"/>
              <a:ext cx="80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K2GW7,0  PGI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262"/>
            <p:cNvSpPr/>
            <p:nvPr/>
          </p:nvSpPr>
          <p:spPr>
            <a:xfrm>
              <a:off x="7902720" y="293220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1325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263"/>
            <p:cNvSpPr/>
            <p:nvPr/>
          </p:nvSpPr>
          <p:spPr>
            <a:xfrm>
              <a:off x="7561440" y="2100240"/>
              <a:ext cx="507960" cy="257040"/>
            </a:xfrm>
            <a:custGeom>
              <a:avLst/>
              <a:gdLst>
                <a:gd name="textAreaLeft" fmla="*/ 0 w 507960"/>
                <a:gd name="textAreaRight" fmla="*/ 508320 w 507960"/>
                <a:gd name="textAreaTop" fmla="*/ 0 h 257040"/>
                <a:gd name="textAreaBottom" fmla="*/ 257040 h 257040"/>
              </a:gdLst>
              <a:ahLst/>
              <a:rect l="textAreaLeft" t="textAreaTop" r="textAreaRight" b="textAreaBottom"/>
              <a:pathLst>
                <a:path w="320" h="162">
                  <a:moveTo>
                    <a:pt x="290" y="72"/>
                  </a:moveTo>
                  <a:lnTo>
                    <a:pt x="320" y="34"/>
                  </a:lnTo>
                  <a:lnTo>
                    <a:pt x="286" y="0"/>
                  </a:lnTo>
                  <a:lnTo>
                    <a:pt x="287" y="16"/>
                  </a:lnTo>
                  <a:lnTo>
                    <a:pt x="242" y="21"/>
                  </a:lnTo>
                  <a:lnTo>
                    <a:pt x="198" y="30"/>
                  </a:lnTo>
                  <a:lnTo>
                    <a:pt x="155" y="44"/>
                  </a:lnTo>
                  <a:lnTo>
                    <a:pt x="113" y="60"/>
                  </a:lnTo>
                  <a:lnTo>
                    <a:pt x="72" y="82"/>
                  </a:lnTo>
                  <a:lnTo>
                    <a:pt x="35" y="105"/>
                  </a:lnTo>
                  <a:lnTo>
                    <a:pt x="0" y="131"/>
                  </a:lnTo>
                  <a:lnTo>
                    <a:pt x="26" y="162"/>
                  </a:lnTo>
                  <a:lnTo>
                    <a:pt x="59" y="136"/>
                  </a:lnTo>
                  <a:lnTo>
                    <a:pt x="95" y="115"/>
                  </a:lnTo>
                  <a:lnTo>
                    <a:pt x="131" y="96"/>
                  </a:lnTo>
                  <a:lnTo>
                    <a:pt x="170" y="81"/>
                  </a:lnTo>
                  <a:lnTo>
                    <a:pt x="210" y="69"/>
                  </a:lnTo>
                  <a:lnTo>
                    <a:pt x="250" y="60"/>
                  </a:lnTo>
                  <a:lnTo>
                    <a:pt x="289" y="56"/>
                  </a:lnTo>
                  <a:lnTo>
                    <a:pt x="290" y="72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Arc 264"/>
            <p:cNvSpPr/>
            <p:nvPr/>
          </p:nvSpPr>
          <p:spPr>
            <a:xfrm>
              <a:off x="7561440" y="2125800"/>
              <a:ext cx="509400" cy="795240"/>
            </a:xfrm>
            <a:custGeom>
              <a:avLst/>
              <a:gdLst>
                <a:gd name="textAreaLeft" fmla="*/ 0 w 509400"/>
                <a:gd name="textAreaRight" fmla="*/ 509760 w 509400"/>
                <a:gd name="textAreaTop" fmla="*/ 0 h 795240"/>
                <a:gd name="textAreaBottom" fmla="*/ 795600 h 795240"/>
              </a:gdLst>
              <a:ahLst/>
              <a:rect l="textAreaLeft" t="textAreaTop" r="textAreaRight" b="textAreaBottom"/>
              <a:pathLst>
                <a:path fill="none" w="13811" h="21550">
                  <a:moveTo>
                    <a:pt x="0" y="4942"/>
                  </a:moveTo>
                  <a:cubicBezTo>
                    <a:pt x="3493" y="2036"/>
                    <a:pt x="7814" y="307"/>
                    <a:pt x="12347" y="-1"/>
                  </a:cubicBezTo>
                </a:path>
                <a:path stroke="0" w="13811" h="21550">
                  <a:moveTo>
                    <a:pt x="0" y="4942"/>
                  </a:moveTo>
                  <a:cubicBezTo>
                    <a:pt x="3493" y="2036"/>
                    <a:pt x="7814" y="307"/>
                    <a:pt x="12347" y="-1"/>
                  </a:cubicBezTo>
                  <a:lnTo>
                    <a:pt x="13811" y="21550"/>
                  </a:lnTo>
                  <a:lnTo>
                    <a:pt x="0" y="494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Arc 265"/>
            <p:cNvSpPr/>
            <p:nvPr/>
          </p:nvSpPr>
          <p:spPr>
            <a:xfrm>
              <a:off x="7602480" y="2189160"/>
              <a:ext cx="468360" cy="731880"/>
            </a:xfrm>
            <a:custGeom>
              <a:avLst/>
              <a:gdLst>
                <a:gd name="textAreaLeft" fmla="*/ 0 w 468360"/>
                <a:gd name="textAreaRight" fmla="*/ 468720 w 468360"/>
                <a:gd name="textAreaTop" fmla="*/ 0 h 731880"/>
                <a:gd name="textAreaBottom" fmla="*/ 732240 h 731880"/>
              </a:gdLst>
              <a:ahLst/>
              <a:rect l="textAreaLeft" t="textAreaTop" r="textAreaRight" b="textAreaBottom"/>
              <a:pathLst>
                <a:path fill="none" w="13796" h="21548">
                  <a:moveTo>
                    <a:pt x="-1" y="4927"/>
                  </a:moveTo>
                  <a:cubicBezTo>
                    <a:pt x="3482" y="2036"/>
                    <a:pt x="7786" y="312"/>
                    <a:pt x="12301" y="-1"/>
                  </a:cubicBezTo>
                </a:path>
                <a:path stroke="0" w="13796" h="21548">
                  <a:moveTo>
                    <a:pt x="-1" y="4927"/>
                  </a:moveTo>
                  <a:cubicBezTo>
                    <a:pt x="3482" y="2036"/>
                    <a:pt x="7786" y="312"/>
                    <a:pt x="12301" y="-1"/>
                  </a:cubicBezTo>
                  <a:lnTo>
                    <a:pt x="13796" y="21548"/>
                  </a:lnTo>
                  <a:lnTo>
                    <a:pt x="-1" y="492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266"/>
            <p:cNvSpPr/>
            <p:nvPr/>
          </p:nvSpPr>
          <p:spPr>
            <a:xfrm flipH="1" flipV="1">
              <a:off x="7561440" y="2308320"/>
              <a:ext cx="410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 267"/>
            <p:cNvSpPr/>
            <p:nvPr/>
          </p:nvSpPr>
          <p:spPr>
            <a:xfrm>
              <a:off x="8015400" y="2100240"/>
              <a:ext cx="54000" cy="11448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32" h="67">
                  <a:moveTo>
                    <a:pt x="3" y="52"/>
                  </a:moveTo>
                  <a:lnTo>
                    <a:pt x="4" y="67"/>
                  </a:lnTo>
                  <a:lnTo>
                    <a:pt x="32" y="32"/>
                  </a:lnTo>
                  <a:lnTo>
                    <a:pt x="0" y="0"/>
                  </a:lnTo>
                  <a:lnTo>
                    <a:pt x="1" y="1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268"/>
            <p:cNvSpPr/>
            <p:nvPr/>
          </p:nvSpPr>
          <p:spPr>
            <a:xfrm>
              <a:off x="7767720" y="2119320"/>
              <a:ext cx="30240" cy="525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269"/>
            <p:cNvSpPr/>
            <p:nvPr/>
          </p:nvSpPr>
          <p:spPr>
            <a:xfrm>
              <a:off x="7602480" y="2030400"/>
              <a:ext cx="201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s-ES" sz="700" spc="-1" strike="noStrike">
                  <a:solidFill>
                    <a:srgbClr val="800000"/>
                  </a:solidFill>
                  <a:latin typeface="Arial"/>
                </a:rPr>
                <a:t>PGI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270"/>
            <p:cNvSpPr/>
            <p:nvPr/>
          </p:nvSpPr>
          <p:spPr>
            <a:xfrm>
              <a:off x="7534440" y="2293920"/>
              <a:ext cx="77760" cy="92160"/>
            </a:xfrm>
            <a:prstGeom prst="line">
              <a:avLst/>
            </a:prstGeom>
            <a:ln w="144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271"/>
            <p:cNvSpPr/>
            <p:nvPr/>
          </p:nvSpPr>
          <p:spPr>
            <a:xfrm>
              <a:off x="7480440" y="2241720"/>
              <a:ext cx="54000" cy="522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272"/>
            <p:cNvSpPr/>
            <p:nvPr/>
          </p:nvSpPr>
          <p:spPr>
            <a:xfrm>
              <a:off x="7317720" y="215280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273"/>
            <p:cNvSpPr/>
            <p:nvPr/>
          </p:nvSpPr>
          <p:spPr>
            <a:xfrm>
              <a:off x="8070840" y="2095560"/>
              <a:ext cx="1440" cy="120600"/>
            </a:xfrm>
            <a:prstGeom prst="line">
              <a:avLst/>
            </a:prstGeom>
            <a:ln w="144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274"/>
            <p:cNvSpPr/>
            <p:nvPr/>
          </p:nvSpPr>
          <p:spPr>
            <a:xfrm flipH="1">
              <a:off x="8070840" y="2017800"/>
              <a:ext cx="6480" cy="777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275"/>
            <p:cNvSpPr/>
            <p:nvPr/>
          </p:nvSpPr>
          <p:spPr>
            <a:xfrm>
              <a:off x="7914600" y="19288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276"/>
            <p:cNvSpPr/>
            <p:nvPr/>
          </p:nvSpPr>
          <p:spPr>
            <a:xfrm>
              <a:off x="7275600" y="2746440"/>
              <a:ext cx="185760" cy="611280"/>
            </a:xfrm>
            <a:custGeom>
              <a:avLst/>
              <a:gdLst>
                <a:gd name="textAreaLeft" fmla="*/ 0 w 185760"/>
                <a:gd name="textAreaRight" fmla="*/ 186120 w 185760"/>
                <a:gd name="textAreaTop" fmla="*/ 0 h 611280"/>
                <a:gd name="textAreaBottom" fmla="*/ 611280 h 611280"/>
              </a:gdLst>
              <a:ahLst/>
              <a:rect l="textAreaLeft" t="textAreaTop" r="textAreaRight" b="textAreaBottom"/>
              <a:pathLst>
                <a:path w="117" h="385">
                  <a:moveTo>
                    <a:pt x="11" y="0"/>
                  </a:moveTo>
                  <a:lnTo>
                    <a:pt x="3" y="44"/>
                  </a:lnTo>
                  <a:lnTo>
                    <a:pt x="0" y="89"/>
                  </a:lnTo>
                  <a:lnTo>
                    <a:pt x="0" y="134"/>
                  </a:lnTo>
                  <a:lnTo>
                    <a:pt x="3" y="179"/>
                  </a:lnTo>
                  <a:lnTo>
                    <a:pt x="11" y="223"/>
                  </a:lnTo>
                  <a:lnTo>
                    <a:pt x="23" y="267"/>
                  </a:lnTo>
                  <a:lnTo>
                    <a:pt x="39" y="309"/>
                  </a:lnTo>
                  <a:lnTo>
                    <a:pt x="59" y="350"/>
                  </a:lnTo>
                  <a:lnTo>
                    <a:pt x="70" y="368"/>
                  </a:lnTo>
                  <a:lnTo>
                    <a:pt x="56" y="377"/>
                  </a:lnTo>
                  <a:lnTo>
                    <a:pt x="103" y="385"/>
                  </a:lnTo>
                  <a:lnTo>
                    <a:pt x="117" y="340"/>
                  </a:lnTo>
                  <a:lnTo>
                    <a:pt x="103" y="348"/>
                  </a:lnTo>
                  <a:lnTo>
                    <a:pt x="83" y="311"/>
                  </a:lnTo>
                  <a:lnTo>
                    <a:pt x="67" y="273"/>
                  </a:lnTo>
                  <a:lnTo>
                    <a:pt x="54" y="234"/>
                  </a:lnTo>
                  <a:lnTo>
                    <a:pt x="46" y="193"/>
                  </a:lnTo>
                  <a:lnTo>
                    <a:pt x="40" y="151"/>
                  </a:lnTo>
                  <a:lnTo>
                    <a:pt x="38" y="111"/>
                  </a:lnTo>
                  <a:lnTo>
                    <a:pt x="40" y="69"/>
                  </a:lnTo>
                  <a:lnTo>
                    <a:pt x="46" y="28"/>
                  </a:lnTo>
                  <a:lnTo>
                    <a:pt x="50" y="9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Arc 277"/>
            <p:cNvSpPr/>
            <p:nvPr/>
          </p:nvSpPr>
          <p:spPr>
            <a:xfrm>
              <a:off x="7273800" y="2746440"/>
              <a:ext cx="797040" cy="584280"/>
            </a:xfrm>
            <a:custGeom>
              <a:avLst/>
              <a:gdLst>
                <a:gd name="textAreaLeft" fmla="*/ 0 w 797040"/>
                <a:gd name="textAreaRight" fmla="*/ 797400 w 797040"/>
                <a:gd name="textAreaTop" fmla="*/ 0 h 584280"/>
                <a:gd name="textAreaBottom" fmla="*/ 584640 h 584280"/>
              </a:gdLst>
              <a:ahLst/>
              <a:rect l="textAreaLeft" t="textAreaTop" r="textAreaRight" b="textAreaBottom"/>
              <a:pathLst>
                <a:path fill="none" w="21600" h="15825">
                  <a:moveTo>
                    <a:pt x="3066" y="15825"/>
                  </a:moveTo>
                  <a:cubicBezTo>
                    <a:pt x="1059" y="12472"/>
                    <a:pt x="0" y="8638"/>
                    <a:pt x="0" y="4731"/>
                  </a:cubicBezTo>
                  <a:cubicBezTo>
                    <a:pt x="-1" y="3139"/>
                    <a:pt x="175" y="1552"/>
                    <a:pt x="524" y="-1"/>
                  </a:cubicBezTo>
                </a:path>
                <a:path stroke="0" w="21600" h="15825">
                  <a:moveTo>
                    <a:pt x="3066" y="15825"/>
                  </a:moveTo>
                  <a:cubicBezTo>
                    <a:pt x="1059" y="12472"/>
                    <a:pt x="0" y="8638"/>
                    <a:pt x="0" y="4731"/>
                  </a:cubicBezTo>
                  <a:cubicBezTo>
                    <a:pt x="-1" y="3139"/>
                    <a:pt x="175" y="1552"/>
                    <a:pt x="524" y="-1"/>
                  </a:cubicBezTo>
                  <a:lnTo>
                    <a:pt x="21600" y="4731"/>
                  </a:lnTo>
                  <a:lnTo>
                    <a:pt x="3066" y="1582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Arc 278"/>
            <p:cNvSpPr/>
            <p:nvPr/>
          </p:nvSpPr>
          <p:spPr>
            <a:xfrm>
              <a:off x="7335720" y="2760840"/>
              <a:ext cx="735120" cy="536400"/>
            </a:xfrm>
            <a:custGeom>
              <a:avLst/>
              <a:gdLst>
                <a:gd name="textAreaLeft" fmla="*/ 0 w 735120"/>
                <a:gd name="textAreaRight" fmla="*/ 735480 w 735120"/>
                <a:gd name="textAreaTop" fmla="*/ 0 h 536400"/>
                <a:gd name="textAreaBottom" fmla="*/ 536760 h 536400"/>
              </a:gdLst>
              <a:ahLst/>
              <a:rect l="textAreaLeft" t="textAreaTop" r="textAreaRight" b="textAreaBottom"/>
              <a:pathLst>
                <a:path fill="none" w="21600" h="15820">
                  <a:moveTo>
                    <a:pt x="3067" y="15819"/>
                  </a:moveTo>
                  <a:cubicBezTo>
                    <a:pt x="1060" y="12467"/>
                    <a:pt x="0" y="8632"/>
                    <a:pt x="0" y="4725"/>
                  </a:cubicBezTo>
                  <a:cubicBezTo>
                    <a:pt x="-1" y="3135"/>
                    <a:pt x="175" y="1550"/>
                    <a:pt x="523" y="0"/>
                  </a:cubicBezTo>
                </a:path>
                <a:path stroke="0" w="21600" h="15820">
                  <a:moveTo>
                    <a:pt x="3067" y="15819"/>
                  </a:moveTo>
                  <a:cubicBezTo>
                    <a:pt x="1060" y="12467"/>
                    <a:pt x="0" y="8632"/>
                    <a:pt x="0" y="4725"/>
                  </a:cubicBezTo>
                  <a:cubicBezTo>
                    <a:pt x="-1" y="3135"/>
                    <a:pt x="175" y="1550"/>
                    <a:pt x="523" y="0"/>
                  </a:cubicBezTo>
                  <a:lnTo>
                    <a:pt x="21600" y="4725"/>
                  </a:lnTo>
                  <a:lnTo>
                    <a:pt x="3067" y="1581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279"/>
            <p:cNvSpPr/>
            <p:nvPr/>
          </p:nvSpPr>
          <p:spPr>
            <a:xfrm flipH="1" flipV="1">
              <a:off x="7292880" y="2746440"/>
              <a:ext cx="61920" cy="14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280"/>
            <p:cNvSpPr/>
            <p:nvPr/>
          </p:nvSpPr>
          <p:spPr>
            <a:xfrm>
              <a:off x="7364520" y="3286080"/>
              <a:ext cx="96840" cy="7164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57" h="42">
                  <a:moveTo>
                    <a:pt x="44" y="7"/>
                  </a:moveTo>
                  <a:lnTo>
                    <a:pt x="57" y="0"/>
                  </a:lnTo>
                  <a:lnTo>
                    <a:pt x="44" y="42"/>
                  </a:lnTo>
                  <a:lnTo>
                    <a:pt x="0" y="34"/>
                  </a:lnTo>
                  <a:lnTo>
                    <a:pt x="13" y="2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281"/>
            <p:cNvSpPr/>
            <p:nvPr/>
          </p:nvSpPr>
          <p:spPr>
            <a:xfrm flipV="1">
              <a:off x="7147080" y="3072960"/>
              <a:ext cx="141120" cy="270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282"/>
            <p:cNvSpPr/>
            <p:nvPr/>
          </p:nvSpPr>
          <p:spPr>
            <a:xfrm>
              <a:off x="7024680" y="301140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K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283"/>
            <p:cNvSpPr/>
            <p:nvPr/>
          </p:nvSpPr>
          <p:spPr>
            <a:xfrm>
              <a:off x="7300800" y="2347920"/>
              <a:ext cx="270000" cy="401760"/>
            </a:xfrm>
            <a:custGeom>
              <a:avLst/>
              <a:gdLst>
                <a:gd name="textAreaLeft" fmla="*/ 0 w 270000"/>
                <a:gd name="textAreaRight" fmla="*/ 270360 w 270000"/>
                <a:gd name="textAreaTop" fmla="*/ 0 h 401760"/>
                <a:gd name="textAreaBottom" fmla="*/ 402120 h 401760"/>
              </a:gdLst>
              <a:ahLst/>
              <a:rect l="textAreaLeft" t="textAreaTop" r="textAreaRight" b="textAreaBottom"/>
              <a:pathLst>
                <a:path w="170" h="253">
                  <a:moveTo>
                    <a:pt x="170" y="49"/>
                  </a:moveTo>
                  <a:lnTo>
                    <a:pt x="167" y="3"/>
                  </a:lnTo>
                  <a:lnTo>
                    <a:pt x="118" y="0"/>
                  </a:lnTo>
                  <a:lnTo>
                    <a:pt x="130" y="10"/>
                  </a:lnTo>
                  <a:lnTo>
                    <a:pt x="100" y="44"/>
                  </a:lnTo>
                  <a:lnTo>
                    <a:pt x="73" y="79"/>
                  </a:lnTo>
                  <a:lnTo>
                    <a:pt x="49" y="118"/>
                  </a:lnTo>
                  <a:lnTo>
                    <a:pt x="29" y="159"/>
                  </a:lnTo>
                  <a:lnTo>
                    <a:pt x="12" y="200"/>
                  </a:lnTo>
                  <a:lnTo>
                    <a:pt x="0" y="243"/>
                  </a:lnTo>
                  <a:lnTo>
                    <a:pt x="38" y="253"/>
                  </a:lnTo>
                  <a:lnTo>
                    <a:pt x="49" y="213"/>
                  </a:lnTo>
                  <a:lnTo>
                    <a:pt x="64" y="175"/>
                  </a:lnTo>
                  <a:lnTo>
                    <a:pt x="84" y="138"/>
                  </a:lnTo>
                  <a:lnTo>
                    <a:pt x="105" y="103"/>
                  </a:lnTo>
                  <a:lnTo>
                    <a:pt x="130" y="69"/>
                  </a:lnTo>
                  <a:lnTo>
                    <a:pt x="158" y="38"/>
                  </a:lnTo>
                  <a:lnTo>
                    <a:pt x="170" y="49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Arc 284"/>
            <p:cNvSpPr/>
            <p:nvPr/>
          </p:nvSpPr>
          <p:spPr>
            <a:xfrm>
              <a:off x="7299360" y="2362320"/>
              <a:ext cx="771480" cy="558720"/>
            </a:xfrm>
            <a:custGeom>
              <a:avLst/>
              <a:gdLst>
                <a:gd name="textAreaLeft" fmla="*/ 0 w 771480"/>
                <a:gd name="textAreaRight" fmla="*/ 771840 w 771480"/>
                <a:gd name="textAreaTop" fmla="*/ 0 h 558720"/>
                <a:gd name="textAreaBottom" fmla="*/ 559080 h 558720"/>
              </a:gdLst>
              <a:ahLst/>
              <a:rect l="textAreaLeft" t="textAreaTop" r="textAreaRight" b="textAreaBottom"/>
              <a:pathLst>
                <a:path fill="none" w="20988" h="15187">
                  <a:moveTo>
                    <a:pt x="0" y="10081"/>
                  </a:moveTo>
                  <a:cubicBezTo>
                    <a:pt x="926" y="6272"/>
                    <a:pt x="2872" y="2787"/>
                    <a:pt x="5628" y="0"/>
                  </a:cubicBezTo>
                </a:path>
                <a:path stroke="0" w="20988" h="15187">
                  <a:moveTo>
                    <a:pt x="0" y="10081"/>
                  </a:moveTo>
                  <a:cubicBezTo>
                    <a:pt x="926" y="6272"/>
                    <a:pt x="2872" y="2787"/>
                    <a:pt x="5628" y="0"/>
                  </a:cubicBezTo>
                  <a:lnTo>
                    <a:pt x="20988" y="15187"/>
                  </a:lnTo>
                  <a:lnTo>
                    <a:pt x="0" y="1008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Arc 285"/>
            <p:cNvSpPr/>
            <p:nvPr/>
          </p:nvSpPr>
          <p:spPr>
            <a:xfrm>
              <a:off x="7359480" y="2408400"/>
              <a:ext cx="711360" cy="512640"/>
            </a:xfrm>
            <a:custGeom>
              <a:avLst/>
              <a:gdLst>
                <a:gd name="textAreaLeft" fmla="*/ 0 w 711360"/>
                <a:gd name="textAreaRight" fmla="*/ 711720 w 711360"/>
                <a:gd name="textAreaTop" fmla="*/ 0 h 512640"/>
                <a:gd name="textAreaBottom" fmla="*/ 513000 h 512640"/>
              </a:gdLst>
              <a:ahLst/>
              <a:rect l="textAreaLeft" t="textAreaTop" r="textAreaRight" b="textAreaBottom"/>
              <a:pathLst>
                <a:path fill="none" w="20995" h="15188">
                  <a:moveTo>
                    <a:pt x="0" y="10110"/>
                  </a:moveTo>
                  <a:cubicBezTo>
                    <a:pt x="924" y="6290"/>
                    <a:pt x="2872" y="2794"/>
                    <a:pt x="5636" y="0"/>
                  </a:cubicBezTo>
                </a:path>
                <a:path stroke="0" w="20995" h="15188">
                  <a:moveTo>
                    <a:pt x="0" y="10110"/>
                  </a:moveTo>
                  <a:cubicBezTo>
                    <a:pt x="924" y="6290"/>
                    <a:pt x="2872" y="2794"/>
                    <a:pt x="5636" y="0"/>
                  </a:cubicBezTo>
                  <a:lnTo>
                    <a:pt x="20995" y="15188"/>
                  </a:lnTo>
                  <a:lnTo>
                    <a:pt x="0" y="1011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286"/>
            <p:cNvSpPr/>
            <p:nvPr/>
          </p:nvSpPr>
          <p:spPr>
            <a:xfrm flipH="1" flipV="1">
              <a:off x="7300800" y="2733840"/>
              <a:ext cx="6048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287"/>
            <p:cNvSpPr/>
            <p:nvPr/>
          </p:nvSpPr>
          <p:spPr>
            <a:xfrm>
              <a:off x="7488360" y="2347920"/>
              <a:ext cx="82440" cy="77760"/>
            </a:xfrm>
            <a:custGeom>
              <a:avLst/>
              <a:gdLst>
                <a:gd name="textAreaLeft" fmla="*/ 0 w 82440"/>
                <a:gd name="textAreaRight" fmla="*/ 82800 w 82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48" h="46">
                  <a:moveTo>
                    <a:pt x="37" y="36"/>
                  </a:moveTo>
                  <a:lnTo>
                    <a:pt x="48" y="46"/>
                  </a:lnTo>
                  <a:lnTo>
                    <a:pt x="46" y="3"/>
                  </a:lnTo>
                  <a:lnTo>
                    <a:pt x="0" y="0"/>
                  </a:lnTo>
                  <a:lnTo>
                    <a:pt x="11" y="1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288"/>
            <p:cNvSpPr/>
            <p:nvPr/>
          </p:nvSpPr>
          <p:spPr>
            <a:xfrm>
              <a:off x="7243920" y="2430360"/>
              <a:ext cx="147600" cy="828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289"/>
            <p:cNvSpPr/>
            <p:nvPr/>
          </p:nvSpPr>
          <p:spPr>
            <a:xfrm>
              <a:off x="7084440" y="23414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290"/>
            <p:cNvSpPr/>
            <p:nvPr/>
          </p:nvSpPr>
          <p:spPr>
            <a:xfrm>
              <a:off x="8091360" y="2114640"/>
              <a:ext cx="109800" cy="71280"/>
            </a:xfrm>
            <a:custGeom>
              <a:avLst/>
              <a:gdLst>
                <a:gd name="textAreaLeft" fmla="*/ 0 w 109800"/>
                <a:gd name="textAreaRight" fmla="*/ 110160 w 1098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69" h="45">
                  <a:moveTo>
                    <a:pt x="69" y="6"/>
                  </a:moveTo>
                  <a:lnTo>
                    <a:pt x="24" y="1"/>
                  </a:lnTo>
                  <a:lnTo>
                    <a:pt x="1" y="0"/>
                  </a:lnTo>
                  <a:lnTo>
                    <a:pt x="0" y="39"/>
                  </a:lnTo>
                  <a:lnTo>
                    <a:pt x="42" y="43"/>
                  </a:lnTo>
                  <a:lnTo>
                    <a:pt x="63" y="45"/>
                  </a:lnTo>
                  <a:lnTo>
                    <a:pt x="69" y="6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Arc 291"/>
            <p:cNvSpPr/>
            <p:nvPr/>
          </p:nvSpPr>
          <p:spPr>
            <a:xfrm>
              <a:off x="8072280" y="2116080"/>
              <a:ext cx="128880" cy="804960"/>
            </a:xfrm>
            <a:custGeom>
              <a:avLst/>
              <a:gdLst>
                <a:gd name="textAreaLeft" fmla="*/ 0 w 128880"/>
                <a:gd name="textAreaRight" fmla="*/ 129240 w 128880"/>
                <a:gd name="textAreaTop" fmla="*/ 0 h 804960"/>
                <a:gd name="textAreaBottom" fmla="*/ 805320 h 804960"/>
              </a:gdLst>
              <a:ahLst/>
              <a:rect l="textAreaLeft" t="textAreaTop" r="textAreaRight" b="textAreaBottom"/>
              <a:pathLst>
                <a:path fill="none" w="3434" h="21593">
                  <a:moveTo>
                    <a:pt x="550" y="0"/>
                  </a:moveTo>
                  <a:cubicBezTo>
                    <a:pt x="1516" y="24"/>
                    <a:pt x="2480" y="114"/>
                    <a:pt x="3434" y="267"/>
                  </a:cubicBezTo>
                </a:path>
                <a:path stroke="0" w="3434" h="21593">
                  <a:moveTo>
                    <a:pt x="550" y="0"/>
                  </a:moveTo>
                  <a:cubicBezTo>
                    <a:pt x="1516" y="24"/>
                    <a:pt x="2480" y="114"/>
                    <a:pt x="3434" y="267"/>
                  </a:cubicBezTo>
                  <a:lnTo>
                    <a:pt x="0" y="21593"/>
                  </a:lnTo>
                  <a:lnTo>
                    <a:pt x="550" y="0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Arc 292"/>
            <p:cNvSpPr/>
            <p:nvPr/>
          </p:nvSpPr>
          <p:spPr>
            <a:xfrm>
              <a:off x="8072280" y="2178000"/>
              <a:ext cx="119160" cy="743040"/>
            </a:xfrm>
            <a:custGeom>
              <a:avLst/>
              <a:gdLst>
                <a:gd name="textAreaLeft" fmla="*/ 0 w 119160"/>
                <a:gd name="textAreaRight" fmla="*/ 119520 w 11916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3454" h="21593">
                  <a:moveTo>
                    <a:pt x="551" y="0"/>
                  </a:moveTo>
                  <a:cubicBezTo>
                    <a:pt x="1524" y="24"/>
                    <a:pt x="2493" y="115"/>
                    <a:pt x="3454" y="270"/>
                  </a:cubicBezTo>
                </a:path>
                <a:path stroke="0" w="3454" h="21593">
                  <a:moveTo>
                    <a:pt x="551" y="0"/>
                  </a:moveTo>
                  <a:cubicBezTo>
                    <a:pt x="1524" y="24"/>
                    <a:pt x="2493" y="115"/>
                    <a:pt x="3454" y="270"/>
                  </a:cubicBezTo>
                  <a:lnTo>
                    <a:pt x="0" y="21593"/>
                  </a:lnTo>
                  <a:lnTo>
                    <a:pt x="551" y="0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293"/>
            <p:cNvSpPr/>
            <p:nvPr/>
          </p:nvSpPr>
          <p:spPr>
            <a:xfrm flipV="1">
              <a:off x="8191440" y="2124000"/>
              <a:ext cx="9720" cy="61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294"/>
            <p:cNvSpPr/>
            <p:nvPr/>
          </p:nvSpPr>
          <p:spPr>
            <a:xfrm flipV="1">
              <a:off x="8091360" y="2114640"/>
              <a:ext cx="1800" cy="61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295"/>
            <p:cNvSpPr/>
            <p:nvPr/>
          </p:nvSpPr>
          <p:spPr>
            <a:xfrm flipH="1">
              <a:off x="8150400" y="1989000"/>
              <a:ext cx="93600" cy="1288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296"/>
            <p:cNvSpPr/>
            <p:nvPr/>
          </p:nvSpPr>
          <p:spPr>
            <a:xfrm>
              <a:off x="8236800" y="18446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297"/>
            <p:cNvSpPr/>
            <p:nvPr/>
          </p:nvSpPr>
          <p:spPr>
            <a:xfrm>
              <a:off x="8199360" y="2136600"/>
              <a:ext cx="101520" cy="810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64" h="51">
                  <a:moveTo>
                    <a:pt x="64" y="12"/>
                  </a:moveTo>
                  <a:lnTo>
                    <a:pt x="20" y="2"/>
                  </a:lnTo>
                  <a:lnTo>
                    <a:pt x="6" y="0"/>
                  </a:lnTo>
                  <a:lnTo>
                    <a:pt x="0" y="38"/>
                  </a:lnTo>
                  <a:lnTo>
                    <a:pt x="41" y="47"/>
                  </a:lnTo>
                  <a:lnTo>
                    <a:pt x="54" y="51"/>
                  </a:lnTo>
                  <a:lnTo>
                    <a:pt x="64" y="1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Arc 298"/>
            <p:cNvSpPr/>
            <p:nvPr/>
          </p:nvSpPr>
          <p:spPr>
            <a:xfrm>
              <a:off x="8070840" y="2136600"/>
              <a:ext cx="230040" cy="784440"/>
            </a:xfrm>
            <a:custGeom>
              <a:avLst/>
              <a:gdLst>
                <a:gd name="textAreaLeft" fmla="*/ 0 w 230040"/>
                <a:gd name="textAreaRight" fmla="*/ 230400 w 230040"/>
                <a:gd name="textAreaTop" fmla="*/ 0 h 784440"/>
                <a:gd name="textAreaBottom" fmla="*/ 784800 h 784440"/>
              </a:gdLst>
              <a:ahLst/>
              <a:rect l="textAreaLeft" t="textAreaTop" r="textAreaRight" b="textAreaBottom"/>
              <a:pathLst>
                <a:path fill="none" w="6222" h="21273">
                  <a:moveTo>
                    <a:pt x="3745" y="0"/>
                  </a:moveTo>
                  <a:cubicBezTo>
                    <a:pt x="4582" y="147"/>
                    <a:pt x="5409" y="343"/>
                    <a:pt x="6222" y="588"/>
                  </a:cubicBezTo>
                </a:path>
                <a:path stroke="0" w="6222" h="21273">
                  <a:moveTo>
                    <a:pt x="3745" y="0"/>
                  </a:moveTo>
                  <a:cubicBezTo>
                    <a:pt x="4582" y="147"/>
                    <a:pt x="5409" y="343"/>
                    <a:pt x="6222" y="588"/>
                  </a:cubicBezTo>
                  <a:lnTo>
                    <a:pt x="0" y="21273"/>
                  </a:lnTo>
                  <a:lnTo>
                    <a:pt x="374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Arc 299"/>
            <p:cNvSpPr/>
            <p:nvPr/>
          </p:nvSpPr>
          <p:spPr>
            <a:xfrm>
              <a:off x="8070840" y="2198520"/>
              <a:ext cx="214200" cy="72252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722520"/>
                <a:gd name="textAreaBottom" fmla="*/ 722880 h 722520"/>
              </a:gdLst>
              <a:ahLst/>
              <a:rect l="textAreaLeft" t="textAreaTop" r="textAreaRight" b="textAreaBottom"/>
              <a:pathLst>
                <a:path fill="none" w="6290" h="21268">
                  <a:moveTo>
                    <a:pt x="3773" y="0"/>
                  </a:moveTo>
                  <a:cubicBezTo>
                    <a:pt x="4623" y="151"/>
                    <a:pt x="5464" y="352"/>
                    <a:pt x="6289" y="604"/>
                  </a:cubicBezTo>
                </a:path>
                <a:path stroke="0" w="6290" h="21268">
                  <a:moveTo>
                    <a:pt x="3773" y="0"/>
                  </a:moveTo>
                  <a:cubicBezTo>
                    <a:pt x="4623" y="151"/>
                    <a:pt x="5464" y="352"/>
                    <a:pt x="6289" y="604"/>
                  </a:cubicBezTo>
                  <a:lnTo>
                    <a:pt x="0" y="21268"/>
                  </a:lnTo>
                  <a:lnTo>
                    <a:pt x="377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300"/>
            <p:cNvSpPr/>
            <p:nvPr/>
          </p:nvSpPr>
          <p:spPr>
            <a:xfrm flipV="1">
              <a:off x="8285040" y="2155680"/>
              <a:ext cx="1584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301"/>
            <p:cNvSpPr/>
            <p:nvPr/>
          </p:nvSpPr>
          <p:spPr>
            <a:xfrm flipV="1">
              <a:off x="8199360" y="2136600"/>
              <a:ext cx="972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302"/>
            <p:cNvSpPr/>
            <p:nvPr/>
          </p:nvSpPr>
          <p:spPr>
            <a:xfrm flipH="1">
              <a:off x="8254800" y="2095560"/>
              <a:ext cx="60120" cy="493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303"/>
            <p:cNvSpPr/>
            <p:nvPr/>
          </p:nvSpPr>
          <p:spPr>
            <a:xfrm>
              <a:off x="8329320" y="198900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304"/>
            <p:cNvSpPr/>
            <p:nvPr/>
          </p:nvSpPr>
          <p:spPr>
            <a:xfrm>
              <a:off x="7415280" y="3341520"/>
              <a:ext cx="144360" cy="154080"/>
            </a:xfrm>
            <a:custGeom>
              <a:avLst/>
              <a:gdLst>
                <a:gd name="textAreaLeft" fmla="*/ 0 w 144360"/>
                <a:gd name="textAreaRight" fmla="*/ 144720 w 144360"/>
                <a:gd name="textAreaTop" fmla="*/ 0 h 154080"/>
                <a:gd name="textAreaBottom" fmla="*/ 154440 h 154080"/>
              </a:gdLst>
              <a:ahLst/>
              <a:rect l="textAreaLeft" t="textAreaTop" r="textAreaRight" b="textAreaBottom"/>
              <a:pathLst>
                <a:path w="91" h="97">
                  <a:moveTo>
                    <a:pt x="0" y="22"/>
                  </a:moveTo>
                  <a:lnTo>
                    <a:pt x="27" y="58"/>
                  </a:lnTo>
                  <a:lnTo>
                    <a:pt x="57" y="92"/>
                  </a:lnTo>
                  <a:lnTo>
                    <a:pt x="63" y="97"/>
                  </a:lnTo>
                  <a:lnTo>
                    <a:pt x="91" y="70"/>
                  </a:lnTo>
                  <a:lnTo>
                    <a:pt x="62" y="38"/>
                  </a:lnTo>
                  <a:lnTo>
                    <a:pt x="36" y="6"/>
                  </a:lnTo>
                  <a:lnTo>
                    <a:pt x="32" y="0"/>
                  </a:lnTo>
                  <a:lnTo>
                    <a:pt x="0" y="2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Arc 305"/>
            <p:cNvSpPr/>
            <p:nvPr/>
          </p:nvSpPr>
          <p:spPr>
            <a:xfrm>
              <a:off x="7416720" y="2921040"/>
              <a:ext cx="654120" cy="573120"/>
            </a:xfrm>
            <a:custGeom>
              <a:avLst/>
              <a:gdLst>
                <a:gd name="textAreaLeft" fmla="*/ 0 w 654120"/>
                <a:gd name="textAreaRight" fmla="*/ 654480 w 654120"/>
                <a:gd name="textAreaTop" fmla="*/ 0 h 573120"/>
                <a:gd name="textAreaBottom" fmla="*/ 573480 h 573120"/>
              </a:gdLst>
              <a:ahLst/>
              <a:rect l="textAreaLeft" t="textAreaTop" r="textAreaRight" b="textAreaBottom"/>
              <a:pathLst>
                <a:path fill="none" w="17738" h="15529">
                  <a:moveTo>
                    <a:pt x="2724" y="15528"/>
                  </a:moveTo>
                  <a:cubicBezTo>
                    <a:pt x="1714" y="14552"/>
                    <a:pt x="801" y="13479"/>
                    <a:pt x="0" y="12325"/>
                  </a:cubicBezTo>
                </a:path>
                <a:path stroke="0" w="17738" h="15529">
                  <a:moveTo>
                    <a:pt x="2724" y="15528"/>
                  </a:moveTo>
                  <a:cubicBezTo>
                    <a:pt x="1714" y="14552"/>
                    <a:pt x="801" y="13479"/>
                    <a:pt x="0" y="12325"/>
                  </a:cubicBezTo>
                  <a:lnTo>
                    <a:pt x="17738" y="0"/>
                  </a:lnTo>
                  <a:lnTo>
                    <a:pt x="2724" y="1552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Arc 306"/>
            <p:cNvSpPr/>
            <p:nvPr/>
          </p:nvSpPr>
          <p:spPr>
            <a:xfrm>
              <a:off x="7467480" y="2921040"/>
              <a:ext cx="603360" cy="528480"/>
            </a:xfrm>
            <a:custGeom>
              <a:avLst/>
              <a:gdLst>
                <a:gd name="textAreaLeft" fmla="*/ 0 w 603360"/>
                <a:gd name="textAreaRight" fmla="*/ 603720 w 603360"/>
                <a:gd name="textAreaTop" fmla="*/ 0 h 528480"/>
                <a:gd name="textAreaBottom" fmla="*/ 528840 h 528480"/>
              </a:gdLst>
              <a:ahLst/>
              <a:rect l="textAreaLeft" t="textAreaTop" r="textAreaRight" b="textAreaBottom"/>
              <a:pathLst>
                <a:path fill="none" w="17726" h="15581">
                  <a:moveTo>
                    <a:pt x="2766" y="15580"/>
                  </a:moveTo>
                  <a:cubicBezTo>
                    <a:pt x="1739" y="14595"/>
                    <a:pt x="813" y="13510"/>
                    <a:pt x="0" y="12342"/>
                  </a:cubicBezTo>
                </a:path>
                <a:path stroke="0" w="17726" h="15581">
                  <a:moveTo>
                    <a:pt x="2766" y="15580"/>
                  </a:moveTo>
                  <a:cubicBezTo>
                    <a:pt x="1739" y="14595"/>
                    <a:pt x="813" y="13510"/>
                    <a:pt x="0" y="12342"/>
                  </a:cubicBezTo>
                  <a:lnTo>
                    <a:pt x="17726" y="0"/>
                  </a:lnTo>
                  <a:lnTo>
                    <a:pt x="2766" y="1558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307"/>
            <p:cNvSpPr/>
            <p:nvPr/>
          </p:nvSpPr>
          <p:spPr>
            <a:xfrm flipH="1">
              <a:off x="7414920" y="3341520"/>
              <a:ext cx="5076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308"/>
            <p:cNvSpPr/>
            <p:nvPr/>
          </p:nvSpPr>
          <p:spPr>
            <a:xfrm flipH="1">
              <a:off x="7515000" y="3452760"/>
              <a:ext cx="4428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309"/>
            <p:cNvSpPr/>
            <p:nvPr/>
          </p:nvSpPr>
          <p:spPr>
            <a:xfrm flipV="1">
              <a:off x="7388280" y="3438360"/>
              <a:ext cx="73080" cy="446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310"/>
            <p:cNvSpPr/>
            <p:nvPr/>
          </p:nvSpPr>
          <p:spPr>
            <a:xfrm>
              <a:off x="7304400" y="347976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Freeform 311"/>
            <p:cNvSpPr/>
            <p:nvPr/>
          </p:nvSpPr>
          <p:spPr>
            <a:xfrm>
              <a:off x="7516800" y="3452760"/>
              <a:ext cx="530280" cy="292320"/>
            </a:xfrm>
            <a:custGeom>
              <a:avLst/>
              <a:gdLst>
                <a:gd name="textAreaLeft" fmla="*/ 0 w 530280"/>
                <a:gd name="textAreaRight" fmla="*/ 530640 w 530280"/>
                <a:gd name="textAreaTop" fmla="*/ 0 h 292320"/>
                <a:gd name="textAreaBottom" fmla="*/ 292680 h 292320"/>
              </a:gdLst>
              <a:ahLst/>
              <a:rect l="textAreaLeft" t="textAreaTop" r="textAreaRight" b="textAreaBottom"/>
              <a:pathLst>
                <a:path w="334" h="184">
                  <a:moveTo>
                    <a:pt x="0" y="29"/>
                  </a:moveTo>
                  <a:lnTo>
                    <a:pt x="34" y="59"/>
                  </a:lnTo>
                  <a:lnTo>
                    <a:pt x="70" y="85"/>
                  </a:lnTo>
                  <a:lnTo>
                    <a:pt x="109" y="109"/>
                  </a:lnTo>
                  <a:lnTo>
                    <a:pt x="148" y="128"/>
                  </a:lnTo>
                  <a:lnTo>
                    <a:pt x="190" y="146"/>
                  </a:lnTo>
                  <a:lnTo>
                    <a:pt x="234" y="157"/>
                  </a:lnTo>
                  <a:lnTo>
                    <a:pt x="278" y="166"/>
                  </a:lnTo>
                  <a:lnTo>
                    <a:pt x="301" y="168"/>
                  </a:lnTo>
                  <a:lnTo>
                    <a:pt x="299" y="184"/>
                  </a:lnTo>
                  <a:lnTo>
                    <a:pt x="334" y="151"/>
                  </a:lnTo>
                  <a:lnTo>
                    <a:pt x="306" y="113"/>
                  </a:lnTo>
                  <a:lnTo>
                    <a:pt x="305" y="128"/>
                  </a:lnTo>
                  <a:lnTo>
                    <a:pt x="263" y="123"/>
                  </a:lnTo>
                  <a:lnTo>
                    <a:pt x="224" y="113"/>
                  </a:lnTo>
                  <a:lnTo>
                    <a:pt x="184" y="100"/>
                  </a:lnTo>
                  <a:lnTo>
                    <a:pt x="146" y="83"/>
                  </a:lnTo>
                  <a:lnTo>
                    <a:pt x="110" y="64"/>
                  </a:lnTo>
                  <a:lnTo>
                    <a:pt x="75" y="40"/>
                  </a:lnTo>
                  <a:lnTo>
                    <a:pt x="42" y="15"/>
                  </a:lnTo>
                  <a:lnTo>
                    <a:pt x="28" y="0"/>
                  </a:lnTo>
                  <a:lnTo>
                    <a:pt x="0" y="29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Arc 312"/>
            <p:cNvSpPr/>
            <p:nvPr/>
          </p:nvSpPr>
          <p:spPr>
            <a:xfrm>
              <a:off x="7520040" y="2921040"/>
              <a:ext cx="550800" cy="793800"/>
            </a:xfrm>
            <a:custGeom>
              <a:avLst/>
              <a:gdLst>
                <a:gd name="textAreaLeft" fmla="*/ 0 w 550800"/>
                <a:gd name="textAreaRight" fmla="*/ 551160 w 550800"/>
                <a:gd name="textAreaTop" fmla="*/ 0 h 793800"/>
                <a:gd name="textAreaBottom" fmla="*/ 794160 h 793800"/>
              </a:gdLst>
              <a:ahLst/>
              <a:rect l="textAreaLeft" t="textAreaTop" r="textAreaRight" b="textAreaBottom"/>
              <a:pathLst>
                <a:path fill="none" w="14949" h="21502">
                  <a:moveTo>
                    <a:pt x="12896" y="21502"/>
                  </a:moveTo>
                  <a:cubicBezTo>
                    <a:pt x="8055" y="21040"/>
                    <a:pt x="3510" y="18957"/>
                    <a:pt x="-1" y="15591"/>
                  </a:cubicBezTo>
                </a:path>
                <a:path stroke="0" w="14949" h="21502">
                  <a:moveTo>
                    <a:pt x="12896" y="21502"/>
                  </a:moveTo>
                  <a:cubicBezTo>
                    <a:pt x="8055" y="21040"/>
                    <a:pt x="3510" y="18957"/>
                    <a:pt x="-1" y="15591"/>
                  </a:cubicBezTo>
                  <a:lnTo>
                    <a:pt x="14949" y="0"/>
                  </a:lnTo>
                  <a:lnTo>
                    <a:pt x="12896" y="2150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Arc 313"/>
            <p:cNvSpPr/>
            <p:nvPr/>
          </p:nvSpPr>
          <p:spPr>
            <a:xfrm>
              <a:off x="7562880" y="2921040"/>
              <a:ext cx="507960" cy="730080"/>
            </a:xfrm>
            <a:custGeom>
              <a:avLst/>
              <a:gdLst>
                <a:gd name="textAreaLeft" fmla="*/ 0 w 507960"/>
                <a:gd name="textAreaRight" fmla="*/ 508320 w 507960"/>
                <a:gd name="textAreaTop" fmla="*/ 0 h 730080"/>
                <a:gd name="textAreaBottom" fmla="*/ 730440 h 730080"/>
              </a:gdLst>
              <a:ahLst/>
              <a:rect l="textAreaLeft" t="textAreaTop" r="textAreaRight" b="textAreaBottom"/>
              <a:pathLst>
                <a:path fill="none" w="14936" h="21503">
                  <a:moveTo>
                    <a:pt x="12894" y="21503"/>
                  </a:moveTo>
                  <a:cubicBezTo>
                    <a:pt x="8055" y="21043"/>
                    <a:pt x="3512" y="18965"/>
                    <a:pt x="0" y="15603"/>
                  </a:cubicBezTo>
                </a:path>
                <a:path stroke="0" w="14936" h="21503">
                  <a:moveTo>
                    <a:pt x="12894" y="21503"/>
                  </a:moveTo>
                  <a:cubicBezTo>
                    <a:pt x="8055" y="21043"/>
                    <a:pt x="3512" y="18965"/>
                    <a:pt x="0" y="15603"/>
                  </a:cubicBezTo>
                  <a:lnTo>
                    <a:pt x="14936" y="0"/>
                  </a:lnTo>
                  <a:lnTo>
                    <a:pt x="12894" y="2150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314"/>
            <p:cNvSpPr/>
            <p:nvPr/>
          </p:nvSpPr>
          <p:spPr>
            <a:xfrm flipH="1">
              <a:off x="7516800" y="3452760"/>
              <a:ext cx="44640" cy="46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315"/>
            <p:cNvSpPr/>
            <p:nvPr/>
          </p:nvSpPr>
          <p:spPr>
            <a:xfrm>
              <a:off x="7991640" y="3632040"/>
              <a:ext cx="55440" cy="11304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13040"/>
                <a:gd name="textAreaBottom" fmla="*/ 113400 h 113040"/>
              </a:gdLst>
              <a:ahLst/>
              <a:rect l="textAreaLeft" t="textAreaTop" r="textAreaRight" b="textAreaBottom"/>
              <a:pathLst>
                <a:path w="33" h="66">
                  <a:moveTo>
                    <a:pt x="6" y="14"/>
                  </a:moveTo>
                  <a:lnTo>
                    <a:pt x="7" y="0"/>
                  </a:lnTo>
                  <a:lnTo>
                    <a:pt x="33" y="35"/>
                  </a:lnTo>
                  <a:lnTo>
                    <a:pt x="0" y="66"/>
                  </a:lnTo>
                  <a:lnTo>
                    <a:pt x="2" y="5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316"/>
            <p:cNvSpPr/>
            <p:nvPr/>
          </p:nvSpPr>
          <p:spPr>
            <a:xfrm flipV="1">
              <a:off x="7556400" y="3660840"/>
              <a:ext cx="204840" cy="252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317"/>
            <p:cNvSpPr/>
            <p:nvPr/>
          </p:nvSpPr>
          <p:spPr>
            <a:xfrm>
              <a:off x="7287840" y="368136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4" name="Group 321"/>
          <p:cNvGrpSpPr/>
          <p:nvPr/>
        </p:nvGrpSpPr>
        <p:grpSpPr>
          <a:xfrm>
            <a:off x="3600360" y="703440"/>
            <a:ext cx="2526480" cy="1788840"/>
            <a:chOff x="3600360" y="703440"/>
            <a:chExt cx="2526480" cy="1788840"/>
          </a:xfrm>
        </p:grpSpPr>
        <p:sp>
          <p:nvSpPr>
            <p:cNvPr id="245" name="AutoShape 320"/>
            <p:cNvSpPr/>
            <p:nvPr/>
          </p:nvSpPr>
          <p:spPr>
            <a:xfrm>
              <a:off x="3600360" y="703440"/>
              <a:ext cx="2484360" cy="178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Freeform 322"/>
            <p:cNvSpPr/>
            <p:nvPr/>
          </p:nvSpPr>
          <p:spPr>
            <a:xfrm>
              <a:off x="3936960" y="923760"/>
              <a:ext cx="1527120" cy="1528920"/>
            </a:xfrm>
            <a:custGeom>
              <a:avLst/>
              <a:gdLst>
                <a:gd name="textAreaLeft" fmla="*/ 0 w 1527120"/>
                <a:gd name="textAreaRight" fmla="*/ 1527480 w 1527120"/>
                <a:gd name="textAreaTop" fmla="*/ 0 h 1528920"/>
                <a:gd name="textAreaBottom" fmla="*/ 1529280 h 1528920"/>
              </a:gdLst>
              <a:ahLst/>
              <a:rect l="textAreaLeft" t="textAreaTop" r="textAreaRight" b="textAreaBottom"/>
              <a:pathLst>
                <a:path w="962" h="963">
                  <a:moveTo>
                    <a:pt x="485" y="0"/>
                  </a:moveTo>
                  <a:lnTo>
                    <a:pt x="442" y="1"/>
                  </a:lnTo>
                  <a:lnTo>
                    <a:pt x="399" y="7"/>
                  </a:lnTo>
                  <a:lnTo>
                    <a:pt x="357" y="17"/>
                  </a:lnTo>
                  <a:lnTo>
                    <a:pt x="316" y="30"/>
                  </a:lnTo>
                  <a:lnTo>
                    <a:pt x="276" y="45"/>
                  </a:lnTo>
                  <a:lnTo>
                    <a:pt x="238" y="65"/>
                  </a:lnTo>
                  <a:lnTo>
                    <a:pt x="202" y="89"/>
                  </a:lnTo>
                  <a:lnTo>
                    <a:pt x="168" y="115"/>
                  </a:lnTo>
                  <a:lnTo>
                    <a:pt x="137" y="145"/>
                  </a:lnTo>
                  <a:lnTo>
                    <a:pt x="109" y="177"/>
                  </a:lnTo>
                  <a:lnTo>
                    <a:pt x="82" y="212"/>
                  </a:lnTo>
                  <a:lnTo>
                    <a:pt x="61" y="249"/>
                  </a:lnTo>
                  <a:lnTo>
                    <a:pt x="41" y="287"/>
                  </a:lnTo>
                  <a:lnTo>
                    <a:pt x="25" y="327"/>
                  </a:lnTo>
                  <a:lnTo>
                    <a:pt x="14" y="369"/>
                  </a:lnTo>
                  <a:lnTo>
                    <a:pt x="5" y="411"/>
                  </a:lnTo>
                  <a:lnTo>
                    <a:pt x="2" y="454"/>
                  </a:lnTo>
                  <a:lnTo>
                    <a:pt x="0" y="497"/>
                  </a:lnTo>
                  <a:lnTo>
                    <a:pt x="4" y="540"/>
                  </a:lnTo>
                  <a:lnTo>
                    <a:pt x="11" y="583"/>
                  </a:lnTo>
                  <a:lnTo>
                    <a:pt x="22" y="624"/>
                  </a:lnTo>
                  <a:lnTo>
                    <a:pt x="36" y="665"/>
                  </a:lnTo>
                  <a:lnTo>
                    <a:pt x="55" y="703"/>
                  </a:lnTo>
                  <a:lnTo>
                    <a:pt x="76" y="741"/>
                  </a:lnTo>
                  <a:lnTo>
                    <a:pt x="101" y="775"/>
                  </a:lnTo>
                  <a:lnTo>
                    <a:pt x="129" y="808"/>
                  </a:lnTo>
                  <a:lnTo>
                    <a:pt x="160" y="838"/>
                  </a:lnTo>
                  <a:lnTo>
                    <a:pt x="193" y="865"/>
                  </a:lnTo>
                  <a:lnTo>
                    <a:pt x="228" y="890"/>
                  </a:lnTo>
                  <a:lnTo>
                    <a:pt x="265" y="912"/>
                  </a:lnTo>
                  <a:lnTo>
                    <a:pt x="304" y="928"/>
                  </a:lnTo>
                  <a:lnTo>
                    <a:pt x="346" y="943"/>
                  </a:lnTo>
                  <a:lnTo>
                    <a:pt x="388" y="953"/>
                  </a:lnTo>
                  <a:lnTo>
                    <a:pt x="429" y="959"/>
                  </a:lnTo>
                  <a:lnTo>
                    <a:pt x="473" y="963"/>
                  </a:lnTo>
                  <a:lnTo>
                    <a:pt x="516" y="962"/>
                  </a:lnTo>
                  <a:lnTo>
                    <a:pt x="558" y="956"/>
                  </a:lnTo>
                  <a:lnTo>
                    <a:pt x="600" y="947"/>
                  </a:lnTo>
                  <a:lnTo>
                    <a:pt x="642" y="934"/>
                  </a:lnTo>
                  <a:lnTo>
                    <a:pt x="681" y="919"/>
                  </a:lnTo>
                  <a:lnTo>
                    <a:pt x="720" y="899"/>
                  </a:lnTo>
                  <a:lnTo>
                    <a:pt x="756" y="876"/>
                  </a:lnTo>
                  <a:lnTo>
                    <a:pt x="790" y="850"/>
                  </a:lnTo>
                  <a:lnTo>
                    <a:pt x="822" y="821"/>
                  </a:lnTo>
                  <a:lnTo>
                    <a:pt x="850" y="789"/>
                  </a:lnTo>
                  <a:lnTo>
                    <a:pt x="877" y="755"/>
                  </a:lnTo>
                  <a:lnTo>
                    <a:pt x="899" y="718"/>
                  </a:lnTo>
                  <a:lnTo>
                    <a:pt x="919" y="680"/>
                  </a:lnTo>
                  <a:lnTo>
                    <a:pt x="935" y="641"/>
                  </a:lnTo>
                  <a:lnTo>
                    <a:pt x="947" y="599"/>
                  </a:lnTo>
                  <a:lnTo>
                    <a:pt x="956" y="556"/>
                  </a:lnTo>
                  <a:lnTo>
                    <a:pt x="961" y="514"/>
                  </a:lnTo>
                  <a:lnTo>
                    <a:pt x="962" y="471"/>
                  </a:lnTo>
                  <a:lnTo>
                    <a:pt x="959" y="428"/>
                  </a:lnTo>
                  <a:lnTo>
                    <a:pt x="953" y="385"/>
                  </a:lnTo>
                  <a:lnTo>
                    <a:pt x="942" y="344"/>
                  </a:lnTo>
                  <a:lnTo>
                    <a:pt x="928" y="303"/>
                  </a:lnTo>
                  <a:lnTo>
                    <a:pt x="910" y="264"/>
                  </a:lnTo>
                  <a:lnTo>
                    <a:pt x="888" y="226"/>
                  </a:lnTo>
                  <a:lnTo>
                    <a:pt x="865" y="191"/>
                  </a:lnTo>
                  <a:lnTo>
                    <a:pt x="837" y="158"/>
                  </a:lnTo>
                  <a:lnTo>
                    <a:pt x="807" y="127"/>
                  </a:lnTo>
                  <a:lnTo>
                    <a:pt x="775" y="100"/>
                  </a:lnTo>
                  <a:lnTo>
                    <a:pt x="739" y="75"/>
                  </a:lnTo>
                  <a:lnTo>
                    <a:pt x="702" y="54"/>
                  </a:lnTo>
                  <a:lnTo>
                    <a:pt x="663" y="36"/>
                  </a:lnTo>
                  <a:lnTo>
                    <a:pt x="623" y="21"/>
                  </a:lnTo>
                  <a:lnTo>
                    <a:pt x="581" y="11"/>
                  </a:lnTo>
                  <a:lnTo>
                    <a:pt x="538" y="4"/>
                  </a:lnTo>
                  <a:lnTo>
                    <a:pt x="496" y="0"/>
                  </a:lnTo>
                  <a:lnTo>
                    <a:pt x="486" y="0"/>
                  </a:lnTo>
                  <a:lnTo>
                    <a:pt x="486" y="11"/>
                  </a:lnTo>
                  <a:lnTo>
                    <a:pt x="528" y="12"/>
                  </a:lnTo>
                  <a:lnTo>
                    <a:pt x="569" y="18"/>
                  </a:lnTo>
                  <a:lnTo>
                    <a:pt x="610" y="29"/>
                  </a:lnTo>
                  <a:lnTo>
                    <a:pt x="650" y="42"/>
                  </a:lnTo>
                  <a:lnTo>
                    <a:pt x="689" y="58"/>
                  </a:lnTo>
                  <a:lnTo>
                    <a:pt x="726" y="79"/>
                  </a:lnTo>
                  <a:lnTo>
                    <a:pt x="760" y="102"/>
                  </a:lnTo>
                  <a:lnTo>
                    <a:pt x="794" y="128"/>
                  </a:lnTo>
                  <a:lnTo>
                    <a:pt x="823" y="158"/>
                  </a:lnTo>
                  <a:lnTo>
                    <a:pt x="850" y="189"/>
                  </a:lnTo>
                  <a:lnTo>
                    <a:pt x="875" y="224"/>
                  </a:lnTo>
                  <a:lnTo>
                    <a:pt x="897" y="260"/>
                  </a:lnTo>
                  <a:lnTo>
                    <a:pt x="915" y="298"/>
                  </a:lnTo>
                  <a:lnTo>
                    <a:pt x="929" y="338"/>
                  </a:lnTo>
                  <a:lnTo>
                    <a:pt x="941" y="378"/>
                  </a:lnTo>
                  <a:lnTo>
                    <a:pt x="948" y="420"/>
                  </a:lnTo>
                  <a:lnTo>
                    <a:pt x="951" y="461"/>
                  </a:lnTo>
                  <a:lnTo>
                    <a:pt x="951" y="504"/>
                  </a:lnTo>
                  <a:lnTo>
                    <a:pt x="947" y="546"/>
                  </a:lnTo>
                  <a:lnTo>
                    <a:pt x="940" y="587"/>
                  </a:lnTo>
                  <a:lnTo>
                    <a:pt x="929" y="628"/>
                  </a:lnTo>
                  <a:lnTo>
                    <a:pt x="913" y="667"/>
                  </a:lnTo>
                  <a:lnTo>
                    <a:pt x="896" y="705"/>
                  </a:lnTo>
                  <a:lnTo>
                    <a:pt x="873" y="742"/>
                  </a:lnTo>
                  <a:lnTo>
                    <a:pt x="848" y="775"/>
                  </a:lnTo>
                  <a:lnTo>
                    <a:pt x="821" y="807"/>
                  </a:lnTo>
                  <a:lnTo>
                    <a:pt x="791" y="836"/>
                  </a:lnTo>
                  <a:lnTo>
                    <a:pt x="758" y="862"/>
                  </a:lnTo>
                  <a:lnTo>
                    <a:pt x="722" y="886"/>
                  </a:lnTo>
                  <a:lnTo>
                    <a:pt x="685" y="906"/>
                  </a:lnTo>
                  <a:lnTo>
                    <a:pt x="646" y="923"/>
                  </a:lnTo>
                  <a:lnTo>
                    <a:pt x="607" y="936"/>
                  </a:lnTo>
                  <a:lnTo>
                    <a:pt x="566" y="945"/>
                  </a:lnTo>
                  <a:lnTo>
                    <a:pt x="524" y="950"/>
                  </a:lnTo>
                  <a:lnTo>
                    <a:pt x="482" y="952"/>
                  </a:lnTo>
                  <a:lnTo>
                    <a:pt x="440" y="951"/>
                  </a:lnTo>
                  <a:lnTo>
                    <a:pt x="398" y="945"/>
                  </a:lnTo>
                  <a:lnTo>
                    <a:pt x="358" y="936"/>
                  </a:lnTo>
                  <a:lnTo>
                    <a:pt x="317" y="923"/>
                  </a:lnTo>
                  <a:lnTo>
                    <a:pt x="278" y="906"/>
                  </a:lnTo>
                  <a:lnTo>
                    <a:pt x="241" y="887"/>
                  </a:lnTo>
                  <a:lnTo>
                    <a:pt x="206" y="863"/>
                  </a:lnTo>
                  <a:lnTo>
                    <a:pt x="174" y="837"/>
                  </a:lnTo>
                  <a:lnTo>
                    <a:pt x="143" y="808"/>
                  </a:lnTo>
                  <a:lnTo>
                    <a:pt x="114" y="776"/>
                  </a:lnTo>
                  <a:lnTo>
                    <a:pt x="90" y="743"/>
                  </a:lnTo>
                  <a:lnTo>
                    <a:pt x="68" y="707"/>
                  </a:lnTo>
                  <a:lnTo>
                    <a:pt x="49" y="669"/>
                  </a:lnTo>
                  <a:lnTo>
                    <a:pt x="35" y="630"/>
                  </a:lnTo>
                  <a:lnTo>
                    <a:pt x="23" y="590"/>
                  </a:lnTo>
                  <a:lnTo>
                    <a:pt x="16" y="548"/>
                  </a:lnTo>
                  <a:lnTo>
                    <a:pt x="11" y="505"/>
                  </a:lnTo>
                  <a:lnTo>
                    <a:pt x="11" y="464"/>
                  </a:lnTo>
                  <a:lnTo>
                    <a:pt x="15" y="422"/>
                  </a:lnTo>
                  <a:lnTo>
                    <a:pt x="22" y="380"/>
                  </a:lnTo>
                  <a:lnTo>
                    <a:pt x="33" y="340"/>
                  </a:lnTo>
                  <a:lnTo>
                    <a:pt x="47" y="300"/>
                  </a:lnTo>
                  <a:lnTo>
                    <a:pt x="65" y="262"/>
                  </a:lnTo>
                  <a:lnTo>
                    <a:pt x="86" y="226"/>
                  </a:lnTo>
                  <a:lnTo>
                    <a:pt x="111" y="191"/>
                  </a:lnTo>
                  <a:lnTo>
                    <a:pt x="138" y="159"/>
                  </a:lnTo>
                  <a:lnTo>
                    <a:pt x="168" y="130"/>
                  </a:lnTo>
                  <a:lnTo>
                    <a:pt x="200" y="103"/>
                  </a:lnTo>
                  <a:lnTo>
                    <a:pt x="236" y="80"/>
                  </a:lnTo>
                  <a:lnTo>
                    <a:pt x="272" y="60"/>
                  </a:lnTo>
                  <a:lnTo>
                    <a:pt x="310" y="42"/>
                  </a:lnTo>
                  <a:lnTo>
                    <a:pt x="351" y="29"/>
                  </a:lnTo>
                  <a:lnTo>
                    <a:pt x="391" y="19"/>
                  </a:lnTo>
                  <a:lnTo>
                    <a:pt x="433" y="13"/>
                  </a:lnTo>
                  <a:lnTo>
                    <a:pt x="475" y="10"/>
                  </a:lnTo>
                  <a:lnTo>
                    <a:pt x="485" y="11"/>
                  </a:lnTo>
                  <a:lnTo>
                    <a:pt x="485" y="0"/>
                  </a:lnTo>
                  <a:close/>
                </a:path>
              </a:pathLst>
            </a:cu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Oval 323"/>
            <p:cNvSpPr/>
            <p:nvPr/>
          </p:nvSpPr>
          <p:spPr>
            <a:xfrm>
              <a:off x="3936960" y="923760"/>
              <a:ext cx="1519200" cy="151956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Oval 324"/>
            <p:cNvSpPr/>
            <p:nvPr/>
          </p:nvSpPr>
          <p:spPr>
            <a:xfrm>
              <a:off x="3954600" y="941400"/>
              <a:ext cx="1485720" cy="148572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325"/>
            <p:cNvSpPr/>
            <p:nvPr/>
          </p:nvSpPr>
          <p:spPr>
            <a:xfrm flipV="1">
              <a:off x="4707000" y="923400"/>
              <a:ext cx="1440" cy="17640"/>
            </a:xfrm>
            <a:prstGeom prst="line">
              <a:avLst/>
            </a:prstGeom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326"/>
            <p:cNvSpPr/>
            <p:nvPr/>
          </p:nvSpPr>
          <p:spPr>
            <a:xfrm>
              <a:off x="4429800" y="1566720"/>
              <a:ext cx="62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DONR PGI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327"/>
            <p:cNvSpPr/>
            <p:nvPr/>
          </p:nvSpPr>
          <p:spPr>
            <a:xfrm>
              <a:off x="4601880" y="171612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3918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328"/>
            <p:cNvSpPr/>
            <p:nvPr/>
          </p:nvSpPr>
          <p:spPr>
            <a:xfrm>
              <a:off x="5010120" y="971640"/>
              <a:ext cx="406440" cy="419040"/>
            </a:xfrm>
            <a:custGeom>
              <a:avLst/>
              <a:gdLst>
                <a:gd name="textAreaLeft" fmla="*/ 0 w 406440"/>
                <a:gd name="textAreaRight" fmla="*/ 406800 w 406440"/>
                <a:gd name="textAreaTop" fmla="*/ 0 h 419040"/>
                <a:gd name="textAreaBottom" fmla="*/ 419400 h 419040"/>
              </a:gdLst>
              <a:ahLst/>
              <a:rect l="textAreaLeft" t="textAreaTop" r="textAreaRight" b="textAreaBottom"/>
              <a:pathLst>
                <a:path w="256" h="264">
                  <a:moveTo>
                    <a:pt x="256" y="247"/>
                  </a:moveTo>
                  <a:lnTo>
                    <a:pt x="236" y="208"/>
                  </a:lnTo>
                  <a:lnTo>
                    <a:pt x="214" y="170"/>
                  </a:lnTo>
                  <a:lnTo>
                    <a:pt x="186" y="135"/>
                  </a:lnTo>
                  <a:lnTo>
                    <a:pt x="157" y="102"/>
                  </a:lnTo>
                  <a:lnTo>
                    <a:pt x="125" y="72"/>
                  </a:lnTo>
                  <a:lnTo>
                    <a:pt x="89" y="45"/>
                  </a:lnTo>
                  <a:lnTo>
                    <a:pt x="52" y="21"/>
                  </a:lnTo>
                  <a:lnTo>
                    <a:pt x="37" y="14"/>
                  </a:lnTo>
                  <a:lnTo>
                    <a:pt x="45" y="0"/>
                  </a:lnTo>
                  <a:lnTo>
                    <a:pt x="0" y="16"/>
                  </a:lnTo>
                  <a:lnTo>
                    <a:pt x="12" y="62"/>
                  </a:lnTo>
                  <a:lnTo>
                    <a:pt x="19" y="49"/>
                  </a:lnTo>
                  <a:lnTo>
                    <a:pt x="55" y="69"/>
                  </a:lnTo>
                  <a:lnTo>
                    <a:pt x="87" y="93"/>
                  </a:lnTo>
                  <a:lnTo>
                    <a:pt x="118" y="119"/>
                  </a:lnTo>
                  <a:lnTo>
                    <a:pt x="146" y="148"/>
                  </a:lnTo>
                  <a:lnTo>
                    <a:pt x="172" y="180"/>
                  </a:lnTo>
                  <a:lnTo>
                    <a:pt x="195" y="214"/>
                  </a:lnTo>
                  <a:lnTo>
                    <a:pt x="215" y="249"/>
                  </a:lnTo>
                  <a:lnTo>
                    <a:pt x="221" y="264"/>
                  </a:lnTo>
                  <a:lnTo>
                    <a:pt x="256" y="247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Arc 329"/>
            <p:cNvSpPr/>
            <p:nvPr/>
          </p:nvSpPr>
          <p:spPr>
            <a:xfrm>
              <a:off x="4697280" y="995400"/>
              <a:ext cx="714600" cy="689040"/>
            </a:xfrm>
            <a:custGeom>
              <a:avLst/>
              <a:gdLst>
                <a:gd name="textAreaLeft" fmla="*/ 0 w 714600"/>
                <a:gd name="textAreaRight" fmla="*/ 714960 w 714600"/>
                <a:gd name="textAreaTop" fmla="*/ 0 h 689040"/>
                <a:gd name="textAreaBottom" fmla="*/ 689400 h 689040"/>
              </a:gdLst>
              <a:ahLst/>
              <a:rect l="textAreaLeft" t="textAreaTop" r="textAreaRight" b="textAreaBottom"/>
              <a:pathLst>
                <a:path fill="none" w="19728" h="19022">
                  <a:moveTo>
                    <a:pt x="10233" y="-1"/>
                  </a:moveTo>
                  <a:cubicBezTo>
                    <a:pt x="14442" y="2264"/>
                    <a:pt x="17781" y="5860"/>
                    <a:pt x="19727" y="10225"/>
                  </a:cubicBezTo>
                </a:path>
                <a:path stroke="0" w="19728" h="19022">
                  <a:moveTo>
                    <a:pt x="10233" y="-1"/>
                  </a:moveTo>
                  <a:cubicBezTo>
                    <a:pt x="14442" y="2264"/>
                    <a:pt x="17781" y="5860"/>
                    <a:pt x="19727" y="10225"/>
                  </a:cubicBezTo>
                  <a:lnTo>
                    <a:pt x="0" y="19022"/>
                  </a:lnTo>
                  <a:lnTo>
                    <a:pt x="10233" y="-1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Arc 330"/>
            <p:cNvSpPr/>
            <p:nvPr/>
          </p:nvSpPr>
          <p:spPr>
            <a:xfrm>
              <a:off x="4697280" y="1050840"/>
              <a:ext cx="658800" cy="633600"/>
            </a:xfrm>
            <a:custGeom>
              <a:avLst/>
              <a:gdLst>
                <a:gd name="textAreaLeft" fmla="*/ 0 w 658800"/>
                <a:gd name="textAreaRight" fmla="*/ 659160 w 658800"/>
                <a:gd name="textAreaTop" fmla="*/ 0 h 633600"/>
                <a:gd name="textAreaBottom" fmla="*/ 633960 h 633600"/>
              </a:gdLst>
              <a:ahLst/>
              <a:rect l="textAreaLeft" t="textAreaTop" r="textAreaRight" b="textAreaBottom"/>
              <a:pathLst>
                <a:path fill="none" w="19756" h="19001">
                  <a:moveTo>
                    <a:pt x="10272" y="-1"/>
                  </a:moveTo>
                  <a:cubicBezTo>
                    <a:pt x="14483" y="2276"/>
                    <a:pt x="17819" y="5888"/>
                    <a:pt x="19755" y="10267"/>
                  </a:cubicBezTo>
                </a:path>
                <a:path stroke="0" w="19756" h="19001">
                  <a:moveTo>
                    <a:pt x="10272" y="-1"/>
                  </a:moveTo>
                  <a:cubicBezTo>
                    <a:pt x="14483" y="2276"/>
                    <a:pt x="17819" y="5888"/>
                    <a:pt x="19755" y="10267"/>
                  </a:cubicBezTo>
                  <a:lnTo>
                    <a:pt x="0" y="19001"/>
                  </a:lnTo>
                  <a:lnTo>
                    <a:pt x="10272" y="-1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331"/>
            <p:cNvSpPr/>
            <p:nvPr/>
          </p:nvSpPr>
          <p:spPr>
            <a:xfrm flipV="1">
              <a:off x="5361120" y="1363320"/>
              <a:ext cx="55440" cy="2700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Freeform 332"/>
            <p:cNvSpPr/>
            <p:nvPr/>
          </p:nvSpPr>
          <p:spPr>
            <a:xfrm>
              <a:off x="5010120" y="971640"/>
              <a:ext cx="71640" cy="982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38" h="52">
                  <a:moveTo>
                    <a:pt x="16" y="41"/>
                  </a:moveTo>
                  <a:lnTo>
                    <a:pt x="10" y="52"/>
                  </a:lnTo>
                  <a:lnTo>
                    <a:pt x="0" y="14"/>
                  </a:lnTo>
                  <a:lnTo>
                    <a:pt x="38" y="0"/>
                  </a:lnTo>
                  <a:lnTo>
                    <a:pt x="31" y="12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333"/>
            <p:cNvSpPr/>
            <p:nvPr/>
          </p:nvSpPr>
          <p:spPr>
            <a:xfrm flipH="1">
              <a:off x="5254200" y="1073160"/>
              <a:ext cx="127080" cy="5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334"/>
            <p:cNvSpPr/>
            <p:nvPr/>
          </p:nvSpPr>
          <p:spPr>
            <a:xfrm>
              <a:off x="5369760" y="985680"/>
              <a:ext cx="277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Zeo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335"/>
            <p:cNvSpPr/>
            <p:nvPr/>
          </p:nvSpPr>
          <p:spPr>
            <a:xfrm>
              <a:off x="3914640" y="879480"/>
              <a:ext cx="770040" cy="1320840"/>
            </a:xfrm>
            <a:custGeom>
              <a:avLst/>
              <a:gdLst>
                <a:gd name="textAreaLeft" fmla="*/ 0 w 770040"/>
                <a:gd name="textAreaRight" fmla="*/ 770400 w 770040"/>
                <a:gd name="textAreaTop" fmla="*/ 0 h 1320840"/>
                <a:gd name="textAreaBottom" fmla="*/ 1321200 h 1320840"/>
              </a:gdLst>
              <a:ahLst/>
              <a:rect l="textAreaLeft" t="textAreaTop" r="textAreaRight" b="textAreaBottom"/>
              <a:pathLst>
                <a:path w="485" h="832">
                  <a:moveTo>
                    <a:pt x="456" y="71"/>
                  </a:moveTo>
                  <a:lnTo>
                    <a:pt x="485" y="33"/>
                  </a:lnTo>
                  <a:lnTo>
                    <a:pt x="450" y="0"/>
                  </a:lnTo>
                  <a:lnTo>
                    <a:pt x="451" y="16"/>
                  </a:lnTo>
                  <a:lnTo>
                    <a:pt x="407" y="21"/>
                  </a:lnTo>
                  <a:lnTo>
                    <a:pt x="364" y="32"/>
                  </a:lnTo>
                  <a:lnTo>
                    <a:pt x="322" y="45"/>
                  </a:lnTo>
                  <a:lnTo>
                    <a:pt x="282" y="63"/>
                  </a:lnTo>
                  <a:lnTo>
                    <a:pt x="242" y="83"/>
                  </a:lnTo>
                  <a:lnTo>
                    <a:pt x="206" y="108"/>
                  </a:lnTo>
                  <a:lnTo>
                    <a:pt x="170" y="135"/>
                  </a:lnTo>
                  <a:lnTo>
                    <a:pt x="138" y="166"/>
                  </a:lnTo>
                  <a:lnTo>
                    <a:pt x="109" y="199"/>
                  </a:lnTo>
                  <a:lnTo>
                    <a:pt x="83" y="235"/>
                  </a:lnTo>
                  <a:lnTo>
                    <a:pt x="60" y="273"/>
                  </a:lnTo>
                  <a:lnTo>
                    <a:pt x="41" y="312"/>
                  </a:lnTo>
                  <a:lnTo>
                    <a:pt x="25" y="354"/>
                  </a:lnTo>
                  <a:lnTo>
                    <a:pt x="13" y="397"/>
                  </a:lnTo>
                  <a:lnTo>
                    <a:pt x="5" y="441"/>
                  </a:lnTo>
                  <a:lnTo>
                    <a:pt x="0" y="485"/>
                  </a:lnTo>
                  <a:lnTo>
                    <a:pt x="0" y="529"/>
                  </a:lnTo>
                  <a:lnTo>
                    <a:pt x="4" y="573"/>
                  </a:lnTo>
                  <a:lnTo>
                    <a:pt x="12" y="616"/>
                  </a:lnTo>
                  <a:lnTo>
                    <a:pt x="23" y="659"/>
                  </a:lnTo>
                  <a:lnTo>
                    <a:pt x="38" y="701"/>
                  </a:lnTo>
                  <a:lnTo>
                    <a:pt x="57" y="741"/>
                  </a:lnTo>
                  <a:lnTo>
                    <a:pt x="80" y="779"/>
                  </a:lnTo>
                  <a:lnTo>
                    <a:pt x="106" y="815"/>
                  </a:lnTo>
                  <a:lnTo>
                    <a:pt x="120" y="832"/>
                  </a:lnTo>
                  <a:lnTo>
                    <a:pt x="150" y="807"/>
                  </a:lnTo>
                  <a:lnTo>
                    <a:pt x="124" y="775"/>
                  </a:lnTo>
                  <a:lnTo>
                    <a:pt x="102" y="740"/>
                  </a:lnTo>
                  <a:lnTo>
                    <a:pt x="83" y="704"/>
                  </a:lnTo>
                  <a:lnTo>
                    <a:pt x="67" y="666"/>
                  </a:lnTo>
                  <a:lnTo>
                    <a:pt x="55" y="627"/>
                  </a:lnTo>
                  <a:lnTo>
                    <a:pt x="47" y="588"/>
                  </a:lnTo>
                  <a:lnTo>
                    <a:pt x="41" y="548"/>
                  </a:lnTo>
                  <a:lnTo>
                    <a:pt x="39" y="507"/>
                  </a:lnTo>
                  <a:lnTo>
                    <a:pt x="42" y="466"/>
                  </a:lnTo>
                  <a:lnTo>
                    <a:pt x="47" y="425"/>
                  </a:lnTo>
                  <a:lnTo>
                    <a:pt x="56" y="386"/>
                  </a:lnTo>
                  <a:lnTo>
                    <a:pt x="69" y="347"/>
                  </a:lnTo>
                  <a:lnTo>
                    <a:pt x="86" y="310"/>
                  </a:lnTo>
                  <a:lnTo>
                    <a:pt x="105" y="273"/>
                  </a:lnTo>
                  <a:lnTo>
                    <a:pt x="127" y="240"/>
                  </a:lnTo>
                  <a:lnTo>
                    <a:pt x="152" y="208"/>
                  </a:lnTo>
                  <a:lnTo>
                    <a:pt x="181" y="178"/>
                  </a:lnTo>
                  <a:lnTo>
                    <a:pt x="212" y="152"/>
                  </a:lnTo>
                  <a:lnTo>
                    <a:pt x="245" y="128"/>
                  </a:lnTo>
                  <a:lnTo>
                    <a:pt x="280" y="107"/>
                  </a:lnTo>
                  <a:lnTo>
                    <a:pt x="317" y="89"/>
                  </a:lnTo>
                  <a:lnTo>
                    <a:pt x="355" y="74"/>
                  </a:lnTo>
                  <a:lnTo>
                    <a:pt x="394" y="64"/>
                  </a:lnTo>
                  <a:lnTo>
                    <a:pt x="435" y="57"/>
                  </a:lnTo>
                  <a:lnTo>
                    <a:pt x="455" y="54"/>
                  </a:lnTo>
                  <a:lnTo>
                    <a:pt x="456" y="71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Arc 336"/>
            <p:cNvSpPr/>
            <p:nvPr/>
          </p:nvSpPr>
          <p:spPr>
            <a:xfrm>
              <a:off x="3914640" y="905040"/>
              <a:ext cx="782640" cy="1293480"/>
            </a:xfrm>
            <a:custGeom>
              <a:avLst/>
              <a:gdLst>
                <a:gd name="textAreaLeft" fmla="*/ 0 w 782640"/>
                <a:gd name="textAreaRight" fmla="*/ 783000 w 782640"/>
                <a:gd name="textAreaTop" fmla="*/ 0 h 1293480"/>
                <a:gd name="textAreaBottom" fmla="*/ 1293840 h 1293480"/>
              </a:gdLst>
              <a:ahLst/>
              <a:rect l="textAreaLeft" t="textAreaTop" r="textAreaRight" b="textAreaBottom"/>
              <a:pathLst>
                <a:path fill="none" w="21600" h="35711">
                  <a:moveTo>
                    <a:pt x="5314" y="35711"/>
                  </a:moveTo>
                  <a:cubicBezTo>
                    <a:pt x="1887" y="31778"/>
                    <a:pt x="0" y="26737"/>
                    <a:pt x="0" y="21521"/>
                  </a:cubicBezTo>
                  <a:cubicBezTo>
                    <a:pt x="-1" y="10305"/>
                    <a:pt x="8584" y="955"/>
                    <a:pt x="19758" y="-1"/>
                  </a:cubicBezTo>
                </a:path>
                <a:path stroke="0" w="21600" h="35711">
                  <a:moveTo>
                    <a:pt x="5314" y="35711"/>
                  </a:moveTo>
                  <a:cubicBezTo>
                    <a:pt x="1887" y="31778"/>
                    <a:pt x="0" y="26737"/>
                    <a:pt x="0" y="21521"/>
                  </a:cubicBezTo>
                  <a:cubicBezTo>
                    <a:pt x="-1" y="10305"/>
                    <a:pt x="8584" y="955"/>
                    <a:pt x="19758" y="-1"/>
                  </a:cubicBezTo>
                  <a:lnTo>
                    <a:pt x="21600" y="21521"/>
                  </a:lnTo>
                  <a:lnTo>
                    <a:pt x="5314" y="3571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Arc 337"/>
            <p:cNvSpPr/>
            <p:nvPr/>
          </p:nvSpPr>
          <p:spPr>
            <a:xfrm>
              <a:off x="3976560" y="966960"/>
              <a:ext cx="720720" cy="1191960"/>
            </a:xfrm>
            <a:custGeom>
              <a:avLst/>
              <a:gdLst>
                <a:gd name="textAreaLeft" fmla="*/ 0 w 720720"/>
                <a:gd name="textAreaRight" fmla="*/ 721080 w 720720"/>
                <a:gd name="textAreaTop" fmla="*/ 0 h 1191960"/>
                <a:gd name="textAreaBottom" fmla="*/ 1192320 h 1191960"/>
              </a:gdLst>
              <a:ahLst/>
              <a:rect l="textAreaLeft" t="textAreaTop" r="textAreaRight" b="textAreaBottom"/>
              <a:pathLst>
                <a:path fill="none" w="21600" h="35735">
                  <a:moveTo>
                    <a:pt x="5333" y="35735"/>
                  </a:moveTo>
                  <a:cubicBezTo>
                    <a:pt x="1894" y="31799"/>
                    <a:pt x="0" y="26750"/>
                    <a:pt x="0" y="21524"/>
                  </a:cubicBezTo>
                  <a:cubicBezTo>
                    <a:pt x="-1" y="10295"/>
                    <a:pt x="8602" y="939"/>
                    <a:pt x="19791" y="-1"/>
                  </a:cubicBezTo>
                </a:path>
                <a:path stroke="0" w="21600" h="35735">
                  <a:moveTo>
                    <a:pt x="5333" y="35735"/>
                  </a:moveTo>
                  <a:cubicBezTo>
                    <a:pt x="1894" y="31799"/>
                    <a:pt x="0" y="26750"/>
                    <a:pt x="0" y="21524"/>
                  </a:cubicBezTo>
                  <a:cubicBezTo>
                    <a:pt x="-1" y="10295"/>
                    <a:pt x="8602" y="939"/>
                    <a:pt x="19791" y="-1"/>
                  </a:cubicBezTo>
                  <a:lnTo>
                    <a:pt x="21600" y="21524"/>
                  </a:lnTo>
                  <a:lnTo>
                    <a:pt x="5333" y="3573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338"/>
            <p:cNvSpPr/>
            <p:nvPr/>
          </p:nvSpPr>
          <p:spPr>
            <a:xfrm flipH="1">
              <a:off x="4105440" y="2160720"/>
              <a:ext cx="4752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Freeform 339"/>
            <p:cNvSpPr/>
            <p:nvPr/>
          </p:nvSpPr>
          <p:spPr>
            <a:xfrm>
              <a:off x="4629240" y="879480"/>
              <a:ext cx="55440" cy="1126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9" h="60">
                  <a:moveTo>
                    <a:pt x="4" y="46"/>
                  </a:moveTo>
                  <a:lnTo>
                    <a:pt x="5" y="60"/>
                  </a:lnTo>
                  <a:lnTo>
                    <a:pt x="29" y="28"/>
                  </a:lnTo>
                  <a:lnTo>
                    <a:pt x="0" y="0"/>
                  </a:lnTo>
                  <a:lnTo>
                    <a:pt x="1" y="1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340"/>
            <p:cNvSpPr/>
            <p:nvPr/>
          </p:nvSpPr>
          <p:spPr>
            <a:xfrm>
              <a:off x="3852720" y="1335240"/>
              <a:ext cx="13032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341"/>
            <p:cNvSpPr/>
            <p:nvPr/>
          </p:nvSpPr>
          <p:spPr>
            <a:xfrm>
              <a:off x="3611520" y="1235160"/>
              <a:ext cx="201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s-ES" sz="700" spc="-1" strike="noStrike">
                  <a:solidFill>
                    <a:srgbClr val="000000"/>
                  </a:solidFill>
                  <a:latin typeface="Arial"/>
                </a:rPr>
                <a:t>PGI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342"/>
            <p:cNvSpPr/>
            <p:nvPr/>
          </p:nvSpPr>
          <p:spPr>
            <a:xfrm>
              <a:off x="4127400" y="2182680"/>
              <a:ext cx="127080" cy="123840"/>
            </a:xfrm>
            <a:custGeom>
              <a:avLst/>
              <a:gdLst>
                <a:gd name="textAreaLeft" fmla="*/ 0 w 127080"/>
                <a:gd name="textAreaRight" fmla="*/ 127440 w 12708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80" h="78">
                  <a:moveTo>
                    <a:pt x="50" y="0"/>
                  </a:moveTo>
                  <a:lnTo>
                    <a:pt x="4" y="2"/>
                  </a:lnTo>
                  <a:lnTo>
                    <a:pt x="0" y="50"/>
                  </a:lnTo>
                  <a:lnTo>
                    <a:pt x="11" y="39"/>
                  </a:lnTo>
                  <a:lnTo>
                    <a:pt x="44" y="69"/>
                  </a:lnTo>
                  <a:lnTo>
                    <a:pt x="55" y="78"/>
                  </a:lnTo>
                  <a:lnTo>
                    <a:pt x="80" y="48"/>
                  </a:lnTo>
                  <a:lnTo>
                    <a:pt x="49" y="20"/>
                  </a:lnTo>
                  <a:lnTo>
                    <a:pt x="38" y="11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Arc 343"/>
            <p:cNvSpPr/>
            <p:nvPr/>
          </p:nvSpPr>
          <p:spPr>
            <a:xfrm>
              <a:off x="4148280" y="1684440"/>
              <a:ext cx="549000" cy="619200"/>
            </a:xfrm>
            <a:custGeom>
              <a:avLst/>
              <a:gdLst>
                <a:gd name="textAreaLeft" fmla="*/ 0 w 549000"/>
                <a:gd name="textAreaRight" fmla="*/ 549360 w 549000"/>
                <a:gd name="textAreaTop" fmla="*/ 0 h 619200"/>
                <a:gd name="textAreaBottom" fmla="*/ 619560 h 619200"/>
              </a:gdLst>
              <a:ahLst/>
              <a:rect l="textAreaLeft" t="textAreaTop" r="textAreaRight" b="textAreaBottom"/>
              <a:pathLst>
                <a:path fill="none" w="15164" h="17069">
                  <a:moveTo>
                    <a:pt x="1927" y="17068"/>
                  </a:moveTo>
                  <a:cubicBezTo>
                    <a:pt x="1251" y="16545"/>
                    <a:pt x="608" y="15981"/>
                    <a:pt x="-1" y="15382"/>
                  </a:cubicBezTo>
                </a:path>
                <a:path stroke="0" w="15164" h="17069">
                  <a:moveTo>
                    <a:pt x="1927" y="17068"/>
                  </a:moveTo>
                  <a:cubicBezTo>
                    <a:pt x="1251" y="16545"/>
                    <a:pt x="608" y="15981"/>
                    <a:pt x="-1" y="15382"/>
                  </a:cubicBezTo>
                  <a:lnTo>
                    <a:pt x="15164" y="0"/>
                  </a:lnTo>
                  <a:lnTo>
                    <a:pt x="1927" y="17068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Arc 344"/>
            <p:cNvSpPr/>
            <p:nvPr/>
          </p:nvSpPr>
          <p:spPr>
            <a:xfrm>
              <a:off x="4191120" y="1684440"/>
              <a:ext cx="506160" cy="569880"/>
            </a:xfrm>
            <a:custGeom>
              <a:avLst/>
              <a:gdLst>
                <a:gd name="textAreaLeft" fmla="*/ 0 w 506160"/>
                <a:gd name="textAreaRight" fmla="*/ 506520 w 506160"/>
                <a:gd name="textAreaTop" fmla="*/ 0 h 569880"/>
                <a:gd name="textAreaBottom" fmla="*/ 569880 h 569880"/>
              </a:gdLst>
              <a:ahLst/>
              <a:rect l="textAreaLeft" t="textAreaTop" r="textAreaRight" b="textAreaBottom"/>
              <a:pathLst>
                <a:path fill="none" w="15187" h="17101">
                  <a:moveTo>
                    <a:pt x="1991" y="17101"/>
                  </a:moveTo>
                  <a:cubicBezTo>
                    <a:pt x="1292" y="16561"/>
                    <a:pt x="627" y="15980"/>
                    <a:pt x="-1" y="15359"/>
                  </a:cubicBezTo>
                </a:path>
                <a:path stroke="0" w="15187" h="17101">
                  <a:moveTo>
                    <a:pt x="1991" y="17101"/>
                  </a:moveTo>
                  <a:cubicBezTo>
                    <a:pt x="1292" y="16561"/>
                    <a:pt x="627" y="15980"/>
                    <a:pt x="-1" y="15359"/>
                  </a:cubicBezTo>
                  <a:lnTo>
                    <a:pt x="15187" y="0"/>
                  </a:lnTo>
                  <a:lnTo>
                    <a:pt x="1991" y="1710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345"/>
            <p:cNvSpPr/>
            <p:nvPr/>
          </p:nvSpPr>
          <p:spPr>
            <a:xfrm flipH="1">
              <a:off x="4214880" y="2259000"/>
              <a:ext cx="39600" cy="4752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Freeform 346"/>
            <p:cNvSpPr/>
            <p:nvPr/>
          </p:nvSpPr>
          <p:spPr>
            <a:xfrm>
              <a:off x="4127400" y="2182680"/>
              <a:ext cx="79560" cy="7956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42" h="42">
                  <a:moveTo>
                    <a:pt x="32" y="9"/>
                  </a:moveTo>
                  <a:lnTo>
                    <a:pt x="42" y="0"/>
                  </a:lnTo>
                  <a:lnTo>
                    <a:pt x="3" y="2"/>
                  </a:lnTo>
                  <a:lnTo>
                    <a:pt x="0" y="42"/>
                  </a:lnTo>
                  <a:lnTo>
                    <a:pt x="9" y="33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347"/>
            <p:cNvSpPr/>
            <p:nvPr/>
          </p:nvSpPr>
          <p:spPr>
            <a:xfrm flipV="1">
              <a:off x="4040280" y="2259000"/>
              <a:ext cx="120600" cy="4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348"/>
            <p:cNvSpPr/>
            <p:nvPr/>
          </p:nvSpPr>
          <p:spPr>
            <a:xfrm>
              <a:off x="3862440" y="230364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349"/>
            <p:cNvSpPr/>
            <p:nvPr/>
          </p:nvSpPr>
          <p:spPr>
            <a:xfrm>
              <a:off x="4689360" y="876240"/>
              <a:ext cx="152640" cy="11448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96" h="72">
                  <a:moveTo>
                    <a:pt x="96" y="24"/>
                  </a:moveTo>
                  <a:lnTo>
                    <a:pt x="52" y="17"/>
                  </a:lnTo>
                  <a:lnTo>
                    <a:pt x="32" y="16"/>
                  </a:lnTo>
                  <a:lnTo>
                    <a:pt x="33" y="0"/>
                  </a:lnTo>
                  <a:lnTo>
                    <a:pt x="0" y="35"/>
                  </a:lnTo>
                  <a:lnTo>
                    <a:pt x="30" y="72"/>
                  </a:lnTo>
                  <a:lnTo>
                    <a:pt x="30" y="55"/>
                  </a:lnTo>
                  <a:lnTo>
                    <a:pt x="70" y="59"/>
                  </a:lnTo>
                  <a:lnTo>
                    <a:pt x="89" y="62"/>
                  </a:lnTo>
                  <a:lnTo>
                    <a:pt x="96" y="24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Arc 350"/>
            <p:cNvSpPr/>
            <p:nvPr/>
          </p:nvSpPr>
          <p:spPr>
            <a:xfrm>
              <a:off x="4697280" y="903240"/>
              <a:ext cx="144720" cy="781200"/>
            </a:xfrm>
            <a:custGeom>
              <a:avLst/>
              <a:gdLst>
                <a:gd name="textAreaLeft" fmla="*/ 0 w 144720"/>
                <a:gd name="textAreaRight" fmla="*/ 145080 w 144720"/>
                <a:gd name="textAreaTop" fmla="*/ 0 h 781200"/>
                <a:gd name="textAreaBottom" fmla="*/ 781560 h 781200"/>
              </a:gdLst>
              <a:ahLst/>
              <a:rect l="textAreaLeft" t="textAreaTop" r="textAreaRight" b="textAreaBottom"/>
              <a:pathLst>
                <a:path fill="none" w="3983" h="21568">
                  <a:moveTo>
                    <a:pt x="1180" y="0"/>
                  </a:moveTo>
                  <a:cubicBezTo>
                    <a:pt x="2121" y="51"/>
                    <a:pt x="3057" y="164"/>
                    <a:pt x="3982" y="338"/>
                  </a:cubicBezTo>
                </a:path>
                <a:path stroke="0" w="3983" h="21568">
                  <a:moveTo>
                    <a:pt x="1180" y="0"/>
                  </a:moveTo>
                  <a:cubicBezTo>
                    <a:pt x="2121" y="51"/>
                    <a:pt x="3057" y="164"/>
                    <a:pt x="3982" y="338"/>
                  </a:cubicBezTo>
                  <a:lnTo>
                    <a:pt x="0" y="21568"/>
                  </a:lnTo>
                  <a:lnTo>
                    <a:pt x="1180" y="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Arc 351"/>
            <p:cNvSpPr/>
            <p:nvPr/>
          </p:nvSpPr>
          <p:spPr>
            <a:xfrm>
              <a:off x="4697280" y="965160"/>
              <a:ext cx="133560" cy="719280"/>
            </a:xfrm>
            <a:custGeom>
              <a:avLst/>
              <a:gdLst>
                <a:gd name="textAreaLeft" fmla="*/ 0 w 133560"/>
                <a:gd name="textAreaRight" fmla="*/ 133920 w 133560"/>
                <a:gd name="textAreaTop" fmla="*/ 0 h 719280"/>
                <a:gd name="textAreaBottom" fmla="*/ 719640 h 719280"/>
              </a:gdLst>
              <a:ahLst/>
              <a:rect l="textAreaLeft" t="textAreaTop" r="textAreaRight" b="textAreaBottom"/>
              <a:pathLst>
                <a:path fill="none" w="3993" h="21567">
                  <a:moveTo>
                    <a:pt x="1189" y="-1"/>
                  </a:moveTo>
                  <a:cubicBezTo>
                    <a:pt x="2130" y="51"/>
                    <a:pt x="3066" y="165"/>
                    <a:pt x="3992" y="339"/>
                  </a:cubicBezTo>
                </a:path>
                <a:path stroke="0" w="3993" h="21567">
                  <a:moveTo>
                    <a:pt x="1189" y="-1"/>
                  </a:moveTo>
                  <a:cubicBezTo>
                    <a:pt x="2130" y="51"/>
                    <a:pt x="3066" y="165"/>
                    <a:pt x="3992" y="339"/>
                  </a:cubicBezTo>
                  <a:lnTo>
                    <a:pt x="0" y="21567"/>
                  </a:lnTo>
                  <a:lnTo>
                    <a:pt x="1189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352"/>
            <p:cNvSpPr/>
            <p:nvPr/>
          </p:nvSpPr>
          <p:spPr>
            <a:xfrm flipV="1">
              <a:off x="4830840" y="914400"/>
              <a:ext cx="11160" cy="6048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353"/>
            <p:cNvSpPr/>
            <p:nvPr/>
          </p:nvSpPr>
          <p:spPr>
            <a:xfrm>
              <a:off x="4689360" y="876240"/>
              <a:ext cx="52560" cy="114480"/>
            </a:xfrm>
            <a:custGeom>
              <a:avLst/>
              <a:gdLst>
                <a:gd name="textAreaLeft" fmla="*/ 0 w 52560"/>
                <a:gd name="textAreaRight" fmla="*/ 52920 w 5256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28" h="60">
                  <a:moveTo>
                    <a:pt x="25" y="46"/>
                  </a:moveTo>
                  <a:lnTo>
                    <a:pt x="25" y="60"/>
                  </a:lnTo>
                  <a:lnTo>
                    <a:pt x="0" y="29"/>
                  </a:lnTo>
                  <a:lnTo>
                    <a:pt x="28" y="0"/>
                  </a:lnTo>
                  <a:lnTo>
                    <a:pt x="27" y="13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354"/>
            <p:cNvSpPr/>
            <p:nvPr/>
          </p:nvSpPr>
          <p:spPr>
            <a:xfrm>
              <a:off x="4761000" y="809640"/>
              <a:ext cx="4680" cy="9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355"/>
            <p:cNvSpPr/>
            <p:nvPr/>
          </p:nvSpPr>
          <p:spPr>
            <a:xfrm>
              <a:off x="4757760" y="72216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Arc 356"/>
            <p:cNvSpPr/>
            <p:nvPr/>
          </p:nvSpPr>
          <p:spPr>
            <a:xfrm>
              <a:off x="4697280" y="1062000"/>
              <a:ext cx="141480" cy="622440"/>
            </a:xfrm>
            <a:custGeom>
              <a:avLst/>
              <a:gdLst>
                <a:gd name="textAreaLeft" fmla="*/ 0 w 141480"/>
                <a:gd name="textAreaRight" fmla="*/ 141840 w 141480"/>
                <a:gd name="textAreaTop" fmla="*/ 0 h 622440"/>
                <a:gd name="textAreaBottom" fmla="*/ 622800 h 622440"/>
              </a:gdLst>
              <a:ahLst/>
              <a:rect l="textAreaLeft" t="textAreaTop" r="textAreaRight" b="textAreaBottom"/>
              <a:pathLst>
                <a:path fill="none" w="4865" h="21389">
                  <a:moveTo>
                    <a:pt x="3009" y="-1"/>
                  </a:moveTo>
                  <a:cubicBezTo>
                    <a:pt x="3632" y="87"/>
                    <a:pt x="4251" y="202"/>
                    <a:pt x="4864" y="344"/>
                  </a:cubicBezTo>
                </a:path>
                <a:path stroke="0" w="4865" h="21389">
                  <a:moveTo>
                    <a:pt x="3009" y="-1"/>
                  </a:moveTo>
                  <a:cubicBezTo>
                    <a:pt x="3632" y="87"/>
                    <a:pt x="4251" y="202"/>
                    <a:pt x="4864" y="344"/>
                  </a:cubicBezTo>
                  <a:lnTo>
                    <a:pt x="0" y="21389"/>
                  </a:lnTo>
                  <a:lnTo>
                    <a:pt x="3009" y="-1"/>
                  </a:lnTo>
                  <a:close/>
                </a:path>
              </a:pathLst>
            </a:custGeom>
            <a:noFill/>
            <a:ln w="79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357"/>
            <p:cNvSpPr/>
            <p:nvPr/>
          </p:nvSpPr>
          <p:spPr>
            <a:xfrm flipH="1">
              <a:off x="4838400" y="1012680"/>
              <a:ext cx="12600" cy="59040"/>
            </a:xfrm>
            <a:prstGeom prst="line">
              <a:avLst/>
            </a:prstGeom>
            <a:ln w="792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358"/>
            <p:cNvSpPr/>
            <p:nvPr/>
          </p:nvSpPr>
          <p:spPr>
            <a:xfrm>
              <a:off x="4784760" y="1044720"/>
              <a:ext cx="30240" cy="42840"/>
            </a:xfrm>
            <a:custGeom>
              <a:avLst/>
              <a:gdLst>
                <a:gd name="textAreaLeft" fmla="*/ 0 w 30240"/>
                <a:gd name="textAreaRight" fmla="*/ 30600 w 30240"/>
                <a:gd name="textAreaTop" fmla="*/ 0 h 42840"/>
                <a:gd name="textAreaBottom" fmla="*/ 43200 h 42840"/>
              </a:gdLst>
              <a:ahLst/>
              <a:rect l="textAreaLeft" t="textAreaTop" r="textAreaRight" b="textAreaBottom"/>
              <a:pathLst>
                <a:path w="16" h="23">
                  <a:moveTo>
                    <a:pt x="16" y="0"/>
                  </a:moveTo>
                  <a:lnTo>
                    <a:pt x="0" y="9"/>
                  </a:lnTo>
                  <a:lnTo>
                    <a:pt x="12" y="23"/>
                  </a:lnTo>
                </a:path>
              </a:pathLst>
            </a:custGeom>
            <a:noFill/>
            <a:ln w="79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359"/>
            <p:cNvSpPr/>
            <p:nvPr/>
          </p:nvSpPr>
          <p:spPr>
            <a:xfrm flipH="1">
              <a:off x="4851000" y="893880"/>
              <a:ext cx="82440" cy="11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360"/>
            <p:cNvSpPr/>
            <p:nvPr/>
          </p:nvSpPr>
          <p:spPr>
            <a:xfrm>
              <a:off x="4894200" y="80640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T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361"/>
            <p:cNvSpPr/>
            <p:nvPr/>
          </p:nvSpPr>
          <p:spPr>
            <a:xfrm>
              <a:off x="5354640" y="1376280"/>
              <a:ext cx="106200" cy="10332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67" h="65">
                  <a:moveTo>
                    <a:pt x="62" y="54"/>
                  </a:moveTo>
                  <a:lnTo>
                    <a:pt x="51" y="23"/>
                  </a:lnTo>
                  <a:lnTo>
                    <a:pt x="67" y="17"/>
                  </a:lnTo>
                  <a:lnTo>
                    <a:pt x="22" y="0"/>
                  </a:lnTo>
                  <a:lnTo>
                    <a:pt x="0" y="42"/>
                  </a:lnTo>
                  <a:lnTo>
                    <a:pt x="16" y="36"/>
                  </a:lnTo>
                  <a:lnTo>
                    <a:pt x="25" y="65"/>
                  </a:lnTo>
                  <a:lnTo>
                    <a:pt x="62" y="54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Arc 362"/>
            <p:cNvSpPr/>
            <p:nvPr/>
          </p:nvSpPr>
          <p:spPr>
            <a:xfrm>
              <a:off x="4697280" y="1414440"/>
              <a:ext cx="750960" cy="270000"/>
            </a:xfrm>
            <a:custGeom>
              <a:avLst/>
              <a:gdLst>
                <a:gd name="textAreaLeft" fmla="*/ 0 w 750960"/>
                <a:gd name="textAreaRight" fmla="*/ 751320 w 750960"/>
                <a:gd name="textAreaTop" fmla="*/ 0 h 270000"/>
                <a:gd name="textAreaBottom" fmla="*/ 270360 h 270000"/>
              </a:gdLst>
              <a:ahLst/>
              <a:rect l="textAreaLeft" t="textAreaTop" r="textAreaRight" b="textAreaBottom"/>
              <a:pathLst>
                <a:path fill="none" w="20722" h="7455">
                  <a:moveTo>
                    <a:pt x="20272" y="0"/>
                  </a:moveTo>
                  <a:cubicBezTo>
                    <a:pt x="20437" y="448"/>
                    <a:pt x="20587" y="901"/>
                    <a:pt x="20722" y="1359"/>
                  </a:cubicBezTo>
                </a:path>
                <a:path stroke="0" w="20722" h="7455">
                  <a:moveTo>
                    <a:pt x="20272" y="0"/>
                  </a:moveTo>
                  <a:cubicBezTo>
                    <a:pt x="20437" y="448"/>
                    <a:pt x="20587" y="901"/>
                    <a:pt x="20722" y="1359"/>
                  </a:cubicBezTo>
                  <a:lnTo>
                    <a:pt x="0" y="7455"/>
                  </a:lnTo>
                  <a:lnTo>
                    <a:pt x="2027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Arc 363"/>
            <p:cNvSpPr/>
            <p:nvPr/>
          </p:nvSpPr>
          <p:spPr>
            <a:xfrm>
              <a:off x="4697280" y="1436760"/>
              <a:ext cx="690840" cy="247680"/>
            </a:xfrm>
            <a:custGeom>
              <a:avLst/>
              <a:gdLst>
                <a:gd name="textAreaLeft" fmla="*/ 0 w 690840"/>
                <a:gd name="textAreaRight" fmla="*/ 691200 w 69084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fill="none" w="20726" h="7443">
                  <a:moveTo>
                    <a:pt x="20277" y="-1"/>
                  </a:moveTo>
                  <a:cubicBezTo>
                    <a:pt x="20441" y="447"/>
                    <a:pt x="20591" y="901"/>
                    <a:pt x="20725" y="1359"/>
                  </a:cubicBezTo>
                </a:path>
                <a:path stroke="0" w="20726" h="7443">
                  <a:moveTo>
                    <a:pt x="20277" y="-1"/>
                  </a:moveTo>
                  <a:cubicBezTo>
                    <a:pt x="20441" y="447"/>
                    <a:pt x="20591" y="901"/>
                    <a:pt x="20725" y="1359"/>
                  </a:cubicBezTo>
                  <a:lnTo>
                    <a:pt x="0" y="7443"/>
                  </a:lnTo>
                  <a:lnTo>
                    <a:pt x="20277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364"/>
            <p:cNvSpPr/>
            <p:nvPr/>
          </p:nvSpPr>
          <p:spPr>
            <a:xfrm flipV="1">
              <a:off x="5394240" y="1461600"/>
              <a:ext cx="586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Freeform 365"/>
            <p:cNvSpPr/>
            <p:nvPr/>
          </p:nvSpPr>
          <p:spPr>
            <a:xfrm>
              <a:off x="5354640" y="1376280"/>
              <a:ext cx="106200" cy="6660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6" h="35">
                  <a:moveTo>
                    <a:pt x="13" y="30"/>
                  </a:moveTo>
                  <a:lnTo>
                    <a:pt x="0" y="35"/>
                  </a:lnTo>
                  <a:lnTo>
                    <a:pt x="18" y="0"/>
                  </a:lnTo>
                  <a:lnTo>
                    <a:pt x="56" y="14"/>
                  </a:lnTo>
                  <a:lnTo>
                    <a:pt x="43" y="1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366"/>
            <p:cNvSpPr/>
            <p:nvPr/>
          </p:nvSpPr>
          <p:spPr>
            <a:xfrm flipH="1">
              <a:off x="5435640" y="1380960"/>
              <a:ext cx="149040" cy="32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367"/>
            <p:cNvSpPr/>
            <p:nvPr/>
          </p:nvSpPr>
          <p:spPr>
            <a:xfrm>
              <a:off x="5533200" y="1379520"/>
              <a:ext cx="59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EM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2" name="365 CuadroTexto"/>
          <p:cNvSpPr/>
          <p:nvPr/>
        </p:nvSpPr>
        <p:spPr>
          <a:xfrm>
            <a:off x="3427560" y="616572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Supplemental Figure 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AutoShape 13"/>
          <p:cNvSpPr/>
          <p:nvPr/>
        </p:nvSpPr>
        <p:spPr>
          <a:xfrm>
            <a:off x="3059280" y="1630440"/>
            <a:ext cx="502920" cy="217440"/>
          </a:xfrm>
          <a:prstGeom prst="rightArrow">
            <a:avLst>
              <a:gd name="adj1" fmla="val 50000"/>
              <a:gd name="adj2" fmla="val 57823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14"/>
          <p:cNvSpPr/>
          <p:nvPr/>
        </p:nvSpPr>
        <p:spPr>
          <a:xfrm>
            <a:off x="2902320" y="1270080"/>
            <a:ext cx="81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BP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16"/>
          <p:cNvSpPr/>
          <p:nvPr/>
        </p:nvSpPr>
        <p:spPr>
          <a:xfrm>
            <a:off x="6228000" y="2158920"/>
            <a:ext cx="81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LR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AutoShape 19"/>
          <p:cNvSpPr/>
          <p:nvPr/>
        </p:nvSpPr>
        <p:spPr>
          <a:xfrm>
            <a:off x="6329520" y="2590920"/>
            <a:ext cx="502920" cy="217440"/>
          </a:xfrm>
          <a:prstGeom prst="rightArrow">
            <a:avLst>
              <a:gd name="adj1" fmla="val 50000"/>
              <a:gd name="adj2" fmla="val 57823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AutoShape 21"/>
          <p:cNvSpPr/>
          <p:nvPr/>
        </p:nvSpPr>
        <p:spPr>
          <a:xfrm>
            <a:off x="2855880" y="982800"/>
            <a:ext cx="73080" cy="2158920"/>
          </a:xfrm>
          <a:custGeom>
            <a:avLst/>
            <a:gdLst>
              <a:gd name="textAreaLeft" fmla="*/ 0 w 73080"/>
              <a:gd name="textAreaRight" fmla="*/ 51480 w 73080"/>
              <a:gd name="textAreaTop" fmla="*/ 89640 h 2158920"/>
              <a:gd name="textAreaBottom" fmla="*/ 2069280 h 2158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AutoShape 22"/>
          <p:cNvSpPr/>
          <p:nvPr/>
        </p:nvSpPr>
        <p:spPr>
          <a:xfrm>
            <a:off x="6084720" y="1582560"/>
            <a:ext cx="144720" cy="2376720"/>
          </a:xfrm>
          <a:custGeom>
            <a:avLst/>
            <a:gdLst>
              <a:gd name="textAreaLeft" fmla="*/ 0 w 144720"/>
              <a:gd name="textAreaRight" fmla="*/ 101520 w 144720"/>
              <a:gd name="textAreaTop" fmla="*/ 99000 h 2376720"/>
              <a:gd name="textAreaBottom" fmla="*/ 2277720 h 2376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9" name="224 Grupo"/>
          <p:cNvGrpSpPr/>
          <p:nvPr/>
        </p:nvGrpSpPr>
        <p:grpSpPr>
          <a:xfrm>
            <a:off x="181440" y="1628640"/>
            <a:ext cx="2414520" cy="1839960"/>
            <a:chOff x="181440" y="1628640"/>
            <a:chExt cx="2414520" cy="1839960"/>
          </a:xfrm>
        </p:grpSpPr>
        <p:sp>
          <p:nvSpPr>
            <p:cNvPr id="300" name="AutoShape 76"/>
            <p:cNvSpPr/>
            <p:nvPr/>
          </p:nvSpPr>
          <p:spPr>
            <a:xfrm>
              <a:off x="323640" y="1628640"/>
              <a:ext cx="2244960" cy="183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78"/>
            <p:cNvSpPr/>
            <p:nvPr/>
          </p:nvSpPr>
          <p:spPr>
            <a:xfrm>
              <a:off x="804600" y="1676160"/>
              <a:ext cx="1592280" cy="1594080"/>
            </a:xfrm>
            <a:custGeom>
              <a:avLst/>
              <a:gdLst>
                <a:gd name="textAreaLeft" fmla="*/ 0 w 1592280"/>
                <a:gd name="textAreaRight" fmla="*/ 1592640 w 1592280"/>
                <a:gd name="textAreaTop" fmla="*/ 0 h 1594080"/>
                <a:gd name="textAreaBottom" fmla="*/ 1594440 h 1594080"/>
              </a:gdLst>
              <a:ahLst/>
              <a:rect l="textAreaLeft" t="textAreaTop" r="textAreaRight" b="textAreaBottom"/>
              <a:pathLst>
                <a:path w="1003" h="1004">
                  <a:moveTo>
                    <a:pt x="506" y="0"/>
                  </a:moveTo>
                  <a:lnTo>
                    <a:pt x="461" y="2"/>
                  </a:lnTo>
                  <a:lnTo>
                    <a:pt x="416" y="7"/>
                  </a:lnTo>
                  <a:lnTo>
                    <a:pt x="373" y="17"/>
                  </a:lnTo>
                  <a:lnTo>
                    <a:pt x="330" y="31"/>
                  </a:lnTo>
                  <a:lnTo>
                    <a:pt x="289" y="48"/>
                  </a:lnTo>
                  <a:lnTo>
                    <a:pt x="249" y="69"/>
                  </a:lnTo>
                  <a:lnTo>
                    <a:pt x="211" y="93"/>
                  </a:lnTo>
                  <a:lnTo>
                    <a:pt x="176" y="121"/>
                  </a:lnTo>
                  <a:lnTo>
                    <a:pt x="143" y="151"/>
                  </a:lnTo>
                  <a:lnTo>
                    <a:pt x="113" y="184"/>
                  </a:lnTo>
                  <a:lnTo>
                    <a:pt x="87" y="220"/>
                  </a:lnTo>
                  <a:lnTo>
                    <a:pt x="64" y="259"/>
                  </a:lnTo>
                  <a:lnTo>
                    <a:pt x="44" y="300"/>
                  </a:lnTo>
                  <a:lnTo>
                    <a:pt x="26" y="341"/>
                  </a:lnTo>
                  <a:lnTo>
                    <a:pt x="14" y="384"/>
                  </a:lnTo>
                  <a:lnTo>
                    <a:pt x="5" y="429"/>
                  </a:lnTo>
                  <a:lnTo>
                    <a:pt x="2" y="473"/>
                  </a:lnTo>
                  <a:lnTo>
                    <a:pt x="0" y="518"/>
                  </a:lnTo>
                  <a:lnTo>
                    <a:pt x="4" y="563"/>
                  </a:lnTo>
                  <a:lnTo>
                    <a:pt x="11" y="607"/>
                  </a:lnTo>
                  <a:lnTo>
                    <a:pt x="23" y="651"/>
                  </a:lnTo>
                  <a:lnTo>
                    <a:pt x="37" y="693"/>
                  </a:lnTo>
                  <a:lnTo>
                    <a:pt x="57" y="734"/>
                  </a:lnTo>
                  <a:lnTo>
                    <a:pt x="80" y="772"/>
                  </a:lnTo>
                  <a:lnTo>
                    <a:pt x="106" y="809"/>
                  </a:lnTo>
                  <a:lnTo>
                    <a:pt x="134" y="843"/>
                  </a:lnTo>
                  <a:lnTo>
                    <a:pt x="166" y="875"/>
                  </a:lnTo>
                  <a:lnTo>
                    <a:pt x="201" y="903"/>
                  </a:lnTo>
                  <a:lnTo>
                    <a:pt x="237" y="928"/>
                  </a:lnTo>
                  <a:lnTo>
                    <a:pt x="276" y="951"/>
                  </a:lnTo>
                  <a:lnTo>
                    <a:pt x="317" y="969"/>
                  </a:lnTo>
                  <a:lnTo>
                    <a:pt x="359" y="983"/>
                  </a:lnTo>
                  <a:lnTo>
                    <a:pt x="403" y="994"/>
                  </a:lnTo>
                  <a:lnTo>
                    <a:pt x="447" y="1001"/>
                  </a:lnTo>
                  <a:lnTo>
                    <a:pt x="492" y="1004"/>
                  </a:lnTo>
                  <a:lnTo>
                    <a:pt x="538" y="1003"/>
                  </a:lnTo>
                  <a:lnTo>
                    <a:pt x="582" y="998"/>
                  </a:lnTo>
                  <a:lnTo>
                    <a:pt x="626" y="988"/>
                  </a:lnTo>
                  <a:lnTo>
                    <a:pt x="669" y="975"/>
                  </a:lnTo>
                  <a:lnTo>
                    <a:pt x="710" y="958"/>
                  </a:lnTo>
                  <a:lnTo>
                    <a:pt x="749" y="938"/>
                  </a:lnTo>
                  <a:lnTo>
                    <a:pt x="788" y="915"/>
                  </a:lnTo>
                  <a:lnTo>
                    <a:pt x="824" y="887"/>
                  </a:lnTo>
                  <a:lnTo>
                    <a:pt x="856" y="856"/>
                  </a:lnTo>
                  <a:lnTo>
                    <a:pt x="887" y="823"/>
                  </a:lnTo>
                  <a:lnTo>
                    <a:pt x="914" y="788"/>
                  </a:lnTo>
                  <a:lnTo>
                    <a:pt x="938" y="750"/>
                  </a:lnTo>
                  <a:lnTo>
                    <a:pt x="957" y="710"/>
                  </a:lnTo>
                  <a:lnTo>
                    <a:pt x="975" y="668"/>
                  </a:lnTo>
                  <a:lnTo>
                    <a:pt x="987" y="624"/>
                  </a:lnTo>
                  <a:lnTo>
                    <a:pt x="997" y="581"/>
                  </a:lnTo>
                  <a:lnTo>
                    <a:pt x="1002" y="536"/>
                  </a:lnTo>
                  <a:lnTo>
                    <a:pt x="1003" y="492"/>
                  </a:lnTo>
                  <a:lnTo>
                    <a:pt x="1000" y="447"/>
                  </a:lnTo>
                  <a:lnTo>
                    <a:pt x="993" y="403"/>
                  </a:lnTo>
                  <a:lnTo>
                    <a:pt x="982" y="359"/>
                  </a:lnTo>
                  <a:lnTo>
                    <a:pt x="967" y="317"/>
                  </a:lnTo>
                  <a:lnTo>
                    <a:pt x="949" y="276"/>
                  </a:lnTo>
                  <a:lnTo>
                    <a:pt x="928" y="237"/>
                  </a:lnTo>
                  <a:lnTo>
                    <a:pt x="902" y="199"/>
                  </a:lnTo>
                  <a:lnTo>
                    <a:pt x="873" y="165"/>
                  </a:lnTo>
                  <a:lnTo>
                    <a:pt x="841" y="134"/>
                  </a:lnTo>
                  <a:lnTo>
                    <a:pt x="808" y="104"/>
                  </a:lnTo>
                  <a:lnTo>
                    <a:pt x="771" y="78"/>
                  </a:lnTo>
                  <a:lnTo>
                    <a:pt x="732" y="56"/>
                  </a:lnTo>
                  <a:lnTo>
                    <a:pt x="691" y="37"/>
                  </a:lnTo>
                  <a:lnTo>
                    <a:pt x="649" y="22"/>
                  </a:lnTo>
                  <a:lnTo>
                    <a:pt x="606" y="11"/>
                  </a:lnTo>
                  <a:lnTo>
                    <a:pt x="561" y="3"/>
                  </a:lnTo>
                  <a:lnTo>
                    <a:pt x="517" y="0"/>
                  </a:lnTo>
                  <a:lnTo>
                    <a:pt x="507" y="0"/>
                  </a:lnTo>
                  <a:lnTo>
                    <a:pt x="507" y="11"/>
                  </a:lnTo>
                  <a:lnTo>
                    <a:pt x="550" y="13"/>
                  </a:lnTo>
                  <a:lnTo>
                    <a:pt x="593" y="20"/>
                  </a:lnTo>
                  <a:lnTo>
                    <a:pt x="637" y="29"/>
                  </a:lnTo>
                  <a:lnTo>
                    <a:pt x="678" y="43"/>
                  </a:lnTo>
                  <a:lnTo>
                    <a:pt x="718" y="60"/>
                  </a:lnTo>
                  <a:lnTo>
                    <a:pt x="757" y="82"/>
                  </a:lnTo>
                  <a:lnTo>
                    <a:pt x="793" y="106"/>
                  </a:lnTo>
                  <a:lnTo>
                    <a:pt x="827" y="135"/>
                  </a:lnTo>
                  <a:lnTo>
                    <a:pt x="858" y="165"/>
                  </a:lnTo>
                  <a:lnTo>
                    <a:pt x="887" y="198"/>
                  </a:lnTo>
                  <a:lnTo>
                    <a:pt x="913" y="234"/>
                  </a:lnTo>
                  <a:lnTo>
                    <a:pt x="935" y="271"/>
                  </a:lnTo>
                  <a:lnTo>
                    <a:pt x="954" y="311"/>
                  </a:lnTo>
                  <a:lnTo>
                    <a:pt x="969" y="353"/>
                  </a:lnTo>
                  <a:lnTo>
                    <a:pt x="981" y="395"/>
                  </a:lnTo>
                  <a:lnTo>
                    <a:pt x="988" y="439"/>
                  </a:lnTo>
                  <a:lnTo>
                    <a:pt x="992" y="482"/>
                  </a:lnTo>
                  <a:lnTo>
                    <a:pt x="992" y="525"/>
                  </a:lnTo>
                  <a:lnTo>
                    <a:pt x="987" y="570"/>
                  </a:lnTo>
                  <a:lnTo>
                    <a:pt x="980" y="613"/>
                  </a:lnTo>
                  <a:lnTo>
                    <a:pt x="967" y="655"/>
                  </a:lnTo>
                  <a:lnTo>
                    <a:pt x="953" y="696"/>
                  </a:lnTo>
                  <a:lnTo>
                    <a:pt x="933" y="736"/>
                  </a:lnTo>
                  <a:lnTo>
                    <a:pt x="910" y="773"/>
                  </a:lnTo>
                  <a:lnTo>
                    <a:pt x="884" y="809"/>
                  </a:lnTo>
                  <a:lnTo>
                    <a:pt x="856" y="841"/>
                  </a:lnTo>
                  <a:lnTo>
                    <a:pt x="824" y="872"/>
                  </a:lnTo>
                  <a:lnTo>
                    <a:pt x="790" y="900"/>
                  </a:lnTo>
                  <a:lnTo>
                    <a:pt x="753" y="923"/>
                  </a:lnTo>
                  <a:lnTo>
                    <a:pt x="715" y="944"/>
                  </a:lnTo>
                  <a:lnTo>
                    <a:pt x="674" y="962"/>
                  </a:lnTo>
                  <a:lnTo>
                    <a:pt x="633" y="975"/>
                  </a:lnTo>
                  <a:lnTo>
                    <a:pt x="590" y="985"/>
                  </a:lnTo>
                  <a:lnTo>
                    <a:pt x="546" y="991"/>
                  </a:lnTo>
                  <a:lnTo>
                    <a:pt x="503" y="993"/>
                  </a:lnTo>
                  <a:lnTo>
                    <a:pt x="458" y="991"/>
                  </a:lnTo>
                  <a:lnTo>
                    <a:pt x="415" y="985"/>
                  </a:lnTo>
                  <a:lnTo>
                    <a:pt x="372" y="975"/>
                  </a:lnTo>
                  <a:lnTo>
                    <a:pt x="331" y="963"/>
                  </a:lnTo>
                  <a:lnTo>
                    <a:pt x="290" y="946"/>
                  </a:lnTo>
                  <a:lnTo>
                    <a:pt x="252" y="924"/>
                  </a:lnTo>
                  <a:lnTo>
                    <a:pt x="215" y="901"/>
                  </a:lnTo>
                  <a:lnTo>
                    <a:pt x="180" y="874"/>
                  </a:lnTo>
                  <a:lnTo>
                    <a:pt x="149" y="843"/>
                  </a:lnTo>
                  <a:lnTo>
                    <a:pt x="119" y="810"/>
                  </a:lnTo>
                  <a:lnTo>
                    <a:pt x="93" y="774"/>
                  </a:lnTo>
                  <a:lnTo>
                    <a:pt x="71" y="737"/>
                  </a:lnTo>
                  <a:lnTo>
                    <a:pt x="51" y="698"/>
                  </a:lnTo>
                  <a:lnTo>
                    <a:pt x="36" y="657"/>
                  </a:lnTo>
                  <a:lnTo>
                    <a:pt x="24" y="615"/>
                  </a:lnTo>
                  <a:lnTo>
                    <a:pt x="16" y="571"/>
                  </a:lnTo>
                  <a:lnTo>
                    <a:pt x="11" y="528"/>
                  </a:lnTo>
                  <a:lnTo>
                    <a:pt x="11" y="483"/>
                  </a:lnTo>
                  <a:lnTo>
                    <a:pt x="15" y="440"/>
                  </a:lnTo>
                  <a:lnTo>
                    <a:pt x="23" y="396"/>
                  </a:lnTo>
                  <a:lnTo>
                    <a:pt x="34" y="354"/>
                  </a:lnTo>
                  <a:lnTo>
                    <a:pt x="49" y="312"/>
                  </a:lnTo>
                  <a:lnTo>
                    <a:pt x="67" y="272"/>
                  </a:lnTo>
                  <a:lnTo>
                    <a:pt x="90" y="235"/>
                  </a:lnTo>
                  <a:lnTo>
                    <a:pt x="116" y="199"/>
                  </a:lnTo>
                  <a:lnTo>
                    <a:pt x="144" y="166"/>
                  </a:lnTo>
                  <a:lnTo>
                    <a:pt x="175" y="135"/>
                  </a:lnTo>
                  <a:lnTo>
                    <a:pt x="210" y="108"/>
                  </a:lnTo>
                  <a:lnTo>
                    <a:pt x="246" y="83"/>
                  </a:lnTo>
                  <a:lnTo>
                    <a:pt x="284" y="62"/>
                  </a:lnTo>
                  <a:lnTo>
                    <a:pt x="324" y="44"/>
                  </a:lnTo>
                  <a:lnTo>
                    <a:pt x="366" y="29"/>
                  </a:lnTo>
                  <a:lnTo>
                    <a:pt x="408" y="20"/>
                  </a:lnTo>
                  <a:lnTo>
                    <a:pt x="452" y="13"/>
                  </a:lnTo>
                  <a:lnTo>
                    <a:pt x="496" y="11"/>
                  </a:lnTo>
                  <a:lnTo>
                    <a:pt x="506" y="11"/>
                  </a:lnTo>
                  <a:lnTo>
                    <a:pt x="506" y="0"/>
                  </a:lnTo>
                  <a:close/>
                </a:path>
              </a:pathLst>
            </a:cu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Oval 79"/>
            <p:cNvSpPr/>
            <p:nvPr/>
          </p:nvSpPr>
          <p:spPr>
            <a:xfrm>
              <a:off x="804600" y="1676160"/>
              <a:ext cx="1592280" cy="159408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Oval 80"/>
            <p:cNvSpPr/>
            <p:nvPr/>
          </p:nvSpPr>
          <p:spPr>
            <a:xfrm>
              <a:off x="822240" y="1693440"/>
              <a:ext cx="1557360" cy="155916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81"/>
            <p:cNvSpPr/>
            <p:nvPr/>
          </p:nvSpPr>
          <p:spPr>
            <a:xfrm flipV="1">
              <a:off x="1608120" y="1676160"/>
              <a:ext cx="1440" cy="17280"/>
            </a:xfrm>
            <a:prstGeom prst="line">
              <a:avLst/>
            </a:prstGeom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82"/>
            <p:cNvSpPr/>
            <p:nvPr/>
          </p:nvSpPr>
          <p:spPr>
            <a:xfrm>
              <a:off x="1343160" y="2349360"/>
              <a:ext cx="57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DONR/Ze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83"/>
            <p:cNvSpPr/>
            <p:nvPr/>
          </p:nvSpPr>
          <p:spPr>
            <a:xfrm>
              <a:off x="1493280" y="250488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4291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Freeform 84"/>
            <p:cNvSpPr/>
            <p:nvPr/>
          </p:nvSpPr>
          <p:spPr>
            <a:xfrm>
              <a:off x="2208240" y="2620800"/>
              <a:ext cx="210960" cy="338040"/>
            </a:xfrm>
            <a:custGeom>
              <a:avLst/>
              <a:gdLst>
                <a:gd name="textAreaLeft" fmla="*/ 0 w 210960"/>
                <a:gd name="textAreaRight" fmla="*/ 211320 w 210960"/>
                <a:gd name="textAreaTop" fmla="*/ 0 h 338040"/>
                <a:gd name="textAreaBottom" fmla="*/ 338400 h 338040"/>
              </a:gdLst>
              <a:ahLst/>
              <a:rect l="textAreaLeft" t="textAreaTop" r="textAreaRight" b="textAreaBottom"/>
              <a:pathLst>
                <a:path w="133" h="213">
                  <a:moveTo>
                    <a:pt x="34" y="213"/>
                  </a:moveTo>
                  <a:lnTo>
                    <a:pt x="59" y="176"/>
                  </a:lnTo>
                  <a:lnTo>
                    <a:pt x="81" y="135"/>
                  </a:lnTo>
                  <a:lnTo>
                    <a:pt x="99" y="93"/>
                  </a:lnTo>
                  <a:lnTo>
                    <a:pt x="114" y="48"/>
                  </a:lnTo>
                  <a:lnTo>
                    <a:pt x="117" y="37"/>
                  </a:lnTo>
                  <a:lnTo>
                    <a:pt x="133" y="41"/>
                  </a:lnTo>
                  <a:lnTo>
                    <a:pt x="104" y="0"/>
                  </a:lnTo>
                  <a:lnTo>
                    <a:pt x="62" y="22"/>
                  </a:lnTo>
                  <a:lnTo>
                    <a:pt x="78" y="26"/>
                  </a:lnTo>
                  <a:lnTo>
                    <a:pt x="66" y="67"/>
                  </a:lnTo>
                  <a:lnTo>
                    <a:pt x="50" y="106"/>
                  </a:lnTo>
                  <a:lnTo>
                    <a:pt x="30" y="145"/>
                  </a:lnTo>
                  <a:lnTo>
                    <a:pt x="7" y="181"/>
                  </a:lnTo>
                  <a:lnTo>
                    <a:pt x="0" y="189"/>
                  </a:lnTo>
                  <a:lnTo>
                    <a:pt x="34" y="213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Arc 85"/>
            <p:cNvSpPr/>
            <p:nvPr/>
          </p:nvSpPr>
          <p:spPr>
            <a:xfrm>
              <a:off x="1601640" y="2473200"/>
              <a:ext cx="793800" cy="485640"/>
            </a:xfrm>
            <a:custGeom>
              <a:avLst/>
              <a:gdLst>
                <a:gd name="textAreaLeft" fmla="*/ 0 w 793800"/>
                <a:gd name="textAreaRight" fmla="*/ 794160 w 793800"/>
                <a:gd name="textAreaTop" fmla="*/ 0 h 485640"/>
                <a:gd name="textAreaBottom" fmla="*/ 486000 h 485640"/>
              </a:gdLst>
              <a:ahLst/>
              <a:rect l="textAreaLeft" t="textAreaTop" r="textAreaRight" b="textAreaBottom"/>
              <a:pathLst>
                <a:path fill="none" w="20904" h="12791">
                  <a:moveTo>
                    <a:pt x="20903" y="5440"/>
                  </a:moveTo>
                  <a:cubicBezTo>
                    <a:pt x="20213" y="8090"/>
                    <a:pt x="19026" y="10584"/>
                    <a:pt x="17405" y="12790"/>
                  </a:cubicBezTo>
                </a:path>
                <a:path stroke="0" w="20904" h="12791">
                  <a:moveTo>
                    <a:pt x="20903" y="5440"/>
                  </a:moveTo>
                  <a:cubicBezTo>
                    <a:pt x="20213" y="8090"/>
                    <a:pt x="19026" y="10584"/>
                    <a:pt x="17405" y="12790"/>
                  </a:cubicBezTo>
                  <a:lnTo>
                    <a:pt x="0" y="0"/>
                  </a:lnTo>
                  <a:lnTo>
                    <a:pt x="20903" y="5440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Arc 86"/>
            <p:cNvSpPr/>
            <p:nvPr/>
          </p:nvSpPr>
          <p:spPr>
            <a:xfrm>
              <a:off x="1601640" y="2473200"/>
              <a:ext cx="730080" cy="449280"/>
            </a:xfrm>
            <a:custGeom>
              <a:avLst/>
              <a:gdLst>
                <a:gd name="textAreaLeft" fmla="*/ 0 w 730080"/>
                <a:gd name="textAreaRight" fmla="*/ 730080 w 730080"/>
                <a:gd name="textAreaTop" fmla="*/ 0 h 449280"/>
                <a:gd name="textAreaBottom" fmla="*/ 449640 h 449280"/>
              </a:gdLst>
              <a:ahLst/>
              <a:rect l="textAreaLeft" t="textAreaTop" r="textAreaRight" b="textAreaBottom"/>
              <a:pathLst>
                <a:path fill="none" w="20913" h="12820">
                  <a:moveTo>
                    <a:pt x="20913" y="5404"/>
                  </a:moveTo>
                  <a:cubicBezTo>
                    <a:pt x="20221" y="8078"/>
                    <a:pt x="19023" y="10596"/>
                    <a:pt x="17384" y="12820"/>
                  </a:cubicBezTo>
                </a:path>
                <a:path stroke="0" w="20913" h="12820">
                  <a:moveTo>
                    <a:pt x="20913" y="5404"/>
                  </a:moveTo>
                  <a:cubicBezTo>
                    <a:pt x="20221" y="8078"/>
                    <a:pt x="19023" y="10596"/>
                    <a:pt x="17384" y="12820"/>
                  </a:cubicBezTo>
                  <a:lnTo>
                    <a:pt x="0" y="0"/>
                  </a:lnTo>
                  <a:lnTo>
                    <a:pt x="20913" y="5404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87"/>
            <p:cNvSpPr/>
            <p:nvPr/>
          </p:nvSpPr>
          <p:spPr>
            <a:xfrm>
              <a:off x="2208240" y="2921040"/>
              <a:ext cx="53640" cy="3780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Freeform 88"/>
            <p:cNvSpPr/>
            <p:nvPr/>
          </p:nvSpPr>
          <p:spPr>
            <a:xfrm>
              <a:off x="2306520" y="2620800"/>
              <a:ext cx="112680" cy="64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57" h="33">
                  <a:moveTo>
                    <a:pt x="13" y="21"/>
                  </a:moveTo>
                  <a:lnTo>
                    <a:pt x="0" y="18"/>
                  </a:lnTo>
                  <a:lnTo>
                    <a:pt x="34" y="0"/>
                  </a:lnTo>
                  <a:lnTo>
                    <a:pt x="57" y="33"/>
                  </a:lnTo>
                  <a:lnTo>
                    <a:pt x="44" y="30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89"/>
            <p:cNvSpPr/>
            <p:nvPr/>
          </p:nvSpPr>
          <p:spPr>
            <a:xfrm flipH="1" flipV="1">
              <a:off x="2352600" y="2801880"/>
              <a:ext cx="2376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90"/>
            <p:cNvSpPr/>
            <p:nvPr/>
          </p:nvSpPr>
          <p:spPr>
            <a:xfrm>
              <a:off x="2380320" y="283356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ccd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Freeform 91"/>
            <p:cNvSpPr/>
            <p:nvPr/>
          </p:nvSpPr>
          <p:spPr>
            <a:xfrm>
              <a:off x="1184040" y="3124080"/>
              <a:ext cx="747720" cy="169560"/>
            </a:xfrm>
            <a:custGeom>
              <a:avLst/>
              <a:gdLst>
                <a:gd name="textAreaLeft" fmla="*/ 0 w 747720"/>
                <a:gd name="textAreaRight" fmla="*/ 748080 w 747720"/>
                <a:gd name="textAreaTop" fmla="*/ 0 h 169560"/>
                <a:gd name="textAreaBottom" fmla="*/ 169560 h 169560"/>
              </a:gdLst>
              <a:ahLst/>
              <a:rect l="textAreaLeft" t="textAreaTop" r="textAreaRight" b="textAreaBottom"/>
              <a:pathLst>
                <a:path w="471" h="107">
                  <a:moveTo>
                    <a:pt x="0" y="35"/>
                  </a:moveTo>
                  <a:lnTo>
                    <a:pt x="41" y="57"/>
                  </a:lnTo>
                  <a:lnTo>
                    <a:pt x="85" y="74"/>
                  </a:lnTo>
                  <a:lnTo>
                    <a:pt x="128" y="89"/>
                  </a:lnTo>
                  <a:lnTo>
                    <a:pt x="174" y="99"/>
                  </a:lnTo>
                  <a:lnTo>
                    <a:pt x="219" y="105"/>
                  </a:lnTo>
                  <a:lnTo>
                    <a:pt x="265" y="107"/>
                  </a:lnTo>
                  <a:lnTo>
                    <a:pt x="311" y="104"/>
                  </a:lnTo>
                  <a:lnTo>
                    <a:pt x="357" y="98"/>
                  </a:lnTo>
                  <a:lnTo>
                    <a:pt x="401" y="88"/>
                  </a:lnTo>
                  <a:lnTo>
                    <a:pt x="446" y="73"/>
                  </a:lnTo>
                  <a:lnTo>
                    <a:pt x="447" y="72"/>
                  </a:lnTo>
                  <a:lnTo>
                    <a:pt x="453" y="88"/>
                  </a:lnTo>
                  <a:lnTo>
                    <a:pt x="471" y="41"/>
                  </a:lnTo>
                  <a:lnTo>
                    <a:pt x="427" y="19"/>
                  </a:lnTo>
                  <a:lnTo>
                    <a:pt x="434" y="34"/>
                  </a:lnTo>
                  <a:lnTo>
                    <a:pt x="393" y="48"/>
                  </a:lnTo>
                  <a:lnTo>
                    <a:pt x="352" y="57"/>
                  </a:lnTo>
                  <a:lnTo>
                    <a:pt x="310" y="63"/>
                  </a:lnTo>
                  <a:lnTo>
                    <a:pt x="267" y="66"/>
                  </a:lnTo>
                  <a:lnTo>
                    <a:pt x="224" y="65"/>
                  </a:lnTo>
                  <a:lnTo>
                    <a:pt x="182" y="60"/>
                  </a:lnTo>
                  <a:lnTo>
                    <a:pt x="141" y="50"/>
                  </a:lnTo>
                  <a:lnTo>
                    <a:pt x="101" y="37"/>
                  </a:lnTo>
                  <a:lnTo>
                    <a:pt x="61" y="21"/>
                  </a:lnTo>
                  <a:lnTo>
                    <a:pt x="24" y="1"/>
                  </a:lnTo>
                  <a:lnTo>
                    <a:pt x="21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Arc 92"/>
            <p:cNvSpPr/>
            <p:nvPr/>
          </p:nvSpPr>
          <p:spPr>
            <a:xfrm>
              <a:off x="1184040" y="2473200"/>
              <a:ext cx="709560" cy="820800"/>
            </a:xfrm>
            <a:custGeom>
              <a:avLst/>
              <a:gdLst>
                <a:gd name="textAreaLeft" fmla="*/ 0 w 709560"/>
                <a:gd name="textAreaRight" fmla="*/ 709920 w 709560"/>
                <a:gd name="textAreaTop" fmla="*/ 0 h 820800"/>
                <a:gd name="textAreaBottom" fmla="*/ 821160 h 820800"/>
              </a:gdLst>
              <a:ahLst/>
              <a:rect l="textAreaLeft" t="textAreaTop" r="textAreaRight" b="textAreaBottom"/>
              <a:pathLst>
                <a:path fill="none" w="18708" h="21600">
                  <a:moveTo>
                    <a:pt x="18708" y="20177"/>
                  </a:moveTo>
                  <a:cubicBezTo>
                    <a:pt x="16246" y="21117"/>
                    <a:pt x="13633" y="21599"/>
                    <a:pt x="10998" y="21600"/>
                  </a:cubicBezTo>
                  <a:cubicBezTo>
                    <a:pt x="7128" y="21600"/>
                    <a:pt x="3330" y="20560"/>
                    <a:pt x="0" y="18590"/>
                  </a:cubicBezTo>
                </a:path>
                <a:path stroke="0" w="18708" h="21600">
                  <a:moveTo>
                    <a:pt x="18708" y="20177"/>
                  </a:moveTo>
                  <a:cubicBezTo>
                    <a:pt x="16246" y="21117"/>
                    <a:pt x="13633" y="21599"/>
                    <a:pt x="10998" y="21600"/>
                  </a:cubicBezTo>
                  <a:cubicBezTo>
                    <a:pt x="7128" y="21600"/>
                    <a:pt x="3330" y="20560"/>
                    <a:pt x="0" y="18590"/>
                  </a:cubicBezTo>
                  <a:lnTo>
                    <a:pt x="10998" y="0"/>
                  </a:lnTo>
                  <a:lnTo>
                    <a:pt x="18708" y="20177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Arc 93"/>
            <p:cNvSpPr/>
            <p:nvPr/>
          </p:nvSpPr>
          <p:spPr>
            <a:xfrm>
              <a:off x="1217520" y="2473200"/>
              <a:ext cx="655560" cy="755640"/>
            </a:xfrm>
            <a:custGeom>
              <a:avLst/>
              <a:gdLst>
                <a:gd name="textAreaLeft" fmla="*/ 0 w 655560"/>
                <a:gd name="textAreaRight" fmla="*/ 655920 w 655560"/>
                <a:gd name="textAreaTop" fmla="*/ 0 h 755640"/>
                <a:gd name="textAreaBottom" fmla="*/ 756000 h 755640"/>
              </a:gdLst>
              <a:ahLst/>
              <a:rect l="textAreaLeft" t="textAreaTop" r="textAreaRight" b="textAreaBottom"/>
              <a:pathLst>
                <a:path fill="none" w="18758" h="21600">
                  <a:moveTo>
                    <a:pt x="18758" y="20154"/>
                  </a:moveTo>
                  <a:cubicBezTo>
                    <a:pt x="16278" y="21109"/>
                    <a:pt x="13644" y="21599"/>
                    <a:pt x="10988" y="21600"/>
                  </a:cubicBezTo>
                  <a:cubicBezTo>
                    <a:pt x="7122" y="21600"/>
                    <a:pt x="3327" y="20562"/>
                    <a:pt x="-1" y="18596"/>
                  </a:cubicBezTo>
                </a:path>
                <a:path stroke="0" w="18758" h="21600">
                  <a:moveTo>
                    <a:pt x="18758" y="20154"/>
                  </a:moveTo>
                  <a:cubicBezTo>
                    <a:pt x="16278" y="21109"/>
                    <a:pt x="13644" y="21599"/>
                    <a:pt x="10988" y="21600"/>
                  </a:cubicBezTo>
                  <a:cubicBezTo>
                    <a:pt x="7122" y="21600"/>
                    <a:pt x="3327" y="20562"/>
                    <a:pt x="-1" y="18596"/>
                  </a:cubicBezTo>
                  <a:lnTo>
                    <a:pt x="10988" y="0"/>
                  </a:lnTo>
                  <a:lnTo>
                    <a:pt x="18758" y="20154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94"/>
            <p:cNvSpPr/>
            <p:nvPr/>
          </p:nvSpPr>
          <p:spPr>
            <a:xfrm flipH="1">
              <a:off x="1184040" y="3124080"/>
              <a:ext cx="33120" cy="5544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95"/>
            <p:cNvSpPr/>
            <p:nvPr/>
          </p:nvSpPr>
          <p:spPr>
            <a:xfrm>
              <a:off x="1861920" y="3154320"/>
              <a:ext cx="69840" cy="1094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35" h="56">
                  <a:moveTo>
                    <a:pt x="5" y="12"/>
                  </a:moveTo>
                  <a:lnTo>
                    <a:pt x="0" y="0"/>
                  </a:lnTo>
                  <a:lnTo>
                    <a:pt x="35" y="18"/>
                  </a:lnTo>
                  <a:lnTo>
                    <a:pt x="21" y="56"/>
                  </a:lnTo>
                  <a:lnTo>
                    <a:pt x="16" y="43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96"/>
            <p:cNvSpPr/>
            <p:nvPr/>
          </p:nvSpPr>
          <p:spPr>
            <a:xfrm flipH="1" flipV="1">
              <a:off x="1560240" y="3290760"/>
              <a:ext cx="2844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97"/>
            <p:cNvSpPr/>
            <p:nvPr/>
          </p:nvSpPr>
          <p:spPr>
            <a:xfrm>
              <a:off x="1385640" y="3359160"/>
              <a:ext cx="26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Cm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Freeform 98"/>
            <p:cNvSpPr/>
            <p:nvPr/>
          </p:nvSpPr>
          <p:spPr>
            <a:xfrm>
              <a:off x="760320" y="2160360"/>
              <a:ext cx="142560" cy="434880"/>
            </a:xfrm>
            <a:custGeom>
              <a:avLst/>
              <a:gdLst>
                <a:gd name="textAreaLeft" fmla="*/ 0 w 142560"/>
                <a:gd name="textAreaRight" fmla="*/ 142920 w 142560"/>
                <a:gd name="textAreaTop" fmla="*/ 0 h 434880"/>
                <a:gd name="textAreaBottom" fmla="*/ 435240 h 434880"/>
              </a:gdLst>
              <a:ahLst/>
              <a:rect l="textAreaLeft" t="textAreaTop" r="textAreaRight" b="textAreaBottom"/>
              <a:pathLst>
                <a:path w="90" h="274">
                  <a:moveTo>
                    <a:pt x="53" y="0"/>
                  </a:moveTo>
                  <a:lnTo>
                    <a:pt x="37" y="43"/>
                  </a:lnTo>
                  <a:lnTo>
                    <a:pt x="25" y="88"/>
                  </a:lnTo>
                  <a:lnTo>
                    <a:pt x="17" y="132"/>
                  </a:lnTo>
                  <a:lnTo>
                    <a:pt x="13" y="179"/>
                  </a:lnTo>
                  <a:lnTo>
                    <a:pt x="13" y="225"/>
                  </a:lnTo>
                  <a:lnTo>
                    <a:pt x="16" y="244"/>
                  </a:lnTo>
                  <a:lnTo>
                    <a:pt x="0" y="245"/>
                  </a:lnTo>
                  <a:lnTo>
                    <a:pt x="39" y="274"/>
                  </a:lnTo>
                  <a:lnTo>
                    <a:pt x="73" y="238"/>
                  </a:lnTo>
                  <a:lnTo>
                    <a:pt x="57" y="240"/>
                  </a:lnTo>
                  <a:lnTo>
                    <a:pt x="54" y="197"/>
                  </a:lnTo>
                  <a:lnTo>
                    <a:pt x="56" y="155"/>
                  </a:lnTo>
                  <a:lnTo>
                    <a:pt x="62" y="112"/>
                  </a:lnTo>
                  <a:lnTo>
                    <a:pt x="72" y="70"/>
                  </a:lnTo>
                  <a:lnTo>
                    <a:pt x="84" y="31"/>
                  </a:lnTo>
                  <a:lnTo>
                    <a:pt x="90" y="15"/>
                  </a:lnTo>
                  <a:lnTo>
                    <a:pt x="53" y="0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Arc 99"/>
            <p:cNvSpPr/>
            <p:nvPr/>
          </p:nvSpPr>
          <p:spPr>
            <a:xfrm>
              <a:off x="780840" y="2160360"/>
              <a:ext cx="820800" cy="387360"/>
            </a:xfrm>
            <a:custGeom>
              <a:avLst/>
              <a:gdLst>
                <a:gd name="textAreaLeft" fmla="*/ 0 w 820800"/>
                <a:gd name="textAreaRight" fmla="*/ 821160 w 82080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fill="none" w="21600" h="10203">
                  <a:moveTo>
                    <a:pt x="89" y="10203"/>
                  </a:moveTo>
                  <a:cubicBezTo>
                    <a:pt x="29" y="9549"/>
                    <a:pt x="0" y="8894"/>
                    <a:pt x="0" y="8238"/>
                  </a:cubicBezTo>
                  <a:cubicBezTo>
                    <a:pt x="-1" y="5411"/>
                    <a:pt x="554" y="2612"/>
                    <a:pt x="1632" y="-1"/>
                  </a:cubicBezTo>
                </a:path>
                <a:path stroke="0" w="21600" h="10203">
                  <a:moveTo>
                    <a:pt x="89" y="10203"/>
                  </a:moveTo>
                  <a:cubicBezTo>
                    <a:pt x="29" y="9549"/>
                    <a:pt x="0" y="8894"/>
                    <a:pt x="0" y="8238"/>
                  </a:cubicBezTo>
                  <a:cubicBezTo>
                    <a:pt x="-1" y="5411"/>
                    <a:pt x="554" y="2612"/>
                    <a:pt x="1632" y="-1"/>
                  </a:cubicBezTo>
                  <a:lnTo>
                    <a:pt x="21600" y="8238"/>
                  </a:lnTo>
                  <a:lnTo>
                    <a:pt x="89" y="10203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Arc 100"/>
            <p:cNvSpPr/>
            <p:nvPr/>
          </p:nvSpPr>
          <p:spPr>
            <a:xfrm>
              <a:off x="846000" y="2184120"/>
              <a:ext cx="755640" cy="357120"/>
            </a:xfrm>
            <a:custGeom>
              <a:avLst/>
              <a:gdLst>
                <a:gd name="textAreaLeft" fmla="*/ 0 w 755640"/>
                <a:gd name="textAreaRight" fmla="*/ 756000 w 755640"/>
                <a:gd name="textAreaTop" fmla="*/ 0 h 357120"/>
                <a:gd name="textAreaBottom" fmla="*/ 357480 h 357120"/>
              </a:gdLst>
              <a:ahLst/>
              <a:rect l="textAreaLeft" t="textAreaTop" r="textAreaRight" b="textAreaBottom"/>
              <a:pathLst>
                <a:path fill="none" w="21600" h="10203">
                  <a:moveTo>
                    <a:pt x="88" y="10203"/>
                  </a:moveTo>
                  <a:cubicBezTo>
                    <a:pt x="29" y="9553"/>
                    <a:pt x="0" y="8901"/>
                    <a:pt x="0" y="8249"/>
                  </a:cubicBezTo>
                  <a:cubicBezTo>
                    <a:pt x="-1" y="5418"/>
                    <a:pt x="556" y="2615"/>
                    <a:pt x="1637" y="0"/>
                  </a:cubicBezTo>
                </a:path>
                <a:path stroke="0" w="21600" h="10203">
                  <a:moveTo>
                    <a:pt x="88" y="10203"/>
                  </a:moveTo>
                  <a:cubicBezTo>
                    <a:pt x="29" y="9553"/>
                    <a:pt x="0" y="8901"/>
                    <a:pt x="0" y="8249"/>
                  </a:cubicBezTo>
                  <a:cubicBezTo>
                    <a:pt x="-1" y="5418"/>
                    <a:pt x="556" y="2615"/>
                    <a:pt x="1637" y="0"/>
                  </a:cubicBezTo>
                  <a:lnTo>
                    <a:pt x="21600" y="8249"/>
                  </a:lnTo>
                  <a:lnTo>
                    <a:pt x="88" y="10203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101"/>
            <p:cNvSpPr/>
            <p:nvPr/>
          </p:nvSpPr>
          <p:spPr>
            <a:xfrm flipH="1" flipV="1">
              <a:off x="843840" y="2160360"/>
              <a:ext cx="58680" cy="2376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Freeform 102"/>
            <p:cNvSpPr/>
            <p:nvPr/>
          </p:nvSpPr>
          <p:spPr>
            <a:xfrm>
              <a:off x="760320" y="2538360"/>
              <a:ext cx="115560" cy="56880"/>
            </a:xfrm>
            <a:custGeom>
              <a:avLst/>
              <a:gdLst>
                <a:gd name="textAreaLeft" fmla="*/ 0 w 115560"/>
                <a:gd name="textAreaRight" fmla="*/ 115920 w 11556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59" h="29">
                  <a:moveTo>
                    <a:pt x="46" y="2"/>
                  </a:moveTo>
                  <a:lnTo>
                    <a:pt x="59" y="0"/>
                  </a:lnTo>
                  <a:lnTo>
                    <a:pt x="32" y="29"/>
                  </a:lnTo>
                  <a:lnTo>
                    <a:pt x="0" y="6"/>
                  </a:lnTo>
                  <a:lnTo>
                    <a:pt x="13" y="5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103"/>
            <p:cNvSpPr/>
            <p:nvPr/>
          </p:nvSpPr>
          <p:spPr>
            <a:xfrm>
              <a:off x="738000" y="2350800"/>
              <a:ext cx="48960" cy="25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104"/>
            <p:cNvSpPr/>
            <p:nvPr/>
          </p:nvSpPr>
          <p:spPr>
            <a:xfrm>
              <a:off x="420840" y="2260440"/>
              <a:ext cx="277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Zeo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Freeform 105"/>
            <p:cNvSpPr/>
            <p:nvPr/>
          </p:nvSpPr>
          <p:spPr>
            <a:xfrm>
              <a:off x="836280" y="2085840"/>
              <a:ext cx="106200" cy="8568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67" h="54">
                  <a:moveTo>
                    <a:pt x="26" y="0"/>
                  </a:moveTo>
                  <a:lnTo>
                    <a:pt x="15" y="23"/>
                  </a:lnTo>
                  <a:lnTo>
                    <a:pt x="0" y="16"/>
                  </a:lnTo>
                  <a:lnTo>
                    <a:pt x="24" y="54"/>
                  </a:lnTo>
                  <a:lnTo>
                    <a:pt x="67" y="47"/>
                  </a:lnTo>
                  <a:lnTo>
                    <a:pt x="52" y="40"/>
                  </a:lnTo>
                  <a:lnTo>
                    <a:pt x="63" y="19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Arc 106"/>
            <p:cNvSpPr/>
            <p:nvPr/>
          </p:nvSpPr>
          <p:spPr>
            <a:xfrm>
              <a:off x="860400" y="2085840"/>
              <a:ext cx="741240" cy="387360"/>
            </a:xfrm>
            <a:custGeom>
              <a:avLst/>
              <a:gdLst>
                <a:gd name="textAreaLeft" fmla="*/ 0 w 741240"/>
                <a:gd name="textAreaRight" fmla="*/ 741600 w 74124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fill="none" w="19528" h="10183">
                  <a:moveTo>
                    <a:pt x="0" y="951"/>
                  </a:moveTo>
                  <a:cubicBezTo>
                    <a:pt x="151" y="630"/>
                    <a:pt x="311" y="313"/>
                    <a:pt x="478" y="-1"/>
                  </a:cubicBezTo>
                </a:path>
                <a:path stroke="0" w="19528" h="10183">
                  <a:moveTo>
                    <a:pt x="0" y="951"/>
                  </a:moveTo>
                  <a:cubicBezTo>
                    <a:pt x="151" y="630"/>
                    <a:pt x="311" y="313"/>
                    <a:pt x="478" y="-1"/>
                  </a:cubicBezTo>
                  <a:lnTo>
                    <a:pt x="19528" y="10183"/>
                  </a:lnTo>
                  <a:lnTo>
                    <a:pt x="0" y="95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Arc 107"/>
            <p:cNvSpPr/>
            <p:nvPr/>
          </p:nvSpPr>
          <p:spPr>
            <a:xfrm>
              <a:off x="919080" y="2116080"/>
              <a:ext cx="682560" cy="357120"/>
            </a:xfrm>
            <a:custGeom>
              <a:avLst/>
              <a:gdLst>
                <a:gd name="textAreaLeft" fmla="*/ 0 w 682560"/>
                <a:gd name="textAreaRight" fmla="*/ 682920 w 682560"/>
                <a:gd name="textAreaTop" fmla="*/ 0 h 357120"/>
                <a:gd name="textAreaBottom" fmla="*/ 357480 h 357120"/>
              </a:gdLst>
              <a:ahLst/>
              <a:rect l="textAreaLeft" t="textAreaTop" r="textAreaRight" b="textAreaBottom"/>
              <a:pathLst>
                <a:path fill="none" w="19519" h="10211">
                  <a:moveTo>
                    <a:pt x="-1" y="960"/>
                  </a:moveTo>
                  <a:cubicBezTo>
                    <a:pt x="153" y="636"/>
                    <a:pt x="315" y="316"/>
                    <a:pt x="484" y="-1"/>
                  </a:cubicBezTo>
                </a:path>
                <a:path stroke="0" w="19519" h="10211">
                  <a:moveTo>
                    <a:pt x="-1" y="960"/>
                  </a:moveTo>
                  <a:cubicBezTo>
                    <a:pt x="153" y="636"/>
                    <a:pt x="315" y="316"/>
                    <a:pt x="484" y="-1"/>
                  </a:cubicBezTo>
                  <a:lnTo>
                    <a:pt x="19519" y="10211"/>
                  </a:lnTo>
                  <a:lnTo>
                    <a:pt x="-1" y="96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108"/>
            <p:cNvSpPr/>
            <p:nvPr/>
          </p:nvSpPr>
          <p:spPr>
            <a:xfrm flipH="1" flipV="1">
              <a:off x="877320" y="2085480"/>
              <a:ext cx="5868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109"/>
            <p:cNvSpPr/>
            <p:nvPr/>
          </p:nvSpPr>
          <p:spPr>
            <a:xfrm>
              <a:off x="836280" y="2111040"/>
              <a:ext cx="106200" cy="6012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54" h="31">
                  <a:moveTo>
                    <a:pt x="42" y="20"/>
                  </a:moveTo>
                  <a:lnTo>
                    <a:pt x="54" y="25"/>
                  </a:lnTo>
                  <a:lnTo>
                    <a:pt x="19" y="31"/>
                  </a:lnTo>
                  <a:lnTo>
                    <a:pt x="0" y="0"/>
                  </a:lnTo>
                  <a:lnTo>
                    <a:pt x="12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110"/>
            <p:cNvSpPr/>
            <p:nvPr/>
          </p:nvSpPr>
          <p:spPr>
            <a:xfrm>
              <a:off x="799920" y="2085840"/>
              <a:ext cx="6012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111"/>
            <p:cNvSpPr/>
            <p:nvPr/>
          </p:nvSpPr>
          <p:spPr>
            <a:xfrm>
              <a:off x="181440" y="1963440"/>
              <a:ext cx="59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EM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 112"/>
            <p:cNvSpPr/>
            <p:nvPr/>
          </p:nvSpPr>
          <p:spPr>
            <a:xfrm>
              <a:off x="2163600" y="1925280"/>
              <a:ext cx="196560" cy="247680"/>
            </a:xfrm>
            <a:custGeom>
              <a:avLst/>
              <a:gdLst>
                <a:gd name="textAreaLeft" fmla="*/ 0 w 196560"/>
                <a:gd name="textAreaRight" fmla="*/ 196920 w 19656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w="124" h="156">
                  <a:moveTo>
                    <a:pt x="58" y="143"/>
                  </a:moveTo>
                  <a:lnTo>
                    <a:pt x="104" y="156"/>
                  </a:lnTo>
                  <a:lnTo>
                    <a:pt x="124" y="110"/>
                  </a:lnTo>
                  <a:lnTo>
                    <a:pt x="109" y="118"/>
                  </a:lnTo>
                  <a:lnTo>
                    <a:pt x="88" y="77"/>
                  </a:lnTo>
                  <a:lnTo>
                    <a:pt x="62" y="39"/>
                  </a:lnTo>
                  <a:lnTo>
                    <a:pt x="32" y="3"/>
                  </a:lnTo>
                  <a:lnTo>
                    <a:pt x="31" y="0"/>
                  </a:lnTo>
                  <a:lnTo>
                    <a:pt x="0" y="27"/>
                  </a:lnTo>
                  <a:lnTo>
                    <a:pt x="27" y="61"/>
                  </a:lnTo>
                  <a:lnTo>
                    <a:pt x="51" y="96"/>
                  </a:lnTo>
                  <a:lnTo>
                    <a:pt x="72" y="133"/>
                  </a:lnTo>
                  <a:lnTo>
                    <a:pt x="73" y="135"/>
                  </a:lnTo>
                  <a:lnTo>
                    <a:pt x="58" y="143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Arc 113"/>
            <p:cNvSpPr/>
            <p:nvPr/>
          </p:nvSpPr>
          <p:spPr>
            <a:xfrm>
              <a:off x="1601640" y="1925280"/>
              <a:ext cx="736560" cy="547560"/>
            </a:xfrm>
            <a:custGeom>
              <a:avLst/>
              <a:gdLst>
                <a:gd name="textAreaLeft" fmla="*/ 0 w 736560"/>
                <a:gd name="textAreaRight" fmla="*/ 736920 w 736560"/>
                <a:gd name="textAreaTop" fmla="*/ 0 h 547560"/>
                <a:gd name="textAreaBottom" fmla="*/ 547920 h 547560"/>
              </a:gdLst>
              <a:ahLst/>
              <a:rect l="textAreaLeft" t="textAreaTop" r="textAreaRight" b="textAreaBottom"/>
              <a:pathLst>
                <a:path fill="none" w="19398" h="14407">
                  <a:moveTo>
                    <a:pt x="16093" y="-1"/>
                  </a:moveTo>
                  <a:cubicBezTo>
                    <a:pt x="17414" y="1475"/>
                    <a:pt x="18526" y="3126"/>
                    <a:pt x="19398" y="4905"/>
                  </a:cubicBezTo>
                </a:path>
                <a:path stroke="0" w="19398" h="14407">
                  <a:moveTo>
                    <a:pt x="16093" y="-1"/>
                  </a:moveTo>
                  <a:cubicBezTo>
                    <a:pt x="17414" y="1475"/>
                    <a:pt x="18526" y="3126"/>
                    <a:pt x="19398" y="4905"/>
                  </a:cubicBezTo>
                  <a:lnTo>
                    <a:pt x="0" y="14407"/>
                  </a:lnTo>
                  <a:lnTo>
                    <a:pt x="16093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Arc 114"/>
            <p:cNvSpPr/>
            <p:nvPr/>
          </p:nvSpPr>
          <p:spPr>
            <a:xfrm>
              <a:off x="1601640" y="1968120"/>
              <a:ext cx="677880" cy="504720"/>
            </a:xfrm>
            <a:custGeom>
              <a:avLst/>
              <a:gdLst>
                <a:gd name="textAreaLeft" fmla="*/ 0 w 677880"/>
                <a:gd name="textAreaRight" fmla="*/ 678240 w 677880"/>
                <a:gd name="textAreaTop" fmla="*/ 0 h 504720"/>
                <a:gd name="textAreaBottom" fmla="*/ 505080 h 504720"/>
              </a:gdLst>
              <a:ahLst/>
              <a:rect l="textAreaLeft" t="textAreaTop" r="textAreaRight" b="textAreaBottom"/>
              <a:pathLst>
                <a:path fill="none" w="19387" h="14426">
                  <a:moveTo>
                    <a:pt x="16076" y="-1"/>
                  </a:moveTo>
                  <a:cubicBezTo>
                    <a:pt x="17399" y="1474"/>
                    <a:pt x="18513" y="3123"/>
                    <a:pt x="19386" y="4902"/>
                  </a:cubicBezTo>
                </a:path>
                <a:path stroke="0" w="19387" h="14426">
                  <a:moveTo>
                    <a:pt x="16076" y="-1"/>
                  </a:moveTo>
                  <a:cubicBezTo>
                    <a:pt x="17399" y="1474"/>
                    <a:pt x="18513" y="3123"/>
                    <a:pt x="19386" y="4902"/>
                  </a:cubicBezTo>
                  <a:lnTo>
                    <a:pt x="0" y="14426"/>
                  </a:lnTo>
                  <a:lnTo>
                    <a:pt x="16076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115"/>
            <p:cNvSpPr/>
            <p:nvPr/>
          </p:nvSpPr>
          <p:spPr>
            <a:xfrm flipV="1">
              <a:off x="2163600" y="1924920"/>
              <a:ext cx="48960" cy="4284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Freeform 116"/>
            <p:cNvSpPr/>
            <p:nvPr/>
          </p:nvSpPr>
          <p:spPr>
            <a:xfrm>
              <a:off x="2255760" y="2099880"/>
              <a:ext cx="104760" cy="7272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72720"/>
                <a:gd name="textAreaBottom" fmla="*/ 73080 h 72720"/>
              </a:gdLst>
              <a:ahLst/>
              <a:rect l="textAreaLeft" t="textAreaTop" r="textAreaRight" b="textAreaBottom"/>
              <a:pathLst>
                <a:path w="53" h="37">
                  <a:moveTo>
                    <a:pt x="12" y="20"/>
                  </a:moveTo>
                  <a:lnTo>
                    <a:pt x="0" y="26"/>
                  </a:lnTo>
                  <a:lnTo>
                    <a:pt x="37" y="37"/>
                  </a:lnTo>
                  <a:lnTo>
                    <a:pt x="53" y="0"/>
                  </a:lnTo>
                  <a:lnTo>
                    <a:pt x="41" y="6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117"/>
            <p:cNvSpPr/>
            <p:nvPr/>
          </p:nvSpPr>
          <p:spPr>
            <a:xfrm flipH="1">
              <a:off x="2295360" y="2025360"/>
              <a:ext cx="5076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118"/>
            <p:cNvSpPr/>
            <p:nvPr/>
          </p:nvSpPr>
          <p:spPr>
            <a:xfrm>
              <a:off x="2351880" y="193500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P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Freeform 119"/>
            <p:cNvSpPr/>
            <p:nvPr/>
          </p:nvSpPr>
          <p:spPr>
            <a:xfrm>
              <a:off x="828360" y="2724120"/>
              <a:ext cx="174600" cy="242640"/>
            </a:xfrm>
            <a:custGeom>
              <a:avLst/>
              <a:gdLst>
                <a:gd name="textAreaLeft" fmla="*/ 0 w 174600"/>
                <a:gd name="textAreaRight" fmla="*/ 174960 w 174600"/>
                <a:gd name="textAreaTop" fmla="*/ 0 h 242640"/>
                <a:gd name="textAreaBottom" fmla="*/ 243000 h 242640"/>
              </a:gdLst>
              <a:ahLst/>
              <a:rect l="textAreaLeft" t="textAreaTop" r="textAreaRight" b="textAreaBottom"/>
              <a:pathLst>
                <a:path w="110" h="153">
                  <a:moveTo>
                    <a:pt x="0" y="14"/>
                  </a:moveTo>
                  <a:lnTo>
                    <a:pt x="16" y="56"/>
                  </a:lnTo>
                  <a:lnTo>
                    <a:pt x="37" y="97"/>
                  </a:lnTo>
                  <a:lnTo>
                    <a:pt x="62" y="137"/>
                  </a:lnTo>
                  <a:lnTo>
                    <a:pt x="65" y="139"/>
                  </a:lnTo>
                  <a:lnTo>
                    <a:pt x="51" y="148"/>
                  </a:lnTo>
                  <a:lnTo>
                    <a:pt x="101" y="153"/>
                  </a:lnTo>
                  <a:lnTo>
                    <a:pt x="110" y="106"/>
                  </a:lnTo>
                  <a:lnTo>
                    <a:pt x="98" y="116"/>
                  </a:lnTo>
                  <a:lnTo>
                    <a:pt x="75" y="80"/>
                  </a:lnTo>
                  <a:lnTo>
                    <a:pt x="55" y="41"/>
                  </a:lnTo>
                  <a:lnTo>
                    <a:pt x="39" y="2"/>
                  </a:lnTo>
                  <a:lnTo>
                    <a:pt x="39" y="0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Arc 120"/>
            <p:cNvSpPr/>
            <p:nvPr/>
          </p:nvSpPr>
          <p:spPr>
            <a:xfrm>
              <a:off x="828360" y="2473200"/>
              <a:ext cx="772920" cy="471240"/>
            </a:xfrm>
            <a:custGeom>
              <a:avLst/>
              <a:gdLst>
                <a:gd name="textAreaLeft" fmla="*/ 0 w 772920"/>
                <a:gd name="textAreaRight" fmla="*/ 773280 w 772920"/>
                <a:gd name="textAreaTop" fmla="*/ 0 h 471240"/>
                <a:gd name="textAreaBottom" fmla="*/ 471600 h 471240"/>
              </a:gdLst>
              <a:ahLst/>
              <a:rect l="textAreaLeft" t="textAreaTop" r="textAreaRight" b="textAreaBottom"/>
              <a:pathLst>
                <a:path fill="none" w="20369" h="12424">
                  <a:moveTo>
                    <a:pt x="2699" y="12423"/>
                  </a:moveTo>
                  <a:cubicBezTo>
                    <a:pt x="1564" y="10809"/>
                    <a:pt x="656" y="9047"/>
                    <a:pt x="-1" y="7187"/>
                  </a:cubicBezTo>
                </a:path>
                <a:path stroke="0" w="20369" h="12424">
                  <a:moveTo>
                    <a:pt x="2699" y="12423"/>
                  </a:moveTo>
                  <a:cubicBezTo>
                    <a:pt x="1564" y="10809"/>
                    <a:pt x="656" y="9047"/>
                    <a:pt x="-1" y="7187"/>
                  </a:cubicBezTo>
                  <a:lnTo>
                    <a:pt x="20369" y="0"/>
                  </a:lnTo>
                  <a:lnTo>
                    <a:pt x="2699" y="12423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Arc 121"/>
            <p:cNvSpPr/>
            <p:nvPr/>
          </p:nvSpPr>
          <p:spPr>
            <a:xfrm>
              <a:off x="890280" y="2473200"/>
              <a:ext cx="711000" cy="434880"/>
            </a:xfrm>
            <a:custGeom>
              <a:avLst/>
              <a:gdLst>
                <a:gd name="textAreaLeft" fmla="*/ 0 w 711000"/>
                <a:gd name="textAreaRight" fmla="*/ 711360 w 711000"/>
                <a:gd name="textAreaTop" fmla="*/ 0 h 434880"/>
                <a:gd name="textAreaBottom" fmla="*/ 435240 h 434880"/>
              </a:gdLst>
              <a:ahLst/>
              <a:rect l="textAreaLeft" t="textAreaTop" r="textAreaRight" b="textAreaBottom"/>
              <a:pathLst>
                <a:path fill="none" w="20373" h="12430">
                  <a:moveTo>
                    <a:pt x="2707" y="12430"/>
                  </a:moveTo>
                  <a:cubicBezTo>
                    <a:pt x="1568" y="10811"/>
                    <a:pt x="657" y="9043"/>
                    <a:pt x="0" y="7176"/>
                  </a:cubicBezTo>
                </a:path>
                <a:path stroke="0" w="20373" h="12430">
                  <a:moveTo>
                    <a:pt x="2707" y="12430"/>
                  </a:moveTo>
                  <a:cubicBezTo>
                    <a:pt x="1568" y="10811"/>
                    <a:pt x="657" y="9043"/>
                    <a:pt x="0" y="7176"/>
                  </a:cubicBezTo>
                  <a:lnTo>
                    <a:pt x="20373" y="0"/>
                  </a:lnTo>
                  <a:lnTo>
                    <a:pt x="2707" y="1243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22"/>
            <p:cNvSpPr/>
            <p:nvPr/>
          </p:nvSpPr>
          <p:spPr>
            <a:xfrm flipH="1">
              <a:off x="828360" y="2724120"/>
              <a:ext cx="61920" cy="2196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123"/>
            <p:cNvSpPr/>
            <p:nvPr/>
          </p:nvSpPr>
          <p:spPr>
            <a:xfrm>
              <a:off x="909360" y="2892240"/>
              <a:ext cx="93600" cy="74520"/>
            </a:xfrm>
            <a:custGeom>
              <a:avLst/>
              <a:gdLst>
                <a:gd name="textAreaLeft" fmla="*/ 0 w 93600"/>
                <a:gd name="textAreaRight" fmla="*/ 93960 w 9360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48" h="38">
                  <a:moveTo>
                    <a:pt x="38" y="8"/>
                  </a:moveTo>
                  <a:lnTo>
                    <a:pt x="48" y="0"/>
                  </a:lnTo>
                  <a:lnTo>
                    <a:pt x="40" y="38"/>
                  </a:lnTo>
                  <a:lnTo>
                    <a:pt x="0" y="34"/>
                  </a:lnTo>
                  <a:lnTo>
                    <a:pt x="11" y="27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124"/>
            <p:cNvSpPr/>
            <p:nvPr/>
          </p:nvSpPr>
          <p:spPr>
            <a:xfrm>
              <a:off x="860400" y="2870280"/>
              <a:ext cx="252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125"/>
            <p:cNvSpPr/>
            <p:nvPr/>
          </p:nvSpPr>
          <p:spPr>
            <a:xfrm>
              <a:off x="616320" y="283212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P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9" name="AutoShape 362"/>
          <p:cNvSpPr/>
          <p:nvPr/>
        </p:nvSpPr>
        <p:spPr>
          <a:xfrm>
            <a:off x="6804000" y="1727280"/>
            <a:ext cx="1920960" cy="1977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0" name="Group 319"/>
          <p:cNvGrpSpPr/>
          <p:nvPr/>
        </p:nvGrpSpPr>
        <p:grpSpPr>
          <a:xfrm>
            <a:off x="3489480" y="3213000"/>
            <a:ext cx="2389680" cy="1766880"/>
            <a:chOff x="3489480" y="3213000"/>
            <a:chExt cx="2389680" cy="1766880"/>
          </a:xfrm>
        </p:grpSpPr>
        <p:sp>
          <p:nvSpPr>
            <p:cNvPr id="351" name="AutoShape 318"/>
            <p:cNvSpPr/>
            <p:nvPr/>
          </p:nvSpPr>
          <p:spPr>
            <a:xfrm>
              <a:off x="3492360" y="3213000"/>
              <a:ext cx="2303640" cy="1766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320"/>
            <p:cNvSpPr/>
            <p:nvPr/>
          </p:nvSpPr>
          <p:spPr>
            <a:xfrm>
              <a:off x="3892320" y="3362040"/>
              <a:ext cx="1576440" cy="1573200"/>
            </a:xfrm>
            <a:custGeom>
              <a:avLst/>
              <a:gdLst>
                <a:gd name="textAreaLeft" fmla="*/ 0 w 1576440"/>
                <a:gd name="textAreaRight" fmla="*/ 1576800 w 1576440"/>
                <a:gd name="textAreaTop" fmla="*/ 0 h 1573200"/>
                <a:gd name="textAreaBottom" fmla="*/ 1573560 h 1573200"/>
              </a:gdLst>
              <a:ahLst/>
              <a:rect l="textAreaLeft" t="textAreaTop" r="textAreaRight" b="textAreaBottom"/>
              <a:pathLst>
                <a:path w="993" h="991">
                  <a:moveTo>
                    <a:pt x="501" y="0"/>
                  </a:moveTo>
                  <a:lnTo>
                    <a:pt x="456" y="1"/>
                  </a:lnTo>
                  <a:lnTo>
                    <a:pt x="411" y="6"/>
                  </a:lnTo>
                  <a:lnTo>
                    <a:pt x="369" y="16"/>
                  </a:lnTo>
                  <a:lnTo>
                    <a:pt x="326" y="29"/>
                  </a:lnTo>
                  <a:lnTo>
                    <a:pt x="285" y="46"/>
                  </a:lnTo>
                  <a:lnTo>
                    <a:pt x="246" y="67"/>
                  </a:lnTo>
                  <a:lnTo>
                    <a:pt x="209" y="91"/>
                  </a:lnTo>
                  <a:lnTo>
                    <a:pt x="174" y="118"/>
                  </a:lnTo>
                  <a:lnTo>
                    <a:pt x="141" y="148"/>
                  </a:lnTo>
                  <a:lnTo>
                    <a:pt x="112" y="181"/>
                  </a:lnTo>
                  <a:lnTo>
                    <a:pt x="85" y="217"/>
                  </a:lnTo>
                  <a:lnTo>
                    <a:pt x="62" y="255"/>
                  </a:lnTo>
                  <a:lnTo>
                    <a:pt x="42" y="294"/>
                  </a:lnTo>
                  <a:lnTo>
                    <a:pt x="26" y="336"/>
                  </a:lnTo>
                  <a:lnTo>
                    <a:pt x="14" y="378"/>
                  </a:lnTo>
                  <a:lnTo>
                    <a:pt x="5" y="423"/>
                  </a:lnTo>
                  <a:lnTo>
                    <a:pt x="1" y="466"/>
                  </a:lnTo>
                  <a:lnTo>
                    <a:pt x="0" y="511"/>
                  </a:lnTo>
                  <a:lnTo>
                    <a:pt x="3" y="554"/>
                  </a:lnTo>
                  <a:lnTo>
                    <a:pt x="11" y="599"/>
                  </a:lnTo>
                  <a:lnTo>
                    <a:pt x="21" y="641"/>
                  </a:lnTo>
                  <a:lnTo>
                    <a:pt x="37" y="684"/>
                  </a:lnTo>
                  <a:lnTo>
                    <a:pt x="55" y="724"/>
                  </a:lnTo>
                  <a:lnTo>
                    <a:pt x="77" y="762"/>
                  </a:lnTo>
                  <a:lnTo>
                    <a:pt x="103" y="798"/>
                  </a:lnTo>
                  <a:lnTo>
                    <a:pt x="131" y="831"/>
                  </a:lnTo>
                  <a:lnTo>
                    <a:pt x="163" y="863"/>
                  </a:lnTo>
                  <a:lnTo>
                    <a:pt x="197" y="891"/>
                  </a:lnTo>
                  <a:lnTo>
                    <a:pt x="234" y="916"/>
                  </a:lnTo>
                  <a:lnTo>
                    <a:pt x="273" y="938"/>
                  </a:lnTo>
                  <a:lnTo>
                    <a:pt x="313" y="956"/>
                  </a:lnTo>
                  <a:lnTo>
                    <a:pt x="355" y="971"/>
                  </a:lnTo>
                  <a:lnTo>
                    <a:pt x="398" y="981"/>
                  </a:lnTo>
                  <a:lnTo>
                    <a:pt x="442" y="988"/>
                  </a:lnTo>
                  <a:lnTo>
                    <a:pt x="486" y="991"/>
                  </a:lnTo>
                  <a:lnTo>
                    <a:pt x="531" y="990"/>
                  </a:lnTo>
                  <a:lnTo>
                    <a:pt x="575" y="985"/>
                  </a:lnTo>
                  <a:lnTo>
                    <a:pt x="618" y="976"/>
                  </a:lnTo>
                  <a:lnTo>
                    <a:pt x="661" y="963"/>
                  </a:lnTo>
                  <a:lnTo>
                    <a:pt x="702" y="947"/>
                  </a:lnTo>
                  <a:lnTo>
                    <a:pt x="741" y="926"/>
                  </a:lnTo>
                  <a:lnTo>
                    <a:pt x="779" y="902"/>
                  </a:lnTo>
                  <a:lnTo>
                    <a:pt x="814" y="876"/>
                  </a:lnTo>
                  <a:lnTo>
                    <a:pt x="847" y="846"/>
                  </a:lnTo>
                  <a:lnTo>
                    <a:pt x="878" y="813"/>
                  </a:lnTo>
                  <a:lnTo>
                    <a:pt x="905" y="778"/>
                  </a:lnTo>
                  <a:lnTo>
                    <a:pt x="928" y="740"/>
                  </a:lnTo>
                  <a:lnTo>
                    <a:pt x="948" y="701"/>
                  </a:lnTo>
                  <a:lnTo>
                    <a:pt x="965" y="660"/>
                  </a:lnTo>
                  <a:lnTo>
                    <a:pt x="978" y="617"/>
                  </a:lnTo>
                  <a:lnTo>
                    <a:pt x="986" y="574"/>
                  </a:lnTo>
                  <a:lnTo>
                    <a:pt x="992" y="530"/>
                  </a:lnTo>
                  <a:lnTo>
                    <a:pt x="993" y="486"/>
                  </a:lnTo>
                  <a:lnTo>
                    <a:pt x="990" y="441"/>
                  </a:lnTo>
                  <a:lnTo>
                    <a:pt x="983" y="398"/>
                  </a:lnTo>
                  <a:lnTo>
                    <a:pt x="972" y="354"/>
                  </a:lnTo>
                  <a:lnTo>
                    <a:pt x="958" y="313"/>
                  </a:lnTo>
                  <a:lnTo>
                    <a:pt x="940" y="272"/>
                  </a:lnTo>
                  <a:lnTo>
                    <a:pt x="918" y="233"/>
                  </a:lnTo>
                  <a:lnTo>
                    <a:pt x="893" y="196"/>
                  </a:lnTo>
                  <a:lnTo>
                    <a:pt x="864" y="163"/>
                  </a:lnTo>
                  <a:lnTo>
                    <a:pt x="833" y="131"/>
                  </a:lnTo>
                  <a:lnTo>
                    <a:pt x="799" y="103"/>
                  </a:lnTo>
                  <a:lnTo>
                    <a:pt x="763" y="77"/>
                  </a:lnTo>
                  <a:lnTo>
                    <a:pt x="725" y="55"/>
                  </a:lnTo>
                  <a:lnTo>
                    <a:pt x="685" y="36"/>
                  </a:lnTo>
                  <a:lnTo>
                    <a:pt x="642" y="21"/>
                  </a:lnTo>
                  <a:lnTo>
                    <a:pt x="600" y="10"/>
                  </a:lnTo>
                  <a:lnTo>
                    <a:pt x="555" y="3"/>
                  </a:lnTo>
                  <a:lnTo>
                    <a:pt x="512" y="0"/>
                  </a:lnTo>
                  <a:lnTo>
                    <a:pt x="502" y="0"/>
                  </a:lnTo>
                  <a:lnTo>
                    <a:pt x="501" y="10"/>
                  </a:lnTo>
                  <a:lnTo>
                    <a:pt x="544" y="13"/>
                  </a:lnTo>
                  <a:lnTo>
                    <a:pt x="588" y="18"/>
                  </a:lnTo>
                  <a:lnTo>
                    <a:pt x="630" y="29"/>
                  </a:lnTo>
                  <a:lnTo>
                    <a:pt x="671" y="42"/>
                  </a:lnTo>
                  <a:lnTo>
                    <a:pt x="711" y="59"/>
                  </a:lnTo>
                  <a:lnTo>
                    <a:pt x="749" y="81"/>
                  </a:lnTo>
                  <a:lnTo>
                    <a:pt x="785" y="105"/>
                  </a:lnTo>
                  <a:lnTo>
                    <a:pt x="819" y="132"/>
                  </a:lnTo>
                  <a:lnTo>
                    <a:pt x="850" y="163"/>
                  </a:lnTo>
                  <a:lnTo>
                    <a:pt x="879" y="195"/>
                  </a:lnTo>
                  <a:lnTo>
                    <a:pt x="904" y="231"/>
                  </a:lnTo>
                  <a:lnTo>
                    <a:pt x="925" y="268"/>
                  </a:lnTo>
                  <a:lnTo>
                    <a:pt x="944" y="307"/>
                  </a:lnTo>
                  <a:lnTo>
                    <a:pt x="959" y="348"/>
                  </a:lnTo>
                  <a:lnTo>
                    <a:pt x="971" y="390"/>
                  </a:lnTo>
                  <a:lnTo>
                    <a:pt x="978" y="432"/>
                  </a:lnTo>
                  <a:lnTo>
                    <a:pt x="982" y="476"/>
                  </a:lnTo>
                  <a:lnTo>
                    <a:pt x="982" y="519"/>
                  </a:lnTo>
                  <a:lnTo>
                    <a:pt x="978" y="563"/>
                  </a:lnTo>
                  <a:lnTo>
                    <a:pt x="970" y="605"/>
                  </a:lnTo>
                  <a:lnTo>
                    <a:pt x="958" y="647"/>
                  </a:lnTo>
                  <a:lnTo>
                    <a:pt x="943" y="688"/>
                  </a:lnTo>
                  <a:lnTo>
                    <a:pt x="923" y="727"/>
                  </a:lnTo>
                  <a:lnTo>
                    <a:pt x="901" y="764"/>
                  </a:lnTo>
                  <a:lnTo>
                    <a:pt x="875" y="799"/>
                  </a:lnTo>
                  <a:lnTo>
                    <a:pt x="847" y="831"/>
                  </a:lnTo>
                  <a:lnTo>
                    <a:pt x="815" y="862"/>
                  </a:lnTo>
                  <a:lnTo>
                    <a:pt x="782" y="888"/>
                  </a:lnTo>
                  <a:lnTo>
                    <a:pt x="745" y="912"/>
                  </a:lnTo>
                  <a:lnTo>
                    <a:pt x="707" y="933"/>
                  </a:lnTo>
                  <a:lnTo>
                    <a:pt x="666" y="950"/>
                  </a:lnTo>
                  <a:lnTo>
                    <a:pt x="625" y="963"/>
                  </a:lnTo>
                  <a:lnTo>
                    <a:pt x="583" y="973"/>
                  </a:lnTo>
                  <a:lnTo>
                    <a:pt x="540" y="978"/>
                  </a:lnTo>
                  <a:lnTo>
                    <a:pt x="496" y="980"/>
                  </a:lnTo>
                  <a:lnTo>
                    <a:pt x="453" y="978"/>
                  </a:lnTo>
                  <a:lnTo>
                    <a:pt x="410" y="973"/>
                  </a:lnTo>
                  <a:lnTo>
                    <a:pt x="368" y="963"/>
                  </a:lnTo>
                  <a:lnTo>
                    <a:pt x="326" y="950"/>
                  </a:lnTo>
                  <a:lnTo>
                    <a:pt x="286" y="933"/>
                  </a:lnTo>
                  <a:lnTo>
                    <a:pt x="248" y="913"/>
                  </a:lnTo>
                  <a:lnTo>
                    <a:pt x="211" y="889"/>
                  </a:lnTo>
                  <a:lnTo>
                    <a:pt x="177" y="862"/>
                  </a:lnTo>
                  <a:lnTo>
                    <a:pt x="146" y="831"/>
                  </a:lnTo>
                  <a:lnTo>
                    <a:pt x="117" y="799"/>
                  </a:lnTo>
                  <a:lnTo>
                    <a:pt x="91" y="764"/>
                  </a:lnTo>
                  <a:lnTo>
                    <a:pt x="69" y="727"/>
                  </a:lnTo>
                  <a:lnTo>
                    <a:pt x="50" y="688"/>
                  </a:lnTo>
                  <a:lnTo>
                    <a:pt x="34" y="648"/>
                  </a:lnTo>
                  <a:lnTo>
                    <a:pt x="22" y="605"/>
                  </a:lnTo>
                  <a:lnTo>
                    <a:pt x="15" y="563"/>
                  </a:lnTo>
                  <a:lnTo>
                    <a:pt x="11" y="520"/>
                  </a:lnTo>
                  <a:lnTo>
                    <a:pt x="11" y="477"/>
                  </a:lnTo>
                  <a:lnTo>
                    <a:pt x="14" y="433"/>
                  </a:lnTo>
                  <a:lnTo>
                    <a:pt x="21" y="391"/>
                  </a:lnTo>
                  <a:lnTo>
                    <a:pt x="32" y="349"/>
                  </a:lnTo>
                  <a:lnTo>
                    <a:pt x="48" y="308"/>
                  </a:lnTo>
                  <a:lnTo>
                    <a:pt x="66" y="268"/>
                  </a:lnTo>
                  <a:lnTo>
                    <a:pt x="88" y="231"/>
                  </a:lnTo>
                  <a:lnTo>
                    <a:pt x="113" y="196"/>
                  </a:lnTo>
                  <a:lnTo>
                    <a:pt x="141" y="163"/>
                  </a:lnTo>
                  <a:lnTo>
                    <a:pt x="173" y="132"/>
                  </a:lnTo>
                  <a:lnTo>
                    <a:pt x="207" y="105"/>
                  </a:lnTo>
                  <a:lnTo>
                    <a:pt x="243" y="81"/>
                  </a:lnTo>
                  <a:lnTo>
                    <a:pt x="281" y="60"/>
                  </a:lnTo>
                  <a:lnTo>
                    <a:pt x="321" y="43"/>
                  </a:lnTo>
                  <a:lnTo>
                    <a:pt x="361" y="29"/>
                  </a:lnTo>
                  <a:lnTo>
                    <a:pt x="404" y="19"/>
                  </a:lnTo>
                  <a:lnTo>
                    <a:pt x="447" y="13"/>
                  </a:lnTo>
                  <a:lnTo>
                    <a:pt x="491" y="9"/>
                  </a:lnTo>
                  <a:lnTo>
                    <a:pt x="501" y="10"/>
                  </a:lnTo>
                  <a:lnTo>
                    <a:pt x="501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Oval 321"/>
            <p:cNvSpPr/>
            <p:nvPr/>
          </p:nvSpPr>
          <p:spPr>
            <a:xfrm>
              <a:off x="3892320" y="3362040"/>
              <a:ext cx="1570320" cy="156708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Oval 322"/>
            <p:cNvSpPr/>
            <p:nvPr/>
          </p:nvSpPr>
          <p:spPr>
            <a:xfrm>
              <a:off x="3909960" y="3377880"/>
              <a:ext cx="1535040" cy="153360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323"/>
            <p:cNvSpPr/>
            <p:nvPr/>
          </p:nvSpPr>
          <p:spPr>
            <a:xfrm flipV="1">
              <a:off x="4687920" y="336204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324"/>
            <p:cNvSpPr/>
            <p:nvPr/>
          </p:nvSpPr>
          <p:spPr>
            <a:xfrm>
              <a:off x="4480560" y="4022640"/>
              <a:ext cx="50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K2GW7,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325"/>
            <p:cNvSpPr/>
            <p:nvPr/>
          </p:nvSpPr>
          <p:spPr>
            <a:xfrm>
              <a:off x="4505400" y="415584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1135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Freeform 326"/>
            <p:cNvSpPr/>
            <p:nvPr/>
          </p:nvSpPr>
          <p:spPr>
            <a:xfrm>
              <a:off x="5151240" y="3517560"/>
              <a:ext cx="338400" cy="579600"/>
            </a:xfrm>
            <a:custGeom>
              <a:avLst/>
              <a:gdLst>
                <a:gd name="textAreaLeft" fmla="*/ 0 w 338400"/>
                <a:gd name="textAreaRight" fmla="*/ 338400 w 338400"/>
                <a:gd name="textAreaTop" fmla="*/ 0 h 579600"/>
                <a:gd name="textAreaBottom" fmla="*/ 579960 h 579600"/>
              </a:gdLst>
              <a:ahLst/>
              <a:rect l="textAreaLeft" t="textAreaTop" r="textAreaRight" b="textAreaBottom"/>
              <a:pathLst>
                <a:path w="213" h="365">
                  <a:moveTo>
                    <a:pt x="213" y="362"/>
                  </a:moveTo>
                  <a:lnTo>
                    <a:pt x="209" y="317"/>
                  </a:lnTo>
                  <a:lnTo>
                    <a:pt x="199" y="272"/>
                  </a:lnTo>
                  <a:lnTo>
                    <a:pt x="186" y="228"/>
                  </a:lnTo>
                  <a:lnTo>
                    <a:pt x="168" y="185"/>
                  </a:lnTo>
                  <a:lnTo>
                    <a:pt x="148" y="145"/>
                  </a:lnTo>
                  <a:lnTo>
                    <a:pt x="124" y="106"/>
                  </a:lnTo>
                  <a:lnTo>
                    <a:pt x="97" y="70"/>
                  </a:lnTo>
                  <a:lnTo>
                    <a:pt x="65" y="36"/>
                  </a:lnTo>
                  <a:lnTo>
                    <a:pt x="31" y="6"/>
                  </a:lnTo>
                  <a:lnTo>
                    <a:pt x="26" y="0"/>
                  </a:lnTo>
                  <a:lnTo>
                    <a:pt x="0" y="32"/>
                  </a:lnTo>
                  <a:lnTo>
                    <a:pt x="31" y="60"/>
                  </a:lnTo>
                  <a:lnTo>
                    <a:pt x="61" y="91"/>
                  </a:lnTo>
                  <a:lnTo>
                    <a:pt x="87" y="123"/>
                  </a:lnTo>
                  <a:lnTo>
                    <a:pt x="110" y="159"/>
                  </a:lnTo>
                  <a:lnTo>
                    <a:pt x="129" y="196"/>
                  </a:lnTo>
                  <a:lnTo>
                    <a:pt x="146" y="235"/>
                  </a:lnTo>
                  <a:lnTo>
                    <a:pt x="159" y="276"/>
                  </a:lnTo>
                  <a:lnTo>
                    <a:pt x="167" y="316"/>
                  </a:lnTo>
                  <a:lnTo>
                    <a:pt x="173" y="358"/>
                  </a:lnTo>
                  <a:lnTo>
                    <a:pt x="173" y="365"/>
                  </a:lnTo>
                  <a:lnTo>
                    <a:pt x="213" y="362"/>
                  </a:lnTo>
                  <a:close/>
                </a:path>
              </a:pathLst>
            </a:custGeom>
            <a:solidFill>
              <a:srgbClr val="ff33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Arc 327"/>
            <p:cNvSpPr/>
            <p:nvPr/>
          </p:nvSpPr>
          <p:spPr>
            <a:xfrm>
              <a:off x="4676760" y="3520800"/>
              <a:ext cx="806400" cy="623880"/>
            </a:xfrm>
            <a:custGeom>
              <a:avLst/>
              <a:gdLst>
                <a:gd name="textAreaLeft" fmla="*/ 0 w 806400"/>
                <a:gd name="textAreaRight" fmla="*/ 806760 w 806400"/>
                <a:gd name="textAreaTop" fmla="*/ 0 h 623880"/>
                <a:gd name="textAreaBottom" fmla="*/ 624240 h 623880"/>
              </a:gdLst>
              <a:ahLst/>
              <a:rect l="textAreaLeft" t="textAreaTop" r="textAreaRight" b="textAreaBottom"/>
              <a:pathLst>
                <a:path fill="none" w="21555" h="16693">
                  <a:moveTo>
                    <a:pt x="13707" y="0"/>
                  </a:moveTo>
                  <a:cubicBezTo>
                    <a:pt x="18328" y="3794"/>
                    <a:pt x="21169" y="9334"/>
                    <a:pt x="21555" y="15300"/>
                  </a:cubicBezTo>
                </a:path>
                <a:path stroke="0" w="21555" h="16693">
                  <a:moveTo>
                    <a:pt x="13707" y="0"/>
                  </a:moveTo>
                  <a:cubicBezTo>
                    <a:pt x="18328" y="3794"/>
                    <a:pt x="21169" y="9334"/>
                    <a:pt x="21555" y="15300"/>
                  </a:cubicBezTo>
                  <a:lnTo>
                    <a:pt x="0" y="16693"/>
                  </a:lnTo>
                  <a:lnTo>
                    <a:pt x="1370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Arc 328"/>
            <p:cNvSpPr/>
            <p:nvPr/>
          </p:nvSpPr>
          <p:spPr>
            <a:xfrm>
              <a:off x="4676760" y="3571560"/>
              <a:ext cx="743040" cy="573120"/>
            </a:xfrm>
            <a:custGeom>
              <a:avLst/>
              <a:gdLst>
                <a:gd name="textAreaLeft" fmla="*/ 0 w 743040"/>
                <a:gd name="textAreaRight" fmla="*/ 743400 w 743040"/>
                <a:gd name="textAreaTop" fmla="*/ 0 h 573120"/>
                <a:gd name="textAreaBottom" fmla="*/ 573480 h 573120"/>
              </a:gdLst>
              <a:ahLst/>
              <a:rect l="textAreaLeft" t="textAreaTop" r="textAreaRight" b="textAreaBottom"/>
              <a:pathLst>
                <a:path fill="none" w="21556" h="16680">
                  <a:moveTo>
                    <a:pt x="13723" y="0"/>
                  </a:moveTo>
                  <a:cubicBezTo>
                    <a:pt x="18340" y="3798"/>
                    <a:pt x="21176" y="9341"/>
                    <a:pt x="21556" y="15307"/>
                  </a:cubicBezTo>
                </a:path>
                <a:path stroke="0" w="21556" h="16680">
                  <a:moveTo>
                    <a:pt x="13723" y="0"/>
                  </a:moveTo>
                  <a:cubicBezTo>
                    <a:pt x="18340" y="3798"/>
                    <a:pt x="21176" y="9341"/>
                    <a:pt x="21556" y="15307"/>
                  </a:cubicBezTo>
                  <a:lnTo>
                    <a:pt x="0" y="16680"/>
                  </a:lnTo>
                  <a:lnTo>
                    <a:pt x="1372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29"/>
            <p:cNvSpPr/>
            <p:nvPr/>
          </p:nvSpPr>
          <p:spPr>
            <a:xfrm flipV="1">
              <a:off x="5425920" y="4092120"/>
              <a:ext cx="6372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30"/>
            <p:cNvSpPr/>
            <p:nvPr/>
          </p:nvSpPr>
          <p:spPr>
            <a:xfrm flipV="1">
              <a:off x="5151240" y="3517200"/>
              <a:ext cx="4140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31"/>
            <p:cNvSpPr/>
            <p:nvPr/>
          </p:nvSpPr>
          <p:spPr>
            <a:xfrm flipH="1">
              <a:off x="5402160" y="3714480"/>
              <a:ext cx="55440" cy="586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332"/>
            <p:cNvSpPr/>
            <p:nvPr/>
          </p:nvSpPr>
          <p:spPr>
            <a:xfrm>
              <a:off x="5427360" y="3625560"/>
              <a:ext cx="451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CmR-ccd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Freeform 333"/>
            <p:cNvSpPr/>
            <p:nvPr/>
          </p:nvSpPr>
          <p:spPr>
            <a:xfrm>
              <a:off x="4120920" y="3336840"/>
              <a:ext cx="554040" cy="272880"/>
            </a:xfrm>
            <a:custGeom>
              <a:avLst/>
              <a:gdLst>
                <a:gd name="textAreaLeft" fmla="*/ 0 w 554040"/>
                <a:gd name="textAreaRight" fmla="*/ 554400 w 554040"/>
                <a:gd name="textAreaTop" fmla="*/ 0 h 272880"/>
                <a:gd name="textAreaBottom" fmla="*/ 273240 h 272880"/>
              </a:gdLst>
              <a:ahLst/>
              <a:rect l="textAreaLeft" t="textAreaTop" r="textAreaRight" b="textAreaBottom"/>
              <a:pathLst>
                <a:path w="349" h="172">
                  <a:moveTo>
                    <a:pt x="348" y="0"/>
                  </a:moveTo>
                  <a:lnTo>
                    <a:pt x="302" y="2"/>
                  </a:lnTo>
                  <a:lnTo>
                    <a:pt x="258" y="9"/>
                  </a:lnTo>
                  <a:lnTo>
                    <a:pt x="213" y="20"/>
                  </a:lnTo>
                  <a:lnTo>
                    <a:pt x="169" y="34"/>
                  </a:lnTo>
                  <a:lnTo>
                    <a:pt x="128" y="52"/>
                  </a:lnTo>
                  <a:lnTo>
                    <a:pt x="88" y="74"/>
                  </a:lnTo>
                  <a:lnTo>
                    <a:pt x="49" y="99"/>
                  </a:lnTo>
                  <a:lnTo>
                    <a:pt x="14" y="129"/>
                  </a:lnTo>
                  <a:lnTo>
                    <a:pt x="11" y="131"/>
                  </a:lnTo>
                  <a:lnTo>
                    <a:pt x="0" y="118"/>
                  </a:lnTo>
                  <a:lnTo>
                    <a:pt x="2" y="168"/>
                  </a:lnTo>
                  <a:lnTo>
                    <a:pt x="49" y="172"/>
                  </a:lnTo>
                  <a:lnTo>
                    <a:pt x="39" y="160"/>
                  </a:lnTo>
                  <a:lnTo>
                    <a:pt x="71" y="134"/>
                  </a:lnTo>
                  <a:lnTo>
                    <a:pt x="106" y="110"/>
                  </a:lnTo>
                  <a:lnTo>
                    <a:pt x="143" y="89"/>
                  </a:lnTo>
                  <a:lnTo>
                    <a:pt x="181" y="73"/>
                  </a:lnTo>
                  <a:lnTo>
                    <a:pt x="222" y="59"/>
                  </a:lnTo>
                  <a:lnTo>
                    <a:pt x="262" y="49"/>
                  </a:lnTo>
                  <a:lnTo>
                    <a:pt x="304" y="43"/>
                  </a:lnTo>
                  <a:lnTo>
                    <a:pt x="346" y="41"/>
                  </a:lnTo>
                  <a:lnTo>
                    <a:pt x="349" y="41"/>
                  </a:lnTo>
                  <a:lnTo>
                    <a:pt x="348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Arc 334"/>
            <p:cNvSpPr/>
            <p:nvPr/>
          </p:nvSpPr>
          <p:spPr>
            <a:xfrm>
              <a:off x="4136760" y="3336840"/>
              <a:ext cx="540000" cy="807840"/>
            </a:xfrm>
            <a:custGeom>
              <a:avLst/>
              <a:gdLst>
                <a:gd name="textAreaLeft" fmla="*/ 0 w 540000"/>
                <a:gd name="textAreaRight" fmla="*/ 540360 w 540000"/>
                <a:gd name="textAreaTop" fmla="*/ 0 h 807840"/>
                <a:gd name="textAreaBottom" fmla="*/ 808200 h 807840"/>
              </a:gdLst>
              <a:ahLst/>
              <a:rect l="textAreaLeft" t="textAreaTop" r="textAreaRight" b="textAreaBottom"/>
              <a:pathLst>
                <a:path fill="none" w="14406" h="21600">
                  <a:moveTo>
                    <a:pt x="0" y="5505"/>
                  </a:moveTo>
                  <a:cubicBezTo>
                    <a:pt x="3939" y="1979"/>
                    <a:pt x="9034" y="20"/>
                    <a:pt x="14321" y="0"/>
                  </a:cubicBezTo>
                </a:path>
                <a:path stroke="0" w="14406" h="21600">
                  <a:moveTo>
                    <a:pt x="0" y="5505"/>
                  </a:moveTo>
                  <a:cubicBezTo>
                    <a:pt x="3939" y="1979"/>
                    <a:pt x="9034" y="20"/>
                    <a:pt x="14321" y="0"/>
                  </a:cubicBezTo>
                  <a:lnTo>
                    <a:pt x="14406" y="21600"/>
                  </a:lnTo>
                  <a:lnTo>
                    <a:pt x="0" y="550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Arc 335"/>
            <p:cNvSpPr/>
            <p:nvPr/>
          </p:nvSpPr>
          <p:spPr>
            <a:xfrm>
              <a:off x="4181400" y="3401640"/>
              <a:ext cx="495360" cy="743040"/>
            </a:xfrm>
            <a:custGeom>
              <a:avLst/>
              <a:gdLst>
                <a:gd name="textAreaLeft" fmla="*/ 0 w 495360"/>
                <a:gd name="textAreaRight" fmla="*/ 495720 w 49536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14362" h="21600">
                  <a:moveTo>
                    <a:pt x="0" y="5466"/>
                  </a:moveTo>
                  <a:cubicBezTo>
                    <a:pt x="3943" y="1955"/>
                    <a:pt x="9036" y="11"/>
                    <a:pt x="14316" y="0"/>
                  </a:cubicBezTo>
                </a:path>
                <a:path stroke="0" w="14362" h="21600">
                  <a:moveTo>
                    <a:pt x="0" y="5466"/>
                  </a:moveTo>
                  <a:cubicBezTo>
                    <a:pt x="3943" y="1955"/>
                    <a:pt x="9036" y="11"/>
                    <a:pt x="14316" y="0"/>
                  </a:cubicBezTo>
                  <a:lnTo>
                    <a:pt x="14362" y="21600"/>
                  </a:lnTo>
                  <a:lnTo>
                    <a:pt x="0" y="546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36"/>
            <p:cNvSpPr/>
            <p:nvPr/>
          </p:nvSpPr>
          <p:spPr>
            <a:xfrm flipH="1" flipV="1">
              <a:off x="4673520" y="333684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Freeform 337"/>
            <p:cNvSpPr/>
            <p:nvPr/>
          </p:nvSpPr>
          <p:spPr>
            <a:xfrm>
              <a:off x="4120920" y="3524040"/>
              <a:ext cx="77760" cy="8568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85680"/>
                <a:gd name="textAreaBottom" fmla="*/ 86040 h 85680"/>
              </a:gdLst>
              <a:ahLst/>
              <a:rect l="textAreaLeft" t="textAreaTop" r="textAreaRight" b="textAreaBottom"/>
              <a:pathLst>
                <a:path w="45" h="50">
                  <a:moveTo>
                    <a:pt x="35" y="39"/>
                  </a:moveTo>
                  <a:lnTo>
                    <a:pt x="45" y="50"/>
                  </a:lnTo>
                  <a:lnTo>
                    <a:pt x="1" y="46"/>
                  </a:lnTo>
                  <a:lnTo>
                    <a:pt x="0" y="0"/>
                  </a:lnTo>
                  <a:lnTo>
                    <a:pt x="10" y="1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38"/>
            <p:cNvSpPr/>
            <p:nvPr/>
          </p:nvSpPr>
          <p:spPr>
            <a:xfrm>
              <a:off x="4302000" y="3331800"/>
              <a:ext cx="61920" cy="716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339"/>
            <p:cNvSpPr/>
            <p:nvPr/>
          </p:nvSpPr>
          <p:spPr>
            <a:xfrm>
              <a:off x="4178160" y="324288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K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Freeform 340"/>
            <p:cNvSpPr/>
            <p:nvPr/>
          </p:nvSpPr>
          <p:spPr>
            <a:xfrm>
              <a:off x="4694040" y="3336840"/>
              <a:ext cx="424080" cy="190440"/>
            </a:xfrm>
            <a:custGeom>
              <a:avLst/>
              <a:gdLst>
                <a:gd name="textAreaLeft" fmla="*/ 0 w 424080"/>
                <a:gd name="textAreaRight" fmla="*/ 424440 w 42408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267" h="120">
                  <a:moveTo>
                    <a:pt x="221" y="120"/>
                  </a:moveTo>
                  <a:lnTo>
                    <a:pt x="267" y="106"/>
                  </a:lnTo>
                  <a:lnTo>
                    <a:pt x="258" y="57"/>
                  </a:lnTo>
                  <a:lnTo>
                    <a:pt x="249" y="71"/>
                  </a:lnTo>
                  <a:lnTo>
                    <a:pt x="209" y="49"/>
                  </a:lnTo>
                  <a:lnTo>
                    <a:pt x="168" y="32"/>
                  </a:lnTo>
                  <a:lnTo>
                    <a:pt x="124" y="18"/>
                  </a:lnTo>
                  <a:lnTo>
                    <a:pt x="80" y="8"/>
                  </a:lnTo>
                  <a:lnTo>
                    <a:pt x="34" y="2"/>
                  </a:lnTo>
                  <a:lnTo>
                    <a:pt x="0" y="0"/>
                  </a:lnTo>
                  <a:lnTo>
                    <a:pt x="0" y="41"/>
                  </a:lnTo>
                  <a:lnTo>
                    <a:pt x="41" y="44"/>
                  </a:lnTo>
                  <a:lnTo>
                    <a:pt x="83" y="50"/>
                  </a:lnTo>
                  <a:lnTo>
                    <a:pt x="124" y="60"/>
                  </a:lnTo>
                  <a:lnTo>
                    <a:pt x="164" y="73"/>
                  </a:lnTo>
                  <a:lnTo>
                    <a:pt x="203" y="91"/>
                  </a:lnTo>
                  <a:lnTo>
                    <a:pt x="230" y="106"/>
                  </a:lnTo>
                  <a:lnTo>
                    <a:pt x="221" y="120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Arc 341"/>
            <p:cNvSpPr/>
            <p:nvPr/>
          </p:nvSpPr>
          <p:spPr>
            <a:xfrm>
              <a:off x="4676760" y="3338280"/>
              <a:ext cx="412560" cy="806400"/>
            </a:xfrm>
            <a:custGeom>
              <a:avLst/>
              <a:gdLst>
                <a:gd name="textAreaLeft" fmla="*/ 0 w 412560"/>
                <a:gd name="textAreaRight" fmla="*/ 412920 w 412560"/>
                <a:gd name="textAreaTop" fmla="*/ 0 h 806400"/>
                <a:gd name="textAreaBottom" fmla="*/ 806760 h 806400"/>
              </a:gdLst>
              <a:ahLst/>
              <a:rect l="textAreaLeft" t="textAreaTop" r="textAreaRight" b="textAreaBottom"/>
              <a:pathLst>
                <a:path fill="none" w="11010" h="21595">
                  <a:moveTo>
                    <a:pt x="465" y="0"/>
                  </a:moveTo>
                  <a:cubicBezTo>
                    <a:pt x="4181" y="80"/>
                    <a:pt x="7812" y="1117"/>
                    <a:pt x="11009" y="3011"/>
                  </a:cubicBezTo>
                </a:path>
                <a:path stroke="0" w="11010" h="21595">
                  <a:moveTo>
                    <a:pt x="465" y="0"/>
                  </a:moveTo>
                  <a:cubicBezTo>
                    <a:pt x="4181" y="80"/>
                    <a:pt x="7812" y="1117"/>
                    <a:pt x="11009" y="3011"/>
                  </a:cubicBezTo>
                  <a:lnTo>
                    <a:pt x="0" y="21595"/>
                  </a:lnTo>
                  <a:lnTo>
                    <a:pt x="46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Arc 342"/>
            <p:cNvSpPr/>
            <p:nvPr/>
          </p:nvSpPr>
          <p:spPr>
            <a:xfrm>
              <a:off x="4676760" y="3401640"/>
              <a:ext cx="380880" cy="743040"/>
            </a:xfrm>
            <a:custGeom>
              <a:avLst/>
              <a:gdLst>
                <a:gd name="textAreaLeft" fmla="*/ 0 w 380880"/>
                <a:gd name="textAreaRight" fmla="*/ 381240 w 38088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11077" h="21594">
                  <a:moveTo>
                    <a:pt x="507" y="-1"/>
                  </a:moveTo>
                  <a:cubicBezTo>
                    <a:pt x="4234" y="87"/>
                    <a:pt x="7876" y="1138"/>
                    <a:pt x="11077" y="3050"/>
                  </a:cubicBezTo>
                </a:path>
                <a:path stroke="0" w="11077" h="21594">
                  <a:moveTo>
                    <a:pt x="507" y="-1"/>
                  </a:moveTo>
                  <a:cubicBezTo>
                    <a:pt x="4234" y="87"/>
                    <a:pt x="7876" y="1138"/>
                    <a:pt x="11077" y="3050"/>
                  </a:cubicBezTo>
                  <a:lnTo>
                    <a:pt x="0" y="21594"/>
                  </a:lnTo>
                  <a:lnTo>
                    <a:pt x="507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43"/>
            <p:cNvSpPr/>
            <p:nvPr/>
          </p:nvSpPr>
          <p:spPr>
            <a:xfrm flipV="1">
              <a:off x="4694040" y="3336840"/>
              <a:ext cx="180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Freeform 344"/>
            <p:cNvSpPr/>
            <p:nvPr/>
          </p:nvSpPr>
          <p:spPr>
            <a:xfrm>
              <a:off x="5045040" y="3427200"/>
              <a:ext cx="73080" cy="100080"/>
            </a:xfrm>
            <a:custGeom>
              <a:avLst/>
              <a:gdLst>
                <a:gd name="textAreaLeft" fmla="*/ 0 w 73080"/>
                <a:gd name="textAreaRight" fmla="*/ 73080 w 73080"/>
                <a:gd name="textAreaTop" fmla="*/ 0 h 100080"/>
                <a:gd name="textAreaBottom" fmla="*/ 100440 h 100080"/>
              </a:gdLst>
              <a:ahLst/>
              <a:rect l="textAreaLeft" t="textAreaTop" r="textAreaRight" b="textAreaBottom"/>
              <a:pathLst>
                <a:path w="42" h="58">
                  <a:moveTo>
                    <a:pt x="8" y="45"/>
                  </a:moveTo>
                  <a:lnTo>
                    <a:pt x="0" y="58"/>
                  </a:lnTo>
                  <a:lnTo>
                    <a:pt x="42" y="45"/>
                  </a:lnTo>
                  <a:lnTo>
                    <a:pt x="34" y="0"/>
                  </a:lnTo>
                  <a:lnTo>
                    <a:pt x="26" y="1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45"/>
            <p:cNvSpPr/>
            <p:nvPr/>
          </p:nvSpPr>
          <p:spPr>
            <a:xfrm flipH="1">
              <a:off x="4925880" y="3315960"/>
              <a:ext cx="38160" cy="586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346"/>
            <p:cNvSpPr/>
            <p:nvPr/>
          </p:nvSpPr>
          <p:spPr>
            <a:xfrm>
              <a:off x="4960440" y="32270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Freeform 347"/>
            <p:cNvSpPr/>
            <p:nvPr/>
          </p:nvSpPr>
          <p:spPr>
            <a:xfrm>
              <a:off x="5419800" y="4154400"/>
              <a:ext cx="71280" cy="10152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5" h="64">
                  <a:moveTo>
                    <a:pt x="41" y="64"/>
                  </a:moveTo>
                  <a:lnTo>
                    <a:pt x="45" y="19"/>
                  </a:lnTo>
                  <a:lnTo>
                    <a:pt x="45" y="0"/>
                  </a:lnTo>
                  <a:lnTo>
                    <a:pt x="5" y="0"/>
                  </a:lnTo>
                  <a:lnTo>
                    <a:pt x="3" y="41"/>
                  </a:lnTo>
                  <a:lnTo>
                    <a:pt x="0" y="59"/>
                  </a:lnTo>
                  <a:lnTo>
                    <a:pt x="41" y="64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Arc 348"/>
            <p:cNvSpPr/>
            <p:nvPr/>
          </p:nvSpPr>
          <p:spPr>
            <a:xfrm>
              <a:off x="4676760" y="4144680"/>
              <a:ext cx="807840" cy="109440"/>
            </a:xfrm>
            <a:custGeom>
              <a:avLst/>
              <a:gdLst>
                <a:gd name="textAreaLeft" fmla="*/ 0 w 807840"/>
                <a:gd name="textAreaRight" fmla="*/ 808200 w 8078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fill="none" w="21599" h="2949">
                  <a:moveTo>
                    <a:pt x="21598" y="252"/>
                  </a:moveTo>
                  <a:cubicBezTo>
                    <a:pt x="21587" y="1154"/>
                    <a:pt x="21520" y="2055"/>
                    <a:pt x="21397" y="2948"/>
                  </a:cubicBezTo>
                </a:path>
                <a:path stroke="0" w="21599" h="2949">
                  <a:moveTo>
                    <a:pt x="21598" y="252"/>
                  </a:moveTo>
                  <a:cubicBezTo>
                    <a:pt x="21587" y="1154"/>
                    <a:pt x="21520" y="2055"/>
                    <a:pt x="21397" y="2948"/>
                  </a:cubicBezTo>
                  <a:lnTo>
                    <a:pt x="0" y="0"/>
                  </a:lnTo>
                  <a:lnTo>
                    <a:pt x="21598" y="252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Arc 349"/>
            <p:cNvSpPr/>
            <p:nvPr/>
          </p:nvSpPr>
          <p:spPr>
            <a:xfrm>
              <a:off x="4676760" y="4144680"/>
              <a:ext cx="743040" cy="101520"/>
            </a:xfrm>
            <a:custGeom>
              <a:avLst/>
              <a:gdLst>
                <a:gd name="textAreaLeft" fmla="*/ 0 w 743040"/>
                <a:gd name="textAreaRight" fmla="*/ 743400 w 7430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fill="none" w="21598" h="2975">
                  <a:moveTo>
                    <a:pt x="21598" y="274"/>
                  </a:moveTo>
                  <a:cubicBezTo>
                    <a:pt x="21586" y="1177"/>
                    <a:pt x="21518" y="2079"/>
                    <a:pt x="21394" y="2975"/>
                  </a:cubicBezTo>
                </a:path>
                <a:path stroke="0" w="21598" h="2975">
                  <a:moveTo>
                    <a:pt x="21598" y="274"/>
                  </a:moveTo>
                  <a:cubicBezTo>
                    <a:pt x="21586" y="1177"/>
                    <a:pt x="21518" y="2079"/>
                    <a:pt x="21394" y="2975"/>
                  </a:cubicBezTo>
                  <a:lnTo>
                    <a:pt x="0" y="0"/>
                  </a:lnTo>
                  <a:lnTo>
                    <a:pt x="21598" y="274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50"/>
            <p:cNvSpPr/>
            <p:nvPr/>
          </p:nvSpPr>
          <p:spPr>
            <a:xfrm>
              <a:off x="5419800" y="4248000"/>
              <a:ext cx="64800" cy="7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51"/>
            <p:cNvSpPr/>
            <p:nvPr/>
          </p:nvSpPr>
          <p:spPr>
            <a:xfrm>
              <a:off x="5427720" y="4154400"/>
              <a:ext cx="63360" cy="144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52"/>
            <p:cNvSpPr/>
            <p:nvPr/>
          </p:nvSpPr>
          <p:spPr>
            <a:xfrm flipH="1" flipV="1">
              <a:off x="5489280" y="4204800"/>
              <a:ext cx="123480" cy="349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353"/>
            <p:cNvSpPr/>
            <p:nvPr/>
          </p:nvSpPr>
          <p:spPr>
            <a:xfrm>
              <a:off x="5611320" y="42368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Freeform 354"/>
            <p:cNvSpPr/>
            <p:nvPr/>
          </p:nvSpPr>
          <p:spPr>
            <a:xfrm>
              <a:off x="5108400" y="3484440"/>
              <a:ext cx="84240" cy="83880"/>
            </a:xfrm>
            <a:custGeom>
              <a:avLst/>
              <a:gdLst>
                <a:gd name="textAreaLeft" fmla="*/ 0 w 84240"/>
                <a:gd name="textAreaRight" fmla="*/ 84240 w 842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53" h="53">
                  <a:moveTo>
                    <a:pt x="53" y="21"/>
                  </a:moveTo>
                  <a:lnTo>
                    <a:pt x="23" y="0"/>
                  </a:lnTo>
                  <a:lnTo>
                    <a:pt x="0" y="33"/>
                  </a:lnTo>
                  <a:lnTo>
                    <a:pt x="27" y="53"/>
                  </a:lnTo>
                  <a:lnTo>
                    <a:pt x="53" y="21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Arc 355"/>
            <p:cNvSpPr/>
            <p:nvPr/>
          </p:nvSpPr>
          <p:spPr>
            <a:xfrm>
              <a:off x="4676760" y="3485880"/>
              <a:ext cx="512640" cy="658800"/>
            </a:xfrm>
            <a:custGeom>
              <a:avLst/>
              <a:gdLst>
                <a:gd name="textAreaLeft" fmla="*/ 0 w 512640"/>
                <a:gd name="textAreaRight" fmla="*/ 513000 w 512640"/>
                <a:gd name="textAreaTop" fmla="*/ 0 h 658800"/>
                <a:gd name="textAreaBottom" fmla="*/ 659160 h 658800"/>
              </a:gdLst>
              <a:ahLst/>
              <a:rect l="textAreaLeft" t="textAreaTop" r="textAreaRight" b="textAreaBottom"/>
              <a:pathLst>
                <a:path fill="none" w="13708" h="17631">
                  <a:moveTo>
                    <a:pt x="12478" y="-1"/>
                  </a:moveTo>
                  <a:cubicBezTo>
                    <a:pt x="12899" y="297"/>
                    <a:pt x="13309" y="610"/>
                    <a:pt x="13707" y="938"/>
                  </a:cubicBezTo>
                </a:path>
                <a:path stroke="0" w="13708" h="17631">
                  <a:moveTo>
                    <a:pt x="12478" y="-1"/>
                  </a:moveTo>
                  <a:cubicBezTo>
                    <a:pt x="12899" y="297"/>
                    <a:pt x="13309" y="610"/>
                    <a:pt x="13707" y="938"/>
                  </a:cubicBezTo>
                  <a:lnTo>
                    <a:pt x="0" y="17631"/>
                  </a:lnTo>
                  <a:lnTo>
                    <a:pt x="12478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Arc 356"/>
            <p:cNvSpPr/>
            <p:nvPr/>
          </p:nvSpPr>
          <p:spPr>
            <a:xfrm>
              <a:off x="4676760" y="3538440"/>
              <a:ext cx="473040" cy="606240"/>
            </a:xfrm>
            <a:custGeom>
              <a:avLst/>
              <a:gdLst>
                <a:gd name="textAreaLeft" fmla="*/ 0 w 473040"/>
                <a:gd name="textAreaRight" fmla="*/ 473400 w 473040"/>
                <a:gd name="textAreaTop" fmla="*/ 0 h 606240"/>
                <a:gd name="textAreaBottom" fmla="*/ 606600 h 606240"/>
              </a:gdLst>
              <a:ahLst/>
              <a:rect l="textAreaLeft" t="textAreaTop" r="textAreaRight" b="textAreaBottom"/>
              <a:pathLst>
                <a:path fill="none" w="13724" h="17617">
                  <a:moveTo>
                    <a:pt x="12498" y="-1"/>
                  </a:moveTo>
                  <a:cubicBezTo>
                    <a:pt x="12917" y="297"/>
                    <a:pt x="13326" y="610"/>
                    <a:pt x="13723" y="937"/>
                  </a:cubicBezTo>
                </a:path>
                <a:path stroke="0" w="13724" h="17617">
                  <a:moveTo>
                    <a:pt x="12498" y="-1"/>
                  </a:moveTo>
                  <a:cubicBezTo>
                    <a:pt x="12917" y="297"/>
                    <a:pt x="13326" y="610"/>
                    <a:pt x="13723" y="937"/>
                  </a:cubicBezTo>
                  <a:lnTo>
                    <a:pt x="0" y="17617"/>
                  </a:lnTo>
                  <a:lnTo>
                    <a:pt x="12498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57"/>
            <p:cNvSpPr/>
            <p:nvPr/>
          </p:nvSpPr>
          <p:spPr>
            <a:xfrm flipV="1">
              <a:off x="5151240" y="3517200"/>
              <a:ext cx="4140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58"/>
            <p:cNvSpPr/>
            <p:nvPr/>
          </p:nvSpPr>
          <p:spPr>
            <a:xfrm flipV="1">
              <a:off x="5108400" y="3484080"/>
              <a:ext cx="3672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359"/>
            <p:cNvSpPr/>
            <p:nvPr/>
          </p:nvSpPr>
          <p:spPr>
            <a:xfrm flipH="1">
              <a:off x="5169960" y="3454200"/>
              <a:ext cx="41400" cy="475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360"/>
            <p:cNvSpPr/>
            <p:nvPr/>
          </p:nvSpPr>
          <p:spPr>
            <a:xfrm>
              <a:off x="5205600" y="33652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Freeform 361"/>
            <p:cNvSpPr/>
            <p:nvPr/>
          </p:nvSpPr>
          <p:spPr>
            <a:xfrm>
              <a:off x="5425920" y="4092480"/>
              <a:ext cx="65160" cy="55440"/>
            </a:xfrm>
            <a:custGeom>
              <a:avLst/>
              <a:gdLst>
                <a:gd name="textAreaLeft" fmla="*/ 0 w 65160"/>
                <a:gd name="textAreaRight" fmla="*/ 65520 w 6516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41" h="35">
                  <a:moveTo>
                    <a:pt x="41" y="35"/>
                  </a:moveTo>
                  <a:lnTo>
                    <a:pt x="40" y="0"/>
                  </a:lnTo>
                  <a:lnTo>
                    <a:pt x="0" y="3"/>
                  </a:lnTo>
                  <a:lnTo>
                    <a:pt x="1" y="35"/>
                  </a:lnTo>
                  <a:lnTo>
                    <a:pt x="41" y="35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Arc 362"/>
            <p:cNvSpPr/>
            <p:nvPr/>
          </p:nvSpPr>
          <p:spPr>
            <a:xfrm>
              <a:off x="4676760" y="4092480"/>
              <a:ext cx="809640" cy="55440"/>
            </a:xfrm>
            <a:custGeom>
              <a:avLst/>
              <a:gdLst>
                <a:gd name="textAreaLeft" fmla="*/ 0 w 809640"/>
                <a:gd name="textAreaRight" fmla="*/ 810000 w 8096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fill="none" w="21600" h="1476">
                  <a:moveTo>
                    <a:pt x="21555" y="-1"/>
                  </a:moveTo>
                  <a:cubicBezTo>
                    <a:pt x="21585" y="463"/>
                    <a:pt x="21600" y="927"/>
                    <a:pt x="21600" y="1392"/>
                  </a:cubicBezTo>
                  <a:cubicBezTo>
                    <a:pt x="21600" y="1419"/>
                    <a:pt x="21599" y="1447"/>
                    <a:pt x="21599" y="1475"/>
                  </a:cubicBezTo>
                </a:path>
                <a:path stroke="0" w="21600" h="1476">
                  <a:moveTo>
                    <a:pt x="21555" y="-1"/>
                  </a:moveTo>
                  <a:cubicBezTo>
                    <a:pt x="21585" y="463"/>
                    <a:pt x="21600" y="927"/>
                    <a:pt x="21600" y="1392"/>
                  </a:cubicBezTo>
                  <a:cubicBezTo>
                    <a:pt x="21600" y="1419"/>
                    <a:pt x="21599" y="1447"/>
                    <a:pt x="21599" y="1475"/>
                  </a:cubicBezTo>
                  <a:lnTo>
                    <a:pt x="0" y="1392"/>
                  </a:lnTo>
                  <a:lnTo>
                    <a:pt x="21555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Arc 363"/>
            <p:cNvSpPr/>
            <p:nvPr/>
          </p:nvSpPr>
          <p:spPr>
            <a:xfrm>
              <a:off x="4676760" y="4097160"/>
              <a:ext cx="744480" cy="50760"/>
            </a:xfrm>
            <a:custGeom>
              <a:avLst/>
              <a:gdLst>
                <a:gd name="textAreaLeft" fmla="*/ 0 w 744480"/>
                <a:gd name="textAreaRight" fmla="*/ 744840 w 744480"/>
                <a:gd name="textAreaTop" fmla="*/ 0 h 50760"/>
                <a:gd name="textAreaBottom" fmla="*/ 51120 h 50760"/>
              </a:gdLst>
              <a:ahLst/>
              <a:rect l="textAreaLeft" t="textAreaTop" r="textAreaRight" b="textAreaBottom"/>
              <a:pathLst>
                <a:path fill="none" w="21600" h="1463">
                  <a:moveTo>
                    <a:pt x="21556" y="-1"/>
                  </a:moveTo>
                  <a:cubicBezTo>
                    <a:pt x="21585" y="456"/>
                    <a:pt x="21600" y="914"/>
                    <a:pt x="21600" y="1372"/>
                  </a:cubicBezTo>
                  <a:cubicBezTo>
                    <a:pt x="21600" y="1402"/>
                    <a:pt x="21599" y="1432"/>
                    <a:pt x="21599" y="1462"/>
                  </a:cubicBezTo>
                </a:path>
                <a:path stroke="0" w="21600" h="1463">
                  <a:moveTo>
                    <a:pt x="21556" y="-1"/>
                  </a:moveTo>
                  <a:cubicBezTo>
                    <a:pt x="21585" y="456"/>
                    <a:pt x="21600" y="914"/>
                    <a:pt x="21600" y="1372"/>
                  </a:cubicBezTo>
                  <a:cubicBezTo>
                    <a:pt x="21600" y="1402"/>
                    <a:pt x="21599" y="1432"/>
                    <a:pt x="21599" y="1462"/>
                  </a:cubicBezTo>
                  <a:lnTo>
                    <a:pt x="0" y="1372"/>
                  </a:lnTo>
                  <a:lnTo>
                    <a:pt x="21556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64"/>
            <p:cNvSpPr/>
            <p:nvPr/>
          </p:nvSpPr>
          <p:spPr>
            <a:xfrm>
              <a:off x="5427720" y="4147920"/>
              <a:ext cx="63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365"/>
            <p:cNvSpPr/>
            <p:nvPr/>
          </p:nvSpPr>
          <p:spPr>
            <a:xfrm flipV="1">
              <a:off x="5425920" y="4092120"/>
              <a:ext cx="6372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366"/>
            <p:cNvSpPr/>
            <p:nvPr/>
          </p:nvSpPr>
          <p:spPr>
            <a:xfrm flipH="1">
              <a:off x="5490720" y="4105080"/>
              <a:ext cx="122040" cy="158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367"/>
            <p:cNvSpPr/>
            <p:nvPr/>
          </p:nvSpPr>
          <p:spPr>
            <a:xfrm>
              <a:off x="5608800" y="41032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Freeform 368"/>
            <p:cNvSpPr/>
            <p:nvPr/>
          </p:nvSpPr>
          <p:spPr>
            <a:xfrm>
              <a:off x="5403600" y="4257360"/>
              <a:ext cx="79560" cy="9864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98640"/>
                <a:gd name="textAreaBottom" fmla="*/ 99000 h 98640"/>
              </a:gdLst>
              <a:ahLst/>
              <a:rect l="textAreaLeft" t="textAreaTop" r="textAreaRight" b="textAreaBottom"/>
              <a:pathLst>
                <a:path w="50" h="62">
                  <a:moveTo>
                    <a:pt x="39" y="62"/>
                  </a:moveTo>
                  <a:lnTo>
                    <a:pt x="49" y="17"/>
                  </a:lnTo>
                  <a:lnTo>
                    <a:pt x="50" y="5"/>
                  </a:lnTo>
                  <a:lnTo>
                    <a:pt x="10" y="0"/>
                  </a:lnTo>
                  <a:lnTo>
                    <a:pt x="2" y="41"/>
                  </a:lnTo>
                  <a:lnTo>
                    <a:pt x="0" y="52"/>
                  </a:lnTo>
                  <a:lnTo>
                    <a:pt x="39" y="6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Arc 369"/>
            <p:cNvSpPr/>
            <p:nvPr/>
          </p:nvSpPr>
          <p:spPr>
            <a:xfrm>
              <a:off x="4676760" y="4144680"/>
              <a:ext cx="799920" cy="209520"/>
            </a:xfrm>
            <a:custGeom>
              <a:avLst/>
              <a:gdLst>
                <a:gd name="textAreaLeft" fmla="*/ 0 w 799920"/>
                <a:gd name="textAreaRight" fmla="*/ 800280 w 799920"/>
                <a:gd name="textAreaTop" fmla="*/ 0 h 209520"/>
                <a:gd name="textAreaBottom" fmla="*/ 209880 h 209520"/>
              </a:gdLst>
              <a:ahLst/>
              <a:rect l="textAreaLeft" t="textAreaTop" r="textAreaRight" b="textAreaBottom"/>
              <a:pathLst>
                <a:path fill="none" w="21361" h="5594">
                  <a:moveTo>
                    <a:pt x="21361" y="3202"/>
                  </a:moveTo>
                  <a:cubicBezTo>
                    <a:pt x="21240" y="4008"/>
                    <a:pt x="21074" y="4806"/>
                    <a:pt x="20863" y="5594"/>
                  </a:cubicBezTo>
                </a:path>
                <a:path stroke="0" w="21361" h="5594">
                  <a:moveTo>
                    <a:pt x="21361" y="3202"/>
                  </a:moveTo>
                  <a:cubicBezTo>
                    <a:pt x="21240" y="4008"/>
                    <a:pt x="21074" y="4806"/>
                    <a:pt x="20863" y="5594"/>
                  </a:cubicBezTo>
                  <a:lnTo>
                    <a:pt x="0" y="0"/>
                  </a:lnTo>
                  <a:lnTo>
                    <a:pt x="21361" y="320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Arc 370"/>
            <p:cNvSpPr/>
            <p:nvPr/>
          </p:nvSpPr>
          <p:spPr>
            <a:xfrm>
              <a:off x="4676760" y="4144680"/>
              <a:ext cx="734760" cy="193680"/>
            </a:xfrm>
            <a:custGeom>
              <a:avLst/>
              <a:gdLst>
                <a:gd name="textAreaLeft" fmla="*/ 0 w 734760"/>
                <a:gd name="textAreaRight" fmla="*/ 734760 w 73476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fill="none" w="21355" h="5608">
                  <a:moveTo>
                    <a:pt x="21355" y="3243"/>
                  </a:moveTo>
                  <a:cubicBezTo>
                    <a:pt x="21234" y="4040"/>
                    <a:pt x="21068" y="4829"/>
                    <a:pt x="20859" y="5608"/>
                  </a:cubicBezTo>
                </a:path>
                <a:path stroke="0" w="21355" h="5608">
                  <a:moveTo>
                    <a:pt x="21355" y="3243"/>
                  </a:moveTo>
                  <a:cubicBezTo>
                    <a:pt x="21234" y="4040"/>
                    <a:pt x="21068" y="4829"/>
                    <a:pt x="20859" y="5608"/>
                  </a:cubicBezTo>
                  <a:lnTo>
                    <a:pt x="0" y="0"/>
                  </a:lnTo>
                  <a:lnTo>
                    <a:pt x="21355" y="324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371"/>
            <p:cNvSpPr/>
            <p:nvPr/>
          </p:nvSpPr>
          <p:spPr>
            <a:xfrm>
              <a:off x="5403600" y="4340160"/>
              <a:ext cx="6192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372"/>
            <p:cNvSpPr/>
            <p:nvPr/>
          </p:nvSpPr>
          <p:spPr>
            <a:xfrm>
              <a:off x="5419800" y="4257360"/>
              <a:ext cx="6336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373"/>
            <p:cNvSpPr/>
            <p:nvPr/>
          </p:nvSpPr>
          <p:spPr>
            <a:xfrm flipH="1" flipV="1">
              <a:off x="5474880" y="4313160"/>
              <a:ext cx="128520" cy="633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374"/>
            <p:cNvSpPr/>
            <p:nvPr/>
          </p:nvSpPr>
          <p:spPr>
            <a:xfrm>
              <a:off x="5608440" y="437328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Freeform 375"/>
            <p:cNvSpPr/>
            <p:nvPr/>
          </p:nvSpPr>
          <p:spPr>
            <a:xfrm>
              <a:off x="4003560" y="3581280"/>
              <a:ext cx="142920" cy="152280"/>
            </a:xfrm>
            <a:custGeom>
              <a:avLst/>
              <a:gdLst>
                <a:gd name="textAreaLeft" fmla="*/ 0 w 142920"/>
                <a:gd name="textAreaRight" fmla="*/ 143280 w 1429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90" h="96">
                  <a:moveTo>
                    <a:pt x="60" y="0"/>
                  </a:moveTo>
                  <a:lnTo>
                    <a:pt x="30" y="34"/>
                  </a:lnTo>
                  <a:lnTo>
                    <a:pt x="3" y="70"/>
                  </a:lnTo>
                  <a:lnTo>
                    <a:pt x="0" y="75"/>
                  </a:lnTo>
                  <a:lnTo>
                    <a:pt x="34" y="96"/>
                  </a:lnTo>
                  <a:lnTo>
                    <a:pt x="58" y="63"/>
                  </a:lnTo>
                  <a:lnTo>
                    <a:pt x="86" y="31"/>
                  </a:lnTo>
                  <a:lnTo>
                    <a:pt x="90" y="28"/>
                  </a:lnTo>
                  <a:lnTo>
                    <a:pt x="60" y="0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Arc 376"/>
            <p:cNvSpPr/>
            <p:nvPr/>
          </p:nvSpPr>
          <p:spPr>
            <a:xfrm>
              <a:off x="4002120" y="3581280"/>
              <a:ext cx="674640" cy="563400"/>
            </a:xfrm>
            <a:custGeom>
              <a:avLst/>
              <a:gdLst>
                <a:gd name="textAreaLeft" fmla="*/ 0 w 674640"/>
                <a:gd name="textAreaRight" fmla="*/ 675000 w 674640"/>
                <a:gd name="textAreaTop" fmla="*/ 0 h 563400"/>
                <a:gd name="textAreaBottom" fmla="*/ 563760 h 563400"/>
              </a:gdLst>
              <a:ahLst/>
              <a:rect l="textAreaLeft" t="textAreaTop" r="textAreaRight" b="textAreaBottom"/>
              <a:pathLst>
                <a:path fill="none" w="18014" h="15096">
                  <a:moveTo>
                    <a:pt x="0" y="3177"/>
                  </a:moveTo>
                  <a:cubicBezTo>
                    <a:pt x="752" y="2039"/>
                    <a:pt x="1611" y="975"/>
                    <a:pt x="2565" y="0"/>
                  </a:cubicBezTo>
                </a:path>
                <a:path stroke="0" w="18014" h="15096">
                  <a:moveTo>
                    <a:pt x="0" y="3177"/>
                  </a:moveTo>
                  <a:cubicBezTo>
                    <a:pt x="752" y="2039"/>
                    <a:pt x="1611" y="975"/>
                    <a:pt x="2565" y="0"/>
                  </a:cubicBezTo>
                  <a:lnTo>
                    <a:pt x="18014" y="15096"/>
                  </a:lnTo>
                  <a:lnTo>
                    <a:pt x="0" y="317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Arc 377"/>
            <p:cNvSpPr/>
            <p:nvPr/>
          </p:nvSpPr>
          <p:spPr>
            <a:xfrm>
              <a:off x="4057560" y="3624120"/>
              <a:ext cx="619200" cy="520560"/>
            </a:xfrm>
            <a:custGeom>
              <a:avLst/>
              <a:gdLst>
                <a:gd name="textAreaLeft" fmla="*/ 0 w 619200"/>
                <a:gd name="textAreaRight" fmla="*/ 619560 w 619200"/>
                <a:gd name="textAreaTop" fmla="*/ 0 h 520560"/>
                <a:gd name="textAreaBottom" fmla="*/ 520920 h 520560"/>
              </a:gdLst>
              <a:ahLst/>
              <a:rect l="textAreaLeft" t="textAreaTop" r="textAreaRight" b="textAreaBottom"/>
              <a:pathLst>
                <a:path fill="none" w="17988" h="15119">
                  <a:moveTo>
                    <a:pt x="0" y="3161"/>
                  </a:moveTo>
                  <a:cubicBezTo>
                    <a:pt x="752" y="2029"/>
                    <a:pt x="1610" y="970"/>
                    <a:pt x="2561" y="-1"/>
                  </a:cubicBezTo>
                </a:path>
                <a:path stroke="0" w="17988" h="15119">
                  <a:moveTo>
                    <a:pt x="0" y="3161"/>
                  </a:moveTo>
                  <a:cubicBezTo>
                    <a:pt x="752" y="2029"/>
                    <a:pt x="1610" y="970"/>
                    <a:pt x="2561" y="-1"/>
                  </a:cubicBezTo>
                  <a:lnTo>
                    <a:pt x="17988" y="15119"/>
                  </a:lnTo>
                  <a:lnTo>
                    <a:pt x="0" y="316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378"/>
            <p:cNvSpPr/>
            <p:nvPr/>
          </p:nvSpPr>
          <p:spPr>
            <a:xfrm flipH="1" flipV="1">
              <a:off x="4098960" y="3580920"/>
              <a:ext cx="4752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379"/>
            <p:cNvSpPr/>
            <p:nvPr/>
          </p:nvSpPr>
          <p:spPr>
            <a:xfrm flipH="1" flipV="1">
              <a:off x="4003560" y="3699720"/>
              <a:ext cx="54000" cy="33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380"/>
            <p:cNvSpPr/>
            <p:nvPr/>
          </p:nvSpPr>
          <p:spPr>
            <a:xfrm>
              <a:off x="4017960" y="3590640"/>
              <a:ext cx="31680" cy="475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381"/>
            <p:cNvSpPr/>
            <p:nvPr/>
          </p:nvSpPr>
          <p:spPr>
            <a:xfrm>
              <a:off x="3934080" y="350172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Freeform 382"/>
            <p:cNvSpPr/>
            <p:nvPr/>
          </p:nvSpPr>
          <p:spPr>
            <a:xfrm>
              <a:off x="3843360" y="3701880"/>
              <a:ext cx="212760" cy="539640"/>
            </a:xfrm>
            <a:custGeom>
              <a:avLst/>
              <a:gdLst>
                <a:gd name="textAreaLeft" fmla="*/ 0 w 212760"/>
                <a:gd name="textAreaRight" fmla="*/ 213120 w 212760"/>
                <a:gd name="textAreaTop" fmla="*/ 0 h 539640"/>
                <a:gd name="textAreaBottom" fmla="*/ 540000 h 539640"/>
              </a:gdLst>
              <a:ahLst/>
              <a:rect l="textAreaLeft" t="textAreaTop" r="textAreaRight" b="textAreaBottom"/>
              <a:pathLst>
                <a:path w="134" h="340">
                  <a:moveTo>
                    <a:pt x="100" y="0"/>
                  </a:moveTo>
                  <a:lnTo>
                    <a:pt x="76" y="39"/>
                  </a:lnTo>
                  <a:lnTo>
                    <a:pt x="57" y="80"/>
                  </a:lnTo>
                  <a:lnTo>
                    <a:pt x="40" y="123"/>
                  </a:lnTo>
                  <a:lnTo>
                    <a:pt x="28" y="166"/>
                  </a:lnTo>
                  <a:lnTo>
                    <a:pt x="20" y="212"/>
                  </a:lnTo>
                  <a:lnTo>
                    <a:pt x="16" y="256"/>
                  </a:lnTo>
                  <a:lnTo>
                    <a:pt x="15" y="302"/>
                  </a:lnTo>
                  <a:lnTo>
                    <a:pt x="16" y="309"/>
                  </a:lnTo>
                  <a:lnTo>
                    <a:pt x="0" y="310"/>
                  </a:lnTo>
                  <a:lnTo>
                    <a:pt x="39" y="340"/>
                  </a:lnTo>
                  <a:lnTo>
                    <a:pt x="73" y="305"/>
                  </a:lnTo>
                  <a:lnTo>
                    <a:pt x="57" y="306"/>
                  </a:lnTo>
                  <a:lnTo>
                    <a:pt x="56" y="265"/>
                  </a:lnTo>
                  <a:lnTo>
                    <a:pt x="60" y="223"/>
                  </a:lnTo>
                  <a:lnTo>
                    <a:pt x="67" y="181"/>
                  </a:lnTo>
                  <a:lnTo>
                    <a:pt x="77" y="140"/>
                  </a:lnTo>
                  <a:lnTo>
                    <a:pt x="92" y="101"/>
                  </a:lnTo>
                  <a:lnTo>
                    <a:pt x="110" y="63"/>
                  </a:lnTo>
                  <a:lnTo>
                    <a:pt x="131" y="27"/>
                  </a:lnTo>
                  <a:lnTo>
                    <a:pt x="134" y="21"/>
                  </a:lnTo>
                  <a:lnTo>
                    <a:pt x="100" y="0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Arc 383"/>
            <p:cNvSpPr/>
            <p:nvPr/>
          </p:nvSpPr>
          <p:spPr>
            <a:xfrm>
              <a:off x="3867120" y="3701880"/>
              <a:ext cx="809640" cy="490320"/>
            </a:xfrm>
            <a:custGeom>
              <a:avLst/>
              <a:gdLst>
                <a:gd name="textAreaLeft" fmla="*/ 0 w 809640"/>
                <a:gd name="textAreaRight" fmla="*/ 810000 w 809640"/>
                <a:gd name="textAreaTop" fmla="*/ 0 h 490320"/>
                <a:gd name="textAreaBottom" fmla="*/ 490680 h 490320"/>
              </a:gdLst>
              <a:ahLst/>
              <a:rect l="textAreaLeft" t="textAreaTop" r="textAreaRight" b="textAreaBottom"/>
              <a:pathLst>
                <a:path fill="none" w="21600" h="13143">
                  <a:moveTo>
                    <a:pt x="37" y="13143"/>
                  </a:moveTo>
                  <a:cubicBezTo>
                    <a:pt x="12" y="12719"/>
                    <a:pt x="0" y="12294"/>
                    <a:pt x="0" y="11870"/>
                  </a:cubicBezTo>
                  <a:cubicBezTo>
                    <a:pt x="-1" y="7651"/>
                    <a:pt x="1235" y="3524"/>
                    <a:pt x="3553" y="-1"/>
                  </a:cubicBezTo>
                </a:path>
                <a:path stroke="0" w="21600" h="13143">
                  <a:moveTo>
                    <a:pt x="37" y="13143"/>
                  </a:moveTo>
                  <a:cubicBezTo>
                    <a:pt x="12" y="12719"/>
                    <a:pt x="0" y="12294"/>
                    <a:pt x="0" y="11870"/>
                  </a:cubicBezTo>
                  <a:cubicBezTo>
                    <a:pt x="-1" y="7651"/>
                    <a:pt x="1235" y="3524"/>
                    <a:pt x="3553" y="-1"/>
                  </a:cubicBezTo>
                  <a:lnTo>
                    <a:pt x="21600" y="11870"/>
                  </a:lnTo>
                  <a:lnTo>
                    <a:pt x="37" y="1314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Arc 384"/>
            <p:cNvSpPr/>
            <p:nvPr/>
          </p:nvSpPr>
          <p:spPr>
            <a:xfrm>
              <a:off x="3932280" y="3735000"/>
              <a:ext cx="744480" cy="452520"/>
            </a:xfrm>
            <a:custGeom>
              <a:avLst/>
              <a:gdLst>
                <a:gd name="textAreaLeft" fmla="*/ 0 w 744480"/>
                <a:gd name="textAreaRight" fmla="*/ 744840 w 744480"/>
                <a:gd name="textAreaTop" fmla="*/ 0 h 452520"/>
                <a:gd name="textAreaBottom" fmla="*/ 452880 h 452520"/>
              </a:gdLst>
              <a:ahLst/>
              <a:rect l="textAreaLeft" t="textAreaTop" r="textAreaRight" b="textAreaBottom"/>
              <a:pathLst>
                <a:path fill="none" w="21600" h="13150">
                  <a:moveTo>
                    <a:pt x="35" y="13150"/>
                  </a:moveTo>
                  <a:cubicBezTo>
                    <a:pt x="11" y="12735"/>
                    <a:pt x="0" y="12320"/>
                    <a:pt x="0" y="11905"/>
                  </a:cubicBezTo>
                  <a:cubicBezTo>
                    <a:pt x="-1" y="7671"/>
                    <a:pt x="1243" y="3532"/>
                    <a:pt x="3576" y="-1"/>
                  </a:cubicBezTo>
                </a:path>
                <a:path stroke="0" w="21600" h="13150">
                  <a:moveTo>
                    <a:pt x="35" y="13150"/>
                  </a:moveTo>
                  <a:cubicBezTo>
                    <a:pt x="11" y="12735"/>
                    <a:pt x="0" y="12320"/>
                    <a:pt x="0" y="11905"/>
                  </a:cubicBezTo>
                  <a:cubicBezTo>
                    <a:pt x="-1" y="7671"/>
                    <a:pt x="1243" y="3532"/>
                    <a:pt x="3576" y="-1"/>
                  </a:cubicBezTo>
                  <a:lnTo>
                    <a:pt x="21600" y="11905"/>
                  </a:lnTo>
                  <a:lnTo>
                    <a:pt x="35" y="1315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385"/>
            <p:cNvSpPr/>
            <p:nvPr/>
          </p:nvSpPr>
          <p:spPr>
            <a:xfrm flipH="1" flipV="1">
              <a:off x="4002120" y="3701880"/>
              <a:ext cx="5400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Freeform 386"/>
            <p:cNvSpPr/>
            <p:nvPr/>
          </p:nvSpPr>
          <p:spPr>
            <a:xfrm>
              <a:off x="3843360" y="4186080"/>
              <a:ext cx="115920" cy="5544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67" h="32">
                  <a:moveTo>
                    <a:pt x="52" y="1"/>
                  </a:moveTo>
                  <a:lnTo>
                    <a:pt x="67" y="0"/>
                  </a:lnTo>
                  <a:lnTo>
                    <a:pt x="36" y="32"/>
                  </a:lnTo>
                  <a:lnTo>
                    <a:pt x="0" y="4"/>
                  </a:lnTo>
                  <a:lnTo>
                    <a:pt x="15" y="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387"/>
            <p:cNvSpPr/>
            <p:nvPr/>
          </p:nvSpPr>
          <p:spPr>
            <a:xfrm>
              <a:off x="3762360" y="3920760"/>
              <a:ext cx="128520" cy="414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388"/>
            <p:cNvSpPr/>
            <p:nvPr/>
          </p:nvSpPr>
          <p:spPr>
            <a:xfrm>
              <a:off x="3489480" y="383184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1" name="Rectangle 59"/>
          <p:cNvSpPr/>
          <p:nvPr/>
        </p:nvSpPr>
        <p:spPr>
          <a:xfrm>
            <a:off x="468360" y="1052640"/>
            <a:ext cx="1798560" cy="19080"/>
          </a:xfrm>
          <a:prstGeom prst="rect">
            <a:avLst/>
          </a:prstGeom>
          <a:solidFill>
            <a:srgbClr val="ffffcc"/>
          </a:solidFill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Freeform 63"/>
          <p:cNvSpPr/>
          <p:nvPr/>
        </p:nvSpPr>
        <p:spPr>
          <a:xfrm>
            <a:off x="558720" y="993600"/>
            <a:ext cx="1663920" cy="138240"/>
          </a:xfrm>
          <a:custGeom>
            <a:avLst/>
            <a:gdLst>
              <a:gd name="textAreaLeft" fmla="*/ 0 w 1663920"/>
              <a:gd name="textAreaRight" fmla="*/ 1664280 w 166392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1536" h="87">
                <a:moveTo>
                  <a:pt x="1496" y="87"/>
                </a:moveTo>
                <a:lnTo>
                  <a:pt x="1536" y="43"/>
                </a:lnTo>
                <a:lnTo>
                  <a:pt x="1496" y="0"/>
                </a:lnTo>
                <a:lnTo>
                  <a:pt x="1496" y="19"/>
                </a:lnTo>
                <a:lnTo>
                  <a:pt x="0" y="19"/>
                </a:lnTo>
                <a:lnTo>
                  <a:pt x="0" y="68"/>
                </a:lnTo>
                <a:lnTo>
                  <a:pt x="1496" y="68"/>
                </a:lnTo>
                <a:lnTo>
                  <a:pt x="1496" y="87"/>
                </a:lnTo>
                <a:close/>
              </a:path>
            </a:pathLst>
          </a:custGeom>
          <a:solidFill>
            <a:srgbClr val="33ffcc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Line 64"/>
          <p:cNvSpPr/>
          <p:nvPr/>
        </p:nvSpPr>
        <p:spPr>
          <a:xfrm flipH="1">
            <a:off x="1456920" y="912960"/>
            <a:ext cx="3240" cy="110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65"/>
          <p:cNvSpPr/>
          <p:nvPr/>
        </p:nvSpPr>
        <p:spPr>
          <a:xfrm>
            <a:off x="1378440" y="8366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600" spc="-1" strike="noStrike">
                <a:solidFill>
                  <a:srgbClr val="000000"/>
                </a:solidFill>
                <a:latin typeface="Arial"/>
              </a:rPr>
              <a:t>PGI1*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Freeform 66"/>
          <p:cNvSpPr/>
          <p:nvPr/>
        </p:nvSpPr>
        <p:spPr>
          <a:xfrm>
            <a:off x="471600" y="993600"/>
            <a:ext cx="81000" cy="138240"/>
          </a:xfrm>
          <a:custGeom>
            <a:avLst/>
            <a:gdLst>
              <a:gd name="textAreaLeft" fmla="*/ 0 w 81000"/>
              <a:gd name="textAreaRight" fmla="*/ 81360 w 8100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56" h="87">
                <a:moveTo>
                  <a:pt x="16" y="87"/>
                </a:moveTo>
                <a:lnTo>
                  <a:pt x="56" y="43"/>
                </a:lnTo>
                <a:lnTo>
                  <a:pt x="16" y="0"/>
                </a:lnTo>
                <a:lnTo>
                  <a:pt x="16" y="19"/>
                </a:lnTo>
                <a:lnTo>
                  <a:pt x="0" y="19"/>
                </a:lnTo>
                <a:lnTo>
                  <a:pt x="0" y="68"/>
                </a:lnTo>
                <a:lnTo>
                  <a:pt x="16" y="68"/>
                </a:lnTo>
                <a:lnTo>
                  <a:pt x="16" y="87"/>
                </a:lnTo>
                <a:close/>
              </a:path>
            </a:pathLst>
          </a:cu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Line 67"/>
          <p:cNvSpPr/>
          <p:nvPr/>
        </p:nvSpPr>
        <p:spPr>
          <a:xfrm>
            <a:off x="511200" y="946080"/>
            <a:ext cx="1440" cy="77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Rectangle 68"/>
          <p:cNvSpPr/>
          <p:nvPr/>
        </p:nvSpPr>
        <p:spPr>
          <a:xfrm>
            <a:off x="378360" y="86832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Arial"/>
              </a:rPr>
              <a:t>attB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Freeform 69"/>
          <p:cNvSpPr/>
          <p:nvPr/>
        </p:nvSpPr>
        <p:spPr>
          <a:xfrm>
            <a:off x="2233440" y="993600"/>
            <a:ext cx="81000" cy="138240"/>
          </a:xfrm>
          <a:custGeom>
            <a:avLst/>
            <a:gdLst>
              <a:gd name="textAreaLeft" fmla="*/ 0 w 81000"/>
              <a:gd name="textAreaRight" fmla="*/ 81360 w 81000"/>
              <a:gd name="textAreaTop" fmla="*/ 0 h 138240"/>
              <a:gd name="textAreaBottom" fmla="*/ 138240 h 138240"/>
            </a:gdLst>
            <a:ahLst/>
            <a:rect l="textAreaLeft" t="textAreaTop" r="textAreaRight" b="textAreaBottom"/>
            <a:pathLst>
              <a:path w="56" h="87">
                <a:moveTo>
                  <a:pt x="56" y="19"/>
                </a:moveTo>
                <a:lnTo>
                  <a:pt x="39" y="19"/>
                </a:lnTo>
                <a:lnTo>
                  <a:pt x="39" y="0"/>
                </a:lnTo>
                <a:lnTo>
                  <a:pt x="0" y="43"/>
                </a:lnTo>
                <a:lnTo>
                  <a:pt x="39" y="87"/>
                </a:lnTo>
                <a:lnTo>
                  <a:pt x="39" y="68"/>
                </a:lnTo>
                <a:lnTo>
                  <a:pt x="56" y="68"/>
                </a:lnTo>
                <a:lnTo>
                  <a:pt x="56" y="19"/>
                </a:lnTo>
                <a:close/>
              </a:path>
            </a:pathLst>
          </a:cu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Rectangle 70"/>
          <p:cNvSpPr/>
          <p:nvPr/>
        </p:nvSpPr>
        <p:spPr>
          <a:xfrm>
            <a:off x="468360" y="1023840"/>
            <a:ext cx="3240" cy="77760"/>
          </a:xfrm>
          <a:prstGeom prst="rect">
            <a:avLst/>
          </a:prstGeom>
          <a:solidFill>
            <a:srgbClr val="66cc99"/>
          </a:solidFill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Line 71"/>
          <p:cNvSpPr/>
          <p:nvPr/>
        </p:nvSpPr>
        <p:spPr>
          <a:xfrm flipH="1">
            <a:off x="2276280" y="949320"/>
            <a:ext cx="21960" cy="745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Rectangle 72"/>
          <p:cNvSpPr/>
          <p:nvPr/>
        </p:nvSpPr>
        <p:spPr>
          <a:xfrm>
            <a:off x="2302200" y="87300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Arial"/>
              </a:rPr>
              <a:t>attB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Text Box 75"/>
          <p:cNvSpPr/>
          <p:nvPr/>
        </p:nvSpPr>
        <p:spPr>
          <a:xfrm>
            <a:off x="971640" y="1123920"/>
            <a:ext cx="12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(PCR produ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3" name="Group 256"/>
          <p:cNvGrpSpPr/>
          <p:nvPr/>
        </p:nvGrpSpPr>
        <p:grpSpPr>
          <a:xfrm>
            <a:off x="7007400" y="1844640"/>
            <a:ext cx="1885680" cy="1944720"/>
            <a:chOff x="7007400" y="1844640"/>
            <a:chExt cx="1885680" cy="1944720"/>
          </a:xfrm>
        </p:grpSpPr>
        <p:sp>
          <p:nvSpPr>
            <p:cNvPr id="434" name="AutoShape 255"/>
            <p:cNvSpPr/>
            <p:nvPr/>
          </p:nvSpPr>
          <p:spPr>
            <a:xfrm>
              <a:off x="7007400" y="1916280"/>
              <a:ext cx="1885680" cy="187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Freeform 257"/>
            <p:cNvSpPr/>
            <p:nvPr/>
          </p:nvSpPr>
          <p:spPr>
            <a:xfrm>
              <a:off x="7297560" y="2146320"/>
              <a:ext cx="1554480" cy="1554120"/>
            </a:xfrm>
            <a:custGeom>
              <a:avLst/>
              <a:gdLst>
                <a:gd name="textAreaLeft" fmla="*/ 0 w 1554480"/>
                <a:gd name="textAreaRight" fmla="*/ 1554840 w 1554480"/>
                <a:gd name="textAreaTop" fmla="*/ 0 h 1554120"/>
                <a:gd name="textAreaBottom" fmla="*/ 1554480 h 1554120"/>
              </a:gdLst>
              <a:ahLst/>
              <a:rect l="textAreaLeft" t="textAreaTop" r="textAreaRight" b="textAreaBottom"/>
              <a:pathLst>
                <a:path w="979" h="979">
                  <a:moveTo>
                    <a:pt x="494" y="0"/>
                  </a:moveTo>
                  <a:lnTo>
                    <a:pt x="450" y="2"/>
                  </a:lnTo>
                  <a:lnTo>
                    <a:pt x="406" y="7"/>
                  </a:lnTo>
                  <a:lnTo>
                    <a:pt x="364" y="17"/>
                  </a:lnTo>
                  <a:lnTo>
                    <a:pt x="322" y="30"/>
                  </a:lnTo>
                  <a:lnTo>
                    <a:pt x="281" y="46"/>
                  </a:lnTo>
                  <a:lnTo>
                    <a:pt x="242" y="67"/>
                  </a:lnTo>
                  <a:lnTo>
                    <a:pt x="206" y="90"/>
                  </a:lnTo>
                  <a:lnTo>
                    <a:pt x="172" y="118"/>
                  </a:lnTo>
                  <a:lnTo>
                    <a:pt x="139" y="147"/>
                  </a:lnTo>
                  <a:lnTo>
                    <a:pt x="110" y="180"/>
                  </a:lnTo>
                  <a:lnTo>
                    <a:pt x="83" y="216"/>
                  </a:lnTo>
                  <a:lnTo>
                    <a:pt x="61" y="252"/>
                  </a:lnTo>
                  <a:lnTo>
                    <a:pt x="42" y="292"/>
                  </a:lnTo>
                  <a:lnTo>
                    <a:pt x="25" y="333"/>
                  </a:lnTo>
                  <a:lnTo>
                    <a:pt x="14" y="375"/>
                  </a:lnTo>
                  <a:lnTo>
                    <a:pt x="5" y="418"/>
                  </a:lnTo>
                  <a:lnTo>
                    <a:pt x="1" y="461"/>
                  </a:lnTo>
                  <a:lnTo>
                    <a:pt x="0" y="505"/>
                  </a:lnTo>
                  <a:lnTo>
                    <a:pt x="3" y="549"/>
                  </a:lnTo>
                  <a:lnTo>
                    <a:pt x="10" y="592"/>
                  </a:lnTo>
                  <a:lnTo>
                    <a:pt x="21" y="635"/>
                  </a:lnTo>
                  <a:lnTo>
                    <a:pt x="36" y="675"/>
                  </a:lnTo>
                  <a:lnTo>
                    <a:pt x="54" y="715"/>
                  </a:lnTo>
                  <a:lnTo>
                    <a:pt x="76" y="753"/>
                  </a:lnTo>
                  <a:lnTo>
                    <a:pt x="102" y="789"/>
                  </a:lnTo>
                  <a:lnTo>
                    <a:pt x="130" y="823"/>
                  </a:lnTo>
                  <a:lnTo>
                    <a:pt x="161" y="853"/>
                  </a:lnTo>
                  <a:lnTo>
                    <a:pt x="194" y="881"/>
                  </a:lnTo>
                  <a:lnTo>
                    <a:pt x="231" y="906"/>
                  </a:lnTo>
                  <a:lnTo>
                    <a:pt x="269" y="927"/>
                  </a:lnTo>
                  <a:lnTo>
                    <a:pt x="309" y="945"/>
                  </a:lnTo>
                  <a:lnTo>
                    <a:pt x="350" y="959"/>
                  </a:lnTo>
                  <a:lnTo>
                    <a:pt x="393" y="970"/>
                  </a:lnTo>
                  <a:lnTo>
                    <a:pt x="436" y="977"/>
                  </a:lnTo>
                  <a:lnTo>
                    <a:pt x="480" y="979"/>
                  </a:lnTo>
                  <a:lnTo>
                    <a:pt x="524" y="978"/>
                  </a:lnTo>
                  <a:lnTo>
                    <a:pt x="567" y="973"/>
                  </a:lnTo>
                  <a:lnTo>
                    <a:pt x="610" y="964"/>
                  </a:lnTo>
                  <a:lnTo>
                    <a:pt x="652" y="951"/>
                  </a:lnTo>
                  <a:lnTo>
                    <a:pt x="693" y="935"/>
                  </a:lnTo>
                  <a:lnTo>
                    <a:pt x="731" y="916"/>
                  </a:lnTo>
                  <a:lnTo>
                    <a:pt x="769" y="892"/>
                  </a:lnTo>
                  <a:lnTo>
                    <a:pt x="803" y="865"/>
                  </a:lnTo>
                  <a:lnTo>
                    <a:pt x="835" y="836"/>
                  </a:lnTo>
                  <a:lnTo>
                    <a:pt x="866" y="804"/>
                  </a:lnTo>
                  <a:lnTo>
                    <a:pt x="892" y="769"/>
                  </a:lnTo>
                  <a:lnTo>
                    <a:pt x="915" y="732"/>
                  </a:lnTo>
                  <a:lnTo>
                    <a:pt x="935" y="693"/>
                  </a:lnTo>
                  <a:lnTo>
                    <a:pt x="952" y="652"/>
                  </a:lnTo>
                  <a:lnTo>
                    <a:pt x="964" y="610"/>
                  </a:lnTo>
                  <a:lnTo>
                    <a:pt x="973" y="568"/>
                  </a:lnTo>
                  <a:lnTo>
                    <a:pt x="978" y="524"/>
                  </a:lnTo>
                  <a:lnTo>
                    <a:pt x="979" y="480"/>
                  </a:lnTo>
                  <a:lnTo>
                    <a:pt x="976" y="437"/>
                  </a:lnTo>
                  <a:lnTo>
                    <a:pt x="970" y="393"/>
                  </a:lnTo>
                  <a:lnTo>
                    <a:pt x="959" y="351"/>
                  </a:lnTo>
                  <a:lnTo>
                    <a:pt x="945" y="309"/>
                  </a:lnTo>
                  <a:lnTo>
                    <a:pt x="927" y="270"/>
                  </a:lnTo>
                  <a:lnTo>
                    <a:pt x="905" y="231"/>
                  </a:lnTo>
                  <a:lnTo>
                    <a:pt x="881" y="195"/>
                  </a:lnTo>
                  <a:lnTo>
                    <a:pt x="853" y="161"/>
                  </a:lnTo>
                  <a:lnTo>
                    <a:pt x="822" y="130"/>
                  </a:lnTo>
                  <a:lnTo>
                    <a:pt x="788" y="102"/>
                  </a:lnTo>
                  <a:lnTo>
                    <a:pt x="753" y="77"/>
                  </a:lnTo>
                  <a:lnTo>
                    <a:pt x="715" y="55"/>
                  </a:lnTo>
                  <a:lnTo>
                    <a:pt x="675" y="36"/>
                  </a:lnTo>
                  <a:lnTo>
                    <a:pt x="634" y="21"/>
                  </a:lnTo>
                  <a:lnTo>
                    <a:pt x="592" y="11"/>
                  </a:lnTo>
                  <a:lnTo>
                    <a:pt x="548" y="3"/>
                  </a:lnTo>
                  <a:lnTo>
                    <a:pt x="505" y="0"/>
                  </a:lnTo>
                  <a:lnTo>
                    <a:pt x="495" y="0"/>
                  </a:lnTo>
                  <a:lnTo>
                    <a:pt x="494" y="11"/>
                  </a:lnTo>
                  <a:lnTo>
                    <a:pt x="537" y="13"/>
                  </a:lnTo>
                  <a:lnTo>
                    <a:pt x="580" y="19"/>
                  </a:lnTo>
                  <a:lnTo>
                    <a:pt x="622" y="29"/>
                  </a:lnTo>
                  <a:lnTo>
                    <a:pt x="661" y="43"/>
                  </a:lnTo>
                  <a:lnTo>
                    <a:pt x="701" y="60"/>
                  </a:lnTo>
                  <a:lnTo>
                    <a:pt x="739" y="81"/>
                  </a:lnTo>
                  <a:lnTo>
                    <a:pt x="774" y="104"/>
                  </a:lnTo>
                  <a:lnTo>
                    <a:pt x="808" y="131"/>
                  </a:lnTo>
                  <a:lnTo>
                    <a:pt x="839" y="161"/>
                  </a:lnTo>
                  <a:lnTo>
                    <a:pt x="867" y="193"/>
                  </a:lnTo>
                  <a:lnTo>
                    <a:pt x="891" y="229"/>
                  </a:lnTo>
                  <a:lnTo>
                    <a:pt x="913" y="265"/>
                  </a:lnTo>
                  <a:lnTo>
                    <a:pt x="931" y="304"/>
                  </a:lnTo>
                  <a:lnTo>
                    <a:pt x="946" y="345"/>
                  </a:lnTo>
                  <a:lnTo>
                    <a:pt x="958" y="385"/>
                  </a:lnTo>
                  <a:lnTo>
                    <a:pt x="964" y="428"/>
                  </a:lnTo>
                  <a:lnTo>
                    <a:pt x="969" y="470"/>
                  </a:lnTo>
                  <a:lnTo>
                    <a:pt x="969" y="513"/>
                  </a:lnTo>
                  <a:lnTo>
                    <a:pt x="964" y="556"/>
                  </a:lnTo>
                  <a:lnTo>
                    <a:pt x="957" y="598"/>
                  </a:lnTo>
                  <a:lnTo>
                    <a:pt x="945" y="640"/>
                  </a:lnTo>
                  <a:lnTo>
                    <a:pt x="930" y="680"/>
                  </a:lnTo>
                  <a:lnTo>
                    <a:pt x="911" y="718"/>
                  </a:lnTo>
                  <a:lnTo>
                    <a:pt x="889" y="755"/>
                  </a:lnTo>
                  <a:lnTo>
                    <a:pt x="863" y="789"/>
                  </a:lnTo>
                  <a:lnTo>
                    <a:pt x="835" y="821"/>
                  </a:lnTo>
                  <a:lnTo>
                    <a:pt x="804" y="852"/>
                  </a:lnTo>
                  <a:lnTo>
                    <a:pt x="771" y="878"/>
                  </a:lnTo>
                  <a:lnTo>
                    <a:pt x="734" y="902"/>
                  </a:lnTo>
                  <a:lnTo>
                    <a:pt x="697" y="922"/>
                  </a:lnTo>
                  <a:lnTo>
                    <a:pt x="657" y="939"/>
                  </a:lnTo>
                  <a:lnTo>
                    <a:pt x="616" y="952"/>
                  </a:lnTo>
                  <a:lnTo>
                    <a:pt x="575" y="961"/>
                  </a:lnTo>
                  <a:lnTo>
                    <a:pt x="533" y="968"/>
                  </a:lnTo>
                  <a:lnTo>
                    <a:pt x="490" y="970"/>
                  </a:lnTo>
                  <a:lnTo>
                    <a:pt x="447" y="968"/>
                  </a:lnTo>
                  <a:lnTo>
                    <a:pt x="405" y="962"/>
                  </a:lnTo>
                  <a:lnTo>
                    <a:pt x="363" y="952"/>
                  </a:lnTo>
                  <a:lnTo>
                    <a:pt x="322" y="939"/>
                  </a:lnTo>
                  <a:lnTo>
                    <a:pt x="282" y="922"/>
                  </a:lnTo>
                  <a:lnTo>
                    <a:pt x="245" y="902"/>
                  </a:lnTo>
                  <a:lnTo>
                    <a:pt x="208" y="878"/>
                  </a:lnTo>
                  <a:lnTo>
                    <a:pt x="175" y="852"/>
                  </a:lnTo>
                  <a:lnTo>
                    <a:pt x="144" y="823"/>
                  </a:lnTo>
                  <a:lnTo>
                    <a:pt x="116" y="790"/>
                  </a:lnTo>
                  <a:lnTo>
                    <a:pt x="90" y="756"/>
                  </a:lnTo>
                  <a:lnTo>
                    <a:pt x="68" y="719"/>
                  </a:lnTo>
                  <a:lnTo>
                    <a:pt x="49" y="681"/>
                  </a:lnTo>
                  <a:lnTo>
                    <a:pt x="34" y="640"/>
                  </a:lnTo>
                  <a:lnTo>
                    <a:pt x="22" y="599"/>
                  </a:lnTo>
                  <a:lnTo>
                    <a:pt x="15" y="557"/>
                  </a:lnTo>
                  <a:lnTo>
                    <a:pt x="10" y="514"/>
                  </a:lnTo>
                  <a:lnTo>
                    <a:pt x="10" y="471"/>
                  </a:lnTo>
                  <a:lnTo>
                    <a:pt x="14" y="428"/>
                  </a:lnTo>
                  <a:lnTo>
                    <a:pt x="21" y="387"/>
                  </a:lnTo>
                  <a:lnTo>
                    <a:pt x="32" y="345"/>
                  </a:lnTo>
                  <a:lnTo>
                    <a:pt x="47" y="305"/>
                  </a:lnTo>
                  <a:lnTo>
                    <a:pt x="65" y="266"/>
                  </a:lnTo>
                  <a:lnTo>
                    <a:pt x="87" y="229"/>
                  </a:lnTo>
                  <a:lnTo>
                    <a:pt x="111" y="194"/>
                  </a:lnTo>
                  <a:lnTo>
                    <a:pt x="139" y="162"/>
                  </a:lnTo>
                  <a:lnTo>
                    <a:pt x="170" y="132"/>
                  </a:lnTo>
                  <a:lnTo>
                    <a:pt x="204" y="105"/>
                  </a:lnTo>
                  <a:lnTo>
                    <a:pt x="239" y="81"/>
                  </a:lnTo>
                  <a:lnTo>
                    <a:pt x="277" y="60"/>
                  </a:lnTo>
                  <a:lnTo>
                    <a:pt x="317" y="43"/>
                  </a:lnTo>
                  <a:lnTo>
                    <a:pt x="356" y="29"/>
                  </a:lnTo>
                  <a:lnTo>
                    <a:pt x="398" y="19"/>
                  </a:lnTo>
                  <a:lnTo>
                    <a:pt x="441" y="13"/>
                  </a:lnTo>
                  <a:lnTo>
                    <a:pt x="484" y="11"/>
                  </a:lnTo>
                  <a:lnTo>
                    <a:pt x="494" y="11"/>
                  </a:lnTo>
                  <a:lnTo>
                    <a:pt x="494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Oval 258"/>
            <p:cNvSpPr/>
            <p:nvPr/>
          </p:nvSpPr>
          <p:spPr>
            <a:xfrm>
              <a:off x="7297560" y="2146320"/>
              <a:ext cx="1548000" cy="154764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Oval 259"/>
            <p:cNvSpPr/>
            <p:nvPr/>
          </p:nvSpPr>
          <p:spPr>
            <a:xfrm>
              <a:off x="7313760" y="2163600"/>
              <a:ext cx="1514160" cy="151308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260"/>
            <p:cNvSpPr/>
            <p:nvPr/>
          </p:nvSpPr>
          <p:spPr>
            <a:xfrm flipV="1">
              <a:off x="8082000" y="21463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261"/>
            <p:cNvSpPr/>
            <p:nvPr/>
          </p:nvSpPr>
          <p:spPr>
            <a:xfrm>
              <a:off x="7671240" y="2798640"/>
              <a:ext cx="84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K2GW7,0  PGI1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262"/>
            <p:cNvSpPr/>
            <p:nvPr/>
          </p:nvSpPr>
          <p:spPr>
            <a:xfrm>
              <a:off x="7902720" y="293220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1319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Freeform 263"/>
            <p:cNvSpPr/>
            <p:nvPr/>
          </p:nvSpPr>
          <p:spPr>
            <a:xfrm>
              <a:off x="7561440" y="2100240"/>
              <a:ext cx="507960" cy="257040"/>
            </a:xfrm>
            <a:custGeom>
              <a:avLst/>
              <a:gdLst>
                <a:gd name="textAreaLeft" fmla="*/ 0 w 507960"/>
                <a:gd name="textAreaRight" fmla="*/ 508320 w 507960"/>
                <a:gd name="textAreaTop" fmla="*/ 0 h 257040"/>
                <a:gd name="textAreaBottom" fmla="*/ 257040 h 257040"/>
              </a:gdLst>
              <a:ahLst/>
              <a:rect l="textAreaLeft" t="textAreaTop" r="textAreaRight" b="textAreaBottom"/>
              <a:pathLst>
                <a:path w="320" h="162">
                  <a:moveTo>
                    <a:pt x="290" y="72"/>
                  </a:moveTo>
                  <a:lnTo>
                    <a:pt x="320" y="34"/>
                  </a:lnTo>
                  <a:lnTo>
                    <a:pt x="286" y="0"/>
                  </a:lnTo>
                  <a:lnTo>
                    <a:pt x="287" y="16"/>
                  </a:lnTo>
                  <a:lnTo>
                    <a:pt x="242" y="21"/>
                  </a:lnTo>
                  <a:lnTo>
                    <a:pt x="198" y="30"/>
                  </a:lnTo>
                  <a:lnTo>
                    <a:pt x="155" y="44"/>
                  </a:lnTo>
                  <a:lnTo>
                    <a:pt x="113" y="60"/>
                  </a:lnTo>
                  <a:lnTo>
                    <a:pt x="72" y="82"/>
                  </a:lnTo>
                  <a:lnTo>
                    <a:pt x="35" y="105"/>
                  </a:lnTo>
                  <a:lnTo>
                    <a:pt x="0" y="131"/>
                  </a:lnTo>
                  <a:lnTo>
                    <a:pt x="26" y="162"/>
                  </a:lnTo>
                  <a:lnTo>
                    <a:pt x="59" y="136"/>
                  </a:lnTo>
                  <a:lnTo>
                    <a:pt x="95" y="115"/>
                  </a:lnTo>
                  <a:lnTo>
                    <a:pt x="131" y="96"/>
                  </a:lnTo>
                  <a:lnTo>
                    <a:pt x="170" y="81"/>
                  </a:lnTo>
                  <a:lnTo>
                    <a:pt x="210" y="69"/>
                  </a:lnTo>
                  <a:lnTo>
                    <a:pt x="250" y="60"/>
                  </a:lnTo>
                  <a:lnTo>
                    <a:pt x="289" y="56"/>
                  </a:lnTo>
                  <a:lnTo>
                    <a:pt x="290" y="72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Arc 264"/>
            <p:cNvSpPr/>
            <p:nvPr/>
          </p:nvSpPr>
          <p:spPr>
            <a:xfrm>
              <a:off x="7561440" y="2125800"/>
              <a:ext cx="509400" cy="795240"/>
            </a:xfrm>
            <a:custGeom>
              <a:avLst/>
              <a:gdLst>
                <a:gd name="textAreaLeft" fmla="*/ 0 w 509400"/>
                <a:gd name="textAreaRight" fmla="*/ 509760 w 509400"/>
                <a:gd name="textAreaTop" fmla="*/ 0 h 795240"/>
                <a:gd name="textAreaBottom" fmla="*/ 795600 h 795240"/>
              </a:gdLst>
              <a:ahLst/>
              <a:rect l="textAreaLeft" t="textAreaTop" r="textAreaRight" b="textAreaBottom"/>
              <a:pathLst>
                <a:path fill="none" w="13811" h="21550">
                  <a:moveTo>
                    <a:pt x="0" y="4942"/>
                  </a:moveTo>
                  <a:cubicBezTo>
                    <a:pt x="3493" y="2036"/>
                    <a:pt x="7814" y="307"/>
                    <a:pt x="12347" y="-1"/>
                  </a:cubicBezTo>
                </a:path>
                <a:path stroke="0" w="13811" h="21550">
                  <a:moveTo>
                    <a:pt x="0" y="4942"/>
                  </a:moveTo>
                  <a:cubicBezTo>
                    <a:pt x="3493" y="2036"/>
                    <a:pt x="7814" y="307"/>
                    <a:pt x="12347" y="-1"/>
                  </a:cubicBezTo>
                  <a:lnTo>
                    <a:pt x="13811" y="21550"/>
                  </a:lnTo>
                  <a:lnTo>
                    <a:pt x="0" y="494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Arc 265"/>
            <p:cNvSpPr/>
            <p:nvPr/>
          </p:nvSpPr>
          <p:spPr>
            <a:xfrm>
              <a:off x="7602480" y="2189160"/>
              <a:ext cx="468360" cy="731880"/>
            </a:xfrm>
            <a:custGeom>
              <a:avLst/>
              <a:gdLst>
                <a:gd name="textAreaLeft" fmla="*/ 0 w 468360"/>
                <a:gd name="textAreaRight" fmla="*/ 468720 w 468360"/>
                <a:gd name="textAreaTop" fmla="*/ 0 h 731880"/>
                <a:gd name="textAreaBottom" fmla="*/ 732240 h 731880"/>
              </a:gdLst>
              <a:ahLst/>
              <a:rect l="textAreaLeft" t="textAreaTop" r="textAreaRight" b="textAreaBottom"/>
              <a:pathLst>
                <a:path fill="none" w="13796" h="21548">
                  <a:moveTo>
                    <a:pt x="-1" y="4927"/>
                  </a:moveTo>
                  <a:cubicBezTo>
                    <a:pt x="3482" y="2036"/>
                    <a:pt x="7786" y="312"/>
                    <a:pt x="12301" y="-1"/>
                  </a:cubicBezTo>
                </a:path>
                <a:path stroke="0" w="13796" h="21548">
                  <a:moveTo>
                    <a:pt x="-1" y="4927"/>
                  </a:moveTo>
                  <a:cubicBezTo>
                    <a:pt x="3482" y="2036"/>
                    <a:pt x="7786" y="312"/>
                    <a:pt x="12301" y="-1"/>
                  </a:cubicBezTo>
                  <a:lnTo>
                    <a:pt x="13796" y="21548"/>
                  </a:lnTo>
                  <a:lnTo>
                    <a:pt x="-1" y="492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Line 266"/>
            <p:cNvSpPr/>
            <p:nvPr/>
          </p:nvSpPr>
          <p:spPr>
            <a:xfrm flipH="1" flipV="1">
              <a:off x="7561440" y="2308320"/>
              <a:ext cx="410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Freeform 267"/>
            <p:cNvSpPr/>
            <p:nvPr/>
          </p:nvSpPr>
          <p:spPr>
            <a:xfrm>
              <a:off x="8015400" y="2100240"/>
              <a:ext cx="54000" cy="11448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32" h="67">
                  <a:moveTo>
                    <a:pt x="3" y="52"/>
                  </a:moveTo>
                  <a:lnTo>
                    <a:pt x="4" y="67"/>
                  </a:lnTo>
                  <a:lnTo>
                    <a:pt x="32" y="32"/>
                  </a:lnTo>
                  <a:lnTo>
                    <a:pt x="0" y="0"/>
                  </a:lnTo>
                  <a:lnTo>
                    <a:pt x="1" y="1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Line 268"/>
            <p:cNvSpPr/>
            <p:nvPr/>
          </p:nvSpPr>
          <p:spPr>
            <a:xfrm>
              <a:off x="7767720" y="2119320"/>
              <a:ext cx="30240" cy="525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269"/>
            <p:cNvSpPr/>
            <p:nvPr/>
          </p:nvSpPr>
          <p:spPr>
            <a:xfrm>
              <a:off x="7602480" y="2030400"/>
              <a:ext cx="23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s-ES" sz="700" spc="-1" strike="noStrike">
                  <a:solidFill>
                    <a:srgbClr val="800000"/>
                  </a:solidFill>
                  <a:latin typeface="Arial"/>
                </a:rPr>
                <a:t>PGI1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Line 270"/>
            <p:cNvSpPr/>
            <p:nvPr/>
          </p:nvSpPr>
          <p:spPr>
            <a:xfrm>
              <a:off x="7534440" y="2293920"/>
              <a:ext cx="77760" cy="92160"/>
            </a:xfrm>
            <a:prstGeom prst="line">
              <a:avLst/>
            </a:prstGeom>
            <a:ln w="144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Line 271"/>
            <p:cNvSpPr/>
            <p:nvPr/>
          </p:nvSpPr>
          <p:spPr>
            <a:xfrm>
              <a:off x="7480440" y="2241720"/>
              <a:ext cx="54000" cy="522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Rectangle 272"/>
            <p:cNvSpPr/>
            <p:nvPr/>
          </p:nvSpPr>
          <p:spPr>
            <a:xfrm>
              <a:off x="7317720" y="215280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273"/>
            <p:cNvSpPr/>
            <p:nvPr/>
          </p:nvSpPr>
          <p:spPr>
            <a:xfrm>
              <a:off x="8070840" y="2095560"/>
              <a:ext cx="1440" cy="120600"/>
            </a:xfrm>
            <a:prstGeom prst="line">
              <a:avLst/>
            </a:prstGeom>
            <a:ln w="144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274"/>
            <p:cNvSpPr/>
            <p:nvPr/>
          </p:nvSpPr>
          <p:spPr>
            <a:xfrm flipH="1">
              <a:off x="8070840" y="2017800"/>
              <a:ext cx="6480" cy="777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275"/>
            <p:cNvSpPr/>
            <p:nvPr/>
          </p:nvSpPr>
          <p:spPr>
            <a:xfrm>
              <a:off x="7914600" y="19288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Freeform 276"/>
            <p:cNvSpPr/>
            <p:nvPr/>
          </p:nvSpPr>
          <p:spPr>
            <a:xfrm>
              <a:off x="7275600" y="2746440"/>
              <a:ext cx="185760" cy="611280"/>
            </a:xfrm>
            <a:custGeom>
              <a:avLst/>
              <a:gdLst>
                <a:gd name="textAreaLeft" fmla="*/ 0 w 185760"/>
                <a:gd name="textAreaRight" fmla="*/ 186120 w 185760"/>
                <a:gd name="textAreaTop" fmla="*/ 0 h 611280"/>
                <a:gd name="textAreaBottom" fmla="*/ 611280 h 611280"/>
              </a:gdLst>
              <a:ahLst/>
              <a:rect l="textAreaLeft" t="textAreaTop" r="textAreaRight" b="textAreaBottom"/>
              <a:pathLst>
                <a:path w="117" h="385">
                  <a:moveTo>
                    <a:pt x="11" y="0"/>
                  </a:moveTo>
                  <a:lnTo>
                    <a:pt x="3" y="44"/>
                  </a:lnTo>
                  <a:lnTo>
                    <a:pt x="0" y="89"/>
                  </a:lnTo>
                  <a:lnTo>
                    <a:pt x="0" y="134"/>
                  </a:lnTo>
                  <a:lnTo>
                    <a:pt x="3" y="179"/>
                  </a:lnTo>
                  <a:lnTo>
                    <a:pt x="11" y="223"/>
                  </a:lnTo>
                  <a:lnTo>
                    <a:pt x="23" y="267"/>
                  </a:lnTo>
                  <a:lnTo>
                    <a:pt x="39" y="309"/>
                  </a:lnTo>
                  <a:lnTo>
                    <a:pt x="59" y="350"/>
                  </a:lnTo>
                  <a:lnTo>
                    <a:pt x="70" y="368"/>
                  </a:lnTo>
                  <a:lnTo>
                    <a:pt x="56" y="377"/>
                  </a:lnTo>
                  <a:lnTo>
                    <a:pt x="103" y="385"/>
                  </a:lnTo>
                  <a:lnTo>
                    <a:pt x="117" y="340"/>
                  </a:lnTo>
                  <a:lnTo>
                    <a:pt x="103" y="348"/>
                  </a:lnTo>
                  <a:lnTo>
                    <a:pt x="83" y="311"/>
                  </a:lnTo>
                  <a:lnTo>
                    <a:pt x="67" y="273"/>
                  </a:lnTo>
                  <a:lnTo>
                    <a:pt x="54" y="234"/>
                  </a:lnTo>
                  <a:lnTo>
                    <a:pt x="46" y="193"/>
                  </a:lnTo>
                  <a:lnTo>
                    <a:pt x="40" y="151"/>
                  </a:lnTo>
                  <a:lnTo>
                    <a:pt x="38" y="111"/>
                  </a:lnTo>
                  <a:lnTo>
                    <a:pt x="40" y="69"/>
                  </a:lnTo>
                  <a:lnTo>
                    <a:pt x="46" y="28"/>
                  </a:lnTo>
                  <a:lnTo>
                    <a:pt x="50" y="9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Arc 277"/>
            <p:cNvSpPr/>
            <p:nvPr/>
          </p:nvSpPr>
          <p:spPr>
            <a:xfrm>
              <a:off x="7273800" y="2746440"/>
              <a:ext cx="797040" cy="584280"/>
            </a:xfrm>
            <a:custGeom>
              <a:avLst/>
              <a:gdLst>
                <a:gd name="textAreaLeft" fmla="*/ 0 w 797040"/>
                <a:gd name="textAreaRight" fmla="*/ 797400 w 797040"/>
                <a:gd name="textAreaTop" fmla="*/ 0 h 584280"/>
                <a:gd name="textAreaBottom" fmla="*/ 584640 h 584280"/>
              </a:gdLst>
              <a:ahLst/>
              <a:rect l="textAreaLeft" t="textAreaTop" r="textAreaRight" b="textAreaBottom"/>
              <a:pathLst>
                <a:path fill="none" w="21600" h="15825">
                  <a:moveTo>
                    <a:pt x="3066" y="15825"/>
                  </a:moveTo>
                  <a:cubicBezTo>
                    <a:pt x="1059" y="12472"/>
                    <a:pt x="0" y="8638"/>
                    <a:pt x="0" y="4731"/>
                  </a:cubicBezTo>
                  <a:cubicBezTo>
                    <a:pt x="-1" y="3139"/>
                    <a:pt x="175" y="1552"/>
                    <a:pt x="524" y="-1"/>
                  </a:cubicBezTo>
                </a:path>
                <a:path stroke="0" w="21600" h="15825">
                  <a:moveTo>
                    <a:pt x="3066" y="15825"/>
                  </a:moveTo>
                  <a:cubicBezTo>
                    <a:pt x="1059" y="12472"/>
                    <a:pt x="0" y="8638"/>
                    <a:pt x="0" y="4731"/>
                  </a:cubicBezTo>
                  <a:cubicBezTo>
                    <a:pt x="-1" y="3139"/>
                    <a:pt x="175" y="1552"/>
                    <a:pt x="524" y="-1"/>
                  </a:cubicBezTo>
                  <a:lnTo>
                    <a:pt x="21600" y="4731"/>
                  </a:lnTo>
                  <a:lnTo>
                    <a:pt x="3066" y="1582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Arc 278"/>
            <p:cNvSpPr/>
            <p:nvPr/>
          </p:nvSpPr>
          <p:spPr>
            <a:xfrm>
              <a:off x="7335720" y="2760840"/>
              <a:ext cx="735120" cy="536400"/>
            </a:xfrm>
            <a:custGeom>
              <a:avLst/>
              <a:gdLst>
                <a:gd name="textAreaLeft" fmla="*/ 0 w 735120"/>
                <a:gd name="textAreaRight" fmla="*/ 735480 w 735120"/>
                <a:gd name="textAreaTop" fmla="*/ 0 h 536400"/>
                <a:gd name="textAreaBottom" fmla="*/ 536760 h 536400"/>
              </a:gdLst>
              <a:ahLst/>
              <a:rect l="textAreaLeft" t="textAreaTop" r="textAreaRight" b="textAreaBottom"/>
              <a:pathLst>
                <a:path fill="none" w="21600" h="15820">
                  <a:moveTo>
                    <a:pt x="3067" y="15819"/>
                  </a:moveTo>
                  <a:cubicBezTo>
                    <a:pt x="1060" y="12467"/>
                    <a:pt x="0" y="8632"/>
                    <a:pt x="0" y="4725"/>
                  </a:cubicBezTo>
                  <a:cubicBezTo>
                    <a:pt x="-1" y="3135"/>
                    <a:pt x="175" y="1550"/>
                    <a:pt x="523" y="0"/>
                  </a:cubicBezTo>
                </a:path>
                <a:path stroke="0" w="21600" h="15820">
                  <a:moveTo>
                    <a:pt x="3067" y="15819"/>
                  </a:moveTo>
                  <a:cubicBezTo>
                    <a:pt x="1060" y="12467"/>
                    <a:pt x="0" y="8632"/>
                    <a:pt x="0" y="4725"/>
                  </a:cubicBezTo>
                  <a:cubicBezTo>
                    <a:pt x="-1" y="3135"/>
                    <a:pt x="175" y="1550"/>
                    <a:pt x="523" y="0"/>
                  </a:cubicBezTo>
                  <a:lnTo>
                    <a:pt x="21600" y="4725"/>
                  </a:lnTo>
                  <a:lnTo>
                    <a:pt x="3067" y="1581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279"/>
            <p:cNvSpPr/>
            <p:nvPr/>
          </p:nvSpPr>
          <p:spPr>
            <a:xfrm flipH="1" flipV="1">
              <a:off x="7292880" y="2746440"/>
              <a:ext cx="61920" cy="14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Freeform 280"/>
            <p:cNvSpPr/>
            <p:nvPr/>
          </p:nvSpPr>
          <p:spPr>
            <a:xfrm>
              <a:off x="7364520" y="3286080"/>
              <a:ext cx="96840" cy="7164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57" h="42">
                  <a:moveTo>
                    <a:pt x="44" y="7"/>
                  </a:moveTo>
                  <a:lnTo>
                    <a:pt x="57" y="0"/>
                  </a:lnTo>
                  <a:lnTo>
                    <a:pt x="44" y="42"/>
                  </a:lnTo>
                  <a:lnTo>
                    <a:pt x="0" y="34"/>
                  </a:lnTo>
                  <a:lnTo>
                    <a:pt x="13" y="2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281"/>
            <p:cNvSpPr/>
            <p:nvPr/>
          </p:nvSpPr>
          <p:spPr>
            <a:xfrm flipV="1">
              <a:off x="7147080" y="3072960"/>
              <a:ext cx="141120" cy="270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Rectangle 282"/>
            <p:cNvSpPr/>
            <p:nvPr/>
          </p:nvSpPr>
          <p:spPr>
            <a:xfrm>
              <a:off x="7024680" y="301140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Ka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Freeform 283"/>
            <p:cNvSpPr/>
            <p:nvPr/>
          </p:nvSpPr>
          <p:spPr>
            <a:xfrm>
              <a:off x="7300800" y="2347920"/>
              <a:ext cx="270000" cy="401760"/>
            </a:xfrm>
            <a:custGeom>
              <a:avLst/>
              <a:gdLst>
                <a:gd name="textAreaLeft" fmla="*/ 0 w 270000"/>
                <a:gd name="textAreaRight" fmla="*/ 270360 w 270000"/>
                <a:gd name="textAreaTop" fmla="*/ 0 h 401760"/>
                <a:gd name="textAreaBottom" fmla="*/ 402120 h 401760"/>
              </a:gdLst>
              <a:ahLst/>
              <a:rect l="textAreaLeft" t="textAreaTop" r="textAreaRight" b="textAreaBottom"/>
              <a:pathLst>
                <a:path w="170" h="253">
                  <a:moveTo>
                    <a:pt x="170" y="49"/>
                  </a:moveTo>
                  <a:lnTo>
                    <a:pt x="167" y="3"/>
                  </a:lnTo>
                  <a:lnTo>
                    <a:pt x="118" y="0"/>
                  </a:lnTo>
                  <a:lnTo>
                    <a:pt x="130" y="10"/>
                  </a:lnTo>
                  <a:lnTo>
                    <a:pt x="100" y="44"/>
                  </a:lnTo>
                  <a:lnTo>
                    <a:pt x="73" y="79"/>
                  </a:lnTo>
                  <a:lnTo>
                    <a:pt x="49" y="118"/>
                  </a:lnTo>
                  <a:lnTo>
                    <a:pt x="29" y="159"/>
                  </a:lnTo>
                  <a:lnTo>
                    <a:pt x="12" y="200"/>
                  </a:lnTo>
                  <a:lnTo>
                    <a:pt x="0" y="243"/>
                  </a:lnTo>
                  <a:lnTo>
                    <a:pt x="38" y="253"/>
                  </a:lnTo>
                  <a:lnTo>
                    <a:pt x="49" y="213"/>
                  </a:lnTo>
                  <a:lnTo>
                    <a:pt x="64" y="175"/>
                  </a:lnTo>
                  <a:lnTo>
                    <a:pt x="84" y="138"/>
                  </a:lnTo>
                  <a:lnTo>
                    <a:pt x="105" y="103"/>
                  </a:lnTo>
                  <a:lnTo>
                    <a:pt x="130" y="69"/>
                  </a:lnTo>
                  <a:lnTo>
                    <a:pt x="158" y="38"/>
                  </a:lnTo>
                  <a:lnTo>
                    <a:pt x="170" y="49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Arc 284"/>
            <p:cNvSpPr/>
            <p:nvPr/>
          </p:nvSpPr>
          <p:spPr>
            <a:xfrm>
              <a:off x="7299360" y="2362320"/>
              <a:ext cx="771480" cy="558720"/>
            </a:xfrm>
            <a:custGeom>
              <a:avLst/>
              <a:gdLst>
                <a:gd name="textAreaLeft" fmla="*/ 0 w 771480"/>
                <a:gd name="textAreaRight" fmla="*/ 771840 w 771480"/>
                <a:gd name="textAreaTop" fmla="*/ 0 h 558720"/>
                <a:gd name="textAreaBottom" fmla="*/ 559080 h 558720"/>
              </a:gdLst>
              <a:ahLst/>
              <a:rect l="textAreaLeft" t="textAreaTop" r="textAreaRight" b="textAreaBottom"/>
              <a:pathLst>
                <a:path fill="none" w="20988" h="15187">
                  <a:moveTo>
                    <a:pt x="0" y="10081"/>
                  </a:moveTo>
                  <a:cubicBezTo>
                    <a:pt x="926" y="6272"/>
                    <a:pt x="2872" y="2787"/>
                    <a:pt x="5628" y="0"/>
                  </a:cubicBezTo>
                </a:path>
                <a:path stroke="0" w="20988" h="15187">
                  <a:moveTo>
                    <a:pt x="0" y="10081"/>
                  </a:moveTo>
                  <a:cubicBezTo>
                    <a:pt x="926" y="6272"/>
                    <a:pt x="2872" y="2787"/>
                    <a:pt x="5628" y="0"/>
                  </a:cubicBezTo>
                  <a:lnTo>
                    <a:pt x="20988" y="15187"/>
                  </a:lnTo>
                  <a:lnTo>
                    <a:pt x="0" y="1008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Arc 285"/>
            <p:cNvSpPr/>
            <p:nvPr/>
          </p:nvSpPr>
          <p:spPr>
            <a:xfrm>
              <a:off x="7359480" y="2408400"/>
              <a:ext cx="711360" cy="512640"/>
            </a:xfrm>
            <a:custGeom>
              <a:avLst/>
              <a:gdLst>
                <a:gd name="textAreaLeft" fmla="*/ 0 w 711360"/>
                <a:gd name="textAreaRight" fmla="*/ 711720 w 711360"/>
                <a:gd name="textAreaTop" fmla="*/ 0 h 512640"/>
                <a:gd name="textAreaBottom" fmla="*/ 513000 h 512640"/>
              </a:gdLst>
              <a:ahLst/>
              <a:rect l="textAreaLeft" t="textAreaTop" r="textAreaRight" b="textAreaBottom"/>
              <a:pathLst>
                <a:path fill="none" w="20995" h="15188">
                  <a:moveTo>
                    <a:pt x="0" y="10110"/>
                  </a:moveTo>
                  <a:cubicBezTo>
                    <a:pt x="924" y="6290"/>
                    <a:pt x="2872" y="2794"/>
                    <a:pt x="5636" y="0"/>
                  </a:cubicBezTo>
                </a:path>
                <a:path stroke="0" w="20995" h="15188">
                  <a:moveTo>
                    <a:pt x="0" y="10110"/>
                  </a:moveTo>
                  <a:cubicBezTo>
                    <a:pt x="924" y="6290"/>
                    <a:pt x="2872" y="2794"/>
                    <a:pt x="5636" y="0"/>
                  </a:cubicBezTo>
                  <a:lnTo>
                    <a:pt x="20995" y="15188"/>
                  </a:lnTo>
                  <a:lnTo>
                    <a:pt x="0" y="1011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286"/>
            <p:cNvSpPr/>
            <p:nvPr/>
          </p:nvSpPr>
          <p:spPr>
            <a:xfrm flipH="1" flipV="1">
              <a:off x="7300800" y="2733840"/>
              <a:ext cx="6048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Freeform 287"/>
            <p:cNvSpPr/>
            <p:nvPr/>
          </p:nvSpPr>
          <p:spPr>
            <a:xfrm>
              <a:off x="7488360" y="2347920"/>
              <a:ext cx="82440" cy="77760"/>
            </a:xfrm>
            <a:custGeom>
              <a:avLst/>
              <a:gdLst>
                <a:gd name="textAreaLeft" fmla="*/ 0 w 82440"/>
                <a:gd name="textAreaRight" fmla="*/ 82800 w 82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48" h="46">
                  <a:moveTo>
                    <a:pt x="37" y="36"/>
                  </a:moveTo>
                  <a:lnTo>
                    <a:pt x="48" y="46"/>
                  </a:lnTo>
                  <a:lnTo>
                    <a:pt x="46" y="3"/>
                  </a:lnTo>
                  <a:lnTo>
                    <a:pt x="0" y="0"/>
                  </a:lnTo>
                  <a:lnTo>
                    <a:pt x="11" y="1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288"/>
            <p:cNvSpPr/>
            <p:nvPr/>
          </p:nvSpPr>
          <p:spPr>
            <a:xfrm>
              <a:off x="7243920" y="2430360"/>
              <a:ext cx="147600" cy="828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ectangle 289"/>
            <p:cNvSpPr/>
            <p:nvPr/>
          </p:nvSpPr>
          <p:spPr>
            <a:xfrm>
              <a:off x="7084440" y="23414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Freeform 290"/>
            <p:cNvSpPr/>
            <p:nvPr/>
          </p:nvSpPr>
          <p:spPr>
            <a:xfrm>
              <a:off x="8091360" y="2114640"/>
              <a:ext cx="109800" cy="71280"/>
            </a:xfrm>
            <a:custGeom>
              <a:avLst/>
              <a:gdLst>
                <a:gd name="textAreaLeft" fmla="*/ 0 w 109800"/>
                <a:gd name="textAreaRight" fmla="*/ 110160 w 1098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69" h="45">
                  <a:moveTo>
                    <a:pt x="69" y="6"/>
                  </a:moveTo>
                  <a:lnTo>
                    <a:pt x="24" y="1"/>
                  </a:lnTo>
                  <a:lnTo>
                    <a:pt x="1" y="0"/>
                  </a:lnTo>
                  <a:lnTo>
                    <a:pt x="0" y="39"/>
                  </a:lnTo>
                  <a:lnTo>
                    <a:pt x="42" y="43"/>
                  </a:lnTo>
                  <a:lnTo>
                    <a:pt x="63" y="45"/>
                  </a:lnTo>
                  <a:lnTo>
                    <a:pt x="69" y="6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Arc 291"/>
            <p:cNvSpPr/>
            <p:nvPr/>
          </p:nvSpPr>
          <p:spPr>
            <a:xfrm>
              <a:off x="8072280" y="2116080"/>
              <a:ext cx="128880" cy="804960"/>
            </a:xfrm>
            <a:custGeom>
              <a:avLst/>
              <a:gdLst>
                <a:gd name="textAreaLeft" fmla="*/ 0 w 128880"/>
                <a:gd name="textAreaRight" fmla="*/ 129240 w 128880"/>
                <a:gd name="textAreaTop" fmla="*/ 0 h 804960"/>
                <a:gd name="textAreaBottom" fmla="*/ 805320 h 804960"/>
              </a:gdLst>
              <a:ahLst/>
              <a:rect l="textAreaLeft" t="textAreaTop" r="textAreaRight" b="textAreaBottom"/>
              <a:pathLst>
                <a:path fill="none" w="3434" h="21593">
                  <a:moveTo>
                    <a:pt x="550" y="0"/>
                  </a:moveTo>
                  <a:cubicBezTo>
                    <a:pt x="1516" y="24"/>
                    <a:pt x="2480" y="114"/>
                    <a:pt x="3434" y="267"/>
                  </a:cubicBezTo>
                </a:path>
                <a:path stroke="0" w="3434" h="21593">
                  <a:moveTo>
                    <a:pt x="550" y="0"/>
                  </a:moveTo>
                  <a:cubicBezTo>
                    <a:pt x="1516" y="24"/>
                    <a:pt x="2480" y="114"/>
                    <a:pt x="3434" y="267"/>
                  </a:cubicBezTo>
                  <a:lnTo>
                    <a:pt x="0" y="21593"/>
                  </a:lnTo>
                  <a:lnTo>
                    <a:pt x="550" y="0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Arc 292"/>
            <p:cNvSpPr/>
            <p:nvPr/>
          </p:nvSpPr>
          <p:spPr>
            <a:xfrm>
              <a:off x="8072280" y="2178000"/>
              <a:ext cx="119160" cy="743040"/>
            </a:xfrm>
            <a:custGeom>
              <a:avLst/>
              <a:gdLst>
                <a:gd name="textAreaLeft" fmla="*/ 0 w 119160"/>
                <a:gd name="textAreaRight" fmla="*/ 119520 w 119160"/>
                <a:gd name="textAreaTop" fmla="*/ 0 h 743040"/>
                <a:gd name="textAreaBottom" fmla="*/ 743400 h 743040"/>
              </a:gdLst>
              <a:ahLst/>
              <a:rect l="textAreaLeft" t="textAreaTop" r="textAreaRight" b="textAreaBottom"/>
              <a:pathLst>
                <a:path fill="none" w="3454" h="21593">
                  <a:moveTo>
                    <a:pt x="551" y="0"/>
                  </a:moveTo>
                  <a:cubicBezTo>
                    <a:pt x="1524" y="24"/>
                    <a:pt x="2493" y="115"/>
                    <a:pt x="3454" y="270"/>
                  </a:cubicBezTo>
                </a:path>
                <a:path stroke="0" w="3454" h="21593">
                  <a:moveTo>
                    <a:pt x="551" y="0"/>
                  </a:moveTo>
                  <a:cubicBezTo>
                    <a:pt x="1524" y="24"/>
                    <a:pt x="2493" y="115"/>
                    <a:pt x="3454" y="270"/>
                  </a:cubicBezTo>
                  <a:lnTo>
                    <a:pt x="0" y="21593"/>
                  </a:lnTo>
                  <a:lnTo>
                    <a:pt x="551" y="0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Line 293"/>
            <p:cNvSpPr/>
            <p:nvPr/>
          </p:nvSpPr>
          <p:spPr>
            <a:xfrm flipV="1">
              <a:off x="8191440" y="2124000"/>
              <a:ext cx="9720" cy="61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294"/>
            <p:cNvSpPr/>
            <p:nvPr/>
          </p:nvSpPr>
          <p:spPr>
            <a:xfrm flipV="1">
              <a:off x="8091360" y="2114640"/>
              <a:ext cx="1800" cy="619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295"/>
            <p:cNvSpPr/>
            <p:nvPr/>
          </p:nvSpPr>
          <p:spPr>
            <a:xfrm flipH="1">
              <a:off x="8150400" y="1989000"/>
              <a:ext cx="93600" cy="1288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Rectangle 296"/>
            <p:cNvSpPr/>
            <p:nvPr/>
          </p:nvSpPr>
          <p:spPr>
            <a:xfrm>
              <a:off x="8236800" y="184464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Freeform 297"/>
            <p:cNvSpPr/>
            <p:nvPr/>
          </p:nvSpPr>
          <p:spPr>
            <a:xfrm>
              <a:off x="8199360" y="2136600"/>
              <a:ext cx="101520" cy="810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64" h="51">
                  <a:moveTo>
                    <a:pt x="64" y="12"/>
                  </a:moveTo>
                  <a:lnTo>
                    <a:pt x="20" y="2"/>
                  </a:lnTo>
                  <a:lnTo>
                    <a:pt x="6" y="0"/>
                  </a:lnTo>
                  <a:lnTo>
                    <a:pt x="0" y="38"/>
                  </a:lnTo>
                  <a:lnTo>
                    <a:pt x="41" y="47"/>
                  </a:lnTo>
                  <a:lnTo>
                    <a:pt x="54" y="51"/>
                  </a:lnTo>
                  <a:lnTo>
                    <a:pt x="64" y="1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Arc 298"/>
            <p:cNvSpPr/>
            <p:nvPr/>
          </p:nvSpPr>
          <p:spPr>
            <a:xfrm>
              <a:off x="8070840" y="2136600"/>
              <a:ext cx="230040" cy="784440"/>
            </a:xfrm>
            <a:custGeom>
              <a:avLst/>
              <a:gdLst>
                <a:gd name="textAreaLeft" fmla="*/ 0 w 230040"/>
                <a:gd name="textAreaRight" fmla="*/ 230400 w 230040"/>
                <a:gd name="textAreaTop" fmla="*/ 0 h 784440"/>
                <a:gd name="textAreaBottom" fmla="*/ 784800 h 784440"/>
              </a:gdLst>
              <a:ahLst/>
              <a:rect l="textAreaLeft" t="textAreaTop" r="textAreaRight" b="textAreaBottom"/>
              <a:pathLst>
                <a:path fill="none" w="6222" h="21273">
                  <a:moveTo>
                    <a:pt x="3745" y="0"/>
                  </a:moveTo>
                  <a:cubicBezTo>
                    <a:pt x="4582" y="147"/>
                    <a:pt x="5409" y="343"/>
                    <a:pt x="6222" y="588"/>
                  </a:cubicBezTo>
                </a:path>
                <a:path stroke="0" w="6222" h="21273">
                  <a:moveTo>
                    <a:pt x="3745" y="0"/>
                  </a:moveTo>
                  <a:cubicBezTo>
                    <a:pt x="4582" y="147"/>
                    <a:pt x="5409" y="343"/>
                    <a:pt x="6222" y="588"/>
                  </a:cubicBezTo>
                  <a:lnTo>
                    <a:pt x="0" y="21273"/>
                  </a:lnTo>
                  <a:lnTo>
                    <a:pt x="374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Arc 299"/>
            <p:cNvSpPr/>
            <p:nvPr/>
          </p:nvSpPr>
          <p:spPr>
            <a:xfrm>
              <a:off x="8070840" y="2198520"/>
              <a:ext cx="214200" cy="72252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722520"/>
                <a:gd name="textAreaBottom" fmla="*/ 722880 h 722520"/>
              </a:gdLst>
              <a:ahLst/>
              <a:rect l="textAreaLeft" t="textAreaTop" r="textAreaRight" b="textAreaBottom"/>
              <a:pathLst>
                <a:path fill="none" w="6290" h="21268">
                  <a:moveTo>
                    <a:pt x="3773" y="0"/>
                  </a:moveTo>
                  <a:cubicBezTo>
                    <a:pt x="4623" y="151"/>
                    <a:pt x="5464" y="352"/>
                    <a:pt x="6289" y="604"/>
                  </a:cubicBezTo>
                </a:path>
                <a:path stroke="0" w="6290" h="21268">
                  <a:moveTo>
                    <a:pt x="3773" y="0"/>
                  </a:moveTo>
                  <a:cubicBezTo>
                    <a:pt x="4623" y="151"/>
                    <a:pt x="5464" y="352"/>
                    <a:pt x="6289" y="604"/>
                  </a:cubicBezTo>
                  <a:lnTo>
                    <a:pt x="0" y="21268"/>
                  </a:lnTo>
                  <a:lnTo>
                    <a:pt x="377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300"/>
            <p:cNvSpPr/>
            <p:nvPr/>
          </p:nvSpPr>
          <p:spPr>
            <a:xfrm flipV="1">
              <a:off x="8285040" y="2155680"/>
              <a:ext cx="1584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301"/>
            <p:cNvSpPr/>
            <p:nvPr/>
          </p:nvSpPr>
          <p:spPr>
            <a:xfrm flipV="1">
              <a:off x="8199360" y="2136600"/>
              <a:ext cx="972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Line 302"/>
            <p:cNvSpPr/>
            <p:nvPr/>
          </p:nvSpPr>
          <p:spPr>
            <a:xfrm flipH="1">
              <a:off x="8254800" y="2095560"/>
              <a:ext cx="60120" cy="493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303"/>
            <p:cNvSpPr/>
            <p:nvPr/>
          </p:nvSpPr>
          <p:spPr>
            <a:xfrm>
              <a:off x="8329320" y="198900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Freeform 304"/>
            <p:cNvSpPr/>
            <p:nvPr/>
          </p:nvSpPr>
          <p:spPr>
            <a:xfrm>
              <a:off x="7415280" y="3341520"/>
              <a:ext cx="144360" cy="154080"/>
            </a:xfrm>
            <a:custGeom>
              <a:avLst/>
              <a:gdLst>
                <a:gd name="textAreaLeft" fmla="*/ 0 w 144360"/>
                <a:gd name="textAreaRight" fmla="*/ 144720 w 144360"/>
                <a:gd name="textAreaTop" fmla="*/ 0 h 154080"/>
                <a:gd name="textAreaBottom" fmla="*/ 154440 h 154080"/>
              </a:gdLst>
              <a:ahLst/>
              <a:rect l="textAreaLeft" t="textAreaTop" r="textAreaRight" b="textAreaBottom"/>
              <a:pathLst>
                <a:path w="91" h="97">
                  <a:moveTo>
                    <a:pt x="0" y="22"/>
                  </a:moveTo>
                  <a:lnTo>
                    <a:pt x="27" y="58"/>
                  </a:lnTo>
                  <a:lnTo>
                    <a:pt x="57" y="92"/>
                  </a:lnTo>
                  <a:lnTo>
                    <a:pt x="63" y="97"/>
                  </a:lnTo>
                  <a:lnTo>
                    <a:pt x="91" y="70"/>
                  </a:lnTo>
                  <a:lnTo>
                    <a:pt x="62" y="38"/>
                  </a:lnTo>
                  <a:lnTo>
                    <a:pt x="36" y="6"/>
                  </a:lnTo>
                  <a:lnTo>
                    <a:pt x="32" y="0"/>
                  </a:lnTo>
                  <a:lnTo>
                    <a:pt x="0" y="22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Arc 305"/>
            <p:cNvSpPr/>
            <p:nvPr/>
          </p:nvSpPr>
          <p:spPr>
            <a:xfrm>
              <a:off x="7416720" y="2921040"/>
              <a:ext cx="654120" cy="573120"/>
            </a:xfrm>
            <a:custGeom>
              <a:avLst/>
              <a:gdLst>
                <a:gd name="textAreaLeft" fmla="*/ 0 w 654120"/>
                <a:gd name="textAreaRight" fmla="*/ 654480 w 654120"/>
                <a:gd name="textAreaTop" fmla="*/ 0 h 573120"/>
                <a:gd name="textAreaBottom" fmla="*/ 573480 h 573120"/>
              </a:gdLst>
              <a:ahLst/>
              <a:rect l="textAreaLeft" t="textAreaTop" r="textAreaRight" b="textAreaBottom"/>
              <a:pathLst>
                <a:path fill="none" w="17738" h="15529">
                  <a:moveTo>
                    <a:pt x="2724" y="15528"/>
                  </a:moveTo>
                  <a:cubicBezTo>
                    <a:pt x="1714" y="14552"/>
                    <a:pt x="801" y="13479"/>
                    <a:pt x="0" y="12325"/>
                  </a:cubicBezTo>
                </a:path>
                <a:path stroke="0" w="17738" h="15529">
                  <a:moveTo>
                    <a:pt x="2724" y="15528"/>
                  </a:moveTo>
                  <a:cubicBezTo>
                    <a:pt x="1714" y="14552"/>
                    <a:pt x="801" y="13479"/>
                    <a:pt x="0" y="12325"/>
                  </a:cubicBezTo>
                  <a:lnTo>
                    <a:pt x="17738" y="0"/>
                  </a:lnTo>
                  <a:lnTo>
                    <a:pt x="2724" y="1552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Arc 306"/>
            <p:cNvSpPr/>
            <p:nvPr/>
          </p:nvSpPr>
          <p:spPr>
            <a:xfrm>
              <a:off x="7467480" y="2921040"/>
              <a:ext cx="603360" cy="528480"/>
            </a:xfrm>
            <a:custGeom>
              <a:avLst/>
              <a:gdLst>
                <a:gd name="textAreaLeft" fmla="*/ 0 w 603360"/>
                <a:gd name="textAreaRight" fmla="*/ 603720 w 603360"/>
                <a:gd name="textAreaTop" fmla="*/ 0 h 528480"/>
                <a:gd name="textAreaBottom" fmla="*/ 528840 h 528480"/>
              </a:gdLst>
              <a:ahLst/>
              <a:rect l="textAreaLeft" t="textAreaTop" r="textAreaRight" b="textAreaBottom"/>
              <a:pathLst>
                <a:path fill="none" w="17726" h="15581">
                  <a:moveTo>
                    <a:pt x="2766" y="15580"/>
                  </a:moveTo>
                  <a:cubicBezTo>
                    <a:pt x="1739" y="14595"/>
                    <a:pt x="813" y="13510"/>
                    <a:pt x="0" y="12342"/>
                  </a:cubicBezTo>
                </a:path>
                <a:path stroke="0" w="17726" h="15581">
                  <a:moveTo>
                    <a:pt x="2766" y="15580"/>
                  </a:moveTo>
                  <a:cubicBezTo>
                    <a:pt x="1739" y="14595"/>
                    <a:pt x="813" y="13510"/>
                    <a:pt x="0" y="12342"/>
                  </a:cubicBezTo>
                  <a:lnTo>
                    <a:pt x="17726" y="0"/>
                  </a:lnTo>
                  <a:lnTo>
                    <a:pt x="2766" y="1558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307"/>
            <p:cNvSpPr/>
            <p:nvPr/>
          </p:nvSpPr>
          <p:spPr>
            <a:xfrm flipH="1">
              <a:off x="7414920" y="3341520"/>
              <a:ext cx="5076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308"/>
            <p:cNvSpPr/>
            <p:nvPr/>
          </p:nvSpPr>
          <p:spPr>
            <a:xfrm flipH="1">
              <a:off x="7515000" y="3452760"/>
              <a:ext cx="4428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309"/>
            <p:cNvSpPr/>
            <p:nvPr/>
          </p:nvSpPr>
          <p:spPr>
            <a:xfrm flipV="1">
              <a:off x="7388280" y="3438360"/>
              <a:ext cx="73080" cy="446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310"/>
            <p:cNvSpPr/>
            <p:nvPr/>
          </p:nvSpPr>
          <p:spPr>
            <a:xfrm>
              <a:off x="7304400" y="347976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Freeform 311"/>
            <p:cNvSpPr/>
            <p:nvPr/>
          </p:nvSpPr>
          <p:spPr>
            <a:xfrm>
              <a:off x="7516800" y="3452760"/>
              <a:ext cx="530280" cy="292320"/>
            </a:xfrm>
            <a:custGeom>
              <a:avLst/>
              <a:gdLst>
                <a:gd name="textAreaLeft" fmla="*/ 0 w 530280"/>
                <a:gd name="textAreaRight" fmla="*/ 530640 w 530280"/>
                <a:gd name="textAreaTop" fmla="*/ 0 h 292320"/>
                <a:gd name="textAreaBottom" fmla="*/ 292680 h 292320"/>
              </a:gdLst>
              <a:ahLst/>
              <a:rect l="textAreaLeft" t="textAreaTop" r="textAreaRight" b="textAreaBottom"/>
              <a:pathLst>
                <a:path w="334" h="184">
                  <a:moveTo>
                    <a:pt x="0" y="29"/>
                  </a:moveTo>
                  <a:lnTo>
                    <a:pt x="34" y="59"/>
                  </a:lnTo>
                  <a:lnTo>
                    <a:pt x="70" y="85"/>
                  </a:lnTo>
                  <a:lnTo>
                    <a:pt x="109" y="109"/>
                  </a:lnTo>
                  <a:lnTo>
                    <a:pt x="148" y="128"/>
                  </a:lnTo>
                  <a:lnTo>
                    <a:pt x="190" y="146"/>
                  </a:lnTo>
                  <a:lnTo>
                    <a:pt x="234" y="157"/>
                  </a:lnTo>
                  <a:lnTo>
                    <a:pt x="278" y="166"/>
                  </a:lnTo>
                  <a:lnTo>
                    <a:pt x="301" y="168"/>
                  </a:lnTo>
                  <a:lnTo>
                    <a:pt x="299" y="184"/>
                  </a:lnTo>
                  <a:lnTo>
                    <a:pt x="334" y="151"/>
                  </a:lnTo>
                  <a:lnTo>
                    <a:pt x="306" y="113"/>
                  </a:lnTo>
                  <a:lnTo>
                    <a:pt x="305" y="128"/>
                  </a:lnTo>
                  <a:lnTo>
                    <a:pt x="263" y="123"/>
                  </a:lnTo>
                  <a:lnTo>
                    <a:pt x="224" y="113"/>
                  </a:lnTo>
                  <a:lnTo>
                    <a:pt x="184" y="100"/>
                  </a:lnTo>
                  <a:lnTo>
                    <a:pt x="146" y="83"/>
                  </a:lnTo>
                  <a:lnTo>
                    <a:pt x="110" y="64"/>
                  </a:lnTo>
                  <a:lnTo>
                    <a:pt x="75" y="40"/>
                  </a:lnTo>
                  <a:lnTo>
                    <a:pt x="42" y="15"/>
                  </a:lnTo>
                  <a:lnTo>
                    <a:pt x="28" y="0"/>
                  </a:lnTo>
                  <a:lnTo>
                    <a:pt x="0" y="29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Arc 312"/>
            <p:cNvSpPr/>
            <p:nvPr/>
          </p:nvSpPr>
          <p:spPr>
            <a:xfrm>
              <a:off x="7520040" y="2921040"/>
              <a:ext cx="550800" cy="793800"/>
            </a:xfrm>
            <a:custGeom>
              <a:avLst/>
              <a:gdLst>
                <a:gd name="textAreaLeft" fmla="*/ 0 w 550800"/>
                <a:gd name="textAreaRight" fmla="*/ 551160 w 550800"/>
                <a:gd name="textAreaTop" fmla="*/ 0 h 793800"/>
                <a:gd name="textAreaBottom" fmla="*/ 794160 h 793800"/>
              </a:gdLst>
              <a:ahLst/>
              <a:rect l="textAreaLeft" t="textAreaTop" r="textAreaRight" b="textAreaBottom"/>
              <a:pathLst>
                <a:path fill="none" w="14949" h="21502">
                  <a:moveTo>
                    <a:pt x="12896" y="21502"/>
                  </a:moveTo>
                  <a:cubicBezTo>
                    <a:pt x="8055" y="21040"/>
                    <a:pt x="3510" y="18957"/>
                    <a:pt x="-1" y="15591"/>
                  </a:cubicBezTo>
                </a:path>
                <a:path stroke="0" w="14949" h="21502">
                  <a:moveTo>
                    <a:pt x="12896" y="21502"/>
                  </a:moveTo>
                  <a:cubicBezTo>
                    <a:pt x="8055" y="21040"/>
                    <a:pt x="3510" y="18957"/>
                    <a:pt x="-1" y="15591"/>
                  </a:cubicBezTo>
                  <a:lnTo>
                    <a:pt x="14949" y="0"/>
                  </a:lnTo>
                  <a:lnTo>
                    <a:pt x="12896" y="2150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Arc 313"/>
            <p:cNvSpPr/>
            <p:nvPr/>
          </p:nvSpPr>
          <p:spPr>
            <a:xfrm>
              <a:off x="7562880" y="2921040"/>
              <a:ext cx="507960" cy="730080"/>
            </a:xfrm>
            <a:custGeom>
              <a:avLst/>
              <a:gdLst>
                <a:gd name="textAreaLeft" fmla="*/ 0 w 507960"/>
                <a:gd name="textAreaRight" fmla="*/ 508320 w 507960"/>
                <a:gd name="textAreaTop" fmla="*/ 0 h 730080"/>
                <a:gd name="textAreaBottom" fmla="*/ 730440 h 730080"/>
              </a:gdLst>
              <a:ahLst/>
              <a:rect l="textAreaLeft" t="textAreaTop" r="textAreaRight" b="textAreaBottom"/>
              <a:pathLst>
                <a:path fill="none" w="14936" h="21503">
                  <a:moveTo>
                    <a:pt x="12894" y="21503"/>
                  </a:moveTo>
                  <a:cubicBezTo>
                    <a:pt x="8055" y="21043"/>
                    <a:pt x="3512" y="18965"/>
                    <a:pt x="0" y="15603"/>
                  </a:cubicBezTo>
                </a:path>
                <a:path stroke="0" w="14936" h="21503">
                  <a:moveTo>
                    <a:pt x="12894" y="21503"/>
                  </a:moveTo>
                  <a:cubicBezTo>
                    <a:pt x="8055" y="21043"/>
                    <a:pt x="3512" y="18965"/>
                    <a:pt x="0" y="15603"/>
                  </a:cubicBezTo>
                  <a:lnTo>
                    <a:pt x="14936" y="0"/>
                  </a:lnTo>
                  <a:lnTo>
                    <a:pt x="12894" y="2150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314"/>
            <p:cNvSpPr/>
            <p:nvPr/>
          </p:nvSpPr>
          <p:spPr>
            <a:xfrm flipH="1">
              <a:off x="7516800" y="3452760"/>
              <a:ext cx="44640" cy="46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Freeform 315"/>
            <p:cNvSpPr/>
            <p:nvPr/>
          </p:nvSpPr>
          <p:spPr>
            <a:xfrm>
              <a:off x="7991640" y="3632040"/>
              <a:ext cx="55440" cy="11304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13040"/>
                <a:gd name="textAreaBottom" fmla="*/ 113400 h 113040"/>
              </a:gdLst>
              <a:ahLst/>
              <a:rect l="textAreaLeft" t="textAreaTop" r="textAreaRight" b="textAreaBottom"/>
              <a:pathLst>
                <a:path w="33" h="66">
                  <a:moveTo>
                    <a:pt x="6" y="14"/>
                  </a:moveTo>
                  <a:lnTo>
                    <a:pt x="7" y="0"/>
                  </a:lnTo>
                  <a:lnTo>
                    <a:pt x="33" y="35"/>
                  </a:lnTo>
                  <a:lnTo>
                    <a:pt x="0" y="66"/>
                  </a:lnTo>
                  <a:lnTo>
                    <a:pt x="2" y="5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316"/>
            <p:cNvSpPr/>
            <p:nvPr/>
          </p:nvSpPr>
          <p:spPr>
            <a:xfrm flipV="1">
              <a:off x="7556400" y="3660840"/>
              <a:ext cx="204840" cy="252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317"/>
            <p:cNvSpPr/>
            <p:nvPr/>
          </p:nvSpPr>
          <p:spPr>
            <a:xfrm>
              <a:off x="7287840" y="368136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6" name="Group 321"/>
          <p:cNvGrpSpPr/>
          <p:nvPr/>
        </p:nvGrpSpPr>
        <p:grpSpPr>
          <a:xfrm>
            <a:off x="3600360" y="703440"/>
            <a:ext cx="2526480" cy="1788840"/>
            <a:chOff x="3600360" y="703440"/>
            <a:chExt cx="2526480" cy="1788840"/>
          </a:xfrm>
        </p:grpSpPr>
        <p:sp>
          <p:nvSpPr>
            <p:cNvPr id="497" name="AutoShape 320"/>
            <p:cNvSpPr/>
            <p:nvPr/>
          </p:nvSpPr>
          <p:spPr>
            <a:xfrm>
              <a:off x="3600360" y="703440"/>
              <a:ext cx="2484360" cy="178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Freeform 322"/>
            <p:cNvSpPr/>
            <p:nvPr/>
          </p:nvSpPr>
          <p:spPr>
            <a:xfrm>
              <a:off x="3936960" y="923760"/>
              <a:ext cx="1527120" cy="1528920"/>
            </a:xfrm>
            <a:custGeom>
              <a:avLst/>
              <a:gdLst>
                <a:gd name="textAreaLeft" fmla="*/ 0 w 1527120"/>
                <a:gd name="textAreaRight" fmla="*/ 1527480 w 1527120"/>
                <a:gd name="textAreaTop" fmla="*/ 0 h 1528920"/>
                <a:gd name="textAreaBottom" fmla="*/ 1529280 h 1528920"/>
              </a:gdLst>
              <a:ahLst/>
              <a:rect l="textAreaLeft" t="textAreaTop" r="textAreaRight" b="textAreaBottom"/>
              <a:pathLst>
                <a:path w="962" h="963">
                  <a:moveTo>
                    <a:pt x="485" y="0"/>
                  </a:moveTo>
                  <a:lnTo>
                    <a:pt x="442" y="1"/>
                  </a:lnTo>
                  <a:lnTo>
                    <a:pt x="399" y="7"/>
                  </a:lnTo>
                  <a:lnTo>
                    <a:pt x="357" y="17"/>
                  </a:lnTo>
                  <a:lnTo>
                    <a:pt x="316" y="30"/>
                  </a:lnTo>
                  <a:lnTo>
                    <a:pt x="276" y="45"/>
                  </a:lnTo>
                  <a:lnTo>
                    <a:pt x="238" y="65"/>
                  </a:lnTo>
                  <a:lnTo>
                    <a:pt x="202" y="89"/>
                  </a:lnTo>
                  <a:lnTo>
                    <a:pt x="168" y="115"/>
                  </a:lnTo>
                  <a:lnTo>
                    <a:pt x="137" y="145"/>
                  </a:lnTo>
                  <a:lnTo>
                    <a:pt x="109" y="177"/>
                  </a:lnTo>
                  <a:lnTo>
                    <a:pt x="82" y="212"/>
                  </a:lnTo>
                  <a:lnTo>
                    <a:pt x="61" y="249"/>
                  </a:lnTo>
                  <a:lnTo>
                    <a:pt x="41" y="287"/>
                  </a:lnTo>
                  <a:lnTo>
                    <a:pt x="25" y="327"/>
                  </a:lnTo>
                  <a:lnTo>
                    <a:pt x="14" y="369"/>
                  </a:lnTo>
                  <a:lnTo>
                    <a:pt x="5" y="411"/>
                  </a:lnTo>
                  <a:lnTo>
                    <a:pt x="2" y="454"/>
                  </a:lnTo>
                  <a:lnTo>
                    <a:pt x="0" y="497"/>
                  </a:lnTo>
                  <a:lnTo>
                    <a:pt x="4" y="540"/>
                  </a:lnTo>
                  <a:lnTo>
                    <a:pt x="11" y="583"/>
                  </a:lnTo>
                  <a:lnTo>
                    <a:pt x="22" y="624"/>
                  </a:lnTo>
                  <a:lnTo>
                    <a:pt x="36" y="665"/>
                  </a:lnTo>
                  <a:lnTo>
                    <a:pt x="55" y="703"/>
                  </a:lnTo>
                  <a:lnTo>
                    <a:pt x="76" y="741"/>
                  </a:lnTo>
                  <a:lnTo>
                    <a:pt x="101" y="775"/>
                  </a:lnTo>
                  <a:lnTo>
                    <a:pt x="129" y="808"/>
                  </a:lnTo>
                  <a:lnTo>
                    <a:pt x="160" y="838"/>
                  </a:lnTo>
                  <a:lnTo>
                    <a:pt x="193" y="865"/>
                  </a:lnTo>
                  <a:lnTo>
                    <a:pt x="228" y="890"/>
                  </a:lnTo>
                  <a:lnTo>
                    <a:pt x="265" y="912"/>
                  </a:lnTo>
                  <a:lnTo>
                    <a:pt x="304" y="928"/>
                  </a:lnTo>
                  <a:lnTo>
                    <a:pt x="346" y="943"/>
                  </a:lnTo>
                  <a:lnTo>
                    <a:pt x="388" y="953"/>
                  </a:lnTo>
                  <a:lnTo>
                    <a:pt x="429" y="959"/>
                  </a:lnTo>
                  <a:lnTo>
                    <a:pt x="473" y="963"/>
                  </a:lnTo>
                  <a:lnTo>
                    <a:pt x="516" y="962"/>
                  </a:lnTo>
                  <a:lnTo>
                    <a:pt x="558" y="956"/>
                  </a:lnTo>
                  <a:lnTo>
                    <a:pt x="600" y="947"/>
                  </a:lnTo>
                  <a:lnTo>
                    <a:pt x="642" y="934"/>
                  </a:lnTo>
                  <a:lnTo>
                    <a:pt x="681" y="919"/>
                  </a:lnTo>
                  <a:lnTo>
                    <a:pt x="720" y="899"/>
                  </a:lnTo>
                  <a:lnTo>
                    <a:pt x="756" y="876"/>
                  </a:lnTo>
                  <a:lnTo>
                    <a:pt x="790" y="850"/>
                  </a:lnTo>
                  <a:lnTo>
                    <a:pt x="822" y="821"/>
                  </a:lnTo>
                  <a:lnTo>
                    <a:pt x="850" y="789"/>
                  </a:lnTo>
                  <a:lnTo>
                    <a:pt x="877" y="755"/>
                  </a:lnTo>
                  <a:lnTo>
                    <a:pt x="899" y="718"/>
                  </a:lnTo>
                  <a:lnTo>
                    <a:pt x="919" y="680"/>
                  </a:lnTo>
                  <a:lnTo>
                    <a:pt x="935" y="641"/>
                  </a:lnTo>
                  <a:lnTo>
                    <a:pt x="947" y="599"/>
                  </a:lnTo>
                  <a:lnTo>
                    <a:pt x="956" y="556"/>
                  </a:lnTo>
                  <a:lnTo>
                    <a:pt x="961" y="514"/>
                  </a:lnTo>
                  <a:lnTo>
                    <a:pt x="962" y="471"/>
                  </a:lnTo>
                  <a:lnTo>
                    <a:pt x="959" y="428"/>
                  </a:lnTo>
                  <a:lnTo>
                    <a:pt x="953" y="385"/>
                  </a:lnTo>
                  <a:lnTo>
                    <a:pt x="942" y="344"/>
                  </a:lnTo>
                  <a:lnTo>
                    <a:pt x="928" y="303"/>
                  </a:lnTo>
                  <a:lnTo>
                    <a:pt x="910" y="264"/>
                  </a:lnTo>
                  <a:lnTo>
                    <a:pt x="888" y="226"/>
                  </a:lnTo>
                  <a:lnTo>
                    <a:pt x="865" y="191"/>
                  </a:lnTo>
                  <a:lnTo>
                    <a:pt x="837" y="158"/>
                  </a:lnTo>
                  <a:lnTo>
                    <a:pt x="807" y="127"/>
                  </a:lnTo>
                  <a:lnTo>
                    <a:pt x="775" y="100"/>
                  </a:lnTo>
                  <a:lnTo>
                    <a:pt x="739" y="75"/>
                  </a:lnTo>
                  <a:lnTo>
                    <a:pt x="702" y="54"/>
                  </a:lnTo>
                  <a:lnTo>
                    <a:pt x="663" y="36"/>
                  </a:lnTo>
                  <a:lnTo>
                    <a:pt x="623" y="21"/>
                  </a:lnTo>
                  <a:lnTo>
                    <a:pt x="581" y="11"/>
                  </a:lnTo>
                  <a:lnTo>
                    <a:pt x="538" y="4"/>
                  </a:lnTo>
                  <a:lnTo>
                    <a:pt x="496" y="0"/>
                  </a:lnTo>
                  <a:lnTo>
                    <a:pt x="486" y="0"/>
                  </a:lnTo>
                  <a:lnTo>
                    <a:pt x="486" y="11"/>
                  </a:lnTo>
                  <a:lnTo>
                    <a:pt x="528" y="12"/>
                  </a:lnTo>
                  <a:lnTo>
                    <a:pt x="569" y="18"/>
                  </a:lnTo>
                  <a:lnTo>
                    <a:pt x="610" y="29"/>
                  </a:lnTo>
                  <a:lnTo>
                    <a:pt x="650" y="42"/>
                  </a:lnTo>
                  <a:lnTo>
                    <a:pt x="689" y="58"/>
                  </a:lnTo>
                  <a:lnTo>
                    <a:pt x="726" y="79"/>
                  </a:lnTo>
                  <a:lnTo>
                    <a:pt x="760" y="102"/>
                  </a:lnTo>
                  <a:lnTo>
                    <a:pt x="794" y="128"/>
                  </a:lnTo>
                  <a:lnTo>
                    <a:pt x="823" y="158"/>
                  </a:lnTo>
                  <a:lnTo>
                    <a:pt x="850" y="189"/>
                  </a:lnTo>
                  <a:lnTo>
                    <a:pt x="875" y="224"/>
                  </a:lnTo>
                  <a:lnTo>
                    <a:pt x="897" y="260"/>
                  </a:lnTo>
                  <a:lnTo>
                    <a:pt x="915" y="298"/>
                  </a:lnTo>
                  <a:lnTo>
                    <a:pt x="929" y="338"/>
                  </a:lnTo>
                  <a:lnTo>
                    <a:pt x="941" y="378"/>
                  </a:lnTo>
                  <a:lnTo>
                    <a:pt x="948" y="420"/>
                  </a:lnTo>
                  <a:lnTo>
                    <a:pt x="951" y="461"/>
                  </a:lnTo>
                  <a:lnTo>
                    <a:pt x="951" y="504"/>
                  </a:lnTo>
                  <a:lnTo>
                    <a:pt x="947" y="546"/>
                  </a:lnTo>
                  <a:lnTo>
                    <a:pt x="940" y="587"/>
                  </a:lnTo>
                  <a:lnTo>
                    <a:pt x="929" y="628"/>
                  </a:lnTo>
                  <a:lnTo>
                    <a:pt x="913" y="667"/>
                  </a:lnTo>
                  <a:lnTo>
                    <a:pt x="896" y="705"/>
                  </a:lnTo>
                  <a:lnTo>
                    <a:pt x="873" y="742"/>
                  </a:lnTo>
                  <a:lnTo>
                    <a:pt x="848" y="775"/>
                  </a:lnTo>
                  <a:lnTo>
                    <a:pt x="821" y="807"/>
                  </a:lnTo>
                  <a:lnTo>
                    <a:pt x="791" y="836"/>
                  </a:lnTo>
                  <a:lnTo>
                    <a:pt x="758" y="862"/>
                  </a:lnTo>
                  <a:lnTo>
                    <a:pt x="722" y="886"/>
                  </a:lnTo>
                  <a:lnTo>
                    <a:pt x="685" y="906"/>
                  </a:lnTo>
                  <a:lnTo>
                    <a:pt x="646" y="923"/>
                  </a:lnTo>
                  <a:lnTo>
                    <a:pt x="607" y="936"/>
                  </a:lnTo>
                  <a:lnTo>
                    <a:pt x="566" y="945"/>
                  </a:lnTo>
                  <a:lnTo>
                    <a:pt x="524" y="950"/>
                  </a:lnTo>
                  <a:lnTo>
                    <a:pt x="482" y="952"/>
                  </a:lnTo>
                  <a:lnTo>
                    <a:pt x="440" y="951"/>
                  </a:lnTo>
                  <a:lnTo>
                    <a:pt x="398" y="945"/>
                  </a:lnTo>
                  <a:lnTo>
                    <a:pt x="358" y="936"/>
                  </a:lnTo>
                  <a:lnTo>
                    <a:pt x="317" y="923"/>
                  </a:lnTo>
                  <a:lnTo>
                    <a:pt x="278" y="906"/>
                  </a:lnTo>
                  <a:lnTo>
                    <a:pt x="241" y="887"/>
                  </a:lnTo>
                  <a:lnTo>
                    <a:pt x="206" y="863"/>
                  </a:lnTo>
                  <a:lnTo>
                    <a:pt x="174" y="837"/>
                  </a:lnTo>
                  <a:lnTo>
                    <a:pt x="143" y="808"/>
                  </a:lnTo>
                  <a:lnTo>
                    <a:pt x="114" y="776"/>
                  </a:lnTo>
                  <a:lnTo>
                    <a:pt x="90" y="743"/>
                  </a:lnTo>
                  <a:lnTo>
                    <a:pt x="68" y="707"/>
                  </a:lnTo>
                  <a:lnTo>
                    <a:pt x="49" y="669"/>
                  </a:lnTo>
                  <a:lnTo>
                    <a:pt x="35" y="630"/>
                  </a:lnTo>
                  <a:lnTo>
                    <a:pt x="23" y="590"/>
                  </a:lnTo>
                  <a:lnTo>
                    <a:pt x="16" y="548"/>
                  </a:lnTo>
                  <a:lnTo>
                    <a:pt x="11" y="505"/>
                  </a:lnTo>
                  <a:lnTo>
                    <a:pt x="11" y="464"/>
                  </a:lnTo>
                  <a:lnTo>
                    <a:pt x="15" y="422"/>
                  </a:lnTo>
                  <a:lnTo>
                    <a:pt x="22" y="380"/>
                  </a:lnTo>
                  <a:lnTo>
                    <a:pt x="33" y="340"/>
                  </a:lnTo>
                  <a:lnTo>
                    <a:pt x="47" y="300"/>
                  </a:lnTo>
                  <a:lnTo>
                    <a:pt x="65" y="262"/>
                  </a:lnTo>
                  <a:lnTo>
                    <a:pt x="86" y="226"/>
                  </a:lnTo>
                  <a:lnTo>
                    <a:pt x="111" y="191"/>
                  </a:lnTo>
                  <a:lnTo>
                    <a:pt x="138" y="159"/>
                  </a:lnTo>
                  <a:lnTo>
                    <a:pt x="168" y="130"/>
                  </a:lnTo>
                  <a:lnTo>
                    <a:pt x="200" y="103"/>
                  </a:lnTo>
                  <a:lnTo>
                    <a:pt x="236" y="80"/>
                  </a:lnTo>
                  <a:lnTo>
                    <a:pt x="272" y="60"/>
                  </a:lnTo>
                  <a:lnTo>
                    <a:pt x="310" y="42"/>
                  </a:lnTo>
                  <a:lnTo>
                    <a:pt x="351" y="29"/>
                  </a:lnTo>
                  <a:lnTo>
                    <a:pt x="391" y="19"/>
                  </a:lnTo>
                  <a:lnTo>
                    <a:pt x="433" y="13"/>
                  </a:lnTo>
                  <a:lnTo>
                    <a:pt x="475" y="10"/>
                  </a:lnTo>
                  <a:lnTo>
                    <a:pt x="485" y="11"/>
                  </a:lnTo>
                  <a:lnTo>
                    <a:pt x="485" y="0"/>
                  </a:lnTo>
                  <a:close/>
                </a:path>
              </a:pathLst>
            </a:cu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Oval 323"/>
            <p:cNvSpPr/>
            <p:nvPr/>
          </p:nvSpPr>
          <p:spPr>
            <a:xfrm>
              <a:off x="3936960" y="923760"/>
              <a:ext cx="1519200" cy="151956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Oval 324"/>
            <p:cNvSpPr/>
            <p:nvPr/>
          </p:nvSpPr>
          <p:spPr>
            <a:xfrm>
              <a:off x="3954600" y="941400"/>
              <a:ext cx="1485720" cy="148572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325"/>
            <p:cNvSpPr/>
            <p:nvPr/>
          </p:nvSpPr>
          <p:spPr>
            <a:xfrm flipV="1">
              <a:off x="4707000" y="923400"/>
              <a:ext cx="1440" cy="17640"/>
            </a:xfrm>
            <a:prstGeom prst="line">
              <a:avLst/>
            </a:prstGeom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326"/>
            <p:cNvSpPr/>
            <p:nvPr/>
          </p:nvSpPr>
          <p:spPr>
            <a:xfrm>
              <a:off x="4429800" y="1566720"/>
              <a:ext cx="66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DONR PGI1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327"/>
            <p:cNvSpPr/>
            <p:nvPr/>
          </p:nvSpPr>
          <p:spPr>
            <a:xfrm>
              <a:off x="4601880" y="171612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3912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Freeform 328"/>
            <p:cNvSpPr/>
            <p:nvPr/>
          </p:nvSpPr>
          <p:spPr>
            <a:xfrm>
              <a:off x="5010120" y="971640"/>
              <a:ext cx="406440" cy="419040"/>
            </a:xfrm>
            <a:custGeom>
              <a:avLst/>
              <a:gdLst>
                <a:gd name="textAreaLeft" fmla="*/ 0 w 406440"/>
                <a:gd name="textAreaRight" fmla="*/ 406800 w 406440"/>
                <a:gd name="textAreaTop" fmla="*/ 0 h 419040"/>
                <a:gd name="textAreaBottom" fmla="*/ 419400 h 419040"/>
              </a:gdLst>
              <a:ahLst/>
              <a:rect l="textAreaLeft" t="textAreaTop" r="textAreaRight" b="textAreaBottom"/>
              <a:pathLst>
                <a:path w="256" h="264">
                  <a:moveTo>
                    <a:pt x="256" y="247"/>
                  </a:moveTo>
                  <a:lnTo>
                    <a:pt x="236" y="208"/>
                  </a:lnTo>
                  <a:lnTo>
                    <a:pt x="214" y="170"/>
                  </a:lnTo>
                  <a:lnTo>
                    <a:pt x="186" y="135"/>
                  </a:lnTo>
                  <a:lnTo>
                    <a:pt x="157" y="102"/>
                  </a:lnTo>
                  <a:lnTo>
                    <a:pt x="125" y="72"/>
                  </a:lnTo>
                  <a:lnTo>
                    <a:pt x="89" y="45"/>
                  </a:lnTo>
                  <a:lnTo>
                    <a:pt x="52" y="21"/>
                  </a:lnTo>
                  <a:lnTo>
                    <a:pt x="37" y="14"/>
                  </a:lnTo>
                  <a:lnTo>
                    <a:pt x="45" y="0"/>
                  </a:lnTo>
                  <a:lnTo>
                    <a:pt x="0" y="16"/>
                  </a:lnTo>
                  <a:lnTo>
                    <a:pt x="12" y="62"/>
                  </a:lnTo>
                  <a:lnTo>
                    <a:pt x="19" y="49"/>
                  </a:lnTo>
                  <a:lnTo>
                    <a:pt x="55" y="69"/>
                  </a:lnTo>
                  <a:lnTo>
                    <a:pt x="87" y="93"/>
                  </a:lnTo>
                  <a:lnTo>
                    <a:pt x="118" y="119"/>
                  </a:lnTo>
                  <a:lnTo>
                    <a:pt x="146" y="148"/>
                  </a:lnTo>
                  <a:lnTo>
                    <a:pt x="172" y="180"/>
                  </a:lnTo>
                  <a:lnTo>
                    <a:pt x="195" y="214"/>
                  </a:lnTo>
                  <a:lnTo>
                    <a:pt x="215" y="249"/>
                  </a:lnTo>
                  <a:lnTo>
                    <a:pt x="221" y="264"/>
                  </a:lnTo>
                  <a:lnTo>
                    <a:pt x="256" y="247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Arc 329"/>
            <p:cNvSpPr/>
            <p:nvPr/>
          </p:nvSpPr>
          <p:spPr>
            <a:xfrm>
              <a:off x="4697280" y="995400"/>
              <a:ext cx="714600" cy="689040"/>
            </a:xfrm>
            <a:custGeom>
              <a:avLst/>
              <a:gdLst>
                <a:gd name="textAreaLeft" fmla="*/ 0 w 714600"/>
                <a:gd name="textAreaRight" fmla="*/ 714960 w 714600"/>
                <a:gd name="textAreaTop" fmla="*/ 0 h 689040"/>
                <a:gd name="textAreaBottom" fmla="*/ 689400 h 689040"/>
              </a:gdLst>
              <a:ahLst/>
              <a:rect l="textAreaLeft" t="textAreaTop" r="textAreaRight" b="textAreaBottom"/>
              <a:pathLst>
                <a:path fill="none" w="19728" h="19022">
                  <a:moveTo>
                    <a:pt x="10233" y="-1"/>
                  </a:moveTo>
                  <a:cubicBezTo>
                    <a:pt x="14442" y="2264"/>
                    <a:pt x="17781" y="5860"/>
                    <a:pt x="19727" y="10225"/>
                  </a:cubicBezTo>
                </a:path>
                <a:path stroke="0" w="19728" h="19022">
                  <a:moveTo>
                    <a:pt x="10233" y="-1"/>
                  </a:moveTo>
                  <a:cubicBezTo>
                    <a:pt x="14442" y="2264"/>
                    <a:pt x="17781" y="5860"/>
                    <a:pt x="19727" y="10225"/>
                  </a:cubicBezTo>
                  <a:lnTo>
                    <a:pt x="0" y="19022"/>
                  </a:lnTo>
                  <a:lnTo>
                    <a:pt x="10233" y="-1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Arc 330"/>
            <p:cNvSpPr/>
            <p:nvPr/>
          </p:nvSpPr>
          <p:spPr>
            <a:xfrm>
              <a:off x="4697280" y="1050840"/>
              <a:ext cx="658800" cy="633600"/>
            </a:xfrm>
            <a:custGeom>
              <a:avLst/>
              <a:gdLst>
                <a:gd name="textAreaLeft" fmla="*/ 0 w 658800"/>
                <a:gd name="textAreaRight" fmla="*/ 659160 w 658800"/>
                <a:gd name="textAreaTop" fmla="*/ 0 h 633600"/>
                <a:gd name="textAreaBottom" fmla="*/ 633960 h 633600"/>
              </a:gdLst>
              <a:ahLst/>
              <a:rect l="textAreaLeft" t="textAreaTop" r="textAreaRight" b="textAreaBottom"/>
              <a:pathLst>
                <a:path fill="none" w="19756" h="19001">
                  <a:moveTo>
                    <a:pt x="10272" y="-1"/>
                  </a:moveTo>
                  <a:cubicBezTo>
                    <a:pt x="14483" y="2276"/>
                    <a:pt x="17819" y="5888"/>
                    <a:pt x="19755" y="10267"/>
                  </a:cubicBezTo>
                </a:path>
                <a:path stroke="0" w="19756" h="19001">
                  <a:moveTo>
                    <a:pt x="10272" y="-1"/>
                  </a:moveTo>
                  <a:cubicBezTo>
                    <a:pt x="14483" y="2276"/>
                    <a:pt x="17819" y="5888"/>
                    <a:pt x="19755" y="10267"/>
                  </a:cubicBezTo>
                  <a:lnTo>
                    <a:pt x="0" y="19001"/>
                  </a:lnTo>
                  <a:lnTo>
                    <a:pt x="10272" y="-1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331"/>
            <p:cNvSpPr/>
            <p:nvPr/>
          </p:nvSpPr>
          <p:spPr>
            <a:xfrm flipV="1">
              <a:off x="5361120" y="1363320"/>
              <a:ext cx="55440" cy="2700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Freeform 332"/>
            <p:cNvSpPr/>
            <p:nvPr/>
          </p:nvSpPr>
          <p:spPr>
            <a:xfrm>
              <a:off x="5010120" y="971640"/>
              <a:ext cx="71640" cy="982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38" h="52">
                  <a:moveTo>
                    <a:pt x="16" y="41"/>
                  </a:moveTo>
                  <a:lnTo>
                    <a:pt x="10" y="52"/>
                  </a:lnTo>
                  <a:lnTo>
                    <a:pt x="0" y="14"/>
                  </a:lnTo>
                  <a:lnTo>
                    <a:pt x="38" y="0"/>
                  </a:lnTo>
                  <a:lnTo>
                    <a:pt x="31" y="12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Line 333"/>
            <p:cNvSpPr/>
            <p:nvPr/>
          </p:nvSpPr>
          <p:spPr>
            <a:xfrm flipH="1">
              <a:off x="5254200" y="1073160"/>
              <a:ext cx="127080" cy="5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334"/>
            <p:cNvSpPr/>
            <p:nvPr/>
          </p:nvSpPr>
          <p:spPr>
            <a:xfrm>
              <a:off x="5369760" y="985680"/>
              <a:ext cx="277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Zeo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Freeform 335"/>
            <p:cNvSpPr/>
            <p:nvPr/>
          </p:nvSpPr>
          <p:spPr>
            <a:xfrm>
              <a:off x="3914640" y="879480"/>
              <a:ext cx="770040" cy="1320840"/>
            </a:xfrm>
            <a:custGeom>
              <a:avLst/>
              <a:gdLst>
                <a:gd name="textAreaLeft" fmla="*/ 0 w 770040"/>
                <a:gd name="textAreaRight" fmla="*/ 770400 w 770040"/>
                <a:gd name="textAreaTop" fmla="*/ 0 h 1320840"/>
                <a:gd name="textAreaBottom" fmla="*/ 1321200 h 1320840"/>
              </a:gdLst>
              <a:ahLst/>
              <a:rect l="textAreaLeft" t="textAreaTop" r="textAreaRight" b="textAreaBottom"/>
              <a:pathLst>
                <a:path w="485" h="832">
                  <a:moveTo>
                    <a:pt x="456" y="71"/>
                  </a:moveTo>
                  <a:lnTo>
                    <a:pt x="485" y="33"/>
                  </a:lnTo>
                  <a:lnTo>
                    <a:pt x="450" y="0"/>
                  </a:lnTo>
                  <a:lnTo>
                    <a:pt x="451" y="16"/>
                  </a:lnTo>
                  <a:lnTo>
                    <a:pt x="407" y="21"/>
                  </a:lnTo>
                  <a:lnTo>
                    <a:pt x="364" y="32"/>
                  </a:lnTo>
                  <a:lnTo>
                    <a:pt x="322" y="45"/>
                  </a:lnTo>
                  <a:lnTo>
                    <a:pt x="282" y="63"/>
                  </a:lnTo>
                  <a:lnTo>
                    <a:pt x="242" y="83"/>
                  </a:lnTo>
                  <a:lnTo>
                    <a:pt x="206" y="108"/>
                  </a:lnTo>
                  <a:lnTo>
                    <a:pt x="170" y="135"/>
                  </a:lnTo>
                  <a:lnTo>
                    <a:pt x="138" y="166"/>
                  </a:lnTo>
                  <a:lnTo>
                    <a:pt x="109" y="199"/>
                  </a:lnTo>
                  <a:lnTo>
                    <a:pt x="83" y="235"/>
                  </a:lnTo>
                  <a:lnTo>
                    <a:pt x="60" y="273"/>
                  </a:lnTo>
                  <a:lnTo>
                    <a:pt x="41" y="312"/>
                  </a:lnTo>
                  <a:lnTo>
                    <a:pt x="25" y="354"/>
                  </a:lnTo>
                  <a:lnTo>
                    <a:pt x="13" y="397"/>
                  </a:lnTo>
                  <a:lnTo>
                    <a:pt x="5" y="441"/>
                  </a:lnTo>
                  <a:lnTo>
                    <a:pt x="0" y="485"/>
                  </a:lnTo>
                  <a:lnTo>
                    <a:pt x="0" y="529"/>
                  </a:lnTo>
                  <a:lnTo>
                    <a:pt x="4" y="573"/>
                  </a:lnTo>
                  <a:lnTo>
                    <a:pt x="12" y="616"/>
                  </a:lnTo>
                  <a:lnTo>
                    <a:pt x="23" y="659"/>
                  </a:lnTo>
                  <a:lnTo>
                    <a:pt x="38" y="701"/>
                  </a:lnTo>
                  <a:lnTo>
                    <a:pt x="57" y="741"/>
                  </a:lnTo>
                  <a:lnTo>
                    <a:pt x="80" y="779"/>
                  </a:lnTo>
                  <a:lnTo>
                    <a:pt x="106" y="815"/>
                  </a:lnTo>
                  <a:lnTo>
                    <a:pt x="120" y="832"/>
                  </a:lnTo>
                  <a:lnTo>
                    <a:pt x="150" y="807"/>
                  </a:lnTo>
                  <a:lnTo>
                    <a:pt x="124" y="775"/>
                  </a:lnTo>
                  <a:lnTo>
                    <a:pt x="102" y="740"/>
                  </a:lnTo>
                  <a:lnTo>
                    <a:pt x="83" y="704"/>
                  </a:lnTo>
                  <a:lnTo>
                    <a:pt x="67" y="666"/>
                  </a:lnTo>
                  <a:lnTo>
                    <a:pt x="55" y="627"/>
                  </a:lnTo>
                  <a:lnTo>
                    <a:pt x="47" y="588"/>
                  </a:lnTo>
                  <a:lnTo>
                    <a:pt x="41" y="548"/>
                  </a:lnTo>
                  <a:lnTo>
                    <a:pt x="39" y="507"/>
                  </a:lnTo>
                  <a:lnTo>
                    <a:pt x="42" y="466"/>
                  </a:lnTo>
                  <a:lnTo>
                    <a:pt x="47" y="425"/>
                  </a:lnTo>
                  <a:lnTo>
                    <a:pt x="56" y="386"/>
                  </a:lnTo>
                  <a:lnTo>
                    <a:pt x="69" y="347"/>
                  </a:lnTo>
                  <a:lnTo>
                    <a:pt x="86" y="310"/>
                  </a:lnTo>
                  <a:lnTo>
                    <a:pt x="105" y="273"/>
                  </a:lnTo>
                  <a:lnTo>
                    <a:pt x="127" y="240"/>
                  </a:lnTo>
                  <a:lnTo>
                    <a:pt x="152" y="208"/>
                  </a:lnTo>
                  <a:lnTo>
                    <a:pt x="181" y="178"/>
                  </a:lnTo>
                  <a:lnTo>
                    <a:pt x="212" y="152"/>
                  </a:lnTo>
                  <a:lnTo>
                    <a:pt x="245" y="128"/>
                  </a:lnTo>
                  <a:lnTo>
                    <a:pt x="280" y="107"/>
                  </a:lnTo>
                  <a:lnTo>
                    <a:pt x="317" y="89"/>
                  </a:lnTo>
                  <a:lnTo>
                    <a:pt x="355" y="74"/>
                  </a:lnTo>
                  <a:lnTo>
                    <a:pt x="394" y="64"/>
                  </a:lnTo>
                  <a:lnTo>
                    <a:pt x="435" y="57"/>
                  </a:lnTo>
                  <a:lnTo>
                    <a:pt x="455" y="54"/>
                  </a:lnTo>
                  <a:lnTo>
                    <a:pt x="456" y="71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Arc 336"/>
            <p:cNvSpPr/>
            <p:nvPr/>
          </p:nvSpPr>
          <p:spPr>
            <a:xfrm>
              <a:off x="3914640" y="905040"/>
              <a:ext cx="782640" cy="1293480"/>
            </a:xfrm>
            <a:custGeom>
              <a:avLst/>
              <a:gdLst>
                <a:gd name="textAreaLeft" fmla="*/ 0 w 782640"/>
                <a:gd name="textAreaRight" fmla="*/ 783000 w 782640"/>
                <a:gd name="textAreaTop" fmla="*/ 0 h 1293480"/>
                <a:gd name="textAreaBottom" fmla="*/ 1293840 h 1293480"/>
              </a:gdLst>
              <a:ahLst/>
              <a:rect l="textAreaLeft" t="textAreaTop" r="textAreaRight" b="textAreaBottom"/>
              <a:pathLst>
                <a:path fill="none" w="21600" h="35711">
                  <a:moveTo>
                    <a:pt x="5314" y="35711"/>
                  </a:moveTo>
                  <a:cubicBezTo>
                    <a:pt x="1887" y="31778"/>
                    <a:pt x="0" y="26737"/>
                    <a:pt x="0" y="21521"/>
                  </a:cubicBezTo>
                  <a:cubicBezTo>
                    <a:pt x="-1" y="10305"/>
                    <a:pt x="8584" y="955"/>
                    <a:pt x="19758" y="-1"/>
                  </a:cubicBezTo>
                </a:path>
                <a:path stroke="0" w="21600" h="35711">
                  <a:moveTo>
                    <a:pt x="5314" y="35711"/>
                  </a:moveTo>
                  <a:cubicBezTo>
                    <a:pt x="1887" y="31778"/>
                    <a:pt x="0" y="26737"/>
                    <a:pt x="0" y="21521"/>
                  </a:cubicBezTo>
                  <a:cubicBezTo>
                    <a:pt x="-1" y="10305"/>
                    <a:pt x="8584" y="955"/>
                    <a:pt x="19758" y="-1"/>
                  </a:cubicBezTo>
                  <a:lnTo>
                    <a:pt x="21600" y="21521"/>
                  </a:lnTo>
                  <a:lnTo>
                    <a:pt x="5314" y="3571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Arc 337"/>
            <p:cNvSpPr/>
            <p:nvPr/>
          </p:nvSpPr>
          <p:spPr>
            <a:xfrm>
              <a:off x="3976560" y="966960"/>
              <a:ext cx="720720" cy="1191960"/>
            </a:xfrm>
            <a:custGeom>
              <a:avLst/>
              <a:gdLst>
                <a:gd name="textAreaLeft" fmla="*/ 0 w 720720"/>
                <a:gd name="textAreaRight" fmla="*/ 721080 w 720720"/>
                <a:gd name="textAreaTop" fmla="*/ 0 h 1191960"/>
                <a:gd name="textAreaBottom" fmla="*/ 1192320 h 1191960"/>
              </a:gdLst>
              <a:ahLst/>
              <a:rect l="textAreaLeft" t="textAreaTop" r="textAreaRight" b="textAreaBottom"/>
              <a:pathLst>
                <a:path fill="none" w="21600" h="35735">
                  <a:moveTo>
                    <a:pt x="5333" y="35735"/>
                  </a:moveTo>
                  <a:cubicBezTo>
                    <a:pt x="1894" y="31799"/>
                    <a:pt x="0" y="26750"/>
                    <a:pt x="0" y="21524"/>
                  </a:cubicBezTo>
                  <a:cubicBezTo>
                    <a:pt x="-1" y="10295"/>
                    <a:pt x="8602" y="939"/>
                    <a:pt x="19791" y="-1"/>
                  </a:cubicBezTo>
                </a:path>
                <a:path stroke="0" w="21600" h="35735">
                  <a:moveTo>
                    <a:pt x="5333" y="35735"/>
                  </a:moveTo>
                  <a:cubicBezTo>
                    <a:pt x="1894" y="31799"/>
                    <a:pt x="0" y="26750"/>
                    <a:pt x="0" y="21524"/>
                  </a:cubicBezTo>
                  <a:cubicBezTo>
                    <a:pt x="-1" y="10295"/>
                    <a:pt x="8602" y="939"/>
                    <a:pt x="19791" y="-1"/>
                  </a:cubicBezTo>
                  <a:lnTo>
                    <a:pt x="21600" y="21524"/>
                  </a:lnTo>
                  <a:lnTo>
                    <a:pt x="5333" y="3573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338"/>
            <p:cNvSpPr/>
            <p:nvPr/>
          </p:nvSpPr>
          <p:spPr>
            <a:xfrm flipH="1">
              <a:off x="4105440" y="2160720"/>
              <a:ext cx="4752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Freeform 339"/>
            <p:cNvSpPr/>
            <p:nvPr/>
          </p:nvSpPr>
          <p:spPr>
            <a:xfrm>
              <a:off x="4629240" y="879480"/>
              <a:ext cx="55440" cy="1126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9" h="60">
                  <a:moveTo>
                    <a:pt x="4" y="46"/>
                  </a:moveTo>
                  <a:lnTo>
                    <a:pt x="5" y="60"/>
                  </a:lnTo>
                  <a:lnTo>
                    <a:pt x="29" y="28"/>
                  </a:lnTo>
                  <a:lnTo>
                    <a:pt x="0" y="0"/>
                  </a:lnTo>
                  <a:lnTo>
                    <a:pt x="1" y="1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Line 340"/>
            <p:cNvSpPr/>
            <p:nvPr/>
          </p:nvSpPr>
          <p:spPr>
            <a:xfrm>
              <a:off x="3852720" y="1335240"/>
              <a:ext cx="13032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341"/>
            <p:cNvSpPr/>
            <p:nvPr/>
          </p:nvSpPr>
          <p:spPr>
            <a:xfrm>
              <a:off x="3611520" y="1235160"/>
              <a:ext cx="23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s-ES" sz="700" spc="-1" strike="noStrike">
                  <a:solidFill>
                    <a:srgbClr val="000000"/>
                  </a:solidFill>
                  <a:latin typeface="Arial"/>
                </a:rPr>
                <a:t>PGI1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Freeform 342"/>
            <p:cNvSpPr/>
            <p:nvPr/>
          </p:nvSpPr>
          <p:spPr>
            <a:xfrm>
              <a:off x="4127400" y="2182680"/>
              <a:ext cx="127080" cy="123840"/>
            </a:xfrm>
            <a:custGeom>
              <a:avLst/>
              <a:gdLst>
                <a:gd name="textAreaLeft" fmla="*/ 0 w 127080"/>
                <a:gd name="textAreaRight" fmla="*/ 127440 w 12708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80" h="78">
                  <a:moveTo>
                    <a:pt x="50" y="0"/>
                  </a:moveTo>
                  <a:lnTo>
                    <a:pt x="4" y="2"/>
                  </a:lnTo>
                  <a:lnTo>
                    <a:pt x="0" y="50"/>
                  </a:lnTo>
                  <a:lnTo>
                    <a:pt x="11" y="39"/>
                  </a:lnTo>
                  <a:lnTo>
                    <a:pt x="44" y="69"/>
                  </a:lnTo>
                  <a:lnTo>
                    <a:pt x="55" y="78"/>
                  </a:lnTo>
                  <a:lnTo>
                    <a:pt x="80" y="48"/>
                  </a:lnTo>
                  <a:lnTo>
                    <a:pt x="49" y="20"/>
                  </a:lnTo>
                  <a:lnTo>
                    <a:pt x="38" y="11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Arc 343"/>
            <p:cNvSpPr/>
            <p:nvPr/>
          </p:nvSpPr>
          <p:spPr>
            <a:xfrm>
              <a:off x="4148280" y="1684440"/>
              <a:ext cx="549000" cy="619200"/>
            </a:xfrm>
            <a:custGeom>
              <a:avLst/>
              <a:gdLst>
                <a:gd name="textAreaLeft" fmla="*/ 0 w 549000"/>
                <a:gd name="textAreaRight" fmla="*/ 549360 w 549000"/>
                <a:gd name="textAreaTop" fmla="*/ 0 h 619200"/>
                <a:gd name="textAreaBottom" fmla="*/ 619560 h 619200"/>
              </a:gdLst>
              <a:ahLst/>
              <a:rect l="textAreaLeft" t="textAreaTop" r="textAreaRight" b="textAreaBottom"/>
              <a:pathLst>
                <a:path fill="none" w="15164" h="17069">
                  <a:moveTo>
                    <a:pt x="1927" y="17068"/>
                  </a:moveTo>
                  <a:cubicBezTo>
                    <a:pt x="1251" y="16545"/>
                    <a:pt x="608" y="15981"/>
                    <a:pt x="-1" y="15382"/>
                  </a:cubicBezTo>
                </a:path>
                <a:path stroke="0" w="15164" h="17069">
                  <a:moveTo>
                    <a:pt x="1927" y="17068"/>
                  </a:moveTo>
                  <a:cubicBezTo>
                    <a:pt x="1251" y="16545"/>
                    <a:pt x="608" y="15981"/>
                    <a:pt x="-1" y="15382"/>
                  </a:cubicBezTo>
                  <a:lnTo>
                    <a:pt x="15164" y="0"/>
                  </a:lnTo>
                  <a:lnTo>
                    <a:pt x="1927" y="17068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Arc 344"/>
            <p:cNvSpPr/>
            <p:nvPr/>
          </p:nvSpPr>
          <p:spPr>
            <a:xfrm>
              <a:off x="4191120" y="1684440"/>
              <a:ext cx="506160" cy="569880"/>
            </a:xfrm>
            <a:custGeom>
              <a:avLst/>
              <a:gdLst>
                <a:gd name="textAreaLeft" fmla="*/ 0 w 506160"/>
                <a:gd name="textAreaRight" fmla="*/ 506520 w 506160"/>
                <a:gd name="textAreaTop" fmla="*/ 0 h 569880"/>
                <a:gd name="textAreaBottom" fmla="*/ 569880 h 569880"/>
              </a:gdLst>
              <a:ahLst/>
              <a:rect l="textAreaLeft" t="textAreaTop" r="textAreaRight" b="textAreaBottom"/>
              <a:pathLst>
                <a:path fill="none" w="15187" h="17101">
                  <a:moveTo>
                    <a:pt x="1991" y="17101"/>
                  </a:moveTo>
                  <a:cubicBezTo>
                    <a:pt x="1292" y="16561"/>
                    <a:pt x="627" y="15980"/>
                    <a:pt x="-1" y="15359"/>
                  </a:cubicBezTo>
                </a:path>
                <a:path stroke="0" w="15187" h="17101">
                  <a:moveTo>
                    <a:pt x="1991" y="17101"/>
                  </a:moveTo>
                  <a:cubicBezTo>
                    <a:pt x="1292" y="16561"/>
                    <a:pt x="627" y="15980"/>
                    <a:pt x="-1" y="15359"/>
                  </a:cubicBezTo>
                  <a:lnTo>
                    <a:pt x="15187" y="0"/>
                  </a:lnTo>
                  <a:lnTo>
                    <a:pt x="1991" y="1710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345"/>
            <p:cNvSpPr/>
            <p:nvPr/>
          </p:nvSpPr>
          <p:spPr>
            <a:xfrm flipH="1">
              <a:off x="4214880" y="2259000"/>
              <a:ext cx="39600" cy="4752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Freeform 346"/>
            <p:cNvSpPr/>
            <p:nvPr/>
          </p:nvSpPr>
          <p:spPr>
            <a:xfrm>
              <a:off x="4127400" y="2182680"/>
              <a:ext cx="79560" cy="7956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42" h="42">
                  <a:moveTo>
                    <a:pt x="32" y="9"/>
                  </a:moveTo>
                  <a:lnTo>
                    <a:pt x="42" y="0"/>
                  </a:lnTo>
                  <a:lnTo>
                    <a:pt x="3" y="2"/>
                  </a:lnTo>
                  <a:lnTo>
                    <a:pt x="0" y="42"/>
                  </a:lnTo>
                  <a:lnTo>
                    <a:pt x="9" y="33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347"/>
            <p:cNvSpPr/>
            <p:nvPr/>
          </p:nvSpPr>
          <p:spPr>
            <a:xfrm flipV="1">
              <a:off x="4040280" y="2259000"/>
              <a:ext cx="120600" cy="4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348"/>
            <p:cNvSpPr/>
            <p:nvPr/>
          </p:nvSpPr>
          <p:spPr>
            <a:xfrm>
              <a:off x="3862440" y="230364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Freeform 349"/>
            <p:cNvSpPr/>
            <p:nvPr/>
          </p:nvSpPr>
          <p:spPr>
            <a:xfrm>
              <a:off x="4689360" y="876240"/>
              <a:ext cx="152640" cy="11448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96" h="72">
                  <a:moveTo>
                    <a:pt x="96" y="24"/>
                  </a:moveTo>
                  <a:lnTo>
                    <a:pt x="52" y="17"/>
                  </a:lnTo>
                  <a:lnTo>
                    <a:pt x="32" y="16"/>
                  </a:lnTo>
                  <a:lnTo>
                    <a:pt x="33" y="0"/>
                  </a:lnTo>
                  <a:lnTo>
                    <a:pt x="0" y="35"/>
                  </a:lnTo>
                  <a:lnTo>
                    <a:pt x="30" y="72"/>
                  </a:lnTo>
                  <a:lnTo>
                    <a:pt x="30" y="55"/>
                  </a:lnTo>
                  <a:lnTo>
                    <a:pt x="70" y="59"/>
                  </a:lnTo>
                  <a:lnTo>
                    <a:pt x="89" y="62"/>
                  </a:lnTo>
                  <a:lnTo>
                    <a:pt x="96" y="24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Arc 350"/>
            <p:cNvSpPr/>
            <p:nvPr/>
          </p:nvSpPr>
          <p:spPr>
            <a:xfrm>
              <a:off x="4697280" y="903240"/>
              <a:ext cx="144720" cy="781200"/>
            </a:xfrm>
            <a:custGeom>
              <a:avLst/>
              <a:gdLst>
                <a:gd name="textAreaLeft" fmla="*/ 0 w 144720"/>
                <a:gd name="textAreaRight" fmla="*/ 145080 w 144720"/>
                <a:gd name="textAreaTop" fmla="*/ 0 h 781200"/>
                <a:gd name="textAreaBottom" fmla="*/ 781560 h 781200"/>
              </a:gdLst>
              <a:ahLst/>
              <a:rect l="textAreaLeft" t="textAreaTop" r="textAreaRight" b="textAreaBottom"/>
              <a:pathLst>
                <a:path fill="none" w="3983" h="21568">
                  <a:moveTo>
                    <a:pt x="1180" y="0"/>
                  </a:moveTo>
                  <a:cubicBezTo>
                    <a:pt x="2121" y="51"/>
                    <a:pt x="3057" y="164"/>
                    <a:pt x="3982" y="338"/>
                  </a:cubicBezTo>
                </a:path>
                <a:path stroke="0" w="3983" h="21568">
                  <a:moveTo>
                    <a:pt x="1180" y="0"/>
                  </a:moveTo>
                  <a:cubicBezTo>
                    <a:pt x="2121" y="51"/>
                    <a:pt x="3057" y="164"/>
                    <a:pt x="3982" y="338"/>
                  </a:cubicBezTo>
                  <a:lnTo>
                    <a:pt x="0" y="21568"/>
                  </a:lnTo>
                  <a:lnTo>
                    <a:pt x="1180" y="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Arc 351"/>
            <p:cNvSpPr/>
            <p:nvPr/>
          </p:nvSpPr>
          <p:spPr>
            <a:xfrm>
              <a:off x="4697280" y="965160"/>
              <a:ext cx="133560" cy="719280"/>
            </a:xfrm>
            <a:custGeom>
              <a:avLst/>
              <a:gdLst>
                <a:gd name="textAreaLeft" fmla="*/ 0 w 133560"/>
                <a:gd name="textAreaRight" fmla="*/ 133920 w 133560"/>
                <a:gd name="textAreaTop" fmla="*/ 0 h 719280"/>
                <a:gd name="textAreaBottom" fmla="*/ 719640 h 719280"/>
              </a:gdLst>
              <a:ahLst/>
              <a:rect l="textAreaLeft" t="textAreaTop" r="textAreaRight" b="textAreaBottom"/>
              <a:pathLst>
                <a:path fill="none" w="3993" h="21567">
                  <a:moveTo>
                    <a:pt x="1189" y="-1"/>
                  </a:moveTo>
                  <a:cubicBezTo>
                    <a:pt x="2130" y="51"/>
                    <a:pt x="3066" y="165"/>
                    <a:pt x="3992" y="339"/>
                  </a:cubicBezTo>
                </a:path>
                <a:path stroke="0" w="3993" h="21567">
                  <a:moveTo>
                    <a:pt x="1189" y="-1"/>
                  </a:moveTo>
                  <a:cubicBezTo>
                    <a:pt x="2130" y="51"/>
                    <a:pt x="3066" y="165"/>
                    <a:pt x="3992" y="339"/>
                  </a:cubicBezTo>
                  <a:lnTo>
                    <a:pt x="0" y="21567"/>
                  </a:lnTo>
                  <a:lnTo>
                    <a:pt x="1189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352"/>
            <p:cNvSpPr/>
            <p:nvPr/>
          </p:nvSpPr>
          <p:spPr>
            <a:xfrm flipV="1">
              <a:off x="4830840" y="914400"/>
              <a:ext cx="11160" cy="6048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Freeform 353"/>
            <p:cNvSpPr/>
            <p:nvPr/>
          </p:nvSpPr>
          <p:spPr>
            <a:xfrm>
              <a:off x="4689360" y="876240"/>
              <a:ext cx="52560" cy="114480"/>
            </a:xfrm>
            <a:custGeom>
              <a:avLst/>
              <a:gdLst>
                <a:gd name="textAreaLeft" fmla="*/ 0 w 52560"/>
                <a:gd name="textAreaRight" fmla="*/ 52920 w 52560"/>
                <a:gd name="textAreaTop" fmla="*/ 0 h 114480"/>
                <a:gd name="textAreaBottom" fmla="*/ 114840 h 114480"/>
              </a:gdLst>
              <a:ahLst/>
              <a:rect l="textAreaLeft" t="textAreaTop" r="textAreaRight" b="textAreaBottom"/>
              <a:pathLst>
                <a:path w="28" h="60">
                  <a:moveTo>
                    <a:pt x="25" y="46"/>
                  </a:moveTo>
                  <a:lnTo>
                    <a:pt x="25" y="60"/>
                  </a:lnTo>
                  <a:lnTo>
                    <a:pt x="0" y="29"/>
                  </a:lnTo>
                  <a:lnTo>
                    <a:pt x="28" y="0"/>
                  </a:lnTo>
                  <a:lnTo>
                    <a:pt x="27" y="13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354"/>
            <p:cNvSpPr/>
            <p:nvPr/>
          </p:nvSpPr>
          <p:spPr>
            <a:xfrm>
              <a:off x="4761000" y="809640"/>
              <a:ext cx="4680" cy="9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355"/>
            <p:cNvSpPr/>
            <p:nvPr/>
          </p:nvSpPr>
          <p:spPr>
            <a:xfrm>
              <a:off x="4757760" y="72216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Arc 356"/>
            <p:cNvSpPr/>
            <p:nvPr/>
          </p:nvSpPr>
          <p:spPr>
            <a:xfrm>
              <a:off x="4697280" y="1062000"/>
              <a:ext cx="141480" cy="622440"/>
            </a:xfrm>
            <a:custGeom>
              <a:avLst/>
              <a:gdLst>
                <a:gd name="textAreaLeft" fmla="*/ 0 w 141480"/>
                <a:gd name="textAreaRight" fmla="*/ 141840 w 141480"/>
                <a:gd name="textAreaTop" fmla="*/ 0 h 622440"/>
                <a:gd name="textAreaBottom" fmla="*/ 622800 h 622440"/>
              </a:gdLst>
              <a:ahLst/>
              <a:rect l="textAreaLeft" t="textAreaTop" r="textAreaRight" b="textAreaBottom"/>
              <a:pathLst>
                <a:path fill="none" w="4865" h="21389">
                  <a:moveTo>
                    <a:pt x="3009" y="-1"/>
                  </a:moveTo>
                  <a:cubicBezTo>
                    <a:pt x="3632" y="87"/>
                    <a:pt x="4251" y="202"/>
                    <a:pt x="4864" y="344"/>
                  </a:cubicBezTo>
                </a:path>
                <a:path stroke="0" w="4865" h="21389">
                  <a:moveTo>
                    <a:pt x="3009" y="-1"/>
                  </a:moveTo>
                  <a:cubicBezTo>
                    <a:pt x="3632" y="87"/>
                    <a:pt x="4251" y="202"/>
                    <a:pt x="4864" y="344"/>
                  </a:cubicBezTo>
                  <a:lnTo>
                    <a:pt x="0" y="21389"/>
                  </a:lnTo>
                  <a:lnTo>
                    <a:pt x="3009" y="-1"/>
                  </a:lnTo>
                  <a:close/>
                </a:path>
              </a:pathLst>
            </a:custGeom>
            <a:noFill/>
            <a:ln w="79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357"/>
            <p:cNvSpPr/>
            <p:nvPr/>
          </p:nvSpPr>
          <p:spPr>
            <a:xfrm flipH="1">
              <a:off x="4838400" y="1012680"/>
              <a:ext cx="12600" cy="59040"/>
            </a:xfrm>
            <a:prstGeom prst="line">
              <a:avLst/>
            </a:prstGeom>
            <a:ln w="792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Freeform 358"/>
            <p:cNvSpPr/>
            <p:nvPr/>
          </p:nvSpPr>
          <p:spPr>
            <a:xfrm>
              <a:off x="4784760" y="1044720"/>
              <a:ext cx="30240" cy="42840"/>
            </a:xfrm>
            <a:custGeom>
              <a:avLst/>
              <a:gdLst>
                <a:gd name="textAreaLeft" fmla="*/ 0 w 30240"/>
                <a:gd name="textAreaRight" fmla="*/ 30600 w 30240"/>
                <a:gd name="textAreaTop" fmla="*/ 0 h 42840"/>
                <a:gd name="textAreaBottom" fmla="*/ 43200 h 42840"/>
              </a:gdLst>
              <a:ahLst/>
              <a:rect l="textAreaLeft" t="textAreaTop" r="textAreaRight" b="textAreaBottom"/>
              <a:pathLst>
                <a:path w="16" h="23">
                  <a:moveTo>
                    <a:pt x="16" y="0"/>
                  </a:moveTo>
                  <a:lnTo>
                    <a:pt x="0" y="9"/>
                  </a:lnTo>
                  <a:lnTo>
                    <a:pt x="12" y="23"/>
                  </a:lnTo>
                </a:path>
              </a:pathLst>
            </a:custGeom>
            <a:noFill/>
            <a:ln w="79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359"/>
            <p:cNvSpPr/>
            <p:nvPr/>
          </p:nvSpPr>
          <p:spPr>
            <a:xfrm flipH="1">
              <a:off x="4851000" y="893880"/>
              <a:ext cx="82440" cy="11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360"/>
            <p:cNvSpPr/>
            <p:nvPr/>
          </p:nvSpPr>
          <p:spPr>
            <a:xfrm>
              <a:off x="4894200" y="80640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T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Freeform 361"/>
            <p:cNvSpPr/>
            <p:nvPr/>
          </p:nvSpPr>
          <p:spPr>
            <a:xfrm>
              <a:off x="5354640" y="1376280"/>
              <a:ext cx="106200" cy="10332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67" h="65">
                  <a:moveTo>
                    <a:pt x="62" y="54"/>
                  </a:moveTo>
                  <a:lnTo>
                    <a:pt x="51" y="23"/>
                  </a:lnTo>
                  <a:lnTo>
                    <a:pt x="67" y="17"/>
                  </a:lnTo>
                  <a:lnTo>
                    <a:pt x="22" y="0"/>
                  </a:lnTo>
                  <a:lnTo>
                    <a:pt x="0" y="42"/>
                  </a:lnTo>
                  <a:lnTo>
                    <a:pt x="16" y="36"/>
                  </a:lnTo>
                  <a:lnTo>
                    <a:pt x="25" y="65"/>
                  </a:lnTo>
                  <a:lnTo>
                    <a:pt x="62" y="54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Arc 362"/>
            <p:cNvSpPr/>
            <p:nvPr/>
          </p:nvSpPr>
          <p:spPr>
            <a:xfrm>
              <a:off x="4697280" y="1414440"/>
              <a:ext cx="750960" cy="270000"/>
            </a:xfrm>
            <a:custGeom>
              <a:avLst/>
              <a:gdLst>
                <a:gd name="textAreaLeft" fmla="*/ 0 w 750960"/>
                <a:gd name="textAreaRight" fmla="*/ 751320 w 750960"/>
                <a:gd name="textAreaTop" fmla="*/ 0 h 270000"/>
                <a:gd name="textAreaBottom" fmla="*/ 270360 h 270000"/>
              </a:gdLst>
              <a:ahLst/>
              <a:rect l="textAreaLeft" t="textAreaTop" r="textAreaRight" b="textAreaBottom"/>
              <a:pathLst>
                <a:path fill="none" w="20722" h="7455">
                  <a:moveTo>
                    <a:pt x="20272" y="0"/>
                  </a:moveTo>
                  <a:cubicBezTo>
                    <a:pt x="20437" y="448"/>
                    <a:pt x="20587" y="901"/>
                    <a:pt x="20722" y="1359"/>
                  </a:cubicBezTo>
                </a:path>
                <a:path stroke="0" w="20722" h="7455">
                  <a:moveTo>
                    <a:pt x="20272" y="0"/>
                  </a:moveTo>
                  <a:cubicBezTo>
                    <a:pt x="20437" y="448"/>
                    <a:pt x="20587" y="901"/>
                    <a:pt x="20722" y="1359"/>
                  </a:cubicBezTo>
                  <a:lnTo>
                    <a:pt x="0" y="7455"/>
                  </a:lnTo>
                  <a:lnTo>
                    <a:pt x="2027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Arc 363"/>
            <p:cNvSpPr/>
            <p:nvPr/>
          </p:nvSpPr>
          <p:spPr>
            <a:xfrm>
              <a:off x="4697280" y="1436760"/>
              <a:ext cx="690840" cy="247680"/>
            </a:xfrm>
            <a:custGeom>
              <a:avLst/>
              <a:gdLst>
                <a:gd name="textAreaLeft" fmla="*/ 0 w 690840"/>
                <a:gd name="textAreaRight" fmla="*/ 691200 w 69084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fill="none" w="20726" h="7443">
                  <a:moveTo>
                    <a:pt x="20277" y="-1"/>
                  </a:moveTo>
                  <a:cubicBezTo>
                    <a:pt x="20441" y="447"/>
                    <a:pt x="20591" y="901"/>
                    <a:pt x="20725" y="1359"/>
                  </a:cubicBezTo>
                </a:path>
                <a:path stroke="0" w="20726" h="7443">
                  <a:moveTo>
                    <a:pt x="20277" y="-1"/>
                  </a:moveTo>
                  <a:cubicBezTo>
                    <a:pt x="20441" y="447"/>
                    <a:pt x="20591" y="901"/>
                    <a:pt x="20725" y="1359"/>
                  </a:cubicBezTo>
                  <a:lnTo>
                    <a:pt x="0" y="7443"/>
                  </a:lnTo>
                  <a:lnTo>
                    <a:pt x="20277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364"/>
            <p:cNvSpPr/>
            <p:nvPr/>
          </p:nvSpPr>
          <p:spPr>
            <a:xfrm flipV="1">
              <a:off x="5394240" y="1461600"/>
              <a:ext cx="586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Freeform 365"/>
            <p:cNvSpPr/>
            <p:nvPr/>
          </p:nvSpPr>
          <p:spPr>
            <a:xfrm>
              <a:off x="5354640" y="1376280"/>
              <a:ext cx="106200" cy="6660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6" h="35">
                  <a:moveTo>
                    <a:pt x="13" y="30"/>
                  </a:moveTo>
                  <a:lnTo>
                    <a:pt x="0" y="35"/>
                  </a:lnTo>
                  <a:lnTo>
                    <a:pt x="18" y="0"/>
                  </a:lnTo>
                  <a:lnTo>
                    <a:pt x="56" y="14"/>
                  </a:lnTo>
                  <a:lnTo>
                    <a:pt x="43" y="1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366"/>
            <p:cNvSpPr/>
            <p:nvPr/>
          </p:nvSpPr>
          <p:spPr>
            <a:xfrm flipH="1">
              <a:off x="5435640" y="1380960"/>
              <a:ext cx="149040" cy="32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Rectangle 367"/>
            <p:cNvSpPr/>
            <p:nvPr/>
          </p:nvSpPr>
          <p:spPr>
            <a:xfrm>
              <a:off x="5533200" y="1379520"/>
              <a:ext cx="59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EM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31T17:49:44Z</dcterms:created>
  <dc:creator>Paco</dc:creator>
  <dc:description/>
  <dc:language>en-US</dc:language>
  <cp:lastModifiedBy>Javier Pozueta</cp:lastModifiedBy>
  <dcterms:modified xsi:type="dcterms:W3CDTF">2015-01-27T09:10:21Z</dcterms:modified>
  <cp:revision>60</cp:revision>
  <dc:subject/>
  <dc:title>Diapositiva 1</dc:title>
</cp:coreProperties>
</file>